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  <p:sldId id="263" r:id="rId5"/>
  </p:sldIdLst>
  <p:sldSz cx="10693400" cy="7562850"/>
  <p:notesSz cx="10693400" cy="75628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-936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802005" y="2344483"/>
            <a:ext cx="9089390" cy="158819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604010" y="4235196"/>
            <a:ext cx="7485379" cy="189071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>
              <a:defRPr sz="7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z="650" spc="15" dirty="0"/>
              <a:t>6     </a:t>
            </a:r>
            <a:r>
              <a:rPr sz="650" spc="40" dirty="0"/>
              <a:t> </a:t>
            </a:r>
            <a:r>
              <a:rPr sz="650" spc="15" dirty="0"/>
              <a:t>7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8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9</a:t>
            </a:r>
            <a:r>
              <a:rPr sz="650" dirty="0"/>
              <a:t>    </a:t>
            </a:r>
            <a:r>
              <a:rPr sz="650" spc="20" dirty="0"/>
              <a:t> </a:t>
            </a:r>
            <a:r>
              <a:rPr sz="650" spc="15" dirty="0"/>
              <a:t>10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1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</a:t>
            </a:r>
            <a:r>
              <a:rPr sz="650" spc="30" dirty="0"/>
              <a:t>2</a:t>
            </a:r>
            <a:r>
              <a:rPr spc="-5" dirty="0"/>
              <a:t>t</a:t>
            </a:r>
            <a:r>
              <a:rPr spc="-10" dirty="0"/>
              <a:t>i</a:t>
            </a:r>
            <a:r>
              <a:rPr spc="-5" dirty="0"/>
              <a:t>me</a:t>
            </a:r>
            <a:r>
              <a:rPr dirty="0"/>
              <a:t> </a:t>
            </a:r>
            <a:r>
              <a:rPr spc="-5" dirty="0"/>
              <a:t>(h)</a:t>
            </a:r>
            <a:endParaRPr sz="650"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>
              <a:defRPr sz="6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pc="15" dirty="0"/>
              <a:t>0     </a:t>
            </a:r>
            <a:r>
              <a:rPr spc="40" dirty="0"/>
              <a:t> </a:t>
            </a:r>
            <a:r>
              <a:rPr spc="15" dirty="0"/>
              <a:t>1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2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3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4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5</a:t>
            </a:r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>
              <a:defRPr sz="7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z="650" spc="15" dirty="0"/>
              <a:t>6     </a:t>
            </a:r>
            <a:r>
              <a:rPr sz="650" spc="40" dirty="0"/>
              <a:t> </a:t>
            </a:r>
            <a:r>
              <a:rPr sz="650" spc="15" dirty="0"/>
              <a:t>7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8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9</a:t>
            </a:r>
            <a:r>
              <a:rPr sz="650" dirty="0"/>
              <a:t>    </a:t>
            </a:r>
            <a:r>
              <a:rPr sz="650" spc="20" dirty="0"/>
              <a:t> </a:t>
            </a:r>
            <a:r>
              <a:rPr sz="650" spc="15" dirty="0"/>
              <a:t>10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1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</a:t>
            </a:r>
            <a:r>
              <a:rPr sz="650" spc="30" dirty="0"/>
              <a:t>2</a:t>
            </a:r>
            <a:r>
              <a:rPr spc="-5" dirty="0"/>
              <a:t>t</a:t>
            </a:r>
            <a:r>
              <a:rPr spc="-10" dirty="0"/>
              <a:t>i</a:t>
            </a:r>
            <a:r>
              <a:rPr spc="-5" dirty="0"/>
              <a:t>me</a:t>
            </a:r>
            <a:r>
              <a:rPr dirty="0"/>
              <a:t> </a:t>
            </a:r>
            <a:r>
              <a:rPr spc="-5" dirty="0"/>
              <a:t>(h)</a:t>
            </a:r>
            <a:endParaRPr sz="650"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>
              <a:defRPr sz="6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pc="15" dirty="0"/>
              <a:t>0     </a:t>
            </a:r>
            <a:r>
              <a:rPr spc="40" dirty="0"/>
              <a:t> </a:t>
            </a:r>
            <a:r>
              <a:rPr spc="15" dirty="0"/>
              <a:t>1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2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3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4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5</a:t>
            </a:r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534670" y="1739455"/>
            <a:ext cx="4651629" cy="499148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5507100" y="1739455"/>
            <a:ext cx="4651629" cy="499148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>
              <a:defRPr sz="7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z="650" spc="15" dirty="0"/>
              <a:t>6     </a:t>
            </a:r>
            <a:r>
              <a:rPr sz="650" spc="40" dirty="0"/>
              <a:t> </a:t>
            </a:r>
            <a:r>
              <a:rPr sz="650" spc="15" dirty="0"/>
              <a:t>7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8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9</a:t>
            </a:r>
            <a:r>
              <a:rPr sz="650" dirty="0"/>
              <a:t>    </a:t>
            </a:r>
            <a:r>
              <a:rPr sz="650" spc="20" dirty="0"/>
              <a:t> </a:t>
            </a:r>
            <a:r>
              <a:rPr sz="650" spc="15" dirty="0"/>
              <a:t>10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1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</a:t>
            </a:r>
            <a:r>
              <a:rPr sz="650" spc="30" dirty="0"/>
              <a:t>2</a:t>
            </a:r>
            <a:r>
              <a:rPr spc="-5" dirty="0"/>
              <a:t>t</a:t>
            </a:r>
            <a:r>
              <a:rPr spc="-10" dirty="0"/>
              <a:t>i</a:t>
            </a:r>
            <a:r>
              <a:rPr spc="-5" dirty="0"/>
              <a:t>me</a:t>
            </a:r>
            <a:r>
              <a:rPr dirty="0"/>
              <a:t> </a:t>
            </a:r>
            <a:r>
              <a:rPr spc="-5" dirty="0"/>
              <a:t>(h)</a:t>
            </a:r>
            <a:endParaRPr sz="650"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>
              <a:defRPr sz="6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pc="15" dirty="0"/>
              <a:t>0     </a:t>
            </a:r>
            <a:r>
              <a:rPr spc="40" dirty="0"/>
              <a:t> </a:t>
            </a:r>
            <a:r>
              <a:rPr spc="15" dirty="0"/>
              <a:t>1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2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3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4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5</a:t>
            </a:r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>
              <a:defRPr sz="7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z="650" spc="15" dirty="0"/>
              <a:t>6     </a:t>
            </a:r>
            <a:r>
              <a:rPr sz="650" spc="40" dirty="0"/>
              <a:t> </a:t>
            </a:r>
            <a:r>
              <a:rPr sz="650" spc="15" dirty="0"/>
              <a:t>7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8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9</a:t>
            </a:r>
            <a:r>
              <a:rPr sz="650" dirty="0"/>
              <a:t>    </a:t>
            </a:r>
            <a:r>
              <a:rPr sz="650" spc="20" dirty="0"/>
              <a:t> </a:t>
            </a:r>
            <a:r>
              <a:rPr sz="650" spc="15" dirty="0"/>
              <a:t>10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1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</a:t>
            </a:r>
            <a:r>
              <a:rPr sz="650" spc="30" dirty="0"/>
              <a:t>2</a:t>
            </a:r>
            <a:r>
              <a:rPr spc="-5" dirty="0"/>
              <a:t>t</a:t>
            </a:r>
            <a:r>
              <a:rPr spc="-10" dirty="0"/>
              <a:t>i</a:t>
            </a:r>
            <a:r>
              <a:rPr spc="-5" dirty="0"/>
              <a:t>me</a:t>
            </a:r>
            <a:r>
              <a:rPr dirty="0"/>
              <a:t> </a:t>
            </a:r>
            <a:r>
              <a:rPr spc="-5" dirty="0"/>
              <a:t>(h)</a:t>
            </a:r>
            <a:endParaRPr sz="650"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>
              <a:defRPr sz="6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pc="15" dirty="0"/>
              <a:t>0     </a:t>
            </a:r>
            <a:r>
              <a:rPr spc="40" dirty="0"/>
              <a:t> </a:t>
            </a:r>
            <a:r>
              <a:rPr spc="15" dirty="0"/>
              <a:t>1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2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3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4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5</a:t>
            </a:r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>
              <a:defRPr sz="7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z="650" spc="15" dirty="0"/>
              <a:t>6     </a:t>
            </a:r>
            <a:r>
              <a:rPr sz="650" spc="40" dirty="0"/>
              <a:t> </a:t>
            </a:r>
            <a:r>
              <a:rPr sz="650" spc="15" dirty="0"/>
              <a:t>7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8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9</a:t>
            </a:r>
            <a:r>
              <a:rPr sz="650" dirty="0"/>
              <a:t>    </a:t>
            </a:r>
            <a:r>
              <a:rPr sz="650" spc="20" dirty="0"/>
              <a:t> </a:t>
            </a:r>
            <a:r>
              <a:rPr sz="650" spc="15" dirty="0"/>
              <a:t>10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1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</a:t>
            </a:r>
            <a:r>
              <a:rPr sz="650" spc="30" dirty="0"/>
              <a:t>2</a:t>
            </a:r>
            <a:r>
              <a:rPr spc="-5" dirty="0"/>
              <a:t>t</a:t>
            </a:r>
            <a:r>
              <a:rPr spc="-10" dirty="0"/>
              <a:t>i</a:t>
            </a:r>
            <a:r>
              <a:rPr spc="-5" dirty="0"/>
              <a:t>me</a:t>
            </a:r>
            <a:r>
              <a:rPr dirty="0"/>
              <a:t> </a:t>
            </a:r>
            <a:r>
              <a:rPr spc="-5" dirty="0"/>
              <a:t>(h)</a:t>
            </a:r>
            <a:endParaRPr sz="650"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>
              <a:defRPr sz="6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pc="15" dirty="0"/>
              <a:t>0     </a:t>
            </a:r>
            <a:r>
              <a:rPr spc="40" dirty="0"/>
              <a:t> </a:t>
            </a:r>
            <a:r>
              <a:rPr spc="15" dirty="0"/>
              <a:t>1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2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3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4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5</a:t>
            </a:r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534670" y="302513"/>
            <a:ext cx="9624059" cy="121005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534670" y="1739455"/>
            <a:ext cx="9624059" cy="499148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693878" y="6336026"/>
            <a:ext cx="1371600" cy="1301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7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z="650" spc="15" dirty="0"/>
              <a:t>6     </a:t>
            </a:r>
            <a:r>
              <a:rPr sz="650" spc="40" dirty="0"/>
              <a:t> </a:t>
            </a:r>
            <a:r>
              <a:rPr sz="650" spc="15" dirty="0"/>
              <a:t>7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8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9</a:t>
            </a:r>
            <a:r>
              <a:rPr sz="650" dirty="0"/>
              <a:t>    </a:t>
            </a:r>
            <a:r>
              <a:rPr sz="650" spc="20" dirty="0"/>
              <a:t> </a:t>
            </a:r>
            <a:r>
              <a:rPr sz="650" spc="15" dirty="0"/>
              <a:t>10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1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</a:t>
            </a:r>
            <a:r>
              <a:rPr sz="650" spc="30" dirty="0"/>
              <a:t>2</a:t>
            </a:r>
            <a:r>
              <a:rPr spc="-5" dirty="0"/>
              <a:t>t</a:t>
            </a:r>
            <a:r>
              <a:rPr spc="-10" dirty="0"/>
              <a:t>i</a:t>
            </a:r>
            <a:r>
              <a:rPr spc="-5" dirty="0"/>
              <a:t>me</a:t>
            </a:r>
            <a:r>
              <a:rPr dirty="0"/>
              <a:t> </a:t>
            </a:r>
            <a:r>
              <a:rPr spc="-5" dirty="0"/>
              <a:t>(h)</a:t>
            </a:r>
            <a:endParaRPr sz="650"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1724536" y="6348726"/>
            <a:ext cx="877569" cy="1174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650">
                <a:latin typeface="Calibri"/>
                <a:cs typeface="Calibri"/>
              </a:defRPr>
            </a:lvl1pPr>
          </a:lstStyle>
          <a:p>
            <a:pPr marL="12700">
              <a:lnSpc>
                <a:spcPct val="100000"/>
              </a:lnSpc>
            </a:pPr>
            <a:r>
              <a:rPr spc="15" dirty="0"/>
              <a:t>0     </a:t>
            </a:r>
            <a:r>
              <a:rPr spc="40" dirty="0"/>
              <a:t> </a:t>
            </a:r>
            <a:r>
              <a:rPr spc="15" dirty="0"/>
              <a:t>1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2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3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4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5</a:t>
            </a:r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7699248" y="7033450"/>
            <a:ext cx="2459482" cy="37814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3000641" y="2247900"/>
            <a:ext cx="615950" cy="0"/>
          </a:xfrm>
          <a:custGeom>
            <a:avLst/>
            <a:gdLst/>
            <a:ahLst/>
            <a:cxnLst/>
            <a:rect l="l" t="t" r="r" b="b"/>
            <a:pathLst>
              <a:path w="615950">
                <a:moveTo>
                  <a:pt x="0" y="0"/>
                </a:moveTo>
                <a:lnTo>
                  <a:pt x="615695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1650377" y="2247900"/>
            <a:ext cx="1289685" cy="0"/>
          </a:xfrm>
          <a:custGeom>
            <a:avLst/>
            <a:gdLst/>
            <a:ahLst/>
            <a:cxnLst/>
            <a:rect l="l" t="t" r="r" b="b"/>
            <a:pathLst>
              <a:path w="1289685">
                <a:moveTo>
                  <a:pt x="0" y="0"/>
                </a:moveTo>
                <a:lnTo>
                  <a:pt x="1289304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1650377" y="2043683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1650377" y="183794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650377" y="163372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1650377" y="1427988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1650377" y="1223772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1650377" y="1018032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1677809" y="1018032"/>
            <a:ext cx="0" cy="1403985"/>
          </a:xfrm>
          <a:custGeom>
            <a:avLst/>
            <a:gdLst/>
            <a:ahLst/>
            <a:cxnLst/>
            <a:rect l="l" t="t" r="r" b="b"/>
            <a:pathLst>
              <a:path h="1403985">
                <a:moveTo>
                  <a:pt x="0" y="0"/>
                </a:moveTo>
                <a:lnTo>
                  <a:pt x="0" y="1403604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1708289" y="2453639"/>
            <a:ext cx="1908175" cy="0"/>
          </a:xfrm>
          <a:custGeom>
            <a:avLst/>
            <a:gdLst/>
            <a:ahLst/>
            <a:cxnLst/>
            <a:rect l="l" t="t" r="r" b="b"/>
            <a:pathLst>
              <a:path w="1908175">
                <a:moveTo>
                  <a:pt x="0" y="0"/>
                </a:moveTo>
                <a:lnTo>
                  <a:pt x="1908047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1637931" y="1097025"/>
            <a:ext cx="2019807" cy="1398397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" name="object 13"/>
          <p:cNvSpPr txBox="1"/>
          <p:nvPr/>
        </p:nvSpPr>
        <p:spPr>
          <a:xfrm>
            <a:off x="1541659" y="2395473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1497460" y="2191256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5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1454791" y="1985517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1454791" y="1781299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1454791" y="1575561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8" name="object 18"/>
          <p:cNvSpPr txBox="1"/>
          <p:nvPr/>
        </p:nvSpPr>
        <p:spPr>
          <a:xfrm>
            <a:off x="1454791" y="1369823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" name="object 19"/>
          <p:cNvSpPr txBox="1"/>
          <p:nvPr/>
        </p:nvSpPr>
        <p:spPr>
          <a:xfrm>
            <a:off x="1454791" y="1165605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" name="object 20"/>
          <p:cNvSpPr txBox="1"/>
          <p:nvPr/>
        </p:nvSpPr>
        <p:spPr>
          <a:xfrm>
            <a:off x="1454791" y="959866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1" name="object 21"/>
          <p:cNvSpPr/>
          <p:nvPr/>
        </p:nvSpPr>
        <p:spPr>
          <a:xfrm>
            <a:off x="3788549" y="148437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3855605" y="1458467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3852557" y="1455419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4" h="56515">
                <a:moveTo>
                  <a:pt x="56388" y="30480"/>
                </a:moveTo>
                <a:lnTo>
                  <a:pt x="56388" y="25908"/>
                </a:lnTo>
                <a:lnTo>
                  <a:pt x="30480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30480"/>
                </a:lnTo>
                <a:lnTo>
                  <a:pt x="4572" y="35052"/>
                </a:lnTo>
                <a:lnTo>
                  <a:pt x="4572" y="25908"/>
                </a:lnTo>
                <a:lnTo>
                  <a:pt x="6858" y="28193"/>
                </a:lnTo>
                <a:lnTo>
                  <a:pt x="25908" y="9143"/>
                </a:lnTo>
                <a:lnTo>
                  <a:pt x="25908" y="4572"/>
                </a:lnTo>
                <a:lnTo>
                  <a:pt x="30480" y="4572"/>
                </a:lnTo>
                <a:lnTo>
                  <a:pt x="30480" y="9144"/>
                </a:lnTo>
                <a:lnTo>
                  <a:pt x="49530" y="28194"/>
                </a:lnTo>
                <a:lnTo>
                  <a:pt x="51816" y="25908"/>
                </a:lnTo>
                <a:lnTo>
                  <a:pt x="51816" y="35052"/>
                </a:lnTo>
                <a:lnTo>
                  <a:pt x="56388" y="30480"/>
                </a:lnTo>
                <a:close/>
              </a:path>
              <a:path w="56514" h="56515">
                <a:moveTo>
                  <a:pt x="6858" y="28194"/>
                </a:moveTo>
                <a:lnTo>
                  <a:pt x="4572" y="25908"/>
                </a:lnTo>
                <a:lnTo>
                  <a:pt x="4572" y="30480"/>
                </a:lnTo>
                <a:lnTo>
                  <a:pt x="6858" y="28194"/>
                </a:lnTo>
                <a:close/>
              </a:path>
              <a:path w="56514" h="56515">
                <a:moveTo>
                  <a:pt x="28194" y="49530"/>
                </a:moveTo>
                <a:lnTo>
                  <a:pt x="6858" y="28194"/>
                </a:lnTo>
                <a:lnTo>
                  <a:pt x="4572" y="30480"/>
                </a:lnTo>
                <a:lnTo>
                  <a:pt x="4572" y="35052"/>
                </a:lnTo>
                <a:lnTo>
                  <a:pt x="25908" y="56388"/>
                </a:lnTo>
                <a:lnTo>
                  <a:pt x="25908" y="51816"/>
                </a:lnTo>
                <a:lnTo>
                  <a:pt x="28194" y="49530"/>
                </a:lnTo>
                <a:close/>
              </a:path>
              <a:path w="56514" h="56515">
                <a:moveTo>
                  <a:pt x="30480" y="4572"/>
                </a:moveTo>
                <a:lnTo>
                  <a:pt x="25908" y="4572"/>
                </a:lnTo>
                <a:lnTo>
                  <a:pt x="28194" y="6857"/>
                </a:lnTo>
                <a:lnTo>
                  <a:pt x="30480" y="4572"/>
                </a:lnTo>
                <a:close/>
              </a:path>
              <a:path w="56514" h="56515">
                <a:moveTo>
                  <a:pt x="28194" y="6858"/>
                </a:moveTo>
                <a:lnTo>
                  <a:pt x="25908" y="4572"/>
                </a:lnTo>
                <a:lnTo>
                  <a:pt x="25908" y="9143"/>
                </a:lnTo>
                <a:lnTo>
                  <a:pt x="28194" y="6858"/>
                </a:lnTo>
                <a:close/>
              </a:path>
              <a:path w="56514" h="56515">
                <a:moveTo>
                  <a:pt x="30480" y="51816"/>
                </a:moveTo>
                <a:lnTo>
                  <a:pt x="28194" y="49530"/>
                </a:lnTo>
                <a:lnTo>
                  <a:pt x="25908" y="51816"/>
                </a:lnTo>
                <a:lnTo>
                  <a:pt x="30480" y="51816"/>
                </a:lnTo>
                <a:close/>
              </a:path>
              <a:path w="56514" h="56515">
                <a:moveTo>
                  <a:pt x="30480" y="56388"/>
                </a:moveTo>
                <a:lnTo>
                  <a:pt x="30480" y="51816"/>
                </a:lnTo>
                <a:lnTo>
                  <a:pt x="25908" y="51816"/>
                </a:lnTo>
                <a:lnTo>
                  <a:pt x="25908" y="56388"/>
                </a:lnTo>
                <a:lnTo>
                  <a:pt x="30480" y="56388"/>
                </a:lnTo>
                <a:close/>
              </a:path>
              <a:path w="56514" h="56515">
                <a:moveTo>
                  <a:pt x="30480" y="9144"/>
                </a:moveTo>
                <a:lnTo>
                  <a:pt x="30480" y="4572"/>
                </a:lnTo>
                <a:lnTo>
                  <a:pt x="28194" y="6858"/>
                </a:lnTo>
                <a:lnTo>
                  <a:pt x="30480" y="9144"/>
                </a:lnTo>
                <a:close/>
              </a:path>
              <a:path w="56514" h="56515">
                <a:moveTo>
                  <a:pt x="51816" y="35052"/>
                </a:moveTo>
                <a:lnTo>
                  <a:pt x="51816" y="30480"/>
                </a:lnTo>
                <a:lnTo>
                  <a:pt x="49530" y="28193"/>
                </a:lnTo>
                <a:lnTo>
                  <a:pt x="28194" y="49530"/>
                </a:lnTo>
                <a:lnTo>
                  <a:pt x="30480" y="51816"/>
                </a:lnTo>
                <a:lnTo>
                  <a:pt x="30480" y="56388"/>
                </a:lnTo>
                <a:lnTo>
                  <a:pt x="51816" y="35052"/>
                </a:lnTo>
                <a:close/>
              </a:path>
              <a:path w="56514" h="56515">
                <a:moveTo>
                  <a:pt x="51816" y="30480"/>
                </a:moveTo>
                <a:lnTo>
                  <a:pt x="51816" y="25908"/>
                </a:lnTo>
                <a:lnTo>
                  <a:pt x="49530" y="28193"/>
                </a:lnTo>
                <a:lnTo>
                  <a:pt x="51816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3788549" y="1778507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3855605" y="1778507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3852557" y="1749551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19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19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19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19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19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19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3788549" y="207263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3855605" y="2046732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3852557" y="2043683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6388"/>
                </a:moveTo>
                <a:lnTo>
                  <a:pt x="57912" y="53340"/>
                </a:lnTo>
                <a:lnTo>
                  <a:pt x="32004" y="1524"/>
                </a:lnTo>
                <a:lnTo>
                  <a:pt x="28956" y="0"/>
                </a:lnTo>
                <a:lnTo>
                  <a:pt x="25908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8382" y="51816"/>
                </a:lnTo>
                <a:lnTo>
                  <a:pt x="25908" y="16764"/>
                </a:lnTo>
                <a:lnTo>
                  <a:pt x="25908" y="4572"/>
                </a:lnTo>
                <a:lnTo>
                  <a:pt x="32004" y="4572"/>
                </a:lnTo>
                <a:lnTo>
                  <a:pt x="32004" y="16764"/>
                </a:lnTo>
                <a:lnTo>
                  <a:pt x="49530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19">
                <a:moveTo>
                  <a:pt x="8382" y="51816"/>
                </a:moveTo>
                <a:lnTo>
                  <a:pt x="3048" y="51816"/>
                </a:lnTo>
                <a:lnTo>
                  <a:pt x="6096" y="56388"/>
                </a:lnTo>
                <a:lnTo>
                  <a:pt x="8382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6388"/>
                </a:lnTo>
                <a:lnTo>
                  <a:pt x="49530" y="51816"/>
                </a:lnTo>
                <a:lnTo>
                  <a:pt x="8382" y="51816"/>
                </a:lnTo>
                <a:lnTo>
                  <a:pt x="6096" y="56388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19">
                <a:moveTo>
                  <a:pt x="32004" y="4572"/>
                </a:moveTo>
                <a:lnTo>
                  <a:pt x="25908" y="4572"/>
                </a:lnTo>
                <a:lnTo>
                  <a:pt x="28956" y="10668"/>
                </a:lnTo>
                <a:lnTo>
                  <a:pt x="32004" y="4572"/>
                </a:lnTo>
                <a:close/>
              </a:path>
              <a:path w="58420" h="58419">
                <a:moveTo>
                  <a:pt x="28956" y="10668"/>
                </a:moveTo>
                <a:lnTo>
                  <a:pt x="25908" y="4572"/>
                </a:lnTo>
                <a:lnTo>
                  <a:pt x="25908" y="16764"/>
                </a:lnTo>
                <a:lnTo>
                  <a:pt x="28956" y="10668"/>
                </a:lnTo>
                <a:close/>
              </a:path>
              <a:path w="58420" h="58419">
                <a:moveTo>
                  <a:pt x="32004" y="16764"/>
                </a:moveTo>
                <a:lnTo>
                  <a:pt x="32004" y="4572"/>
                </a:lnTo>
                <a:lnTo>
                  <a:pt x="28956" y="10668"/>
                </a:lnTo>
                <a:lnTo>
                  <a:pt x="32004" y="16764"/>
                </a:lnTo>
                <a:close/>
              </a:path>
              <a:path w="58420" h="58419">
                <a:moveTo>
                  <a:pt x="54864" y="51816"/>
                </a:moveTo>
                <a:lnTo>
                  <a:pt x="49530" y="51816"/>
                </a:lnTo>
                <a:lnTo>
                  <a:pt x="51816" y="56388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0" name="object 30"/>
          <p:cNvSpPr/>
          <p:nvPr/>
        </p:nvSpPr>
        <p:spPr>
          <a:xfrm>
            <a:off x="1003300" y="902208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5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5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5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5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1" name="object 31"/>
          <p:cNvSpPr txBox="1"/>
          <p:nvPr/>
        </p:nvSpPr>
        <p:spPr>
          <a:xfrm>
            <a:off x="1643764" y="2495554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3969391" y="1420068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3969391" y="1720341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3969391" y="2014473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3874903" y="1014260"/>
            <a:ext cx="433705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2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36" name="object 36"/>
          <p:cNvSpPr txBox="1"/>
          <p:nvPr/>
        </p:nvSpPr>
        <p:spPr>
          <a:xfrm>
            <a:off x="1060076" y="964392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7" name="object 37"/>
          <p:cNvSpPr/>
          <p:nvPr/>
        </p:nvSpPr>
        <p:spPr>
          <a:xfrm>
            <a:off x="5861189" y="197510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8" name="object 38"/>
          <p:cNvSpPr/>
          <p:nvPr/>
        </p:nvSpPr>
        <p:spPr>
          <a:xfrm>
            <a:off x="5861189" y="149656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5861189" y="1018032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5888621" y="1018032"/>
            <a:ext cx="0" cy="1466215"/>
          </a:xfrm>
          <a:custGeom>
            <a:avLst/>
            <a:gdLst/>
            <a:ahLst/>
            <a:cxnLst/>
            <a:rect l="l" t="t" r="r" b="b"/>
            <a:pathLst>
              <a:path h="1466214">
                <a:moveTo>
                  <a:pt x="0" y="0"/>
                </a:moveTo>
                <a:lnTo>
                  <a:pt x="0" y="1466087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1" name="object 41"/>
          <p:cNvSpPr/>
          <p:nvPr/>
        </p:nvSpPr>
        <p:spPr>
          <a:xfrm>
            <a:off x="5861189" y="245363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2" name="object 42"/>
          <p:cNvSpPr/>
          <p:nvPr/>
        </p:nvSpPr>
        <p:spPr>
          <a:xfrm>
            <a:off x="6047117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3" name="object 43"/>
          <p:cNvSpPr/>
          <p:nvPr/>
        </p:nvSpPr>
        <p:spPr>
          <a:xfrm>
            <a:off x="6208662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4" name="object 44"/>
          <p:cNvSpPr/>
          <p:nvPr/>
        </p:nvSpPr>
        <p:spPr>
          <a:xfrm>
            <a:off x="6370193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5" name="object 45"/>
          <p:cNvSpPr/>
          <p:nvPr/>
        </p:nvSpPr>
        <p:spPr>
          <a:xfrm>
            <a:off x="6531749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6" name="object 46"/>
          <p:cNvSpPr/>
          <p:nvPr/>
        </p:nvSpPr>
        <p:spPr>
          <a:xfrm>
            <a:off x="6693281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7" name="object 47"/>
          <p:cNvSpPr/>
          <p:nvPr/>
        </p:nvSpPr>
        <p:spPr>
          <a:xfrm>
            <a:off x="6854825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8" name="object 48"/>
          <p:cNvSpPr/>
          <p:nvPr/>
        </p:nvSpPr>
        <p:spPr>
          <a:xfrm>
            <a:off x="7016381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9" name="object 49"/>
          <p:cNvSpPr/>
          <p:nvPr/>
        </p:nvSpPr>
        <p:spPr>
          <a:xfrm>
            <a:off x="7177925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0" name="object 50"/>
          <p:cNvSpPr/>
          <p:nvPr/>
        </p:nvSpPr>
        <p:spPr>
          <a:xfrm>
            <a:off x="7339469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1" name="object 51"/>
          <p:cNvSpPr/>
          <p:nvPr/>
        </p:nvSpPr>
        <p:spPr>
          <a:xfrm>
            <a:off x="7501001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2" name="object 52"/>
          <p:cNvSpPr/>
          <p:nvPr/>
        </p:nvSpPr>
        <p:spPr>
          <a:xfrm>
            <a:off x="7662557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3" name="object 53"/>
          <p:cNvSpPr/>
          <p:nvPr/>
        </p:nvSpPr>
        <p:spPr>
          <a:xfrm>
            <a:off x="7824101" y="2453639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5889891" y="1212850"/>
            <a:ext cx="1978647" cy="678688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5919101" y="1443227"/>
            <a:ext cx="1914525" cy="542925"/>
          </a:xfrm>
          <a:custGeom>
            <a:avLst/>
            <a:gdLst/>
            <a:ahLst/>
            <a:cxnLst/>
            <a:rect l="l" t="t" r="r" b="b"/>
            <a:pathLst>
              <a:path w="1914525" h="542925">
                <a:moveTo>
                  <a:pt x="86150" y="80771"/>
                </a:moveTo>
                <a:lnTo>
                  <a:pt x="47244" y="80771"/>
                </a:lnTo>
                <a:lnTo>
                  <a:pt x="44196" y="82295"/>
                </a:lnTo>
                <a:lnTo>
                  <a:pt x="42672" y="83819"/>
                </a:lnTo>
                <a:lnTo>
                  <a:pt x="3048" y="132587"/>
                </a:lnTo>
                <a:lnTo>
                  <a:pt x="0" y="137159"/>
                </a:lnTo>
                <a:lnTo>
                  <a:pt x="1524" y="143255"/>
                </a:lnTo>
                <a:lnTo>
                  <a:pt x="4572" y="146303"/>
                </a:lnTo>
                <a:lnTo>
                  <a:pt x="9144" y="149351"/>
                </a:lnTo>
                <a:lnTo>
                  <a:pt x="15240" y="147827"/>
                </a:lnTo>
                <a:lnTo>
                  <a:pt x="18288" y="144779"/>
                </a:lnTo>
                <a:lnTo>
                  <a:pt x="50292" y="105390"/>
                </a:lnTo>
                <a:lnTo>
                  <a:pt x="50292" y="99059"/>
                </a:lnTo>
                <a:lnTo>
                  <a:pt x="57912" y="96011"/>
                </a:lnTo>
                <a:lnTo>
                  <a:pt x="57912" y="99059"/>
                </a:lnTo>
                <a:lnTo>
                  <a:pt x="83820" y="99059"/>
                </a:lnTo>
                <a:lnTo>
                  <a:pt x="83820" y="85343"/>
                </a:lnTo>
                <a:lnTo>
                  <a:pt x="86150" y="80771"/>
                </a:lnTo>
                <a:close/>
              </a:path>
              <a:path w="1914525" h="542925">
                <a:moveTo>
                  <a:pt x="57912" y="96011"/>
                </a:moveTo>
                <a:lnTo>
                  <a:pt x="50292" y="99059"/>
                </a:lnTo>
                <a:lnTo>
                  <a:pt x="55435" y="99059"/>
                </a:lnTo>
                <a:lnTo>
                  <a:pt x="57912" y="96011"/>
                </a:lnTo>
                <a:close/>
              </a:path>
              <a:path w="1914525" h="542925">
                <a:moveTo>
                  <a:pt x="55435" y="99059"/>
                </a:moveTo>
                <a:lnTo>
                  <a:pt x="50292" y="99059"/>
                </a:lnTo>
                <a:lnTo>
                  <a:pt x="50292" y="105390"/>
                </a:lnTo>
                <a:lnTo>
                  <a:pt x="55435" y="99059"/>
                </a:lnTo>
                <a:close/>
              </a:path>
              <a:path w="1914525" h="542925">
                <a:moveTo>
                  <a:pt x="57912" y="99059"/>
                </a:moveTo>
                <a:lnTo>
                  <a:pt x="57912" y="96011"/>
                </a:lnTo>
                <a:lnTo>
                  <a:pt x="55435" y="99059"/>
                </a:lnTo>
                <a:lnTo>
                  <a:pt x="57912" y="99059"/>
                </a:lnTo>
                <a:close/>
              </a:path>
              <a:path w="1914525" h="542925">
                <a:moveTo>
                  <a:pt x="91440" y="80771"/>
                </a:moveTo>
                <a:lnTo>
                  <a:pt x="86150" y="80771"/>
                </a:lnTo>
                <a:lnTo>
                  <a:pt x="83820" y="85343"/>
                </a:lnTo>
                <a:lnTo>
                  <a:pt x="91440" y="80771"/>
                </a:lnTo>
                <a:close/>
              </a:path>
              <a:path w="1914525" h="542925">
                <a:moveTo>
                  <a:pt x="91440" y="99059"/>
                </a:moveTo>
                <a:lnTo>
                  <a:pt x="91440" y="80771"/>
                </a:lnTo>
                <a:lnTo>
                  <a:pt x="83820" y="85343"/>
                </a:lnTo>
                <a:lnTo>
                  <a:pt x="83820" y="99059"/>
                </a:lnTo>
                <a:lnTo>
                  <a:pt x="91440" y="99059"/>
                </a:lnTo>
                <a:close/>
              </a:path>
              <a:path w="1914525" h="542925">
                <a:moveTo>
                  <a:pt x="211769" y="53412"/>
                </a:moveTo>
                <a:lnTo>
                  <a:pt x="135636" y="4571"/>
                </a:lnTo>
                <a:lnTo>
                  <a:pt x="134112" y="3047"/>
                </a:lnTo>
                <a:lnTo>
                  <a:pt x="128016" y="3047"/>
                </a:lnTo>
                <a:lnTo>
                  <a:pt x="126492" y="4571"/>
                </a:lnTo>
                <a:lnTo>
                  <a:pt x="123444" y="6095"/>
                </a:lnTo>
                <a:lnTo>
                  <a:pt x="123444" y="7619"/>
                </a:lnTo>
                <a:lnTo>
                  <a:pt x="86150" y="80771"/>
                </a:lnTo>
                <a:lnTo>
                  <a:pt x="91440" y="80771"/>
                </a:lnTo>
                <a:lnTo>
                  <a:pt x="91440" y="99059"/>
                </a:lnTo>
                <a:lnTo>
                  <a:pt x="94488" y="99059"/>
                </a:lnTo>
                <a:lnTo>
                  <a:pt x="97536" y="97535"/>
                </a:lnTo>
                <a:lnTo>
                  <a:pt x="126492" y="40679"/>
                </a:lnTo>
                <a:lnTo>
                  <a:pt x="126492" y="19811"/>
                </a:lnTo>
                <a:lnTo>
                  <a:pt x="138684" y="16763"/>
                </a:lnTo>
                <a:lnTo>
                  <a:pt x="138684" y="27633"/>
                </a:lnTo>
                <a:lnTo>
                  <a:pt x="207264" y="71627"/>
                </a:lnTo>
                <a:lnTo>
                  <a:pt x="207264" y="56387"/>
                </a:lnTo>
                <a:lnTo>
                  <a:pt x="211769" y="53412"/>
                </a:lnTo>
                <a:close/>
              </a:path>
              <a:path w="1914525" h="542925">
                <a:moveTo>
                  <a:pt x="138684" y="16763"/>
                </a:moveTo>
                <a:lnTo>
                  <a:pt x="126492" y="19811"/>
                </a:lnTo>
                <a:lnTo>
                  <a:pt x="134508" y="24954"/>
                </a:lnTo>
                <a:lnTo>
                  <a:pt x="138684" y="16763"/>
                </a:lnTo>
                <a:close/>
              </a:path>
              <a:path w="1914525" h="542925">
                <a:moveTo>
                  <a:pt x="134508" y="24954"/>
                </a:moveTo>
                <a:lnTo>
                  <a:pt x="126492" y="19811"/>
                </a:lnTo>
                <a:lnTo>
                  <a:pt x="126492" y="40679"/>
                </a:lnTo>
                <a:lnTo>
                  <a:pt x="134508" y="24954"/>
                </a:lnTo>
                <a:close/>
              </a:path>
              <a:path w="1914525" h="542925">
                <a:moveTo>
                  <a:pt x="138684" y="27633"/>
                </a:moveTo>
                <a:lnTo>
                  <a:pt x="138684" y="16763"/>
                </a:lnTo>
                <a:lnTo>
                  <a:pt x="134508" y="24954"/>
                </a:lnTo>
                <a:lnTo>
                  <a:pt x="138684" y="27633"/>
                </a:lnTo>
                <a:close/>
              </a:path>
              <a:path w="1914525" h="542925">
                <a:moveTo>
                  <a:pt x="216408" y="56387"/>
                </a:moveTo>
                <a:lnTo>
                  <a:pt x="211769" y="53412"/>
                </a:lnTo>
                <a:lnTo>
                  <a:pt x="207264" y="56387"/>
                </a:lnTo>
                <a:lnTo>
                  <a:pt x="216408" y="56387"/>
                </a:lnTo>
                <a:close/>
              </a:path>
              <a:path w="1914525" h="542925">
                <a:moveTo>
                  <a:pt x="216408" y="71627"/>
                </a:moveTo>
                <a:lnTo>
                  <a:pt x="216408" y="56387"/>
                </a:lnTo>
                <a:lnTo>
                  <a:pt x="207264" y="56387"/>
                </a:lnTo>
                <a:lnTo>
                  <a:pt x="207264" y="71627"/>
                </a:lnTo>
                <a:lnTo>
                  <a:pt x="210312" y="73151"/>
                </a:lnTo>
                <a:lnTo>
                  <a:pt x="213360" y="73151"/>
                </a:lnTo>
                <a:lnTo>
                  <a:pt x="216408" y="71627"/>
                </a:lnTo>
                <a:close/>
              </a:path>
              <a:path w="1914525" h="542925">
                <a:moveTo>
                  <a:pt x="373847" y="91058"/>
                </a:moveTo>
                <a:lnTo>
                  <a:pt x="298704" y="4571"/>
                </a:lnTo>
                <a:lnTo>
                  <a:pt x="297180" y="1523"/>
                </a:lnTo>
                <a:lnTo>
                  <a:pt x="291084" y="0"/>
                </a:lnTo>
                <a:lnTo>
                  <a:pt x="288036" y="3047"/>
                </a:lnTo>
                <a:lnTo>
                  <a:pt x="211769" y="53412"/>
                </a:lnTo>
                <a:lnTo>
                  <a:pt x="216408" y="56387"/>
                </a:lnTo>
                <a:lnTo>
                  <a:pt x="216408" y="71627"/>
                </a:lnTo>
                <a:lnTo>
                  <a:pt x="284988" y="26339"/>
                </a:lnTo>
                <a:lnTo>
                  <a:pt x="284988" y="16763"/>
                </a:lnTo>
                <a:lnTo>
                  <a:pt x="297180" y="18287"/>
                </a:lnTo>
                <a:lnTo>
                  <a:pt x="297180" y="30796"/>
                </a:lnTo>
                <a:lnTo>
                  <a:pt x="365760" y="109727"/>
                </a:lnTo>
                <a:lnTo>
                  <a:pt x="367284" y="110743"/>
                </a:lnTo>
                <a:lnTo>
                  <a:pt x="367284" y="96011"/>
                </a:lnTo>
                <a:lnTo>
                  <a:pt x="373847" y="91058"/>
                </a:lnTo>
                <a:close/>
              </a:path>
              <a:path w="1914525" h="542925">
                <a:moveTo>
                  <a:pt x="297180" y="18287"/>
                </a:moveTo>
                <a:lnTo>
                  <a:pt x="284988" y="16763"/>
                </a:lnTo>
                <a:lnTo>
                  <a:pt x="290274" y="22848"/>
                </a:lnTo>
                <a:lnTo>
                  <a:pt x="297180" y="18287"/>
                </a:lnTo>
                <a:close/>
              </a:path>
              <a:path w="1914525" h="542925">
                <a:moveTo>
                  <a:pt x="290274" y="22848"/>
                </a:moveTo>
                <a:lnTo>
                  <a:pt x="284988" y="16763"/>
                </a:lnTo>
                <a:lnTo>
                  <a:pt x="284988" y="26339"/>
                </a:lnTo>
                <a:lnTo>
                  <a:pt x="290274" y="22848"/>
                </a:lnTo>
                <a:close/>
              </a:path>
              <a:path w="1914525" h="542925">
                <a:moveTo>
                  <a:pt x="297180" y="30796"/>
                </a:moveTo>
                <a:lnTo>
                  <a:pt x="297180" y="18287"/>
                </a:lnTo>
                <a:lnTo>
                  <a:pt x="290274" y="22848"/>
                </a:lnTo>
                <a:lnTo>
                  <a:pt x="297180" y="30796"/>
                </a:lnTo>
                <a:close/>
              </a:path>
              <a:path w="1914525" h="542925">
                <a:moveTo>
                  <a:pt x="379476" y="97535"/>
                </a:moveTo>
                <a:lnTo>
                  <a:pt x="373847" y="91058"/>
                </a:lnTo>
                <a:lnTo>
                  <a:pt x="367284" y="96011"/>
                </a:lnTo>
                <a:lnTo>
                  <a:pt x="379476" y="97535"/>
                </a:lnTo>
                <a:close/>
              </a:path>
              <a:path w="1914525" h="542925">
                <a:moveTo>
                  <a:pt x="379476" y="111251"/>
                </a:moveTo>
                <a:lnTo>
                  <a:pt x="379476" y="97535"/>
                </a:lnTo>
                <a:lnTo>
                  <a:pt x="367284" y="96011"/>
                </a:lnTo>
                <a:lnTo>
                  <a:pt x="367284" y="110743"/>
                </a:lnTo>
                <a:lnTo>
                  <a:pt x="370332" y="112775"/>
                </a:lnTo>
                <a:lnTo>
                  <a:pt x="374904" y="114299"/>
                </a:lnTo>
                <a:lnTo>
                  <a:pt x="379476" y="111251"/>
                </a:lnTo>
                <a:close/>
              </a:path>
              <a:path w="1914525" h="542925">
                <a:moveTo>
                  <a:pt x="621792" y="163067"/>
                </a:moveTo>
                <a:lnTo>
                  <a:pt x="460248" y="35051"/>
                </a:lnTo>
                <a:lnTo>
                  <a:pt x="457200" y="33527"/>
                </a:lnTo>
                <a:lnTo>
                  <a:pt x="452628" y="33527"/>
                </a:lnTo>
                <a:lnTo>
                  <a:pt x="448056" y="35051"/>
                </a:lnTo>
                <a:lnTo>
                  <a:pt x="373847" y="91058"/>
                </a:lnTo>
                <a:lnTo>
                  <a:pt x="379476" y="97535"/>
                </a:lnTo>
                <a:lnTo>
                  <a:pt x="379476" y="111251"/>
                </a:lnTo>
                <a:lnTo>
                  <a:pt x="448056" y="59493"/>
                </a:lnTo>
                <a:lnTo>
                  <a:pt x="448056" y="50291"/>
                </a:lnTo>
                <a:lnTo>
                  <a:pt x="460248" y="50291"/>
                </a:lnTo>
                <a:lnTo>
                  <a:pt x="460248" y="59953"/>
                </a:lnTo>
                <a:lnTo>
                  <a:pt x="609600" y="178307"/>
                </a:lnTo>
                <a:lnTo>
                  <a:pt x="611124" y="178307"/>
                </a:lnTo>
                <a:lnTo>
                  <a:pt x="618744" y="181830"/>
                </a:lnTo>
                <a:lnTo>
                  <a:pt x="618744" y="163067"/>
                </a:lnTo>
                <a:lnTo>
                  <a:pt x="621792" y="163067"/>
                </a:lnTo>
                <a:close/>
              </a:path>
              <a:path w="1914525" h="542925">
                <a:moveTo>
                  <a:pt x="460248" y="50291"/>
                </a:moveTo>
                <a:lnTo>
                  <a:pt x="448056" y="50291"/>
                </a:lnTo>
                <a:lnTo>
                  <a:pt x="454003" y="55004"/>
                </a:lnTo>
                <a:lnTo>
                  <a:pt x="460248" y="50291"/>
                </a:lnTo>
                <a:close/>
              </a:path>
              <a:path w="1914525" h="542925">
                <a:moveTo>
                  <a:pt x="454003" y="55004"/>
                </a:moveTo>
                <a:lnTo>
                  <a:pt x="448056" y="50291"/>
                </a:lnTo>
                <a:lnTo>
                  <a:pt x="448056" y="59493"/>
                </a:lnTo>
                <a:lnTo>
                  <a:pt x="454003" y="55004"/>
                </a:lnTo>
                <a:close/>
              </a:path>
              <a:path w="1914525" h="542925">
                <a:moveTo>
                  <a:pt x="460248" y="59953"/>
                </a:moveTo>
                <a:lnTo>
                  <a:pt x="460248" y="50291"/>
                </a:lnTo>
                <a:lnTo>
                  <a:pt x="454003" y="55004"/>
                </a:lnTo>
                <a:lnTo>
                  <a:pt x="460248" y="59953"/>
                </a:lnTo>
                <a:close/>
              </a:path>
              <a:path w="1914525" h="542925">
                <a:moveTo>
                  <a:pt x="941832" y="330240"/>
                </a:moveTo>
                <a:lnTo>
                  <a:pt x="941832" y="312419"/>
                </a:lnTo>
                <a:lnTo>
                  <a:pt x="618744" y="163067"/>
                </a:lnTo>
                <a:lnTo>
                  <a:pt x="618744" y="181830"/>
                </a:lnTo>
                <a:lnTo>
                  <a:pt x="934212" y="327659"/>
                </a:lnTo>
                <a:lnTo>
                  <a:pt x="935736" y="329183"/>
                </a:lnTo>
                <a:lnTo>
                  <a:pt x="937260" y="329183"/>
                </a:lnTo>
                <a:lnTo>
                  <a:pt x="941832" y="330240"/>
                </a:lnTo>
                <a:close/>
              </a:path>
              <a:path w="1914525" h="542925">
                <a:moveTo>
                  <a:pt x="1588008" y="483107"/>
                </a:moveTo>
                <a:lnTo>
                  <a:pt x="1263396" y="385571"/>
                </a:lnTo>
                <a:lnTo>
                  <a:pt x="940308" y="310895"/>
                </a:lnTo>
                <a:lnTo>
                  <a:pt x="941832" y="312419"/>
                </a:lnTo>
                <a:lnTo>
                  <a:pt x="941832" y="330240"/>
                </a:lnTo>
                <a:lnTo>
                  <a:pt x="1260348" y="403859"/>
                </a:lnTo>
                <a:lnTo>
                  <a:pt x="1581912" y="501395"/>
                </a:lnTo>
                <a:lnTo>
                  <a:pt x="1583436" y="501395"/>
                </a:lnTo>
                <a:lnTo>
                  <a:pt x="1586484" y="501784"/>
                </a:lnTo>
                <a:lnTo>
                  <a:pt x="1586484" y="483107"/>
                </a:lnTo>
                <a:lnTo>
                  <a:pt x="1588008" y="483107"/>
                </a:lnTo>
                <a:close/>
              </a:path>
              <a:path w="1914525" h="542925">
                <a:moveTo>
                  <a:pt x="1914143" y="541020"/>
                </a:moveTo>
                <a:lnTo>
                  <a:pt x="1914143" y="524255"/>
                </a:lnTo>
                <a:lnTo>
                  <a:pt x="1909572" y="524255"/>
                </a:lnTo>
                <a:lnTo>
                  <a:pt x="1586484" y="483107"/>
                </a:lnTo>
                <a:lnTo>
                  <a:pt x="1586484" y="501784"/>
                </a:lnTo>
                <a:lnTo>
                  <a:pt x="1906524" y="542543"/>
                </a:lnTo>
                <a:lnTo>
                  <a:pt x="1911096" y="542543"/>
                </a:lnTo>
                <a:lnTo>
                  <a:pt x="1914143" y="54102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5900813" y="1551432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60" h="60959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5896241" y="1546860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4289" y="10668"/>
                </a:moveTo>
                <a:lnTo>
                  <a:pt x="32003" y="6096"/>
                </a:lnTo>
                <a:lnTo>
                  <a:pt x="32003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4289" y="10668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435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2003" y="1524"/>
                </a:lnTo>
                <a:lnTo>
                  <a:pt x="32003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36575" y="6096"/>
                </a:moveTo>
                <a:lnTo>
                  <a:pt x="32003" y="6096"/>
                </a:lnTo>
                <a:lnTo>
                  <a:pt x="34289" y="10668"/>
                </a:lnTo>
                <a:lnTo>
                  <a:pt x="36575" y="6096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4289" y="10668"/>
                </a:lnTo>
                <a:lnTo>
                  <a:pt x="59435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435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5940437" y="1504188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60" h="60959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5935865" y="1499616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4289" y="10668"/>
                </a:moveTo>
                <a:lnTo>
                  <a:pt x="32003" y="6096"/>
                </a:lnTo>
                <a:lnTo>
                  <a:pt x="32003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4289" y="10668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435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2003" y="1524"/>
                </a:lnTo>
                <a:lnTo>
                  <a:pt x="32003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36575" y="6096"/>
                </a:moveTo>
                <a:lnTo>
                  <a:pt x="32003" y="6096"/>
                </a:lnTo>
                <a:lnTo>
                  <a:pt x="34289" y="10668"/>
                </a:lnTo>
                <a:lnTo>
                  <a:pt x="36575" y="6096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4289" y="10668"/>
                </a:lnTo>
                <a:lnTo>
                  <a:pt x="59435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435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0" name="object 60"/>
          <p:cNvSpPr/>
          <p:nvPr/>
        </p:nvSpPr>
        <p:spPr>
          <a:xfrm>
            <a:off x="5981585" y="1504188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60" h="60959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1" name="object 61"/>
          <p:cNvSpPr/>
          <p:nvPr/>
        </p:nvSpPr>
        <p:spPr>
          <a:xfrm>
            <a:off x="5977013" y="1499616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4289" y="10668"/>
                </a:moveTo>
                <a:lnTo>
                  <a:pt x="32003" y="6096"/>
                </a:lnTo>
                <a:lnTo>
                  <a:pt x="32003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4289" y="10668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435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2003" y="1524"/>
                </a:lnTo>
                <a:lnTo>
                  <a:pt x="32003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36575" y="6096"/>
                </a:moveTo>
                <a:lnTo>
                  <a:pt x="32003" y="6096"/>
                </a:lnTo>
                <a:lnTo>
                  <a:pt x="34289" y="10668"/>
                </a:lnTo>
                <a:lnTo>
                  <a:pt x="36575" y="6096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4289" y="10668"/>
                </a:lnTo>
                <a:lnTo>
                  <a:pt x="59435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435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2" name="object 62"/>
          <p:cNvSpPr/>
          <p:nvPr/>
        </p:nvSpPr>
        <p:spPr>
          <a:xfrm>
            <a:off x="6021209" y="1424939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60" h="60959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3" name="object 63"/>
          <p:cNvSpPr/>
          <p:nvPr/>
        </p:nvSpPr>
        <p:spPr>
          <a:xfrm>
            <a:off x="6016637" y="1420367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4289" y="10668"/>
                </a:moveTo>
                <a:lnTo>
                  <a:pt x="32003" y="6096"/>
                </a:lnTo>
                <a:lnTo>
                  <a:pt x="32003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4289" y="10668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435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2003" y="1524"/>
                </a:lnTo>
                <a:lnTo>
                  <a:pt x="32003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36575" y="6096"/>
                </a:moveTo>
                <a:lnTo>
                  <a:pt x="32003" y="6096"/>
                </a:lnTo>
                <a:lnTo>
                  <a:pt x="34289" y="10668"/>
                </a:lnTo>
                <a:lnTo>
                  <a:pt x="36575" y="6096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4289" y="10668"/>
                </a:lnTo>
                <a:lnTo>
                  <a:pt x="59435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435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4" name="object 64"/>
          <p:cNvSpPr/>
          <p:nvPr/>
        </p:nvSpPr>
        <p:spPr>
          <a:xfrm>
            <a:off x="6101981" y="1478280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60" h="60959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5" name="object 65"/>
          <p:cNvSpPr/>
          <p:nvPr/>
        </p:nvSpPr>
        <p:spPr>
          <a:xfrm>
            <a:off x="6097409" y="1473708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4289" y="10668"/>
                </a:moveTo>
                <a:lnTo>
                  <a:pt x="32003" y="6096"/>
                </a:lnTo>
                <a:lnTo>
                  <a:pt x="32003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4289" y="10668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435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2003" y="1524"/>
                </a:lnTo>
                <a:lnTo>
                  <a:pt x="32003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36575" y="6096"/>
                </a:moveTo>
                <a:lnTo>
                  <a:pt x="32003" y="6096"/>
                </a:lnTo>
                <a:lnTo>
                  <a:pt x="34289" y="10668"/>
                </a:lnTo>
                <a:lnTo>
                  <a:pt x="36575" y="6096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4289" y="10668"/>
                </a:lnTo>
                <a:lnTo>
                  <a:pt x="59435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435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6" name="object 66"/>
          <p:cNvSpPr/>
          <p:nvPr/>
        </p:nvSpPr>
        <p:spPr>
          <a:xfrm>
            <a:off x="6182753" y="1423416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60" h="60959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7" name="object 67"/>
          <p:cNvSpPr/>
          <p:nvPr/>
        </p:nvSpPr>
        <p:spPr>
          <a:xfrm>
            <a:off x="6178181" y="1418844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4289" y="10668"/>
                </a:moveTo>
                <a:lnTo>
                  <a:pt x="32003" y="6096"/>
                </a:lnTo>
                <a:lnTo>
                  <a:pt x="32003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4289" y="10668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435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2003" y="1524"/>
                </a:lnTo>
                <a:lnTo>
                  <a:pt x="32003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36575" y="6096"/>
                </a:moveTo>
                <a:lnTo>
                  <a:pt x="32003" y="6096"/>
                </a:lnTo>
                <a:lnTo>
                  <a:pt x="34289" y="10668"/>
                </a:lnTo>
                <a:lnTo>
                  <a:pt x="36575" y="6096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4289" y="10668"/>
                </a:lnTo>
                <a:lnTo>
                  <a:pt x="59435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435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8" name="object 68"/>
          <p:cNvSpPr/>
          <p:nvPr/>
        </p:nvSpPr>
        <p:spPr>
          <a:xfrm>
            <a:off x="6263513" y="1517903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60" h="60959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9" name="object 69"/>
          <p:cNvSpPr/>
          <p:nvPr/>
        </p:nvSpPr>
        <p:spPr>
          <a:xfrm>
            <a:off x="6258940" y="1513332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4289" y="10668"/>
                </a:moveTo>
                <a:lnTo>
                  <a:pt x="32003" y="6096"/>
                </a:lnTo>
                <a:lnTo>
                  <a:pt x="32003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4289" y="10668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435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2003" y="1524"/>
                </a:lnTo>
                <a:lnTo>
                  <a:pt x="32003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36575" y="6096"/>
                </a:moveTo>
                <a:lnTo>
                  <a:pt x="32003" y="6096"/>
                </a:lnTo>
                <a:lnTo>
                  <a:pt x="34289" y="10668"/>
                </a:lnTo>
                <a:lnTo>
                  <a:pt x="36575" y="6096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4289" y="10668"/>
                </a:lnTo>
                <a:lnTo>
                  <a:pt x="59435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435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0" name="object 70"/>
          <p:cNvSpPr/>
          <p:nvPr/>
        </p:nvSpPr>
        <p:spPr>
          <a:xfrm>
            <a:off x="6344297" y="1456944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60" h="60959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1" name="object 71"/>
          <p:cNvSpPr/>
          <p:nvPr/>
        </p:nvSpPr>
        <p:spPr>
          <a:xfrm>
            <a:off x="6339725" y="1452372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4289" y="10668"/>
                </a:moveTo>
                <a:lnTo>
                  <a:pt x="32003" y="6096"/>
                </a:lnTo>
                <a:lnTo>
                  <a:pt x="32003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4289" y="10668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435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2003" y="1524"/>
                </a:lnTo>
                <a:lnTo>
                  <a:pt x="32003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36575" y="6096"/>
                </a:moveTo>
                <a:lnTo>
                  <a:pt x="32003" y="6096"/>
                </a:lnTo>
                <a:lnTo>
                  <a:pt x="34289" y="10668"/>
                </a:lnTo>
                <a:lnTo>
                  <a:pt x="36575" y="6096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4289" y="10668"/>
                </a:lnTo>
                <a:lnTo>
                  <a:pt x="59435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435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2" name="object 72"/>
          <p:cNvSpPr/>
          <p:nvPr/>
        </p:nvSpPr>
        <p:spPr>
          <a:xfrm>
            <a:off x="6505829" y="1583436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59" h="60960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3" name="object 73"/>
          <p:cNvSpPr/>
          <p:nvPr/>
        </p:nvSpPr>
        <p:spPr>
          <a:xfrm>
            <a:off x="6501257" y="1578863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0479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0479" y="18288"/>
                </a:lnTo>
                <a:lnTo>
                  <a:pt x="30479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283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0479" y="6096"/>
                </a:lnTo>
                <a:lnTo>
                  <a:pt x="33602" y="12043"/>
                </a:lnTo>
                <a:lnTo>
                  <a:pt x="36575" y="6096"/>
                </a:lnTo>
                <a:close/>
              </a:path>
              <a:path w="68579" h="68580">
                <a:moveTo>
                  <a:pt x="33602" y="12043"/>
                </a:moveTo>
                <a:lnTo>
                  <a:pt x="30479" y="6096"/>
                </a:lnTo>
                <a:lnTo>
                  <a:pt x="30479" y="18288"/>
                </a:lnTo>
                <a:lnTo>
                  <a:pt x="33602" y="12043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3602" y="12043"/>
                </a:lnTo>
                <a:lnTo>
                  <a:pt x="59283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283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4" name="object 74"/>
          <p:cNvSpPr/>
          <p:nvPr/>
        </p:nvSpPr>
        <p:spPr>
          <a:xfrm>
            <a:off x="6828917" y="1734311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59" h="60960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5" name="object 75"/>
          <p:cNvSpPr/>
          <p:nvPr/>
        </p:nvSpPr>
        <p:spPr>
          <a:xfrm>
            <a:off x="6824344" y="1729739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0479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0479" y="18288"/>
                </a:lnTo>
                <a:lnTo>
                  <a:pt x="30479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283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0479" y="6096"/>
                </a:lnTo>
                <a:lnTo>
                  <a:pt x="33602" y="12043"/>
                </a:lnTo>
                <a:lnTo>
                  <a:pt x="36575" y="6096"/>
                </a:lnTo>
                <a:close/>
              </a:path>
              <a:path w="68579" h="68580">
                <a:moveTo>
                  <a:pt x="33602" y="12043"/>
                </a:moveTo>
                <a:lnTo>
                  <a:pt x="30479" y="6096"/>
                </a:lnTo>
                <a:lnTo>
                  <a:pt x="30479" y="18288"/>
                </a:lnTo>
                <a:lnTo>
                  <a:pt x="33602" y="12043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3602" y="12043"/>
                </a:lnTo>
                <a:lnTo>
                  <a:pt x="59283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283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6" name="object 76"/>
          <p:cNvSpPr/>
          <p:nvPr/>
        </p:nvSpPr>
        <p:spPr>
          <a:xfrm>
            <a:off x="7152005" y="1807464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59" h="60960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7" name="object 77"/>
          <p:cNvSpPr/>
          <p:nvPr/>
        </p:nvSpPr>
        <p:spPr>
          <a:xfrm>
            <a:off x="7147432" y="1802892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0479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0479" y="18288"/>
                </a:lnTo>
                <a:lnTo>
                  <a:pt x="30479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283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0479" y="6096"/>
                </a:lnTo>
                <a:lnTo>
                  <a:pt x="33602" y="12043"/>
                </a:lnTo>
                <a:lnTo>
                  <a:pt x="36575" y="6096"/>
                </a:lnTo>
                <a:close/>
              </a:path>
              <a:path w="68579" h="68580">
                <a:moveTo>
                  <a:pt x="33602" y="12043"/>
                </a:moveTo>
                <a:lnTo>
                  <a:pt x="30479" y="6096"/>
                </a:lnTo>
                <a:lnTo>
                  <a:pt x="30479" y="18288"/>
                </a:lnTo>
                <a:lnTo>
                  <a:pt x="33602" y="12043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3602" y="12043"/>
                </a:lnTo>
                <a:lnTo>
                  <a:pt x="59283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283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8" name="object 78"/>
          <p:cNvSpPr/>
          <p:nvPr/>
        </p:nvSpPr>
        <p:spPr>
          <a:xfrm>
            <a:off x="7475093" y="1906523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59" h="60960">
                <a:moveTo>
                  <a:pt x="60959" y="60960"/>
                </a:moveTo>
                <a:lnTo>
                  <a:pt x="28955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9" name="object 79"/>
          <p:cNvSpPr/>
          <p:nvPr/>
        </p:nvSpPr>
        <p:spPr>
          <a:xfrm>
            <a:off x="7470520" y="1901951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0479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4571" y="68580"/>
                </a:lnTo>
                <a:lnTo>
                  <a:pt x="4571" y="60960"/>
                </a:lnTo>
                <a:lnTo>
                  <a:pt x="9143" y="60960"/>
                </a:lnTo>
                <a:lnTo>
                  <a:pt x="30479" y="18288"/>
                </a:lnTo>
                <a:lnTo>
                  <a:pt x="30479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9143" y="60960"/>
                </a:moveTo>
                <a:lnTo>
                  <a:pt x="4571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65531" y="60960"/>
                </a:lnTo>
                <a:lnTo>
                  <a:pt x="62483" y="67056"/>
                </a:lnTo>
                <a:lnTo>
                  <a:pt x="59283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4571" y="60960"/>
                </a:lnTo>
                <a:lnTo>
                  <a:pt x="4571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36575" y="6096"/>
                </a:moveTo>
                <a:lnTo>
                  <a:pt x="30479" y="6096"/>
                </a:lnTo>
                <a:lnTo>
                  <a:pt x="33602" y="12043"/>
                </a:lnTo>
                <a:lnTo>
                  <a:pt x="36575" y="6096"/>
                </a:lnTo>
                <a:close/>
              </a:path>
              <a:path w="68579" h="68580">
                <a:moveTo>
                  <a:pt x="33602" y="12043"/>
                </a:moveTo>
                <a:lnTo>
                  <a:pt x="30479" y="6096"/>
                </a:lnTo>
                <a:lnTo>
                  <a:pt x="30479" y="18288"/>
                </a:lnTo>
                <a:lnTo>
                  <a:pt x="33602" y="12043"/>
                </a:lnTo>
                <a:close/>
              </a:path>
              <a:path w="68579" h="68580">
                <a:moveTo>
                  <a:pt x="65531" y="60960"/>
                </a:moveTo>
                <a:lnTo>
                  <a:pt x="36575" y="3048"/>
                </a:lnTo>
                <a:lnTo>
                  <a:pt x="36575" y="6096"/>
                </a:lnTo>
                <a:lnTo>
                  <a:pt x="33602" y="12043"/>
                </a:lnTo>
                <a:lnTo>
                  <a:pt x="59283" y="60960"/>
                </a:lnTo>
                <a:lnTo>
                  <a:pt x="65531" y="60960"/>
                </a:lnTo>
                <a:close/>
              </a:path>
              <a:path w="68579" h="68580">
                <a:moveTo>
                  <a:pt x="65531" y="60960"/>
                </a:moveTo>
                <a:lnTo>
                  <a:pt x="59283" y="60960"/>
                </a:lnTo>
                <a:lnTo>
                  <a:pt x="62483" y="67056"/>
                </a:lnTo>
                <a:lnTo>
                  <a:pt x="65531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0" name="object 80"/>
          <p:cNvSpPr/>
          <p:nvPr/>
        </p:nvSpPr>
        <p:spPr>
          <a:xfrm>
            <a:off x="7796656" y="1946148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59" h="60960">
                <a:moveTo>
                  <a:pt x="60959" y="60960"/>
                </a:moveTo>
                <a:lnTo>
                  <a:pt x="30479" y="0"/>
                </a:lnTo>
                <a:lnTo>
                  <a:pt x="0" y="60960"/>
                </a:lnTo>
                <a:lnTo>
                  <a:pt x="60959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1" name="object 81"/>
          <p:cNvSpPr/>
          <p:nvPr/>
        </p:nvSpPr>
        <p:spPr>
          <a:xfrm>
            <a:off x="7793608" y="1941576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80">
                <a:moveTo>
                  <a:pt x="36575" y="6096"/>
                </a:moveTo>
                <a:lnTo>
                  <a:pt x="36575" y="1524"/>
                </a:lnTo>
                <a:lnTo>
                  <a:pt x="35051" y="0"/>
                </a:lnTo>
                <a:lnTo>
                  <a:pt x="33527" y="0"/>
                </a:lnTo>
                <a:lnTo>
                  <a:pt x="30479" y="3048"/>
                </a:lnTo>
                <a:lnTo>
                  <a:pt x="1523" y="64008"/>
                </a:lnTo>
                <a:lnTo>
                  <a:pt x="0" y="64008"/>
                </a:lnTo>
                <a:lnTo>
                  <a:pt x="0" y="65532"/>
                </a:lnTo>
                <a:lnTo>
                  <a:pt x="3047" y="68580"/>
                </a:lnTo>
                <a:lnTo>
                  <a:pt x="3047" y="60960"/>
                </a:lnTo>
                <a:lnTo>
                  <a:pt x="9143" y="60960"/>
                </a:lnTo>
                <a:lnTo>
                  <a:pt x="30479" y="18288"/>
                </a:lnTo>
                <a:lnTo>
                  <a:pt x="30479" y="6096"/>
                </a:lnTo>
                <a:lnTo>
                  <a:pt x="36575" y="6096"/>
                </a:lnTo>
                <a:close/>
              </a:path>
              <a:path w="68579" h="68580">
                <a:moveTo>
                  <a:pt x="9143" y="60960"/>
                </a:moveTo>
                <a:lnTo>
                  <a:pt x="3047" y="60960"/>
                </a:lnTo>
                <a:lnTo>
                  <a:pt x="6095" y="67056"/>
                </a:lnTo>
                <a:lnTo>
                  <a:pt x="9143" y="60960"/>
                </a:lnTo>
                <a:close/>
              </a:path>
              <a:path w="68579" h="68580">
                <a:moveTo>
                  <a:pt x="64007" y="68580"/>
                </a:moveTo>
                <a:lnTo>
                  <a:pt x="64007" y="60960"/>
                </a:lnTo>
                <a:lnTo>
                  <a:pt x="62483" y="67056"/>
                </a:lnTo>
                <a:lnTo>
                  <a:pt x="59283" y="60960"/>
                </a:lnTo>
                <a:lnTo>
                  <a:pt x="9143" y="60960"/>
                </a:lnTo>
                <a:lnTo>
                  <a:pt x="6095" y="67056"/>
                </a:lnTo>
                <a:lnTo>
                  <a:pt x="3047" y="60960"/>
                </a:lnTo>
                <a:lnTo>
                  <a:pt x="3047" y="68580"/>
                </a:lnTo>
                <a:lnTo>
                  <a:pt x="64007" y="68580"/>
                </a:lnTo>
                <a:close/>
              </a:path>
              <a:path w="68579" h="68580">
                <a:moveTo>
                  <a:pt x="36575" y="6096"/>
                </a:moveTo>
                <a:lnTo>
                  <a:pt x="30479" y="6096"/>
                </a:lnTo>
                <a:lnTo>
                  <a:pt x="33602" y="12043"/>
                </a:lnTo>
                <a:lnTo>
                  <a:pt x="36575" y="6096"/>
                </a:lnTo>
                <a:close/>
              </a:path>
              <a:path w="68579" h="68580">
                <a:moveTo>
                  <a:pt x="33602" y="12043"/>
                </a:moveTo>
                <a:lnTo>
                  <a:pt x="30479" y="6096"/>
                </a:lnTo>
                <a:lnTo>
                  <a:pt x="30479" y="18288"/>
                </a:lnTo>
                <a:lnTo>
                  <a:pt x="33602" y="12043"/>
                </a:lnTo>
                <a:close/>
              </a:path>
              <a:path w="68579" h="68580">
                <a:moveTo>
                  <a:pt x="68579" y="65532"/>
                </a:moveTo>
                <a:lnTo>
                  <a:pt x="68579" y="64008"/>
                </a:lnTo>
                <a:lnTo>
                  <a:pt x="67055" y="64008"/>
                </a:lnTo>
                <a:lnTo>
                  <a:pt x="36575" y="3048"/>
                </a:lnTo>
                <a:lnTo>
                  <a:pt x="36575" y="6096"/>
                </a:lnTo>
                <a:lnTo>
                  <a:pt x="33602" y="12043"/>
                </a:lnTo>
                <a:lnTo>
                  <a:pt x="59283" y="60960"/>
                </a:lnTo>
                <a:lnTo>
                  <a:pt x="64007" y="60960"/>
                </a:lnTo>
                <a:lnTo>
                  <a:pt x="64007" y="68580"/>
                </a:lnTo>
                <a:lnTo>
                  <a:pt x="65531" y="68580"/>
                </a:lnTo>
                <a:lnTo>
                  <a:pt x="68579" y="65532"/>
                </a:lnTo>
                <a:close/>
              </a:path>
              <a:path w="68579" h="68580">
                <a:moveTo>
                  <a:pt x="64007" y="60960"/>
                </a:moveTo>
                <a:lnTo>
                  <a:pt x="59283" y="60960"/>
                </a:lnTo>
                <a:lnTo>
                  <a:pt x="62483" y="67056"/>
                </a:lnTo>
                <a:lnTo>
                  <a:pt x="64007" y="60960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2" name="object 82"/>
          <p:cNvSpPr txBox="1"/>
          <p:nvPr/>
        </p:nvSpPr>
        <p:spPr>
          <a:xfrm>
            <a:off x="5752471" y="2395473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3" name="object 83"/>
          <p:cNvSpPr txBox="1"/>
          <p:nvPr/>
        </p:nvSpPr>
        <p:spPr>
          <a:xfrm>
            <a:off x="5708272" y="1916935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4" name="object 84"/>
          <p:cNvSpPr txBox="1"/>
          <p:nvPr/>
        </p:nvSpPr>
        <p:spPr>
          <a:xfrm>
            <a:off x="5665603" y="1438397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5" name="object 85"/>
          <p:cNvSpPr txBox="1"/>
          <p:nvPr/>
        </p:nvSpPr>
        <p:spPr>
          <a:xfrm>
            <a:off x="5621404" y="959858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6" name="object 86"/>
          <p:cNvSpPr/>
          <p:nvPr/>
        </p:nvSpPr>
        <p:spPr>
          <a:xfrm>
            <a:off x="7999361" y="148437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7" name="object 87"/>
          <p:cNvSpPr/>
          <p:nvPr/>
        </p:nvSpPr>
        <p:spPr>
          <a:xfrm>
            <a:off x="8066405" y="1458467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8" name="object 88"/>
          <p:cNvSpPr/>
          <p:nvPr/>
        </p:nvSpPr>
        <p:spPr>
          <a:xfrm>
            <a:off x="8063369" y="1455419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5" h="56515">
                <a:moveTo>
                  <a:pt x="56387" y="30480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30480"/>
                </a:lnTo>
                <a:lnTo>
                  <a:pt x="4571" y="35052"/>
                </a:lnTo>
                <a:lnTo>
                  <a:pt x="4571" y="25908"/>
                </a:lnTo>
                <a:lnTo>
                  <a:pt x="6857" y="28193"/>
                </a:lnTo>
                <a:lnTo>
                  <a:pt x="25907" y="9143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9144"/>
                </a:lnTo>
                <a:lnTo>
                  <a:pt x="49529" y="28194"/>
                </a:lnTo>
                <a:lnTo>
                  <a:pt x="51815" y="25908"/>
                </a:lnTo>
                <a:lnTo>
                  <a:pt x="51815" y="35052"/>
                </a:lnTo>
                <a:lnTo>
                  <a:pt x="56387" y="30480"/>
                </a:lnTo>
                <a:close/>
              </a:path>
              <a:path w="56515" h="56515">
                <a:moveTo>
                  <a:pt x="6857" y="28194"/>
                </a:moveTo>
                <a:lnTo>
                  <a:pt x="4571" y="25908"/>
                </a:lnTo>
                <a:lnTo>
                  <a:pt x="4571" y="30480"/>
                </a:lnTo>
                <a:lnTo>
                  <a:pt x="6857" y="28194"/>
                </a:lnTo>
                <a:close/>
              </a:path>
              <a:path w="56515" h="56515">
                <a:moveTo>
                  <a:pt x="28193" y="49530"/>
                </a:moveTo>
                <a:lnTo>
                  <a:pt x="6857" y="28194"/>
                </a:lnTo>
                <a:lnTo>
                  <a:pt x="4571" y="30480"/>
                </a:lnTo>
                <a:lnTo>
                  <a:pt x="4571" y="35052"/>
                </a:lnTo>
                <a:lnTo>
                  <a:pt x="25907" y="56388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6515">
                <a:moveTo>
                  <a:pt x="30479" y="4572"/>
                </a:moveTo>
                <a:lnTo>
                  <a:pt x="25907" y="4572"/>
                </a:lnTo>
                <a:lnTo>
                  <a:pt x="28193" y="6857"/>
                </a:lnTo>
                <a:lnTo>
                  <a:pt x="30479" y="4572"/>
                </a:lnTo>
                <a:close/>
              </a:path>
              <a:path w="56515" h="56515">
                <a:moveTo>
                  <a:pt x="28193" y="6858"/>
                </a:moveTo>
                <a:lnTo>
                  <a:pt x="25907" y="4572"/>
                </a:lnTo>
                <a:lnTo>
                  <a:pt x="25907" y="9143"/>
                </a:lnTo>
                <a:lnTo>
                  <a:pt x="28193" y="6858"/>
                </a:lnTo>
                <a:close/>
              </a:path>
              <a:path w="56515" h="56515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6515">
                <a:moveTo>
                  <a:pt x="30479" y="56388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6388"/>
                </a:lnTo>
                <a:lnTo>
                  <a:pt x="30479" y="56388"/>
                </a:lnTo>
                <a:close/>
              </a:path>
              <a:path w="56515" h="56515">
                <a:moveTo>
                  <a:pt x="30479" y="9144"/>
                </a:moveTo>
                <a:lnTo>
                  <a:pt x="30479" y="4572"/>
                </a:lnTo>
                <a:lnTo>
                  <a:pt x="28193" y="6858"/>
                </a:lnTo>
                <a:lnTo>
                  <a:pt x="30479" y="9144"/>
                </a:lnTo>
                <a:close/>
              </a:path>
              <a:path w="56515" h="56515">
                <a:moveTo>
                  <a:pt x="51815" y="35052"/>
                </a:moveTo>
                <a:lnTo>
                  <a:pt x="51815" y="30480"/>
                </a:lnTo>
                <a:lnTo>
                  <a:pt x="49529" y="28193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6388"/>
                </a:lnTo>
                <a:lnTo>
                  <a:pt x="51815" y="35052"/>
                </a:lnTo>
                <a:close/>
              </a:path>
              <a:path w="56515" h="56515">
                <a:moveTo>
                  <a:pt x="51815" y="30480"/>
                </a:moveTo>
                <a:lnTo>
                  <a:pt x="51815" y="25908"/>
                </a:lnTo>
                <a:lnTo>
                  <a:pt x="49529" y="28193"/>
                </a:lnTo>
                <a:lnTo>
                  <a:pt x="51815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9" name="object 89"/>
          <p:cNvSpPr/>
          <p:nvPr/>
        </p:nvSpPr>
        <p:spPr>
          <a:xfrm>
            <a:off x="7999361" y="1778507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0" name="object 90"/>
          <p:cNvSpPr/>
          <p:nvPr/>
        </p:nvSpPr>
        <p:spPr>
          <a:xfrm>
            <a:off x="8066417" y="1778507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1" name="object 91"/>
          <p:cNvSpPr/>
          <p:nvPr/>
        </p:nvSpPr>
        <p:spPr>
          <a:xfrm>
            <a:off x="8063369" y="1749551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19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19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19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19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19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19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2" name="object 92"/>
          <p:cNvSpPr/>
          <p:nvPr/>
        </p:nvSpPr>
        <p:spPr>
          <a:xfrm>
            <a:off x="7999361" y="207263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3" name="object 93"/>
          <p:cNvSpPr/>
          <p:nvPr/>
        </p:nvSpPr>
        <p:spPr>
          <a:xfrm>
            <a:off x="8066405" y="2046732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4" name="object 94"/>
          <p:cNvSpPr/>
          <p:nvPr/>
        </p:nvSpPr>
        <p:spPr>
          <a:xfrm>
            <a:off x="8063369" y="2043683"/>
            <a:ext cx="56515" cy="58419"/>
          </a:xfrm>
          <a:custGeom>
            <a:avLst/>
            <a:gdLst/>
            <a:ahLst/>
            <a:cxnLst/>
            <a:rect l="l" t="t" r="r" b="b"/>
            <a:pathLst>
              <a:path w="56515" h="58419">
                <a:moveTo>
                  <a:pt x="56387" y="56388"/>
                </a:moveTo>
                <a:lnTo>
                  <a:pt x="56387" y="53340"/>
                </a:lnTo>
                <a:lnTo>
                  <a:pt x="30479" y="1524"/>
                </a:lnTo>
                <a:lnTo>
                  <a:pt x="28955" y="0"/>
                </a:lnTo>
                <a:lnTo>
                  <a:pt x="25907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6857" y="51816"/>
                </a:lnTo>
                <a:lnTo>
                  <a:pt x="25907" y="13716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13716"/>
                </a:lnTo>
                <a:lnTo>
                  <a:pt x="49529" y="51816"/>
                </a:lnTo>
                <a:lnTo>
                  <a:pt x="54863" y="51816"/>
                </a:lnTo>
                <a:lnTo>
                  <a:pt x="54863" y="57912"/>
                </a:lnTo>
                <a:lnTo>
                  <a:pt x="56387" y="56388"/>
                </a:lnTo>
                <a:close/>
              </a:path>
              <a:path w="56515" h="58419">
                <a:moveTo>
                  <a:pt x="6857" y="51816"/>
                </a:moveTo>
                <a:lnTo>
                  <a:pt x="3047" y="51816"/>
                </a:lnTo>
                <a:lnTo>
                  <a:pt x="4571" y="56388"/>
                </a:lnTo>
                <a:lnTo>
                  <a:pt x="6857" y="51816"/>
                </a:lnTo>
                <a:close/>
              </a:path>
              <a:path w="56515" h="58419">
                <a:moveTo>
                  <a:pt x="54863" y="57912"/>
                </a:moveTo>
                <a:lnTo>
                  <a:pt x="54863" y="51816"/>
                </a:lnTo>
                <a:lnTo>
                  <a:pt x="51815" y="56388"/>
                </a:lnTo>
                <a:lnTo>
                  <a:pt x="49529" y="51816"/>
                </a:lnTo>
                <a:lnTo>
                  <a:pt x="6857" y="51816"/>
                </a:lnTo>
                <a:lnTo>
                  <a:pt x="4571" y="56388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close/>
              </a:path>
              <a:path w="56515" h="58419">
                <a:moveTo>
                  <a:pt x="30479" y="4572"/>
                </a:moveTo>
                <a:lnTo>
                  <a:pt x="25907" y="4572"/>
                </a:lnTo>
                <a:lnTo>
                  <a:pt x="28193" y="9144"/>
                </a:lnTo>
                <a:lnTo>
                  <a:pt x="30479" y="4572"/>
                </a:lnTo>
                <a:close/>
              </a:path>
              <a:path w="56515" h="58419">
                <a:moveTo>
                  <a:pt x="28193" y="9144"/>
                </a:moveTo>
                <a:lnTo>
                  <a:pt x="25907" y="4572"/>
                </a:lnTo>
                <a:lnTo>
                  <a:pt x="25907" y="13716"/>
                </a:lnTo>
                <a:lnTo>
                  <a:pt x="28193" y="9144"/>
                </a:lnTo>
                <a:close/>
              </a:path>
              <a:path w="56515" h="58419">
                <a:moveTo>
                  <a:pt x="30479" y="13716"/>
                </a:moveTo>
                <a:lnTo>
                  <a:pt x="30479" y="4572"/>
                </a:lnTo>
                <a:lnTo>
                  <a:pt x="28193" y="9144"/>
                </a:lnTo>
                <a:lnTo>
                  <a:pt x="30479" y="13716"/>
                </a:lnTo>
                <a:close/>
              </a:path>
              <a:path w="56515" h="58419">
                <a:moveTo>
                  <a:pt x="54863" y="51816"/>
                </a:moveTo>
                <a:lnTo>
                  <a:pt x="49529" y="51816"/>
                </a:lnTo>
                <a:lnTo>
                  <a:pt x="51815" y="56388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5" name="object 95"/>
          <p:cNvSpPr/>
          <p:nvPr/>
        </p:nvSpPr>
        <p:spPr>
          <a:xfrm>
            <a:off x="5178437" y="902208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5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5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5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5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6" name="object 96"/>
          <p:cNvSpPr txBox="1"/>
          <p:nvPr/>
        </p:nvSpPr>
        <p:spPr>
          <a:xfrm>
            <a:off x="5854575" y="2495546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97" name="object 97"/>
          <p:cNvSpPr txBox="1"/>
          <p:nvPr/>
        </p:nvSpPr>
        <p:spPr>
          <a:xfrm>
            <a:off x="8180203" y="1420068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98" name="object 98"/>
          <p:cNvSpPr txBox="1"/>
          <p:nvPr/>
        </p:nvSpPr>
        <p:spPr>
          <a:xfrm>
            <a:off x="8180203" y="1720341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99" name="object 99"/>
          <p:cNvSpPr txBox="1"/>
          <p:nvPr/>
        </p:nvSpPr>
        <p:spPr>
          <a:xfrm>
            <a:off x="8180203" y="2014473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00" name="object 100"/>
          <p:cNvSpPr txBox="1"/>
          <p:nvPr/>
        </p:nvSpPr>
        <p:spPr>
          <a:xfrm>
            <a:off x="8085714" y="1014260"/>
            <a:ext cx="433705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2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01" name="object 101"/>
          <p:cNvSpPr txBox="1"/>
          <p:nvPr/>
        </p:nvSpPr>
        <p:spPr>
          <a:xfrm>
            <a:off x="5270887" y="964392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 dirty="0">
              <a:latin typeface="Calibri"/>
              <a:cs typeface="Calibri"/>
            </a:endParaRPr>
          </a:p>
        </p:txBody>
      </p:sp>
      <p:sp>
        <p:nvSpPr>
          <p:cNvPr id="102" name="object 102"/>
          <p:cNvSpPr/>
          <p:nvPr/>
        </p:nvSpPr>
        <p:spPr>
          <a:xfrm>
            <a:off x="1731149" y="418947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3" name="object 103"/>
          <p:cNvSpPr/>
          <p:nvPr/>
        </p:nvSpPr>
        <p:spPr>
          <a:xfrm>
            <a:off x="1731149" y="3950208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4" name="object 104"/>
          <p:cNvSpPr/>
          <p:nvPr/>
        </p:nvSpPr>
        <p:spPr>
          <a:xfrm>
            <a:off x="1731149" y="3710940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5" name="object 105"/>
          <p:cNvSpPr/>
          <p:nvPr/>
        </p:nvSpPr>
        <p:spPr>
          <a:xfrm>
            <a:off x="1731149" y="347167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6" name="object 106"/>
          <p:cNvSpPr/>
          <p:nvPr/>
        </p:nvSpPr>
        <p:spPr>
          <a:xfrm>
            <a:off x="1731149" y="3232403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7" name="object 107"/>
          <p:cNvSpPr/>
          <p:nvPr/>
        </p:nvSpPr>
        <p:spPr>
          <a:xfrm>
            <a:off x="1731149" y="2993135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8" name="object 108"/>
          <p:cNvSpPr/>
          <p:nvPr/>
        </p:nvSpPr>
        <p:spPr>
          <a:xfrm>
            <a:off x="1758569" y="2993135"/>
            <a:ext cx="0" cy="1403985"/>
          </a:xfrm>
          <a:custGeom>
            <a:avLst/>
            <a:gdLst/>
            <a:ahLst/>
            <a:cxnLst/>
            <a:rect l="l" t="t" r="r" b="b"/>
            <a:pathLst>
              <a:path h="1403985">
                <a:moveTo>
                  <a:pt x="0" y="0"/>
                </a:moveTo>
                <a:lnTo>
                  <a:pt x="0" y="1403603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9" name="object 109"/>
          <p:cNvSpPr/>
          <p:nvPr/>
        </p:nvSpPr>
        <p:spPr>
          <a:xfrm>
            <a:off x="1789061" y="4428744"/>
            <a:ext cx="1908175" cy="0"/>
          </a:xfrm>
          <a:custGeom>
            <a:avLst/>
            <a:gdLst/>
            <a:ahLst/>
            <a:cxnLst/>
            <a:rect l="l" t="t" r="r" b="b"/>
            <a:pathLst>
              <a:path w="1908175">
                <a:moveTo>
                  <a:pt x="0" y="0"/>
                </a:moveTo>
                <a:lnTo>
                  <a:pt x="1908047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0" name="object 110"/>
          <p:cNvSpPr/>
          <p:nvPr/>
        </p:nvSpPr>
        <p:spPr>
          <a:xfrm>
            <a:off x="1718703" y="3096514"/>
            <a:ext cx="2019807" cy="1374013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1" name="object 111"/>
          <p:cNvSpPr txBox="1"/>
          <p:nvPr/>
        </p:nvSpPr>
        <p:spPr>
          <a:xfrm>
            <a:off x="1622431" y="4370578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12" name="object 112"/>
          <p:cNvSpPr txBox="1"/>
          <p:nvPr/>
        </p:nvSpPr>
        <p:spPr>
          <a:xfrm>
            <a:off x="1578232" y="4131308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5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13" name="object 113"/>
          <p:cNvSpPr txBox="1"/>
          <p:nvPr/>
        </p:nvSpPr>
        <p:spPr>
          <a:xfrm>
            <a:off x="1535563" y="3892039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14" name="object 114"/>
          <p:cNvSpPr txBox="1"/>
          <p:nvPr/>
        </p:nvSpPr>
        <p:spPr>
          <a:xfrm>
            <a:off x="1535563" y="3652770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15" name="object 115"/>
          <p:cNvSpPr txBox="1"/>
          <p:nvPr/>
        </p:nvSpPr>
        <p:spPr>
          <a:xfrm>
            <a:off x="1535563" y="3413500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16" name="object 116"/>
          <p:cNvSpPr txBox="1"/>
          <p:nvPr/>
        </p:nvSpPr>
        <p:spPr>
          <a:xfrm>
            <a:off x="1535563" y="3174231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17" name="object 117"/>
          <p:cNvSpPr txBox="1"/>
          <p:nvPr/>
        </p:nvSpPr>
        <p:spPr>
          <a:xfrm>
            <a:off x="1535563" y="2934962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18" name="object 118"/>
          <p:cNvSpPr/>
          <p:nvPr/>
        </p:nvSpPr>
        <p:spPr>
          <a:xfrm>
            <a:off x="3869321" y="345947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9" name="object 119"/>
          <p:cNvSpPr/>
          <p:nvPr/>
        </p:nvSpPr>
        <p:spPr>
          <a:xfrm>
            <a:off x="3936377" y="3433571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0" name="object 120"/>
          <p:cNvSpPr/>
          <p:nvPr/>
        </p:nvSpPr>
        <p:spPr>
          <a:xfrm>
            <a:off x="3933329" y="3430523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4" h="56514">
                <a:moveTo>
                  <a:pt x="56388" y="30480"/>
                </a:moveTo>
                <a:lnTo>
                  <a:pt x="56388" y="25908"/>
                </a:lnTo>
                <a:lnTo>
                  <a:pt x="30480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30480"/>
                </a:lnTo>
                <a:lnTo>
                  <a:pt x="4572" y="35052"/>
                </a:lnTo>
                <a:lnTo>
                  <a:pt x="4572" y="25908"/>
                </a:lnTo>
                <a:lnTo>
                  <a:pt x="6858" y="28193"/>
                </a:lnTo>
                <a:lnTo>
                  <a:pt x="25908" y="9143"/>
                </a:lnTo>
                <a:lnTo>
                  <a:pt x="25908" y="4572"/>
                </a:lnTo>
                <a:lnTo>
                  <a:pt x="30480" y="4572"/>
                </a:lnTo>
                <a:lnTo>
                  <a:pt x="30480" y="9144"/>
                </a:lnTo>
                <a:lnTo>
                  <a:pt x="49530" y="28194"/>
                </a:lnTo>
                <a:lnTo>
                  <a:pt x="51816" y="25908"/>
                </a:lnTo>
                <a:lnTo>
                  <a:pt x="51816" y="35052"/>
                </a:lnTo>
                <a:lnTo>
                  <a:pt x="56388" y="30480"/>
                </a:lnTo>
                <a:close/>
              </a:path>
              <a:path w="56514" h="56514">
                <a:moveTo>
                  <a:pt x="6858" y="28194"/>
                </a:moveTo>
                <a:lnTo>
                  <a:pt x="4572" y="25908"/>
                </a:lnTo>
                <a:lnTo>
                  <a:pt x="4572" y="30480"/>
                </a:lnTo>
                <a:lnTo>
                  <a:pt x="6858" y="28194"/>
                </a:lnTo>
                <a:close/>
              </a:path>
              <a:path w="56514" h="56514">
                <a:moveTo>
                  <a:pt x="28194" y="49530"/>
                </a:moveTo>
                <a:lnTo>
                  <a:pt x="6858" y="28194"/>
                </a:lnTo>
                <a:lnTo>
                  <a:pt x="4572" y="30480"/>
                </a:lnTo>
                <a:lnTo>
                  <a:pt x="4572" y="35052"/>
                </a:lnTo>
                <a:lnTo>
                  <a:pt x="25908" y="56388"/>
                </a:lnTo>
                <a:lnTo>
                  <a:pt x="25908" y="51816"/>
                </a:lnTo>
                <a:lnTo>
                  <a:pt x="28194" y="49530"/>
                </a:lnTo>
                <a:close/>
              </a:path>
              <a:path w="56514" h="56514">
                <a:moveTo>
                  <a:pt x="30480" y="4572"/>
                </a:moveTo>
                <a:lnTo>
                  <a:pt x="25908" y="4572"/>
                </a:lnTo>
                <a:lnTo>
                  <a:pt x="28194" y="6857"/>
                </a:lnTo>
                <a:lnTo>
                  <a:pt x="30480" y="4572"/>
                </a:lnTo>
                <a:close/>
              </a:path>
              <a:path w="56514" h="56514">
                <a:moveTo>
                  <a:pt x="28194" y="6858"/>
                </a:moveTo>
                <a:lnTo>
                  <a:pt x="25908" y="4572"/>
                </a:lnTo>
                <a:lnTo>
                  <a:pt x="25908" y="9143"/>
                </a:lnTo>
                <a:lnTo>
                  <a:pt x="28194" y="6858"/>
                </a:lnTo>
                <a:close/>
              </a:path>
              <a:path w="56514" h="56514">
                <a:moveTo>
                  <a:pt x="30480" y="51816"/>
                </a:moveTo>
                <a:lnTo>
                  <a:pt x="28194" y="49530"/>
                </a:lnTo>
                <a:lnTo>
                  <a:pt x="25908" y="51816"/>
                </a:lnTo>
                <a:lnTo>
                  <a:pt x="30480" y="51816"/>
                </a:lnTo>
                <a:close/>
              </a:path>
              <a:path w="56514" h="56514">
                <a:moveTo>
                  <a:pt x="30480" y="56388"/>
                </a:moveTo>
                <a:lnTo>
                  <a:pt x="30480" y="51816"/>
                </a:lnTo>
                <a:lnTo>
                  <a:pt x="25908" y="51816"/>
                </a:lnTo>
                <a:lnTo>
                  <a:pt x="25908" y="56388"/>
                </a:lnTo>
                <a:lnTo>
                  <a:pt x="30480" y="56388"/>
                </a:lnTo>
                <a:close/>
              </a:path>
              <a:path w="56514" h="56514">
                <a:moveTo>
                  <a:pt x="30480" y="9144"/>
                </a:moveTo>
                <a:lnTo>
                  <a:pt x="30480" y="4572"/>
                </a:lnTo>
                <a:lnTo>
                  <a:pt x="28194" y="6858"/>
                </a:lnTo>
                <a:lnTo>
                  <a:pt x="30480" y="9144"/>
                </a:lnTo>
                <a:close/>
              </a:path>
              <a:path w="56514" h="56514">
                <a:moveTo>
                  <a:pt x="51816" y="35052"/>
                </a:moveTo>
                <a:lnTo>
                  <a:pt x="51816" y="30480"/>
                </a:lnTo>
                <a:lnTo>
                  <a:pt x="49530" y="28193"/>
                </a:lnTo>
                <a:lnTo>
                  <a:pt x="28194" y="49530"/>
                </a:lnTo>
                <a:lnTo>
                  <a:pt x="30480" y="51816"/>
                </a:lnTo>
                <a:lnTo>
                  <a:pt x="30480" y="56388"/>
                </a:lnTo>
                <a:lnTo>
                  <a:pt x="51816" y="35052"/>
                </a:lnTo>
                <a:close/>
              </a:path>
              <a:path w="56514" h="56514">
                <a:moveTo>
                  <a:pt x="51816" y="30480"/>
                </a:moveTo>
                <a:lnTo>
                  <a:pt x="51816" y="25908"/>
                </a:lnTo>
                <a:lnTo>
                  <a:pt x="49530" y="28193"/>
                </a:lnTo>
                <a:lnTo>
                  <a:pt x="51816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1" name="object 121"/>
          <p:cNvSpPr/>
          <p:nvPr/>
        </p:nvSpPr>
        <p:spPr>
          <a:xfrm>
            <a:off x="3869321" y="3753611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2" name="object 122"/>
          <p:cNvSpPr/>
          <p:nvPr/>
        </p:nvSpPr>
        <p:spPr>
          <a:xfrm>
            <a:off x="3936377" y="3753611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3" name="object 123"/>
          <p:cNvSpPr/>
          <p:nvPr/>
        </p:nvSpPr>
        <p:spPr>
          <a:xfrm>
            <a:off x="3933329" y="3724655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4" name="object 124"/>
          <p:cNvSpPr/>
          <p:nvPr/>
        </p:nvSpPr>
        <p:spPr>
          <a:xfrm>
            <a:off x="3869321" y="4047744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5" name="object 125"/>
          <p:cNvSpPr/>
          <p:nvPr/>
        </p:nvSpPr>
        <p:spPr>
          <a:xfrm>
            <a:off x="3936377" y="4021835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6" name="object 126"/>
          <p:cNvSpPr/>
          <p:nvPr/>
        </p:nvSpPr>
        <p:spPr>
          <a:xfrm>
            <a:off x="3933329" y="4018788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6388"/>
                </a:moveTo>
                <a:lnTo>
                  <a:pt x="57912" y="53340"/>
                </a:lnTo>
                <a:lnTo>
                  <a:pt x="32004" y="1524"/>
                </a:lnTo>
                <a:lnTo>
                  <a:pt x="28956" y="0"/>
                </a:lnTo>
                <a:lnTo>
                  <a:pt x="25908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8382" y="51816"/>
                </a:lnTo>
                <a:lnTo>
                  <a:pt x="25908" y="16764"/>
                </a:lnTo>
                <a:lnTo>
                  <a:pt x="25908" y="4572"/>
                </a:lnTo>
                <a:lnTo>
                  <a:pt x="32004" y="4572"/>
                </a:lnTo>
                <a:lnTo>
                  <a:pt x="32004" y="16764"/>
                </a:lnTo>
                <a:lnTo>
                  <a:pt x="49530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20">
                <a:moveTo>
                  <a:pt x="8382" y="51816"/>
                </a:moveTo>
                <a:lnTo>
                  <a:pt x="3048" y="51816"/>
                </a:lnTo>
                <a:lnTo>
                  <a:pt x="6096" y="56388"/>
                </a:lnTo>
                <a:lnTo>
                  <a:pt x="8382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6388"/>
                </a:lnTo>
                <a:lnTo>
                  <a:pt x="49530" y="51816"/>
                </a:lnTo>
                <a:lnTo>
                  <a:pt x="8382" y="51816"/>
                </a:lnTo>
                <a:lnTo>
                  <a:pt x="6096" y="56388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20">
                <a:moveTo>
                  <a:pt x="32004" y="4572"/>
                </a:moveTo>
                <a:lnTo>
                  <a:pt x="25908" y="4572"/>
                </a:lnTo>
                <a:lnTo>
                  <a:pt x="28956" y="10668"/>
                </a:lnTo>
                <a:lnTo>
                  <a:pt x="32004" y="4572"/>
                </a:lnTo>
                <a:close/>
              </a:path>
              <a:path w="58420" h="58420">
                <a:moveTo>
                  <a:pt x="28956" y="10668"/>
                </a:moveTo>
                <a:lnTo>
                  <a:pt x="25908" y="4572"/>
                </a:lnTo>
                <a:lnTo>
                  <a:pt x="25908" y="16764"/>
                </a:lnTo>
                <a:lnTo>
                  <a:pt x="28956" y="10668"/>
                </a:lnTo>
                <a:close/>
              </a:path>
              <a:path w="58420" h="58420">
                <a:moveTo>
                  <a:pt x="32004" y="16764"/>
                </a:moveTo>
                <a:lnTo>
                  <a:pt x="32004" y="4572"/>
                </a:lnTo>
                <a:lnTo>
                  <a:pt x="28956" y="10668"/>
                </a:lnTo>
                <a:lnTo>
                  <a:pt x="32004" y="16764"/>
                </a:lnTo>
                <a:close/>
              </a:path>
              <a:path w="58420" h="58420">
                <a:moveTo>
                  <a:pt x="54864" y="51816"/>
                </a:moveTo>
                <a:lnTo>
                  <a:pt x="49530" y="51816"/>
                </a:lnTo>
                <a:lnTo>
                  <a:pt x="51816" y="56388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7" name="object 127"/>
          <p:cNvSpPr/>
          <p:nvPr/>
        </p:nvSpPr>
        <p:spPr>
          <a:xfrm>
            <a:off x="1048397" y="2877311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8" name="object 128"/>
          <p:cNvSpPr txBox="1"/>
          <p:nvPr/>
        </p:nvSpPr>
        <p:spPr>
          <a:xfrm>
            <a:off x="1724536" y="4470649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29" name="object 129"/>
          <p:cNvSpPr txBox="1"/>
          <p:nvPr/>
        </p:nvSpPr>
        <p:spPr>
          <a:xfrm>
            <a:off x="4050163" y="3395172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0" name="object 130"/>
          <p:cNvSpPr txBox="1"/>
          <p:nvPr/>
        </p:nvSpPr>
        <p:spPr>
          <a:xfrm>
            <a:off x="4050163" y="3695446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1" name="object 131"/>
          <p:cNvSpPr txBox="1"/>
          <p:nvPr/>
        </p:nvSpPr>
        <p:spPr>
          <a:xfrm>
            <a:off x="4050163" y="3989578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2" name="object 132"/>
          <p:cNvSpPr txBox="1"/>
          <p:nvPr/>
        </p:nvSpPr>
        <p:spPr>
          <a:xfrm>
            <a:off x="3955675" y="2989364"/>
            <a:ext cx="433705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3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33" name="object 133"/>
          <p:cNvSpPr txBox="1"/>
          <p:nvPr/>
        </p:nvSpPr>
        <p:spPr>
          <a:xfrm>
            <a:off x="1140847" y="2939496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4" name="object 134"/>
          <p:cNvSpPr/>
          <p:nvPr/>
        </p:nvSpPr>
        <p:spPr>
          <a:xfrm>
            <a:off x="1731149" y="616457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60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5" name="object 135"/>
          <p:cNvSpPr/>
          <p:nvPr/>
        </p:nvSpPr>
        <p:spPr>
          <a:xfrm>
            <a:off x="1731149" y="59253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60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6" name="object 136"/>
          <p:cNvSpPr/>
          <p:nvPr/>
        </p:nvSpPr>
        <p:spPr>
          <a:xfrm>
            <a:off x="1731149" y="568604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7" name="object 137"/>
          <p:cNvSpPr/>
          <p:nvPr/>
        </p:nvSpPr>
        <p:spPr>
          <a:xfrm>
            <a:off x="1731149" y="544677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8" name="object 138"/>
          <p:cNvSpPr/>
          <p:nvPr/>
        </p:nvSpPr>
        <p:spPr>
          <a:xfrm>
            <a:off x="1731149" y="5207508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9" name="object 139"/>
          <p:cNvSpPr/>
          <p:nvPr/>
        </p:nvSpPr>
        <p:spPr>
          <a:xfrm>
            <a:off x="1731149" y="4968240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0" name="object 140"/>
          <p:cNvSpPr/>
          <p:nvPr/>
        </p:nvSpPr>
        <p:spPr>
          <a:xfrm>
            <a:off x="1718703" y="4964557"/>
            <a:ext cx="2019808" cy="1481074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1" name="object 141"/>
          <p:cNvSpPr txBox="1"/>
          <p:nvPr/>
        </p:nvSpPr>
        <p:spPr>
          <a:xfrm>
            <a:off x="1622431" y="6345682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42" name="object 142"/>
          <p:cNvSpPr txBox="1"/>
          <p:nvPr/>
        </p:nvSpPr>
        <p:spPr>
          <a:xfrm>
            <a:off x="1535563" y="6106412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43" name="object 143"/>
          <p:cNvSpPr txBox="1"/>
          <p:nvPr/>
        </p:nvSpPr>
        <p:spPr>
          <a:xfrm>
            <a:off x="1535563" y="5867143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44" name="object 144"/>
          <p:cNvSpPr txBox="1"/>
          <p:nvPr/>
        </p:nvSpPr>
        <p:spPr>
          <a:xfrm>
            <a:off x="1535563" y="5627874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45" name="object 145"/>
          <p:cNvSpPr txBox="1"/>
          <p:nvPr/>
        </p:nvSpPr>
        <p:spPr>
          <a:xfrm>
            <a:off x="1535563" y="5388605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46" name="object 146"/>
          <p:cNvSpPr txBox="1"/>
          <p:nvPr/>
        </p:nvSpPr>
        <p:spPr>
          <a:xfrm>
            <a:off x="1491364" y="5149336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47" name="object 147"/>
          <p:cNvSpPr txBox="1"/>
          <p:nvPr/>
        </p:nvSpPr>
        <p:spPr>
          <a:xfrm>
            <a:off x="1491364" y="4910066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48" name="object 148"/>
          <p:cNvSpPr/>
          <p:nvPr/>
        </p:nvSpPr>
        <p:spPr>
          <a:xfrm>
            <a:off x="3869321" y="543305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9" name="object 149"/>
          <p:cNvSpPr/>
          <p:nvPr/>
        </p:nvSpPr>
        <p:spPr>
          <a:xfrm>
            <a:off x="3936377" y="5407152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0" name="object 150"/>
          <p:cNvSpPr/>
          <p:nvPr/>
        </p:nvSpPr>
        <p:spPr>
          <a:xfrm>
            <a:off x="3933329" y="5405628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4" h="56514">
                <a:moveTo>
                  <a:pt x="56388" y="30480"/>
                </a:moveTo>
                <a:lnTo>
                  <a:pt x="56388" y="25908"/>
                </a:lnTo>
                <a:lnTo>
                  <a:pt x="30480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30480"/>
                </a:lnTo>
                <a:lnTo>
                  <a:pt x="4572" y="35052"/>
                </a:lnTo>
                <a:lnTo>
                  <a:pt x="4572" y="25908"/>
                </a:lnTo>
                <a:lnTo>
                  <a:pt x="6858" y="28193"/>
                </a:lnTo>
                <a:lnTo>
                  <a:pt x="25908" y="9143"/>
                </a:lnTo>
                <a:lnTo>
                  <a:pt x="25908" y="4572"/>
                </a:lnTo>
                <a:lnTo>
                  <a:pt x="30480" y="4572"/>
                </a:lnTo>
                <a:lnTo>
                  <a:pt x="30480" y="9144"/>
                </a:lnTo>
                <a:lnTo>
                  <a:pt x="49530" y="28194"/>
                </a:lnTo>
                <a:lnTo>
                  <a:pt x="51816" y="25908"/>
                </a:lnTo>
                <a:lnTo>
                  <a:pt x="51816" y="35052"/>
                </a:lnTo>
                <a:lnTo>
                  <a:pt x="56388" y="30480"/>
                </a:lnTo>
                <a:close/>
              </a:path>
              <a:path w="56514" h="56514">
                <a:moveTo>
                  <a:pt x="6858" y="28194"/>
                </a:moveTo>
                <a:lnTo>
                  <a:pt x="4572" y="25908"/>
                </a:lnTo>
                <a:lnTo>
                  <a:pt x="4572" y="30480"/>
                </a:lnTo>
                <a:lnTo>
                  <a:pt x="6858" y="28194"/>
                </a:lnTo>
                <a:close/>
              </a:path>
              <a:path w="56514" h="56514">
                <a:moveTo>
                  <a:pt x="28194" y="49530"/>
                </a:moveTo>
                <a:lnTo>
                  <a:pt x="6858" y="28194"/>
                </a:lnTo>
                <a:lnTo>
                  <a:pt x="4572" y="30480"/>
                </a:lnTo>
                <a:lnTo>
                  <a:pt x="4572" y="35052"/>
                </a:lnTo>
                <a:lnTo>
                  <a:pt x="25908" y="56388"/>
                </a:lnTo>
                <a:lnTo>
                  <a:pt x="25908" y="51816"/>
                </a:lnTo>
                <a:lnTo>
                  <a:pt x="28194" y="49530"/>
                </a:lnTo>
                <a:close/>
              </a:path>
              <a:path w="56514" h="56514">
                <a:moveTo>
                  <a:pt x="30480" y="4572"/>
                </a:moveTo>
                <a:lnTo>
                  <a:pt x="25908" y="4572"/>
                </a:lnTo>
                <a:lnTo>
                  <a:pt x="28194" y="6857"/>
                </a:lnTo>
                <a:lnTo>
                  <a:pt x="30480" y="4572"/>
                </a:lnTo>
                <a:close/>
              </a:path>
              <a:path w="56514" h="56514">
                <a:moveTo>
                  <a:pt x="28194" y="6858"/>
                </a:moveTo>
                <a:lnTo>
                  <a:pt x="25908" y="4572"/>
                </a:lnTo>
                <a:lnTo>
                  <a:pt x="25908" y="9143"/>
                </a:lnTo>
                <a:lnTo>
                  <a:pt x="28194" y="6858"/>
                </a:lnTo>
                <a:close/>
              </a:path>
              <a:path w="56514" h="56514">
                <a:moveTo>
                  <a:pt x="30480" y="51816"/>
                </a:moveTo>
                <a:lnTo>
                  <a:pt x="28194" y="49530"/>
                </a:lnTo>
                <a:lnTo>
                  <a:pt x="25908" y="51816"/>
                </a:lnTo>
                <a:lnTo>
                  <a:pt x="30480" y="51816"/>
                </a:lnTo>
                <a:close/>
              </a:path>
              <a:path w="56514" h="56514">
                <a:moveTo>
                  <a:pt x="30480" y="56388"/>
                </a:moveTo>
                <a:lnTo>
                  <a:pt x="30480" y="51816"/>
                </a:lnTo>
                <a:lnTo>
                  <a:pt x="25908" y="51816"/>
                </a:lnTo>
                <a:lnTo>
                  <a:pt x="25908" y="56388"/>
                </a:lnTo>
                <a:lnTo>
                  <a:pt x="30480" y="56388"/>
                </a:lnTo>
                <a:close/>
              </a:path>
              <a:path w="56514" h="56514">
                <a:moveTo>
                  <a:pt x="30480" y="9144"/>
                </a:moveTo>
                <a:lnTo>
                  <a:pt x="30480" y="4572"/>
                </a:lnTo>
                <a:lnTo>
                  <a:pt x="28194" y="6858"/>
                </a:lnTo>
                <a:lnTo>
                  <a:pt x="30480" y="9144"/>
                </a:lnTo>
                <a:close/>
              </a:path>
              <a:path w="56514" h="56514">
                <a:moveTo>
                  <a:pt x="51816" y="35052"/>
                </a:moveTo>
                <a:lnTo>
                  <a:pt x="51816" y="30480"/>
                </a:lnTo>
                <a:lnTo>
                  <a:pt x="49530" y="28193"/>
                </a:lnTo>
                <a:lnTo>
                  <a:pt x="28194" y="49530"/>
                </a:lnTo>
                <a:lnTo>
                  <a:pt x="30480" y="51816"/>
                </a:lnTo>
                <a:lnTo>
                  <a:pt x="30480" y="56388"/>
                </a:lnTo>
                <a:lnTo>
                  <a:pt x="51816" y="35052"/>
                </a:lnTo>
                <a:close/>
              </a:path>
              <a:path w="56514" h="56514">
                <a:moveTo>
                  <a:pt x="51816" y="30480"/>
                </a:moveTo>
                <a:lnTo>
                  <a:pt x="51816" y="25908"/>
                </a:lnTo>
                <a:lnTo>
                  <a:pt x="49530" y="28193"/>
                </a:lnTo>
                <a:lnTo>
                  <a:pt x="51816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1" name="object 151"/>
          <p:cNvSpPr/>
          <p:nvPr/>
        </p:nvSpPr>
        <p:spPr>
          <a:xfrm>
            <a:off x="3869321" y="572871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2" name="object 152"/>
          <p:cNvSpPr/>
          <p:nvPr/>
        </p:nvSpPr>
        <p:spPr>
          <a:xfrm>
            <a:off x="3936377" y="5728715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3" name="object 153"/>
          <p:cNvSpPr/>
          <p:nvPr/>
        </p:nvSpPr>
        <p:spPr>
          <a:xfrm>
            <a:off x="3933329" y="5699759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4" name="object 154"/>
          <p:cNvSpPr/>
          <p:nvPr/>
        </p:nvSpPr>
        <p:spPr>
          <a:xfrm>
            <a:off x="3869321" y="6022847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5" name="object 155"/>
          <p:cNvSpPr/>
          <p:nvPr/>
        </p:nvSpPr>
        <p:spPr>
          <a:xfrm>
            <a:off x="3936377" y="5995415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6" name="object 156"/>
          <p:cNvSpPr/>
          <p:nvPr/>
        </p:nvSpPr>
        <p:spPr>
          <a:xfrm>
            <a:off x="3933329" y="5993891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6388"/>
                </a:moveTo>
                <a:lnTo>
                  <a:pt x="57912" y="53340"/>
                </a:lnTo>
                <a:lnTo>
                  <a:pt x="32004" y="1524"/>
                </a:lnTo>
                <a:lnTo>
                  <a:pt x="28956" y="0"/>
                </a:lnTo>
                <a:lnTo>
                  <a:pt x="25908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7620" y="51816"/>
                </a:lnTo>
                <a:lnTo>
                  <a:pt x="25908" y="15240"/>
                </a:lnTo>
                <a:lnTo>
                  <a:pt x="25908" y="3048"/>
                </a:lnTo>
                <a:lnTo>
                  <a:pt x="32004" y="3048"/>
                </a:lnTo>
                <a:lnTo>
                  <a:pt x="32004" y="15240"/>
                </a:lnTo>
                <a:lnTo>
                  <a:pt x="50292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20">
                <a:moveTo>
                  <a:pt x="7620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7620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0292" y="51816"/>
                </a:lnTo>
                <a:lnTo>
                  <a:pt x="7620" y="51816"/>
                </a:ln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20">
                <a:moveTo>
                  <a:pt x="32004" y="3048"/>
                </a:moveTo>
                <a:lnTo>
                  <a:pt x="25908" y="3048"/>
                </a:lnTo>
                <a:lnTo>
                  <a:pt x="28956" y="9144"/>
                </a:lnTo>
                <a:lnTo>
                  <a:pt x="32004" y="3048"/>
                </a:lnTo>
                <a:close/>
              </a:path>
              <a:path w="58420" h="58420">
                <a:moveTo>
                  <a:pt x="28956" y="9144"/>
                </a:moveTo>
                <a:lnTo>
                  <a:pt x="25908" y="3048"/>
                </a:lnTo>
                <a:lnTo>
                  <a:pt x="25908" y="15240"/>
                </a:lnTo>
                <a:lnTo>
                  <a:pt x="28956" y="9144"/>
                </a:lnTo>
                <a:close/>
              </a:path>
              <a:path w="58420" h="58420">
                <a:moveTo>
                  <a:pt x="32004" y="15240"/>
                </a:moveTo>
                <a:lnTo>
                  <a:pt x="32004" y="3048"/>
                </a:lnTo>
                <a:lnTo>
                  <a:pt x="28956" y="9144"/>
                </a:lnTo>
                <a:lnTo>
                  <a:pt x="32004" y="15240"/>
                </a:lnTo>
                <a:close/>
              </a:path>
              <a:path w="58420" h="58420">
                <a:moveTo>
                  <a:pt x="54864" y="51816"/>
                </a:moveTo>
                <a:lnTo>
                  <a:pt x="50292" y="51816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7" name="object 157"/>
          <p:cNvSpPr/>
          <p:nvPr/>
        </p:nvSpPr>
        <p:spPr>
          <a:xfrm>
            <a:off x="1048397" y="4852415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8" name="object 158"/>
          <p:cNvSpPr txBox="1"/>
          <p:nvPr/>
        </p:nvSpPr>
        <p:spPr>
          <a:xfrm>
            <a:off x="1724536" y="6445753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59" name="object 159"/>
          <p:cNvSpPr txBox="1"/>
          <p:nvPr/>
        </p:nvSpPr>
        <p:spPr>
          <a:xfrm>
            <a:off x="4050163" y="5370276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0" name="object 160"/>
          <p:cNvSpPr txBox="1"/>
          <p:nvPr/>
        </p:nvSpPr>
        <p:spPr>
          <a:xfrm>
            <a:off x="4050163" y="5670550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1" name="object 161"/>
          <p:cNvSpPr txBox="1"/>
          <p:nvPr/>
        </p:nvSpPr>
        <p:spPr>
          <a:xfrm>
            <a:off x="4050163" y="5964682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2" name="object 162"/>
          <p:cNvSpPr txBox="1"/>
          <p:nvPr/>
        </p:nvSpPr>
        <p:spPr>
          <a:xfrm>
            <a:off x="3955675" y="4964468"/>
            <a:ext cx="433705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4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63" name="object 163"/>
          <p:cNvSpPr txBox="1"/>
          <p:nvPr/>
        </p:nvSpPr>
        <p:spPr>
          <a:xfrm>
            <a:off x="1140847" y="4914600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4" name="object 164"/>
          <p:cNvSpPr/>
          <p:nvPr/>
        </p:nvSpPr>
        <p:spPr>
          <a:xfrm>
            <a:off x="5861189" y="3950208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5" name="object 165"/>
          <p:cNvSpPr/>
          <p:nvPr/>
        </p:nvSpPr>
        <p:spPr>
          <a:xfrm>
            <a:off x="5861189" y="347167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6" name="object 166"/>
          <p:cNvSpPr/>
          <p:nvPr/>
        </p:nvSpPr>
        <p:spPr>
          <a:xfrm>
            <a:off x="5861189" y="2993135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7" name="object 167"/>
          <p:cNvSpPr/>
          <p:nvPr/>
        </p:nvSpPr>
        <p:spPr>
          <a:xfrm>
            <a:off x="5888621" y="2993135"/>
            <a:ext cx="0" cy="1466215"/>
          </a:xfrm>
          <a:custGeom>
            <a:avLst/>
            <a:gdLst/>
            <a:ahLst/>
            <a:cxnLst/>
            <a:rect l="l" t="t" r="r" b="b"/>
            <a:pathLst>
              <a:path h="1466214">
                <a:moveTo>
                  <a:pt x="0" y="0"/>
                </a:moveTo>
                <a:lnTo>
                  <a:pt x="0" y="1466087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8" name="object 168"/>
          <p:cNvSpPr/>
          <p:nvPr/>
        </p:nvSpPr>
        <p:spPr>
          <a:xfrm>
            <a:off x="5861189" y="442874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9" name="object 169"/>
          <p:cNvSpPr/>
          <p:nvPr/>
        </p:nvSpPr>
        <p:spPr>
          <a:xfrm>
            <a:off x="6047117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0" name="object 170"/>
          <p:cNvSpPr/>
          <p:nvPr/>
        </p:nvSpPr>
        <p:spPr>
          <a:xfrm>
            <a:off x="6208662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1" name="object 171"/>
          <p:cNvSpPr/>
          <p:nvPr/>
        </p:nvSpPr>
        <p:spPr>
          <a:xfrm>
            <a:off x="6370193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2" name="object 172"/>
          <p:cNvSpPr/>
          <p:nvPr/>
        </p:nvSpPr>
        <p:spPr>
          <a:xfrm>
            <a:off x="6531749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3" name="object 173"/>
          <p:cNvSpPr/>
          <p:nvPr/>
        </p:nvSpPr>
        <p:spPr>
          <a:xfrm>
            <a:off x="6693281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4" name="object 174"/>
          <p:cNvSpPr/>
          <p:nvPr/>
        </p:nvSpPr>
        <p:spPr>
          <a:xfrm>
            <a:off x="6854825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5" name="object 175"/>
          <p:cNvSpPr/>
          <p:nvPr/>
        </p:nvSpPr>
        <p:spPr>
          <a:xfrm>
            <a:off x="7016381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6" name="object 176"/>
          <p:cNvSpPr/>
          <p:nvPr/>
        </p:nvSpPr>
        <p:spPr>
          <a:xfrm>
            <a:off x="7177925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7" name="object 177"/>
          <p:cNvSpPr/>
          <p:nvPr/>
        </p:nvSpPr>
        <p:spPr>
          <a:xfrm>
            <a:off x="7339469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8" name="object 178"/>
          <p:cNvSpPr/>
          <p:nvPr/>
        </p:nvSpPr>
        <p:spPr>
          <a:xfrm>
            <a:off x="7501001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9" name="object 179"/>
          <p:cNvSpPr/>
          <p:nvPr/>
        </p:nvSpPr>
        <p:spPr>
          <a:xfrm>
            <a:off x="7662557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0" name="object 180"/>
          <p:cNvSpPr/>
          <p:nvPr/>
        </p:nvSpPr>
        <p:spPr>
          <a:xfrm>
            <a:off x="7824101" y="4428744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1" name="object 181"/>
          <p:cNvSpPr/>
          <p:nvPr/>
        </p:nvSpPr>
        <p:spPr>
          <a:xfrm>
            <a:off x="5889891" y="3224529"/>
            <a:ext cx="1978647" cy="724407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2" name="object 182"/>
          <p:cNvSpPr txBox="1"/>
          <p:nvPr/>
        </p:nvSpPr>
        <p:spPr>
          <a:xfrm>
            <a:off x="5752471" y="4370578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83" name="object 183"/>
          <p:cNvSpPr txBox="1"/>
          <p:nvPr/>
        </p:nvSpPr>
        <p:spPr>
          <a:xfrm>
            <a:off x="5708272" y="3892039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84" name="object 184"/>
          <p:cNvSpPr txBox="1"/>
          <p:nvPr/>
        </p:nvSpPr>
        <p:spPr>
          <a:xfrm>
            <a:off x="5665603" y="3413500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85" name="object 185"/>
          <p:cNvSpPr txBox="1"/>
          <p:nvPr/>
        </p:nvSpPr>
        <p:spPr>
          <a:xfrm>
            <a:off x="5621404" y="2934962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86" name="object 186"/>
          <p:cNvSpPr/>
          <p:nvPr/>
        </p:nvSpPr>
        <p:spPr>
          <a:xfrm>
            <a:off x="7999361" y="345947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7" name="object 187"/>
          <p:cNvSpPr/>
          <p:nvPr/>
        </p:nvSpPr>
        <p:spPr>
          <a:xfrm>
            <a:off x="8066405" y="3433571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8" name="object 188"/>
          <p:cNvSpPr/>
          <p:nvPr/>
        </p:nvSpPr>
        <p:spPr>
          <a:xfrm>
            <a:off x="8063369" y="3430523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5" h="56514">
                <a:moveTo>
                  <a:pt x="56387" y="30480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30480"/>
                </a:lnTo>
                <a:lnTo>
                  <a:pt x="4571" y="35052"/>
                </a:lnTo>
                <a:lnTo>
                  <a:pt x="4571" y="25908"/>
                </a:lnTo>
                <a:lnTo>
                  <a:pt x="6857" y="28193"/>
                </a:lnTo>
                <a:lnTo>
                  <a:pt x="25907" y="9143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9144"/>
                </a:lnTo>
                <a:lnTo>
                  <a:pt x="49529" y="28194"/>
                </a:lnTo>
                <a:lnTo>
                  <a:pt x="51815" y="25908"/>
                </a:lnTo>
                <a:lnTo>
                  <a:pt x="51815" y="35052"/>
                </a:lnTo>
                <a:lnTo>
                  <a:pt x="56387" y="30480"/>
                </a:lnTo>
                <a:close/>
              </a:path>
              <a:path w="56515" h="56514">
                <a:moveTo>
                  <a:pt x="6857" y="28194"/>
                </a:moveTo>
                <a:lnTo>
                  <a:pt x="4571" y="25908"/>
                </a:lnTo>
                <a:lnTo>
                  <a:pt x="4571" y="30480"/>
                </a:lnTo>
                <a:lnTo>
                  <a:pt x="6857" y="28194"/>
                </a:lnTo>
                <a:close/>
              </a:path>
              <a:path w="56515" h="56514">
                <a:moveTo>
                  <a:pt x="28193" y="49530"/>
                </a:moveTo>
                <a:lnTo>
                  <a:pt x="6857" y="28194"/>
                </a:lnTo>
                <a:lnTo>
                  <a:pt x="4571" y="30480"/>
                </a:lnTo>
                <a:lnTo>
                  <a:pt x="4571" y="35052"/>
                </a:lnTo>
                <a:lnTo>
                  <a:pt x="25907" y="56388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6514">
                <a:moveTo>
                  <a:pt x="30479" y="4572"/>
                </a:moveTo>
                <a:lnTo>
                  <a:pt x="25907" y="4572"/>
                </a:lnTo>
                <a:lnTo>
                  <a:pt x="28193" y="6857"/>
                </a:lnTo>
                <a:lnTo>
                  <a:pt x="30479" y="4572"/>
                </a:lnTo>
                <a:close/>
              </a:path>
              <a:path w="56515" h="56514">
                <a:moveTo>
                  <a:pt x="28193" y="6858"/>
                </a:moveTo>
                <a:lnTo>
                  <a:pt x="25907" y="4572"/>
                </a:lnTo>
                <a:lnTo>
                  <a:pt x="25907" y="9143"/>
                </a:lnTo>
                <a:lnTo>
                  <a:pt x="28193" y="6858"/>
                </a:lnTo>
                <a:close/>
              </a:path>
              <a:path w="56515" h="56514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6514">
                <a:moveTo>
                  <a:pt x="30479" y="56388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6388"/>
                </a:lnTo>
                <a:lnTo>
                  <a:pt x="30479" y="56388"/>
                </a:lnTo>
                <a:close/>
              </a:path>
              <a:path w="56515" h="56514">
                <a:moveTo>
                  <a:pt x="30479" y="9144"/>
                </a:moveTo>
                <a:lnTo>
                  <a:pt x="30479" y="4572"/>
                </a:lnTo>
                <a:lnTo>
                  <a:pt x="28193" y="6858"/>
                </a:lnTo>
                <a:lnTo>
                  <a:pt x="30479" y="9144"/>
                </a:lnTo>
                <a:close/>
              </a:path>
              <a:path w="56515" h="56514">
                <a:moveTo>
                  <a:pt x="51815" y="35052"/>
                </a:moveTo>
                <a:lnTo>
                  <a:pt x="51815" y="30480"/>
                </a:lnTo>
                <a:lnTo>
                  <a:pt x="49529" y="28193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6388"/>
                </a:lnTo>
                <a:lnTo>
                  <a:pt x="51815" y="35052"/>
                </a:lnTo>
                <a:close/>
              </a:path>
              <a:path w="56515" h="56514">
                <a:moveTo>
                  <a:pt x="51815" y="30480"/>
                </a:moveTo>
                <a:lnTo>
                  <a:pt x="51815" y="25908"/>
                </a:lnTo>
                <a:lnTo>
                  <a:pt x="49529" y="28193"/>
                </a:lnTo>
                <a:lnTo>
                  <a:pt x="51815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9" name="object 189"/>
          <p:cNvSpPr/>
          <p:nvPr/>
        </p:nvSpPr>
        <p:spPr>
          <a:xfrm>
            <a:off x="7999361" y="3753611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0" name="object 190"/>
          <p:cNvSpPr/>
          <p:nvPr/>
        </p:nvSpPr>
        <p:spPr>
          <a:xfrm>
            <a:off x="8066417" y="3753611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1" name="object 191"/>
          <p:cNvSpPr/>
          <p:nvPr/>
        </p:nvSpPr>
        <p:spPr>
          <a:xfrm>
            <a:off x="8063369" y="3724655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2" name="object 192"/>
          <p:cNvSpPr/>
          <p:nvPr/>
        </p:nvSpPr>
        <p:spPr>
          <a:xfrm>
            <a:off x="7999361" y="4047744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3" name="object 193"/>
          <p:cNvSpPr/>
          <p:nvPr/>
        </p:nvSpPr>
        <p:spPr>
          <a:xfrm>
            <a:off x="8066405" y="4021835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4" name="object 194"/>
          <p:cNvSpPr/>
          <p:nvPr/>
        </p:nvSpPr>
        <p:spPr>
          <a:xfrm>
            <a:off x="8063369" y="4018788"/>
            <a:ext cx="56515" cy="58419"/>
          </a:xfrm>
          <a:custGeom>
            <a:avLst/>
            <a:gdLst/>
            <a:ahLst/>
            <a:cxnLst/>
            <a:rect l="l" t="t" r="r" b="b"/>
            <a:pathLst>
              <a:path w="56515" h="58420">
                <a:moveTo>
                  <a:pt x="56387" y="56388"/>
                </a:moveTo>
                <a:lnTo>
                  <a:pt x="56387" y="53340"/>
                </a:lnTo>
                <a:lnTo>
                  <a:pt x="30479" y="1524"/>
                </a:lnTo>
                <a:lnTo>
                  <a:pt x="28955" y="0"/>
                </a:lnTo>
                <a:lnTo>
                  <a:pt x="25907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6857" y="51816"/>
                </a:lnTo>
                <a:lnTo>
                  <a:pt x="25907" y="13716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13716"/>
                </a:lnTo>
                <a:lnTo>
                  <a:pt x="49529" y="51816"/>
                </a:lnTo>
                <a:lnTo>
                  <a:pt x="54863" y="51816"/>
                </a:lnTo>
                <a:lnTo>
                  <a:pt x="54863" y="57912"/>
                </a:lnTo>
                <a:lnTo>
                  <a:pt x="56387" y="56388"/>
                </a:lnTo>
                <a:close/>
              </a:path>
              <a:path w="56515" h="58420">
                <a:moveTo>
                  <a:pt x="6857" y="51816"/>
                </a:moveTo>
                <a:lnTo>
                  <a:pt x="3047" y="51816"/>
                </a:lnTo>
                <a:lnTo>
                  <a:pt x="4571" y="56388"/>
                </a:lnTo>
                <a:lnTo>
                  <a:pt x="6857" y="51816"/>
                </a:lnTo>
                <a:close/>
              </a:path>
              <a:path w="56515" h="58420">
                <a:moveTo>
                  <a:pt x="54863" y="57912"/>
                </a:moveTo>
                <a:lnTo>
                  <a:pt x="54863" y="51816"/>
                </a:lnTo>
                <a:lnTo>
                  <a:pt x="51815" y="56388"/>
                </a:lnTo>
                <a:lnTo>
                  <a:pt x="49529" y="51816"/>
                </a:lnTo>
                <a:lnTo>
                  <a:pt x="6857" y="51816"/>
                </a:lnTo>
                <a:lnTo>
                  <a:pt x="4571" y="56388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close/>
              </a:path>
              <a:path w="56515" h="58420">
                <a:moveTo>
                  <a:pt x="30479" y="4572"/>
                </a:moveTo>
                <a:lnTo>
                  <a:pt x="25907" y="4572"/>
                </a:lnTo>
                <a:lnTo>
                  <a:pt x="28193" y="9144"/>
                </a:lnTo>
                <a:lnTo>
                  <a:pt x="30479" y="4572"/>
                </a:lnTo>
                <a:close/>
              </a:path>
              <a:path w="56515" h="58420">
                <a:moveTo>
                  <a:pt x="28193" y="9144"/>
                </a:moveTo>
                <a:lnTo>
                  <a:pt x="25907" y="4572"/>
                </a:lnTo>
                <a:lnTo>
                  <a:pt x="25907" y="13716"/>
                </a:lnTo>
                <a:lnTo>
                  <a:pt x="28193" y="9144"/>
                </a:lnTo>
                <a:close/>
              </a:path>
              <a:path w="56515" h="58420">
                <a:moveTo>
                  <a:pt x="30479" y="13716"/>
                </a:moveTo>
                <a:lnTo>
                  <a:pt x="30479" y="4572"/>
                </a:lnTo>
                <a:lnTo>
                  <a:pt x="28193" y="9144"/>
                </a:lnTo>
                <a:lnTo>
                  <a:pt x="30479" y="13716"/>
                </a:lnTo>
                <a:close/>
              </a:path>
              <a:path w="56515" h="58420">
                <a:moveTo>
                  <a:pt x="54863" y="51816"/>
                </a:moveTo>
                <a:lnTo>
                  <a:pt x="49529" y="51816"/>
                </a:lnTo>
                <a:lnTo>
                  <a:pt x="51815" y="56388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5" name="object 195"/>
          <p:cNvSpPr/>
          <p:nvPr/>
        </p:nvSpPr>
        <p:spPr>
          <a:xfrm>
            <a:off x="5178437" y="2877311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6" name="object 196"/>
          <p:cNvSpPr txBox="1"/>
          <p:nvPr/>
        </p:nvSpPr>
        <p:spPr>
          <a:xfrm>
            <a:off x="5854575" y="4470649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97" name="object 197"/>
          <p:cNvSpPr txBox="1"/>
          <p:nvPr/>
        </p:nvSpPr>
        <p:spPr>
          <a:xfrm>
            <a:off x="8180203" y="3395172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8" name="object 198"/>
          <p:cNvSpPr txBox="1"/>
          <p:nvPr/>
        </p:nvSpPr>
        <p:spPr>
          <a:xfrm>
            <a:off x="8180203" y="3695446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9" name="object 199"/>
          <p:cNvSpPr txBox="1"/>
          <p:nvPr/>
        </p:nvSpPr>
        <p:spPr>
          <a:xfrm>
            <a:off x="8180203" y="3989578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0" name="object 200"/>
          <p:cNvSpPr txBox="1"/>
          <p:nvPr/>
        </p:nvSpPr>
        <p:spPr>
          <a:xfrm>
            <a:off x="8085714" y="2989364"/>
            <a:ext cx="433705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3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201" name="object 201"/>
          <p:cNvSpPr txBox="1"/>
          <p:nvPr/>
        </p:nvSpPr>
        <p:spPr>
          <a:xfrm>
            <a:off x="5270887" y="2939496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2" name="object 202"/>
          <p:cNvSpPr/>
          <p:nvPr/>
        </p:nvSpPr>
        <p:spPr>
          <a:xfrm>
            <a:off x="5861189" y="59253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3" name="object 203"/>
          <p:cNvSpPr/>
          <p:nvPr/>
        </p:nvSpPr>
        <p:spPr>
          <a:xfrm>
            <a:off x="6242189" y="5446776"/>
            <a:ext cx="1584960" cy="0"/>
          </a:xfrm>
          <a:custGeom>
            <a:avLst/>
            <a:gdLst/>
            <a:ahLst/>
            <a:cxnLst/>
            <a:rect l="l" t="t" r="r" b="b"/>
            <a:pathLst>
              <a:path w="1584959">
                <a:moveTo>
                  <a:pt x="0" y="0"/>
                </a:moveTo>
                <a:lnTo>
                  <a:pt x="1584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4" name="object 204"/>
          <p:cNvSpPr/>
          <p:nvPr/>
        </p:nvSpPr>
        <p:spPr>
          <a:xfrm>
            <a:off x="5861189" y="5446776"/>
            <a:ext cx="320040" cy="0"/>
          </a:xfrm>
          <a:custGeom>
            <a:avLst/>
            <a:gdLst/>
            <a:ahLst/>
            <a:cxnLst/>
            <a:rect l="l" t="t" r="r" b="b"/>
            <a:pathLst>
              <a:path w="320039">
                <a:moveTo>
                  <a:pt x="0" y="0"/>
                </a:moveTo>
                <a:lnTo>
                  <a:pt x="32003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5" name="object 205"/>
          <p:cNvSpPr/>
          <p:nvPr/>
        </p:nvSpPr>
        <p:spPr>
          <a:xfrm>
            <a:off x="5861189" y="4968240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6" name="object 206"/>
          <p:cNvSpPr/>
          <p:nvPr/>
        </p:nvSpPr>
        <p:spPr>
          <a:xfrm>
            <a:off x="5888621" y="4968240"/>
            <a:ext cx="0" cy="1466215"/>
          </a:xfrm>
          <a:custGeom>
            <a:avLst/>
            <a:gdLst/>
            <a:ahLst/>
            <a:cxnLst/>
            <a:rect l="l" t="t" r="r" b="b"/>
            <a:pathLst>
              <a:path h="1466214">
                <a:moveTo>
                  <a:pt x="0" y="0"/>
                </a:moveTo>
                <a:lnTo>
                  <a:pt x="0" y="1466087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7" name="object 207"/>
          <p:cNvSpPr/>
          <p:nvPr/>
        </p:nvSpPr>
        <p:spPr>
          <a:xfrm>
            <a:off x="5861189" y="640384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8" name="object 208"/>
          <p:cNvSpPr/>
          <p:nvPr/>
        </p:nvSpPr>
        <p:spPr>
          <a:xfrm>
            <a:off x="6047117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9" name="object 209"/>
          <p:cNvSpPr/>
          <p:nvPr/>
        </p:nvSpPr>
        <p:spPr>
          <a:xfrm>
            <a:off x="6208662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0" name="object 210"/>
          <p:cNvSpPr/>
          <p:nvPr/>
        </p:nvSpPr>
        <p:spPr>
          <a:xfrm>
            <a:off x="6370193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1" name="object 211"/>
          <p:cNvSpPr/>
          <p:nvPr/>
        </p:nvSpPr>
        <p:spPr>
          <a:xfrm>
            <a:off x="6531749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2" name="object 212"/>
          <p:cNvSpPr/>
          <p:nvPr/>
        </p:nvSpPr>
        <p:spPr>
          <a:xfrm>
            <a:off x="6693281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3" name="object 213"/>
          <p:cNvSpPr/>
          <p:nvPr/>
        </p:nvSpPr>
        <p:spPr>
          <a:xfrm>
            <a:off x="6854825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4" name="object 214"/>
          <p:cNvSpPr/>
          <p:nvPr/>
        </p:nvSpPr>
        <p:spPr>
          <a:xfrm>
            <a:off x="7016381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5" name="object 215"/>
          <p:cNvSpPr/>
          <p:nvPr/>
        </p:nvSpPr>
        <p:spPr>
          <a:xfrm>
            <a:off x="7177925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6" name="object 216"/>
          <p:cNvSpPr/>
          <p:nvPr/>
        </p:nvSpPr>
        <p:spPr>
          <a:xfrm>
            <a:off x="7339469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7" name="object 217"/>
          <p:cNvSpPr/>
          <p:nvPr/>
        </p:nvSpPr>
        <p:spPr>
          <a:xfrm>
            <a:off x="7501001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8" name="object 218"/>
          <p:cNvSpPr/>
          <p:nvPr/>
        </p:nvSpPr>
        <p:spPr>
          <a:xfrm>
            <a:off x="7662557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9" name="object 219"/>
          <p:cNvSpPr/>
          <p:nvPr/>
        </p:nvSpPr>
        <p:spPr>
          <a:xfrm>
            <a:off x="7824101" y="6403847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20" name="object 220"/>
          <p:cNvSpPr/>
          <p:nvPr/>
        </p:nvSpPr>
        <p:spPr>
          <a:xfrm>
            <a:off x="5920625" y="4968240"/>
            <a:ext cx="1912620" cy="696595"/>
          </a:xfrm>
          <a:custGeom>
            <a:avLst/>
            <a:gdLst/>
            <a:ahLst/>
            <a:cxnLst/>
            <a:rect l="l" t="t" r="r" b="b"/>
            <a:pathLst>
              <a:path w="1912620" h="696595">
                <a:moveTo>
                  <a:pt x="81361" y="216162"/>
                </a:moveTo>
                <a:lnTo>
                  <a:pt x="44195" y="242315"/>
                </a:lnTo>
                <a:lnTo>
                  <a:pt x="41147" y="243839"/>
                </a:lnTo>
                <a:lnTo>
                  <a:pt x="39623" y="246887"/>
                </a:lnTo>
                <a:lnTo>
                  <a:pt x="39623" y="248411"/>
                </a:lnTo>
                <a:lnTo>
                  <a:pt x="0" y="620267"/>
                </a:lnTo>
                <a:lnTo>
                  <a:pt x="0" y="626363"/>
                </a:lnTo>
                <a:lnTo>
                  <a:pt x="3048" y="630935"/>
                </a:lnTo>
                <a:lnTo>
                  <a:pt x="13716" y="630935"/>
                </a:lnTo>
                <a:lnTo>
                  <a:pt x="18288" y="627887"/>
                </a:lnTo>
                <a:lnTo>
                  <a:pt x="18288" y="623315"/>
                </a:lnTo>
                <a:lnTo>
                  <a:pt x="53339" y="294366"/>
                </a:lnTo>
                <a:lnTo>
                  <a:pt x="53339" y="257555"/>
                </a:lnTo>
                <a:lnTo>
                  <a:pt x="57911" y="251459"/>
                </a:lnTo>
                <a:lnTo>
                  <a:pt x="57911" y="254338"/>
                </a:lnTo>
                <a:lnTo>
                  <a:pt x="80771" y="238251"/>
                </a:lnTo>
                <a:lnTo>
                  <a:pt x="80771" y="217931"/>
                </a:lnTo>
                <a:lnTo>
                  <a:pt x="81361" y="216162"/>
                </a:lnTo>
                <a:close/>
              </a:path>
              <a:path w="1912620" h="696595">
                <a:moveTo>
                  <a:pt x="57911" y="251459"/>
                </a:moveTo>
                <a:lnTo>
                  <a:pt x="53339" y="257555"/>
                </a:lnTo>
                <a:lnTo>
                  <a:pt x="57580" y="254571"/>
                </a:lnTo>
                <a:lnTo>
                  <a:pt x="57911" y="251459"/>
                </a:lnTo>
                <a:close/>
              </a:path>
              <a:path w="1912620" h="696595">
                <a:moveTo>
                  <a:pt x="57580" y="254571"/>
                </a:moveTo>
                <a:lnTo>
                  <a:pt x="53339" y="257555"/>
                </a:lnTo>
                <a:lnTo>
                  <a:pt x="53339" y="294366"/>
                </a:lnTo>
                <a:lnTo>
                  <a:pt x="57580" y="254571"/>
                </a:lnTo>
                <a:close/>
              </a:path>
              <a:path w="1912620" h="696595">
                <a:moveTo>
                  <a:pt x="57911" y="254338"/>
                </a:moveTo>
                <a:lnTo>
                  <a:pt x="57911" y="251459"/>
                </a:lnTo>
                <a:lnTo>
                  <a:pt x="57580" y="254571"/>
                </a:lnTo>
                <a:lnTo>
                  <a:pt x="57911" y="254338"/>
                </a:lnTo>
                <a:close/>
              </a:path>
              <a:path w="1912620" h="696595">
                <a:moveTo>
                  <a:pt x="85343" y="213359"/>
                </a:moveTo>
                <a:lnTo>
                  <a:pt x="81361" y="216162"/>
                </a:lnTo>
                <a:lnTo>
                  <a:pt x="80771" y="217931"/>
                </a:lnTo>
                <a:lnTo>
                  <a:pt x="85343" y="213359"/>
                </a:lnTo>
                <a:close/>
              </a:path>
              <a:path w="1912620" h="696595">
                <a:moveTo>
                  <a:pt x="85343" y="235034"/>
                </a:moveTo>
                <a:lnTo>
                  <a:pt x="85343" y="213359"/>
                </a:lnTo>
                <a:lnTo>
                  <a:pt x="80771" y="217931"/>
                </a:lnTo>
                <a:lnTo>
                  <a:pt x="80771" y="238251"/>
                </a:lnTo>
                <a:lnTo>
                  <a:pt x="85343" y="235034"/>
                </a:lnTo>
                <a:close/>
              </a:path>
              <a:path w="1912620" h="696595">
                <a:moveTo>
                  <a:pt x="206903" y="73614"/>
                </a:moveTo>
                <a:lnTo>
                  <a:pt x="128015" y="92963"/>
                </a:lnTo>
                <a:lnTo>
                  <a:pt x="121919" y="96011"/>
                </a:lnTo>
                <a:lnTo>
                  <a:pt x="120395" y="99059"/>
                </a:lnTo>
                <a:lnTo>
                  <a:pt x="81361" y="216162"/>
                </a:lnTo>
                <a:lnTo>
                  <a:pt x="85343" y="213359"/>
                </a:lnTo>
                <a:lnTo>
                  <a:pt x="85343" y="235034"/>
                </a:lnTo>
                <a:lnTo>
                  <a:pt x="94487" y="228599"/>
                </a:lnTo>
                <a:lnTo>
                  <a:pt x="99059" y="224027"/>
                </a:lnTo>
                <a:lnTo>
                  <a:pt x="131063" y="128015"/>
                </a:lnTo>
                <a:lnTo>
                  <a:pt x="131063" y="111251"/>
                </a:lnTo>
                <a:lnTo>
                  <a:pt x="138683" y="105155"/>
                </a:lnTo>
                <a:lnTo>
                  <a:pt x="138684" y="109382"/>
                </a:lnTo>
                <a:lnTo>
                  <a:pt x="204215" y="93308"/>
                </a:lnTo>
                <a:lnTo>
                  <a:pt x="204215" y="76199"/>
                </a:lnTo>
                <a:lnTo>
                  <a:pt x="206903" y="73614"/>
                </a:lnTo>
                <a:close/>
              </a:path>
              <a:path w="1912620" h="696595">
                <a:moveTo>
                  <a:pt x="138683" y="105155"/>
                </a:moveTo>
                <a:lnTo>
                  <a:pt x="131063" y="111251"/>
                </a:lnTo>
                <a:lnTo>
                  <a:pt x="137149" y="109759"/>
                </a:lnTo>
                <a:lnTo>
                  <a:pt x="138683" y="105155"/>
                </a:lnTo>
                <a:close/>
              </a:path>
              <a:path w="1912620" h="696595">
                <a:moveTo>
                  <a:pt x="137149" y="109759"/>
                </a:moveTo>
                <a:lnTo>
                  <a:pt x="131063" y="111251"/>
                </a:lnTo>
                <a:lnTo>
                  <a:pt x="131063" y="128015"/>
                </a:lnTo>
                <a:lnTo>
                  <a:pt x="137149" y="109759"/>
                </a:lnTo>
                <a:close/>
              </a:path>
              <a:path w="1912620" h="696595">
                <a:moveTo>
                  <a:pt x="138684" y="109382"/>
                </a:moveTo>
                <a:lnTo>
                  <a:pt x="138683" y="105155"/>
                </a:lnTo>
                <a:lnTo>
                  <a:pt x="137149" y="109759"/>
                </a:lnTo>
                <a:lnTo>
                  <a:pt x="138684" y="109382"/>
                </a:lnTo>
                <a:close/>
              </a:path>
              <a:path w="1912620" h="696595">
                <a:moveTo>
                  <a:pt x="208787" y="73151"/>
                </a:moveTo>
                <a:lnTo>
                  <a:pt x="206903" y="73614"/>
                </a:lnTo>
                <a:lnTo>
                  <a:pt x="204215" y="76199"/>
                </a:lnTo>
                <a:lnTo>
                  <a:pt x="208787" y="73151"/>
                </a:lnTo>
                <a:close/>
              </a:path>
              <a:path w="1912620" h="696595">
                <a:moveTo>
                  <a:pt x="208787" y="92187"/>
                </a:moveTo>
                <a:lnTo>
                  <a:pt x="208787" y="73151"/>
                </a:lnTo>
                <a:lnTo>
                  <a:pt x="204215" y="76199"/>
                </a:lnTo>
                <a:lnTo>
                  <a:pt x="204215" y="93308"/>
                </a:lnTo>
                <a:lnTo>
                  <a:pt x="208787" y="92187"/>
                </a:lnTo>
                <a:close/>
              </a:path>
              <a:path w="1912620" h="696595">
                <a:moveTo>
                  <a:pt x="377129" y="133175"/>
                </a:moveTo>
                <a:lnTo>
                  <a:pt x="298704" y="0"/>
                </a:lnTo>
                <a:lnTo>
                  <a:pt x="283404" y="0"/>
                </a:lnTo>
                <a:lnTo>
                  <a:pt x="206903" y="73614"/>
                </a:lnTo>
                <a:lnTo>
                  <a:pt x="208787" y="73151"/>
                </a:lnTo>
                <a:lnTo>
                  <a:pt x="208787" y="92187"/>
                </a:lnTo>
                <a:lnTo>
                  <a:pt x="211835" y="91439"/>
                </a:lnTo>
                <a:lnTo>
                  <a:pt x="213359" y="91439"/>
                </a:lnTo>
                <a:lnTo>
                  <a:pt x="216407" y="88391"/>
                </a:lnTo>
                <a:lnTo>
                  <a:pt x="283463" y="23866"/>
                </a:lnTo>
                <a:lnTo>
                  <a:pt x="283463" y="9143"/>
                </a:lnTo>
                <a:lnTo>
                  <a:pt x="297179" y="10667"/>
                </a:lnTo>
                <a:lnTo>
                  <a:pt x="297179" y="32435"/>
                </a:lnTo>
                <a:lnTo>
                  <a:pt x="364235" y="146303"/>
                </a:lnTo>
                <a:lnTo>
                  <a:pt x="368807" y="150875"/>
                </a:lnTo>
                <a:lnTo>
                  <a:pt x="374903" y="152486"/>
                </a:lnTo>
                <a:lnTo>
                  <a:pt x="374903" y="132587"/>
                </a:lnTo>
                <a:lnTo>
                  <a:pt x="377129" y="133175"/>
                </a:lnTo>
                <a:close/>
              </a:path>
              <a:path w="1912620" h="696595">
                <a:moveTo>
                  <a:pt x="297179" y="10667"/>
                </a:moveTo>
                <a:lnTo>
                  <a:pt x="283463" y="9143"/>
                </a:lnTo>
                <a:lnTo>
                  <a:pt x="288997" y="18541"/>
                </a:lnTo>
                <a:lnTo>
                  <a:pt x="297179" y="10667"/>
                </a:lnTo>
                <a:close/>
              </a:path>
              <a:path w="1912620" h="696595">
                <a:moveTo>
                  <a:pt x="288997" y="18541"/>
                </a:moveTo>
                <a:lnTo>
                  <a:pt x="283463" y="9143"/>
                </a:lnTo>
                <a:lnTo>
                  <a:pt x="283463" y="23866"/>
                </a:lnTo>
                <a:lnTo>
                  <a:pt x="288997" y="18541"/>
                </a:lnTo>
                <a:close/>
              </a:path>
              <a:path w="1912620" h="696595">
                <a:moveTo>
                  <a:pt x="297179" y="32435"/>
                </a:moveTo>
                <a:lnTo>
                  <a:pt x="297179" y="10667"/>
                </a:lnTo>
                <a:lnTo>
                  <a:pt x="288997" y="18541"/>
                </a:lnTo>
                <a:lnTo>
                  <a:pt x="297179" y="32435"/>
                </a:lnTo>
                <a:close/>
              </a:path>
              <a:path w="1912620" h="696595">
                <a:moveTo>
                  <a:pt x="379475" y="137159"/>
                </a:moveTo>
                <a:lnTo>
                  <a:pt x="377129" y="133175"/>
                </a:lnTo>
                <a:lnTo>
                  <a:pt x="374903" y="132587"/>
                </a:lnTo>
                <a:lnTo>
                  <a:pt x="379475" y="137159"/>
                </a:lnTo>
                <a:close/>
              </a:path>
              <a:path w="1912620" h="696595">
                <a:moveTo>
                  <a:pt x="379475" y="153693"/>
                </a:moveTo>
                <a:lnTo>
                  <a:pt x="379475" y="137159"/>
                </a:lnTo>
                <a:lnTo>
                  <a:pt x="374903" y="132587"/>
                </a:lnTo>
                <a:lnTo>
                  <a:pt x="374903" y="152486"/>
                </a:lnTo>
                <a:lnTo>
                  <a:pt x="379475" y="153693"/>
                </a:lnTo>
                <a:close/>
              </a:path>
              <a:path w="1912620" h="696595">
                <a:moveTo>
                  <a:pt x="941832" y="409495"/>
                </a:moveTo>
                <a:lnTo>
                  <a:pt x="941832" y="390143"/>
                </a:lnTo>
                <a:lnTo>
                  <a:pt x="617220" y="216407"/>
                </a:lnTo>
                <a:lnTo>
                  <a:pt x="455676" y="153923"/>
                </a:lnTo>
                <a:lnTo>
                  <a:pt x="377129" y="133175"/>
                </a:lnTo>
                <a:lnTo>
                  <a:pt x="379475" y="137159"/>
                </a:lnTo>
                <a:lnTo>
                  <a:pt x="379475" y="153693"/>
                </a:lnTo>
                <a:lnTo>
                  <a:pt x="449580" y="172211"/>
                </a:lnTo>
                <a:lnTo>
                  <a:pt x="611124" y="234695"/>
                </a:lnTo>
                <a:lnTo>
                  <a:pt x="932688" y="405383"/>
                </a:lnTo>
                <a:lnTo>
                  <a:pt x="934212" y="406907"/>
                </a:lnTo>
                <a:lnTo>
                  <a:pt x="941832" y="409495"/>
                </a:lnTo>
                <a:close/>
              </a:path>
              <a:path w="1912620" h="696595">
                <a:moveTo>
                  <a:pt x="1912619" y="694181"/>
                </a:moveTo>
                <a:lnTo>
                  <a:pt x="1912619" y="677671"/>
                </a:lnTo>
                <a:lnTo>
                  <a:pt x="1909572" y="676655"/>
                </a:lnTo>
                <a:lnTo>
                  <a:pt x="1584960" y="571499"/>
                </a:lnTo>
                <a:lnTo>
                  <a:pt x="1263396" y="498347"/>
                </a:lnTo>
                <a:lnTo>
                  <a:pt x="940308" y="388619"/>
                </a:lnTo>
                <a:lnTo>
                  <a:pt x="941832" y="390143"/>
                </a:lnTo>
                <a:lnTo>
                  <a:pt x="941832" y="409495"/>
                </a:lnTo>
                <a:lnTo>
                  <a:pt x="1257300" y="516635"/>
                </a:lnTo>
                <a:lnTo>
                  <a:pt x="1581912" y="589787"/>
                </a:lnTo>
                <a:lnTo>
                  <a:pt x="1903476" y="694943"/>
                </a:lnTo>
                <a:lnTo>
                  <a:pt x="1908048" y="696467"/>
                </a:lnTo>
                <a:lnTo>
                  <a:pt x="1912619" y="694181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21" name="object 221"/>
          <p:cNvSpPr/>
          <p:nvPr/>
        </p:nvSpPr>
        <p:spPr>
          <a:xfrm>
            <a:off x="5889891" y="4931409"/>
            <a:ext cx="1978647" cy="1077975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22" name="object 222"/>
          <p:cNvSpPr/>
          <p:nvPr/>
        </p:nvSpPr>
        <p:spPr>
          <a:xfrm>
            <a:off x="6505829" y="5164835"/>
            <a:ext cx="60960" cy="60960"/>
          </a:xfrm>
          <a:custGeom>
            <a:avLst/>
            <a:gdLst/>
            <a:ahLst/>
            <a:cxnLst/>
            <a:rect l="l" t="t" r="r" b="b"/>
            <a:pathLst>
              <a:path w="60959" h="60960">
                <a:moveTo>
                  <a:pt x="60959" y="28956"/>
                </a:moveTo>
                <a:lnTo>
                  <a:pt x="28955" y="0"/>
                </a:lnTo>
                <a:lnTo>
                  <a:pt x="0" y="28956"/>
                </a:lnTo>
                <a:lnTo>
                  <a:pt x="28955" y="60960"/>
                </a:lnTo>
                <a:lnTo>
                  <a:pt x="60959" y="28956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23" name="object 223"/>
          <p:cNvSpPr/>
          <p:nvPr/>
        </p:nvSpPr>
        <p:spPr>
          <a:xfrm>
            <a:off x="6501257" y="5160264"/>
            <a:ext cx="68580" cy="68580"/>
          </a:xfrm>
          <a:custGeom>
            <a:avLst/>
            <a:gdLst/>
            <a:ahLst/>
            <a:cxnLst/>
            <a:rect l="l" t="t" r="r" b="b"/>
            <a:pathLst>
              <a:path w="68579" h="68579">
                <a:moveTo>
                  <a:pt x="68579" y="35052"/>
                </a:moveTo>
                <a:lnTo>
                  <a:pt x="68579" y="33528"/>
                </a:lnTo>
                <a:lnTo>
                  <a:pt x="35051" y="0"/>
                </a:lnTo>
                <a:lnTo>
                  <a:pt x="33527" y="0"/>
                </a:lnTo>
                <a:lnTo>
                  <a:pt x="0" y="33528"/>
                </a:lnTo>
                <a:lnTo>
                  <a:pt x="0" y="35052"/>
                </a:lnTo>
                <a:lnTo>
                  <a:pt x="6095" y="41148"/>
                </a:lnTo>
                <a:lnTo>
                  <a:pt x="6095" y="32004"/>
                </a:lnTo>
                <a:lnTo>
                  <a:pt x="8381" y="34290"/>
                </a:lnTo>
                <a:lnTo>
                  <a:pt x="32003" y="10668"/>
                </a:lnTo>
                <a:lnTo>
                  <a:pt x="32003" y="6096"/>
                </a:lnTo>
                <a:lnTo>
                  <a:pt x="36575" y="6096"/>
                </a:lnTo>
                <a:lnTo>
                  <a:pt x="36575" y="10668"/>
                </a:lnTo>
                <a:lnTo>
                  <a:pt x="60197" y="34290"/>
                </a:lnTo>
                <a:lnTo>
                  <a:pt x="62483" y="32004"/>
                </a:lnTo>
                <a:lnTo>
                  <a:pt x="62483" y="41148"/>
                </a:lnTo>
                <a:lnTo>
                  <a:pt x="68579" y="35052"/>
                </a:lnTo>
                <a:close/>
              </a:path>
              <a:path w="68579" h="68579">
                <a:moveTo>
                  <a:pt x="8381" y="34290"/>
                </a:moveTo>
                <a:lnTo>
                  <a:pt x="6095" y="32004"/>
                </a:lnTo>
                <a:lnTo>
                  <a:pt x="6095" y="36576"/>
                </a:lnTo>
                <a:lnTo>
                  <a:pt x="8381" y="34290"/>
                </a:lnTo>
                <a:close/>
              </a:path>
              <a:path w="68579" h="68579">
                <a:moveTo>
                  <a:pt x="34289" y="60198"/>
                </a:moveTo>
                <a:lnTo>
                  <a:pt x="8381" y="34290"/>
                </a:lnTo>
                <a:lnTo>
                  <a:pt x="6095" y="36576"/>
                </a:lnTo>
                <a:lnTo>
                  <a:pt x="6095" y="41148"/>
                </a:lnTo>
                <a:lnTo>
                  <a:pt x="32003" y="67056"/>
                </a:lnTo>
                <a:lnTo>
                  <a:pt x="32003" y="62484"/>
                </a:lnTo>
                <a:lnTo>
                  <a:pt x="34289" y="60198"/>
                </a:lnTo>
                <a:close/>
              </a:path>
              <a:path w="68579" h="68579">
                <a:moveTo>
                  <a:pt x="36575" y="6096"/>
                </a:moveTo>
                <a:lnTo>
                  <a:pt x="32003" y="6096"/>
                </a:lnTo>
                <a:lnTo>
                  <a:pt x="34289" y="8382"/>
                </a:lnTo>
                <a:lnTo>
                  <a:pt x="36575" y="6096"/>
                </a:lnTo>
                <a:close/>
              </a:path>
              <a:path w="68579" h="68579">
                <a:moveTo>
                  <a:pt x="34289" y="8382"/>
                </a:moveTo>
                <a:lnTo>
                  <a:pt x="32003" y="6096"/>
                </a:lnTo>
                <a:lnTo>
                  <a:pt x="32003" y="10668"/>
                </a:lnTo>
                <a:lnTo>
                  <a:pt x="34289" y="8382"/>
                </a:lnTo>
                <a:close/>
              </a:path>
              <a:path w="68579" h="68579">
                <a:moveTo>
                  <a:pt x="36575" y="62484"/>
                </a:moveTo>
                <a:lnTo>
                  <a:pt x="34289" y="60198"/>
                </a:lnTo>
                <a:lnTo>
                  <a:pt x="32003" y="62484"/>
                </a:lnTo>
                <a:lnTo>
                  <a:pt x="36575" y="62484"/>
                </a:lnTo>
                <a:close/>
              </a:path>
              <a:path w="68579" h="68579">
                <a:moveTo>
                  <a:pt x="36575" y="67056"/>
                </a:moveTo>
                <a:lnTo>
                  <a:pt x="36575" y="62484"/>
                </a:lnTo>
                <a:lnTo>
                  <a:pt x="32003" y="62484"/>
                </a:lnTo>
                <a:lnTo>
                  <a:pt x="32003" y="68580"/>
                </a:lnTo>
                <a:lnTo>
                  <a:pt x="35051" y="68580"/>
                </a:lnTo>
                <a:lnTo>
                  <a:pt x="36575" y="67056"/>
                </a:lnTo>
                <a:close/>
              </a:path>
              <a:path w="68579" h="68579">
                <a:moveTo>
                  <a:pt x="36575" y="10668"/>
                </a:moveTo>
                <a:lnTo>
                  <a:pt x="36575" y="6096"/>
                </a:lnTo>
                <a:lnTo>
                  <a:pt x="34289" y="8382"/>
                </a:lnTo>
                <a:lnTo>
                  <a:pt x="36575" y="10668"/>
                </a:lnTo>
                <a:close/>
              </a:path>
              <a:path w="68579" h="68579">
                <a:moveTo>
                  <a:pt x="62483" y="41148"/>
                </a:moveTo>
                <a:lnTo>
                  <a:pt x="62483" y="36576"/>
                </a:lnTo>
                <a:lnTo>
                  <a:pt x="60197" y="34290"/>
                </a:lnTo>
                <a:lnTo>
                  <a:pt x="34289" y="60198"/>
                </a:lnTo>
                <a:lnTo>
                  <a:pt x="36575" y="62484"/>
                </a:lnTo>
                <a:lnTo>
                  <a:pt x="36575" y="67056"/>
                </a:lnTo>
                <a:lnTo>
                  <a:pt x="62483" y="41148"/>
                </a:lnTo>
                <a:close/>
              </a:path>
              <a:path w="68579" h="68579">
                <a:moveTo>
                  <a:pt x="62483" y="36576"/>
                </a:moveTo>
                <a:lnTo>
                  <a:pt x="62483" y="32004"/>
                </a:lnTo>
                <a:lnTo>
                  <a:pt x="60197" y="34290"/>
                </a:lnTo>
                <a:lnTo>
                  <a:pt x="62483" y="36576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24" name="object 224"/>
          <p:cNvSpPr txBox="1"/>
          <p:nvPr/>
        </p:nvSpPr>
        <p:spPr>
          <a:xfrm>
            <a:off x="5752471" y="6345682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25" name="object 225"/>
          <p:cNvSpPr txBox="1"/>
          <p:nvPr/>
        </p:nvSpPr>
        <p:spPr>
          <a:xfrm>
            <a:off x="5708272" y="5867143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26" name="object 226"/>
          <p:cNvSpPr txBox="1"/>
          <p:nvPr/>
        </p:nvSpPr>
        <p:spPr>
          <a:xfrm>
            <a:off x="5665603" y="5388605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27" name="object 227"/>
          <p:cNvSpPr txBox="1"/>
          <p:nvPr/>
        </p:nvSpPr>
        <p:spPr>
          <a:xfrm>
            <a:off x="5621404" y="4910066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28" name="object 228"/>
          <p:cNvSpPr/>
          <p:nvPr/>
        </p:nvSpPr>
        <p:spPr>
          <a:xfrm>
            <a:off x="7999361" y="543305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29" name="object 229"/>
          <p:cNvSpPr/>
          <p:nvPr/>
        </p:nvSpPr>
        <p:spPr>
          <a:xfrm>
            <a:off x="8066405" y="5407152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0" name="object 230"/>
          <p:cNvSpPr/>
          <p:nvPr/>
        </p:nvSpPr>
        <p:spPr>
          <a:xfrm>
            <a:off x="8063369" y="5405628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5" h="56514">
                <a:moveTo>
                  <a:pt x="56387" y="30480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30480"/>
                </a:lnTo>
                <a:lnTo>
                  <a:pt x="4571" y="35052"/>
                </a:lnTo>
                <a:lnTo>
                  <a:pt x="4571" y="25908"/>
                </a:lnTo>
                <a:lnTo>
                  <a:pt x="6857" y="28193"/>
                </a:lnTo>
                <a:lnTo>
                  <a:pt x="25907" y="9143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9144"/>
                </a:lnTo>
                <a:lnTo>
                  <a:pt x="49529" y="28194"/>
                </a:lnTo>
                <a:lnTo>
                  <a:pt x="51815" y="25908"/>
                </a:lnTo>
                <a:lnTo>
                  <a:pt x="51815" y="35052"/>
                </a:lnTo>
                <a:lnTo>
                  <a:pt x="56387" y="30480"/>
                </a:lnTo>
                <a:close/>
              </a:path>
              <a:path w="56515" h="56514">
                <a:moveTo>
                  <a:pt x="6857" y="28194"/>
                </a:moveTo>
                <a:lnTo>
                  <a:pt x="4571" y="25908"/>
                </a:lnTo>
                <a:lnTo>
                  <a:pt x="4571" y="30480"/>
                </a:lnTo>
                <a:lnTo>
                  <a:pt x="6857" y="28194"/>
                </a:lnTo>
                <a:close/>
              </a:path>
              <a:path w="56515" h="56514">
                <a:moveTo>
                  <a:pt x="28193" y="49530"/>
                </a:moveTo>
                <a:lnTo>
                  <a:pt x="6857" y="28194"/>
                </a:lnTo>
                <a:lnTo>
                  <a:pt x="4571" y="30480"/>
                </a:lnTo>
                <a:lnTo>
                  <a:pt x="4571" y="35052"/>
                </a:lnTo>
                <a:lnTo>
                  <a:pt x="25907" y="56388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6514">
                <a:moveTo>
                  <a:pt x="30479" y="4572"/>
                </a:moveTo>
                <a:lnTo>
                  <a:pt x="25907" y="4572"/>
                </a:lnTo>
                <a:lnTo>
                  <a:pt x="28193" y="6857"/>
                </a:lnTo>
                <a:lnTo>
                  <a:pt x="30479" y="4572"/>
                </a:lnTo>
                <a:close/>
              </a:path>
              <a:path w="56515" h="56514">
                <a:moveTo>
                  <a:pt x="28193" y="6858"/>
                </a:moveTo>
                <a:lnTo>
                  <a:pt x="25907" y="4572"/>
                </a:lnTo>
                <a:lnTo>
                  <a:pt x="25907" y="9143"/>
                </a:lnTo>
                <a:lnTo>
                  <a:pt x="28193" y="6858"/>
                </a:lnTo>
                <a:close/>
              </a:path>
              <a:path w="56515" h="56514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6514">
                <a:moveTo>
                  <a:pt x="30479" y="56388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6388"/>
                </a:lnTo>
                <a:lnTo>
                  <a:pt x="30479" y="56388"/>
                </a:lnTo>
                <a:close/>
              </a:path>
              <a:path w="56515" h="56514">
                <a:moveTo>
                  <a:pt x="30479" y="9144"/>
                </a:moveTo>
                <a:lnTo>
                  <a:pt x="30479" y="4572"/>
                </a:lnTo>
                <a:lnTo>
                  <a:pt x="28193" y="6858"/>
                </a:lnTo>
                <a:lnTo>
                  <a:pt x="30479" y="9144"/>
                </a:lnTo>
                <a:close/>
              </a:path>
              <a:path w="56515" h="56514">
                <a:moveTo>
                  <a:pt x="51815" y="35052"/>
                </a:moveTo>
                <a:lnTo>
                  <a:pt x="51815" y="30480"/>
                </a:lnTo>
                <a:lnTo>
                  <a:pt x="49529" y="28193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6388"/>
                </a:lnTo>
                <a:lnTo>
                  <a:pt x="51815" y="35052"/>
                </a:lnTo>
                <a:close/>
              </a:path>
              <a:path w="56515" h="56514">
                <a:moveTo>
                  <a:pt x="51815" y="30480"/>
                </a:moveTo>
                <a:lnTo>
                  <a:pt x="51815" y="25908"/>
                </a:lnTo>
                <a:lnTo>
                  <a:pt x="49529" y="28193"/>
                </a:lnTo>
                <a:lnTo>
                  <a:pt x="51815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1" name="object 231"/>
          <p:cNvSpPr/>
          <p:nvPr/>
        </p:nvSpPr>
        <p:spPr>
          <a:xfrm>
            <a:off x="7999361" y="572871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2" name="object 232"/>
          <p:cNvSpPr/>
          <p:nvPr/>
        </p:nvSpPr>
        <p:spPr>
          <a:xfrm>
            <a:off x="8066417" y="5728715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3" name="object 233"/>
          <p:cNvSpPr/>
          <p:nvPr/>
        </p:nvSpPr>
        <p:spPr>
          <a:xfrm>
            <a:off x="8063369" y="5699759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4" name="object 234"/>
          <p:cNvSpPr/>
          <p:nvPr/>
        </p:nvSpPr>
        <p:spPr>
          <a:xfrm>
            <a:off x="7999361" y="6022847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5" name="object 235"/>
          <p:cNvSpPr/>
          <p:nvPr/>
        </p:nvSpPr>
        <p:spPr>
          <a:xfrm>
            <a:off x="8066405" y="5995415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6" name="object 236"/>
          <p:cNvSpPr/>
          <p:nvPr/>
        </p:nvSpPr>
        <p:spPr>
          <a:xfrm>
            <a:off x="8063369" y="5993891"/>
            <a:ext cx="56515" cy="58419"/>
          </a:xfrm>
          <a:custGeom>
            <a:avLst/>
            <a:gdLst/>
            <a:ahLst/>
            <a:cxnLst/>
            <a:rect l="l" t="t" r="r" b="b"/>
            <a:pathLst>
              <a:path w="56515" h="58420">
                <a:moveTo>
                  <a:pt x="56387" y="56388"/>
                </a:moveTo>
                <a:lnTo>
                  <a:pt x="56387" y="53340"/>
                </a:lnTo>
                <a:lnTo>
                  <a:pt x="30479" y="1524"/>
                </a:lnTo>
                <a:lnTo>
                  <a:pt x="28955" y="0"/>
                </a:lnTo>
                <a:lnTo>
                  <a:pt x="25907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6095" y="51816"/>
                </a:lnTo>
                <a:lnTo>
                  <a:pt x="25907" y="12192"/>
                </a:lnTo>
                <a:lnTo>
                  <a:pt x="25907" y="3048"/>
                </a:lnTo>
                <a:lnTo>
                  <a:pt x="30479" y="3048"/>
                </a:lnTo>
                <a:lnTo>
                  <a:pt x="30479" y="12192"/>
                </a:lnTo>
                <a:lnTo>
                  <a:pt x="50291" y="51816"/>
                </a:lnTo>
                <a:lnTo>
                  <a:pt x="54863" y="51816"/>
                </a:lnTo>
                <a:lnTo>
                  <a:pt x="54863" y="57912"/>
                </a:lnTo>
                <a:lnTo>
                  <a:pt x="56387" y="56388"/>
                </a:lnTo>
                <a:close/>
              </a:path>
              <a:path w="56515" h="58420">
                <a:moveTo>
                  <a:pt x="6095" y="51816"/>
                </a:moveTo>
                <a:lnTo>
                  <a:pt x="3047" y="51816"/>
                </a:lnTo>
                <a:lnTo>
                  <a:pt x="4571" y="54864"/>
                </a:lnTo>
                <a:lnTo>
                  <a:pt x="6095" y="51816"/>
                </a:lnTo>
                <a:close/>
              </a:path>
              <a:path w="56515" h="58420">
                <a:moveTo>
                  <a:pt x="54863" y="57912"/>
                </a:moveTo>
                <a:lnTo>
                  <a:pt x="54863" y="51816"/>
                </a:lnTo>
                <a:lnTo>
                  <a:pt x="51815" y="54864"/>
                </a:lnTo>
                <a:lnTo>
                  <a:pt x="50291" y="51816"/>
                </a:lnTo>
                <a:lnTo>
                  <a:pt x="6095" y="51816"/>
                </a:lnTo>
                <a:lnTo>
                  <a:pt x="4571" y="54864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close/>
              </a:path>
              <a:path w="56515" h="58420">
                <a:moveTo>
                  <a:pt x="30479" y="3048"/>
                </a:moveTo>
                <a:lnTo>
                  <a:pt x="25907" y="3048"/>
                </a:lnTo>
                <a:lnTo>
                  <a:pt x="28193" y="7620"/>
                </a:lnTo>
                <a:lnTo>
                  <a:pt x="30479" y="3048"/>
                </a:lnTo>
                <a:close/>
              </a:path>
              <a:path w="56515" h="58420">
                <a:moveTo>
                  <a:pt x="28193" y="7620"/>
                </a:moveTo>
                <a:lnTo>
                  <a:pt x="25907" y="3048"/>
                </a:lnTo>
                <a:lnTo>
                  <a:pt x="25907" y="12192"/>
                </a:lnTo>
                <a:lnTo>
                  <a:pt x="28193" y="7620"/>
                </a:lnTo>
                <a:close/>
              </a:path>
              <a:path w="56515" h="58420">
                <a:moveTo>
                  <a:pt x="30479" y="12192"/>
                </a:moveTo>
                <a:lnTo>
                  <a:pt x="30479" y="3048"/>
                </a:lnTo>
                <a:lnTo>
                  <a:pt x="28193" y="7620"/>
                </a:lnTo>
                <a:lnTo>
                  <a:pt x="30479" y="12192"/>
                </a:lnTo>
                <a:close/>
              </a:path>
              <a:path w="56515" h="58420">
                <a:moveTo>
                  <a:pt x="54863" y="51816"/>
                </a:moveTo>
                <a:lnTo>
                  <a:pt x="50291" y="51816"/>
                </a:lnTo>
                <a:lnTo>
                  <a:pt x="51815" y="54864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7" name="object 237"/>
          <p:cNvSpPr/>
          <p:nvPr/>
        </p:nvSpPr>
        <p:spPr>
          <a:xfrm>
            <a:off x="5178437" y="4852415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8" name="object 238"/>
          <p:cNvSpPr txBox="1"/>
          <p:nvPr/>
        </p:nvSpPr>
        <p:spPr>
          <a:xfrm>
            <a:off x="5854575" y="6445753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239" name="object 239"/>
          <p:cNvSpPr txBox="1"/>
          <p:nvPr/>
        </p:nvSpPr>
        <p:spPr>
          <a:xfrm>
            <a:off x="8180203" y="5370276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40" name="object 240"/>
          <p:cNvSpPr txBox="1"/>
          <p:nvPr/>
        </p:nvSpPr>
        <p:spPr>
          <a:xfrm>
            <a:off x="8180203" y="5670550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41" name="object 241"/>
          <p:cNvSpPr txBox="1"/>
          <p:nvPr/>
        </p:nvSpPr>
        <p:spPr>
          <a:xfrm>
            <a:off x="8180203" y="5964682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42" name="object 242"/>
          <p:cNvSpPr txBox="1"/>
          <p:nvPr/>
        </p:nvSpPr>
        <p:spPr>
          <a:xfrm>
            <a:off x="8085714" y="4964468"/>
            <a:ext cx="433705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4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243" name="object 243"/>
          <p:cNvSpPr txBox="1"/>
          <p:nvPr/>
        </p:nvSpPr>
        <p:spPr>
          <a:xfrm>
            <a:off x="5270887" y="4914600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44" name="TextBox 243"/>
          <p:cNvSpPr txBox="1"/>
          <p:nvPr/>
        </p:nvSpPr>
        <p:spPr>
          <a:xfrm>
            <a:off x="967625" y="428625"/>
            <a:ext cx="77953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information 1_ Individual plasma profiles per volunteer (linear and log/linear)</a:t>
            </a:r>
            <a:endParaRPr lang="en-US" sz="1200" dirty="0"/>
          </a:p>
          <a:p>
            <a:r>
              <a:rPr lang="en-US" sz="1200" dirty="0"/>
              <a:t> </a:t>
            </a:r>
            <a:r>
              <a:rPr lang="en-US" sz="1200" dirty="0" smtClean="0"/>
              <a:t>(</a:t>
            </a:r>
            <a:r>
              <a:rPr lang="en-US" sz="1200" dirty="0"/>
              <a:t>P indicates the volunteer number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731149" y="2199131"/>
            <a:ext cx="1935480" cy="0"/>
          </a:xfrm>
          <a:custGeom>
            <a:avLst/>
            <a:gdLst/>
            <a:ahLst/>
            <a:cxnLst/>
            <a:rect l="l" t="t" r="r" b="b"/>
            <a:pathLst>
              <a:path w="1935479">
                <a:moveTo>
                  <a:pt x="0" y="0"/>
                </a:moveTo>
                <a:lnTo>
                  <a:pt x="1935480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1731149" y="205587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1731149" y="1912620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1731149" y="176936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2435237" y="1626107"/>
            <a:ext cx="1262380" cy="0"/>
          </a:xfrm>
          <a:custGeom>
            <a:avLst/>
            <a:gdLst/>
            <a:ahLst/>
            <a:cxnLst/>
            <a:rect l="l" t="t" r="r" b="b"/>
            <a:pathLst>
              <a:path w="1262379">
                <a:moveTo>
                  <a:pt x="0" y="0"/>
                </a:moveTo>
                <a:lnTo>
                  <a:pt x="1261871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1869833" y="1626107"/>
            <a:ext cx="504825" cy="0"/>
          </a:xfrm>
          <a:custGeom>
            <a:avLst/>
            <a:gdLst/>
            <a:ahLst/>
            <a:cxnLst/>
            <a:rect l="l" t="t" r="r" b="b"/>
            <a:pathLst>
              <a:path w="504825">
                <a:moveTo>
                  <a:pt x="0" y="0"/>
                </a:moveTo>
                <a:lnTo>
                  <a:pt x="504443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1731149" y="1626107"/>
            <a:ext cx="78105" cy="0"/>
          </a:xfrm>
          <a:custGeom>
            <a:avLst/>
            <a:gdLst/>
            <a:ahLst/>
            <a:cxnLst/>
            <a:rect l="l" t="t" r="r" b="b"/>
            <a:pathLst>
              <a:path w="78105">
                <a:moveTo>
                  <a:pt x="0" y="0"/>
                </a:moveTo>
                <a:lnTo>
                  <a:pt x="77724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1731149" y="148132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2273693" y="1338071"/>
            <a:ext cx="1423670" cy="0"/>
          </a:xfrm>
          <a:custGeom>
            <a:avLst/>
            <a:gdLst/>
            <a:ahLst/>
            <a:cxnLst/>
            <a:rect l="l" t="t" r="r" b="b"/>
            <a:pathLst>
              <a:path w="1423670">
                <a:moveTo>
                  <a:pt x="0" y="0"/>
                </a:moveTo>
                <a:lnTo>
                  <a:pt x="1423415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1731149" y="1338071"/>
            <a:ext cx="481965" cy="0"/>
          </a:xfrm>
          <a:custGeom>
            <a:avLst/>
            <a:gdLst/>
            <a:ahLst/>
            <a:cxnLst/>
            <a:rect l="l" t="t" r="r" b="b"/>
            <a:pathLst>
              <a:path w="481964">
                <a:moveTo>
                  <a:pt x="0" y="0"/>
                </a:moveTo>
                <a:lnTo>
                  <a:pt x="481583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1731149" y="119481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1731149" y="1051560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1731149" y="908303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1758569" y="908303"/>
            <a:ext cx="0" cy="1403985"/>
          </a:xfrm>
          <a:custGeom>
            <a:avLst/>
            <a:gdLst/>
            <a:ahLst/>
            <a:cxnLst/>
            <a:rect l="l" t="t" r="r" b="b"/>
            <a:pathLst>
              <a:path h="1403985">
                <a:moveTo>
                  <a:pt x="0" y="0"/>
                </a:moveTo>
                <a:lnTo>
                  <a:pt x="0" y="1403603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1789061" y="2343911"/>
            <a:ext cx="1908175" cy="0"/>
          </a:xfrm>
          <a:custGeom>
            <a:avLst/>
            <a:gdLst/>
            <a:ahLst/>
            <a:cxnLst/>
            <a:rect l="l" t="t" r="r" b="b"/>
            <a:pathLst>
              <a:path w="1908175">
                <a:moveTo>
                  <a:pt x="0" y="0"/>
                </a:moveTo>
                <a:lnTo>
                  <a:pt x="1908047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1718703" y="946150"/>
            <a:ext cx="2019808" cy="1439545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" name="object 18"/>
          <p:cNvSpPr txBox="1"/>
          <p:nvPr/>
        </p:nvSpPr>
        <p:spPr>
          <a:xfrm>
            <a:off x="1535563" y="850148"/>
            <a:ext cx="156845" cy="15525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ctr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algn="ctr">
              <a:lnSpc>
                <a:spcPct val="100000"/>
              </a:lnSpc>
              <a:spcBef>
                <a:spcPts val="360"/>
              </a:spcBef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8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algn="ctr">
              <a:lnSpc>
                <a:spcPct val="100000"/>
              </a:lnSpc>
              <a:spcBef>
                <a:spcPts val="345"/>
              </a:spcBef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6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algn="ctr">
              <a:lnSpc>
                <a:spcPct val="100000"/>
              </a:lnSpc>
              <a:spcBef>
                <a:spcPts val="345"/>
              </a:spcBef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4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algn="ctr">
              <a:lnSpc>
                <a:spcPct val="100000"/>
              </a:lnSpc>
              <a:spcBef>
                <a:spcPts val="345"/>
              </a:spcBef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algn="ctr">
              <a:lnSpc>
                <a:spcPct val="100000"/>
              </a:lnSpc>
              <a:spcBef>
                <a:spcPts val="345"/>
              </a:spcBef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marL="55244">
              <a:lnSpc>
                <a:spcPct val="100000"/>
              </a:lnSpc>
              <a:spcBef>
                <a:spcPts val="345"/>
              </a:spcBef>
            </a:pPr>
            <a:r>
              <a:rPr sz="650" spc="15" dirty="0">
                <a:latin typeface="Calibri"/>
                <a:cs typeface="Calibri"/>
              </a:rPr>
              <a:t>80</a:t>
            </a:r>
            <a:endParaRPr sz="650">
              <a:latin typeface="Calibri"/>
              <a:cs typeface="Calibri"/>
            </a:endParaRPr>
          </a:p>
          <a:p>
            <a:pPr marL="55244">
              <a:lnSpc>
                <a:spcPct val="100000"/>
              </a:lnSpc>
              <a:spcBef>
                <a:spcPts val="360"/>
              </a:spcBef>
            </a:pPr>
            <a:r>
              <a:rPr sz="650" spc="15" dirty="0">
                <a:latin typeface="Calibri"/>
                <a:cs typeface="Calibri"/>
              </a:rPr>
              <a:t>60</a:t>
            </a:r>
            <a:endParaRPr sz="650">
              <a:latin typeface="Calibri"/>
              <a:cs typeface="Calibri"/>
            </a:endParaRPr>
          </a:p>
          <a:p>
            <a:pPr marL="55244">
              <a:lnSpc>
                <a:spcPct val="100000"/>
              </a:lnSpc>
              <a:spcBef>
                <a:spcPts val="345"/>
              </a:spcBef>
            </a:pPr>
            <a:r>
              <a:rPr sz="650" spc="15" dirty="0">
                <a:latin typeface="Calibri"/>
                <a:cs typeface="Calibri"/>
              </a:rPr>
              <a:t>40</a:t>
            </a:r>
            <a:endParaRPr sz="650">
              <a:latin typeface="Calibri"/>
              <a:cs typeface="Calibri"/>
            </a:endParaRPr>
          </a:p>
          <a:p>
            <a:pPr marL="55244">
              <a:lnSpc>
                <a:spcPct val="100000"/>
              </a:lnSpc>
              <a:spcBef>
                <a:spcPts val="345"/>
              </a:spcBef>
            </a:pPr>
            <a:r>
              <a:rPr sz="650" spc="15" dirty="0">
                <a:latin typeface="Calibri"/>
                <a:cs typeface="Calibri"/>
              </a:rPr>
              <a:t>20</a:t>
            </a:r>
            <a:endParaRPr sz="650">
              <a:latin typeface="Calibri"/>
              <a:cs typeface="Calibri"/>
            </a:endParaRPr>
          </a:p>
          <a:p>
            <a:pPr marL="86360" algn="ctr">
              <a:lnSpc>
                <a:spcPct val="100000"/>
              </a:lnSpc>
              <a:spcBef>
                <a:spcPts val="345"/>
              </a:spcBef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" name="object 19"/>
          <p:cNvSpPr/>
          <p:nvPr/>
        </p:nvSpPr>
        <p:spPr>
          <a:xfrm>
            <a:off x="3869321" y="1373124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" name="object 20"/>
          <p:cNvSpPr/>
          <p:nvPr/>
        </p:nvSpPr>
        <p:spPr>
          <a:xfrm>
            <a:off x="3936377" y="1347216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" name="object 21"/>
          <p:cNvSpPr/>
          <p:nvPr/>
        </p:nvSpPr>
        <p:spPr>
          <a:xfrm>
            <a:off x="3933329" y="1345691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4" h="56515">
                <a:moveTo>
                  <a:pt x="56388" y="30480"/>
                </a:moveTo>
                <a:lnTo>
                  <a:pt x="56388" y="25908"/>
                </a:lnTo>
                <a:lnTo>
                  <a:pt x="30480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30480"/>
                </a:lnTo>
                <a:lnTo>
                  <a:pt x="4572" y="35052"/>
                </a:lnTo>
                <a:lnTo>
                  <a:pt x="4572" y="25908"/>
                </a:lnTo>
                <a:lnTo>
                  <a:pt x="6858" y="28193"/>
                </a:lnTo>
                <a:lnTo>
                  <a:pt x="25908" y="9143"/>
                </a:lnTo>
                <a:lnTo>
                  <a:pt x="25908" y="4572"/>
                </a:lnTo>
                <a:lnTo>
                  <a:pt x="30480" y="4572"/>
                </a:lnTo>
                <a:lnTo>
                  <a:pt x="30480" y="9144"/>
                </a:lnTo>
                <a:lnTo>
                  <a:pt x="49530" y="28194"/>
                </a:lnTo>
                <a:lnTo>
                  <a:pt x="51816" y="25908"/>
                </a:lnTo>
                <a:lnTo>
                  <a:pt x="51816" y="35052"/>
                </a:lnTo>
                <a:lnTo>
                  <a:pt x="56388" y="30480"/>
                </a:lnTo>
                <a:close/>
              </a:path>
              <a:path w="56514" h="56515">
                <a:moveTo>
                  <a:pt x="6858" y="28194"/>
                </a:moveTo>
                <a:lnTo>
                  <a:pt x="4572" y="25908"/>
                </a:lnTo>
                <a:lnTo>
                  <a:pt x="4572" y="30480"/>
                </a:lnTo>
                <a:lnTo>
                  <a:pt x="6858" y="28194"/>
                </a:lnTo>
                <a:close/>
              </a:path>
              <a:path w="56514" h="56515">
                <a:moveTo>
                  <a:pt x="28194" y="49530"/>
                </a:moveTo>
                <a:lnTo>
                  <a:pt x="6858" y="28194"/>
                </a:lnTo>
                <a:lnTo>
                  <a:pt x="4572" y="30480"/>
                </a:lnTo>
                <a:lnTo>
                  <a:pt x="4572" y="35052"/>
                </a:lnTo>
                <a:lnTo>
                  <a:pt x="25908" y="56388"/>
                </a:lnTo>
                <a:lnTo>
                  <a:pt x="25908" y="51816"/>
                </a:lnTo>
                <a:lnTo>
                  <a:pt x="28194" y="49530"/>
                </a:lnTo>
                <a:close/>
              </a:path>
              <a:path w="56514" h="56515">
                <a:moveTo>
                  <a:pt x="30480" y="4572"/>
                </a:moveTo>
                <a:lnTo>
                  <a:pt x="25908" y="4572"/>
                </a:lnTo>
                <a:lnTo>
                  <a:pt x="28194" y="6857"/>
                </a:lnTo>
                <a:lnTo>
                  <a:pt x="30480" y="4572"/>
                </a:lnTo>
                <a:close/>
              </a:path>
              <a:path w="56514" h="56515">
                <a:moveTo>
                  <a:pt x="28194" y="6858"/>
                </a:moveTo>
                <a:lnTo>
                  <a:pt x="25908" y="4572"/>
                </a:lnTo>
                <a:lnTo>
                  <a:pt x="25908" y="9143"/>
                </a:lnTo>
                <a:lnTo>
                  <a:pt x="28194" y="6858"/>
                </a:lnTo>
                <a:close/>
              </a:path>
              <a:path w="56514" h="56515">
                <a:moveTo>
                  <a:pt x="30480" y="51816"/>
                </a:moveTo>
                <a:lnTo>
                  <a:pt x="28194" y="49530"/>
                </a:lnTo>
                <a:lnTo>
                  <a:pt x="25908" y="51816"/>
                </a:lnTo>
                <a:lnTo>
                  <a:pt x="30480" y="51816"/>
                </a:lnTo>
                <a:close/>
              </a:path>
              <a:path w="56514" h="56515">
                <a:moveTo>
                  <a:pt x="30480" y="56388"/>
                </a:moveTo>
                <a:lnTo>
                  <a:pt x="30480" y="51816"/>
                </a:lnTo>
                <a:lnTo>
                  <a:pt x="25908" y="51816"/>
                </a:lnTo>
                <a:lnTo>
                  <a:pt x="25908" y="56388"/>
                </a:lnTo>
                <a:lnTo>
                  <a:pt x="30480" y="56388"/>
                </a:lnTo>
                <a:close/>
              </a:path>
              <a:path w="56514" h="56515">
                <a:moveTo>
                  <a:pt x="30480" y="9144"/>
                </a:moveTo>
                <a:lnTo>
                  <a:pt x="30480" y="4572"/>
                </a:lnTo>
                <a:lnTo>
                  <a:pt x="28194" y="6858"/>
                </a:lnTo>
                <a:lnTo>
                  <a:pt x="30480" y="9144"/>
                </a:lnTo>
                <a:close/>
              </a:path>
              <a:path w="56514" h="56515">
                <a:moveTo>
                  <a:pt x="51816" y="35052"/>
                </a:moveTo>
                <a:lnTo>
                  <a:pt x="51816" y="30480"/>
                </a:lnTo>
                <a:lnTo>
                  <a:pt x="49530" y="28193"/>
                </a:lnTo>
                <a:lnTo>
                  <a:pt x="28194" y="49530"/>
                </a:lnTo>
                <a:lnTo>
                  <a:pt x="30480" y="51816"/>
                </a:lnTo>
                <a:lnTo>
                  <a:pt x="30480" y="56388"/>
                </a:lnTo>
                <a:lnTo>
                  <a:pt x="51816" y="35052"/>
                </a:lnTo>
                <a:close/>
              </a:path>
              <a:path w="56514" h="56515">
                <a:moveTo>
                  <a:pt x="51816" y="30480"/>
                </a:moveTo>
                <a:lnTo>
                  <a:pt x="51816" y="25908"/>
                </a:lnTo>
                <a:lnTo>
                  <a:pt x="49530" y="28193"/>
                </a:lnTo>
                <a:lnTo>
                  <a:pt x="51816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3869321" y="166725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3936377" y="1667255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3933329" y="1638300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19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19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19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19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19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19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3869321" y="1961388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3936377" y="1935479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3933329" y="1932432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6388"/>
                </a:moveTo>
                <a:lnTo>
                  <a:pt x="57912" y="54864"/>
                </a:lnTo>
                <a:lnTo>
                  <a:pt x="32004" y="3048"/>
                </a:lnTo>
                <a:lnTo>
                  <a:pt x="28956" y="0"/>
                </a:lnTo>
                <a:lnTo>
                  <a:pt x="25908" y="3048"/>
                </a:lnTo>
                <a:lnTo>
                  <a:pt x="0" y="54864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8382" y="51816"/>
                </a:lnTo>
                <a:lnTo>
                  <a:pt x="25908" y="16764"/>
                </a:lnTo>
                <a:lnTo>
                  <a:pt x="25908" y="4572"/>
                </a:lnTo>
                <a:lnTo>
                  <a:pt x="32004" y="4572"/>
                </a:lnTo>
                <a:lnTo>
                  <a:pt x="32004" y="16764"/>
                </a:lnTo>
                <a:lnTo>
                  <a:pt x="49530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19">
                <a:moveTo>
                  <a:pt x="8382" y="51816"/>
                </a:moveTo>
                <a:lnTo>
                  <a:pt x="3048" y="51816"/>
                </a:lnTo>
                <a:lnTo>
                  <a:pt x="6096" y="56388"/>
                </a:lnTo>
                <a:lnTo>
                  <a:pt x="8382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6388"/>
                </a:lnTo>
                <a:lnTo>
                  <a:pt x="49530" y="51816"/>
                </a:lnTo>
                <a:lnTo>
                  <a:pt x="8382" y="51816"/>
                </a:lnTo>
                <a:lnTo>
                  <a:pt x="6096" y="56388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19">
                <a:moveTo>
                  <a:pt x="32004" y="4572"/>
                </a:moveTo>
                <a:lnTo>
                  <a:pt x="25908" y="4572"/>
                </a:lnTo>
                <a:lnTo>
                  <a:pt x="28956" y="10668"/>
                </a:lnTo>
                <a:lnTo>
                  <a:pt x="32004" y="4572"/>
                </a:lnTo>
                <a:close/>
              </a:path>
              <a:path w="58420" h="58419">
                <a:moveTo>
                  <a:pt x="28956" y="10668"/>
                </a:moveTo>
                <a:lnTo>
                  <a:pt x="25908" y="4572"/>
                </a:lnTo>
                <a:lnTo>
                  <a:pt x="25908" y="16764"/>
                </a:lnTo>
                <a:lnTo>
                  <a:pt x="28956" y="10668"/>
                </a:lnTo>
                <a:close/>
              </a:path>
              <a:path w="58420" h="58419">
                <a:moveTo>
                  <a:pt x="32004" y="16764"/>
                </a:moveTo>
                <a:lnTo>
                  <a:pt x="32004" y="4572"/>
                </a:lnTo>
                <a:lnTo>
                  <a:pt x="28956" y="10668"/>
                </a:lnTo>
                <a:lnTo>
                  <a:pt x="32004" y="16764"/>
                </a:lnTo>
                <a:close/>
              </a:path>
              <a:path w="58420" h="58419">
                <a:moveTo>
                  <a:pt x="54864" y="51816"/>
                </a:moveTo>
                <a:lnTo>
                  <a:pt x="49530" y="51816"/>
                </a:lnTo>
                <a:lnTo>
                  <a:pt x="51816" y="56388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1048397" y="792480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5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5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5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5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9" name="object 29"/>
          <p:cNvSpPr txBox="1"/>
          <p:nvPr/>
        </p:nvSpPr>
        <p:spPr>
          <a:xfrm>
            <a:off x="1724536" y="2385835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30" name="object 30"/>
          <p:cNvSpPr txBox="1"/>
          <p:nvPr/>
        </p:nvSpPr>
        <p:spPr>
          <a:xfrm>
            <a:off x="4050163" y="1310340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4050163" y="1610614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4050163" y="1904746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3955675" y="904532"/>
            <a:ext cx="433705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6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1140847" y="854664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5" name="object 35"/>
          <p:cNvSpPr/>
          <p:nvPr/>
        </p:nvSpPr>
        <p:spPr>
          <a:xfrm>
            <a:off x="1731149" y="4078223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6" name="object 36"/>
          <p:cNvSpPr/>
          <p:nvPr/>
        </p:nvSpPr>
        <p:spPr>
          <a:xfrm>
            <a:off x="1731149" y="384047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7" name="object 37"/>
          <p:cNvSpPr/>
          <p:nvPr/>
        </p:nvSpPr>
        <p:spPr>
          <a:xfrm>
            <a:off x="1731149" y="36012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8" name="object 38"/>
          <p:cNvSpPr/>
          <p:nvPr/>
        </p:nvSpPr>
        <p:spPr>
          <a:xfrm>
            <a:off x="1731149" y="336194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1731149" y="312267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1731149" y="288340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1" name="object 41"/>
          <p:cNvSpPr/>
          <p:nvPr/>
        </p:nvSpPr>
        <p:spPr>
          <a:xfrm>
            <a:off x="1758569" y="2883407"/>
            <a:ext cx="0" cy="1403985"/>
          </a:xfrm>
          <a:custGeom>
            <a:avLst/>
            <a:gdLst/>
            <a:ahLst/>
            <a:cxnLst/>
            <a:rect l="l" t="t" r="r" b="b"/>
            <a:pathLst>
              <a:path h="1403985">
                <a:moveTo>
                  <a:pt x="0" y="0"/>
                </a:moveTo>
                <a:lnTo>
                  <a:pt x="0" y="1403604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2" name="object 42"/>
          <p:cNvSpPr/>
          <p:nvPr/>
        </p:nvSpPr>
        <p:spPr>
          <a:xfrm>
            <a:off x="1789061" y="4317491"/>
            <a:ext cx="1908175" cy="0"/>
          </a:xfrm>
          <a:custGeom>
            <a:avLst/>
            <a:gdLst/>
            <a:ahLst/>
            <a:cxnLst/>
            <a:rect l="l" t="t" r="r" b="b"/>
            <a:pathLst>
              <a:path w="1908175">
                <a:moveTo>
                  <a:pt x="0" y="0"/>
                </a:moveTo>
                <a:lnTo>
                  <a:pt x="1908047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3" name="object 43"/>
          <p:cNvSpPr/>
          <p:nvPr/>
        </p:nvSpPr>
        <p:spPr>
          <a:xfrm>
            <a:off x="1718703" y="3047745"/>
            <a:ext cx="2019807" cy="1311529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4" name="object 44"/>
          <p:cNvSpPr txBox="1"/>
          <p:nvPr/>
        </p:nvSpPr>
        <p:spPr>
          <a:xfrm>
            <a:off x="1622431" y="4260850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45" name="object 45"/>
          <p:cNvSpPr txBox="1"/>
          <p:nvPr/>
        </p:nvSpPr>
        <p:spPr>
          <a:xfrm>
            <a:off x="1535563" y="4021580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46" name="object 46"/>
          <p:cNvSpPr txBox="1"/>
          <p:nvPr/>
        </p:nvSpPr>
        <p:spPr>
          <a:xfrm>
            <a:off x="1535563" y="3782311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1535563" y="3543042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1535563" y="3303773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1491364" y="3064504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50" name="object 50"/>
          <p:cNvSpPr txBox="1"/>
          <p:nvPr/>
        </p:nvSpPr>
        <p:spPr>
          <a:xfrm>
            <a:off x="1491364" y="2825234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51" name="object 51"/>
          <p:cNvSpPr/>
          <p:nvPr/>
        </p:nvSpPr>
        <p:spPr>
          <a:xfrm>
            <a:off x="3869321" y="3348228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2" name="object 52"/>
          <p:cNvSpPr/>
          <p:nvPr/>
        </p:nvSpPr>
        <p:spPr>
          <a:xfrm>
            <a:off x="3936377" y="3322320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3" name="object 53"/>
          <p:cNvSpPr/>
          <p:nvPr/>
        </p:nvSpPr>
        <p:spPr>
          <a:xfrm>
            <a:off x="3933329" y="3320796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4" h="56514">
                <a:moveTo>
                  <a:pt x="56388" y="30480"/>
                </a:moveTo>
                <a:lnTo>
                  <a:pt x="56388" y="25908"/>
                </a:lnTo>
                <a:lnTo>
                  <a:pt x="30480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30480"/>
                </a:lnTo>
                <a:lnTo>
                  <a:pt x="4572" y="35052"/>
                </a:lnTo>
                <a:lnTo>
                  <a:pt x="4572" y="25908"/>
                </a:lnTo>
                <a:lnTo>
                  <a:pt x="6858" y="28193"/>
                </a:lnTo>
                <a:lnTo>
                  <a:pt x="25908" y="9143"/>
                </a:lnTo>
                <a:lnTo>
                  <a:pt x="25908" y="4572"/>
                </a:lnTo>
                <a:lnTo>
                  <a:pt x="30480" y="4572"/>
                </a:lnTo>
                <a:lnTo>
                  <a:pt x="30480" y="9144"/>
                </a:lnTo>
                <a:lnTo>
                  <a:pt x="49530" y="28194"/>
                </a:lnTo>
                <a:lnTo>
                  <a:pt x="51816" y="25908"/>
                </a:lnTo>
                <a:lnTo>
                  <a:pt x="51816" y="35052"/>
                </a:lnTo>
                <a:lnTo>
                  <a:pt x="56388" y="30480"/>
                </a:lnTo>
                <a:close/>
              </a:path>
              <a:path w="56514" h="56514">
                <a:moveTo>
                  <a:pt x="6858" y="28194"/>
                </a:moveTo>
                <a:lnTo>
                  <a:pt x="4572" y="25908"/>
                </a:lnTo>
                <a:lnTo>
                  <a:pt x="4572" y="30480"/>
                </a:lnTo>
                <a:lnTo>
                  <a:pt x="6858" y="28194"/>
                </a:lnTo>
                <a:close/>
              </a:path>
              <a:path w="56514" h="56514">
                <a:moveTo>
                  <a:pt x="28194" y="49530"/>
                </a:moveTo>
                <a:lnTo>
                  <a:pt x="6858" y="28194"/>
                </a:lnTo>
                <a:lnTo>
                  <a:pt x="4572" y="30480"/>
                </a:lnTo>
                <a:lnTo>
                  <a:pt x="4572" y="35052"/>
                </a:lnTo>
                <a:lnTo>
                  <a:pt x="25908" y="56388"/>
                </a:lnTo>
                <a:lnTo>
                  <a:pt x="25908" y="51816"/>
                </a:lnTo>
                <a:lnTo>
                  <a:pt x="28194" y="49530"/>
                </a:lnTo>
                <a:close/>
              </a:path>
              <a:path w="56514" h="56514">
                <a:moveTo>
                  <a:pt x="30480" y="4572"/>
                </a:moveTo>
                <a:lnTo>
                  <a:pt x="25908" y="4572"/>
                </a:lnTo>
                <a:lnTo>
                  <a:pt x="28194" y="6857"/>
                </a:lnTo>
                <a:lnTo>
                  <a:pt x="30480" y="4572"/>
                </a:lnTo>
                <a:close/>
              </a:path>
              <a:path w="56514" h="56514">
                <a:moveTo>
                  <a:pt x="28194" y="6858"/>
                </a:moveTo>
                <a:lnTo>
                  <a:pt x="25908" y="4572"/>
                </a:lnTo>
                <a:lnTo>
                  <a:pt x="25908" y="9143"/>
                </a:lnTo>
                <a:lnTo>
                  <a:pt x="28194" y="6858"/>
                </a:lnTo>
                <a:close/>
              </a:path>
              <a:path w="56514" h="56514">
                <a:moveTo>
                  <a:pt x="30480" y="51816"/>
                </a:moveTo>
                <a:lnTo>
                  <a:pt x="28194" y="49530"/>
                </a:lnTo>
                <a:lnTo>
                  <a:pt x="25908" y="51816"/>
                </a:lnTo>
                <a:lnTo>
                  <a:pt x="30480" y="51816"/>
                </a:lnTo>
                <a:close/>
              </a:path>
              <a:path w="56514" h="56514">
                <a:moveTo>
                  <a:pt x="30480" y="56388"/>
                </a:moveTo>
                <a:lnTo>
                  <a:pt x="30480" y="51816"/>
                </a:lnTo>
                <a:lnTo>
                  <a:pt x="25908" y="51816"/>
                </a:lnTo>
                <a:lnTo>
                  <a:pt x="25908" y="56388"/>
                </a:lnTo>
                <a:lnTo>
                  <a:pt x="30480" y="56388"/>
                </a:lnTo>
                <a:close/>
              </a:path>
              <a:path w="56514" h="56514">
                <a:moveTo>
                  <a:pt x="30480" y="9144"/>
                </a:moveTo>
                <a:lnTo>
                  <a:pt x="30480" y="4572"/>
                </a:lnTo>
                <a:lnTo>
                  <a:pt x="28194" y="6858"/>
                </a:lnTo>
                <a:lnTo>
                  <a:pt x="30480" y="9144"/>
                </a:lnTo>
                <a:close/>
              </a:path>
              <a:path w="56514" h="56514">
                <a:moveTo>
                  <a:pt x="51816" y="35052"/>
                </a:moveTo>
                <a:lnTo>
                  <a:pt x="51816" y="30480"/>
                </a:lnTo>
                <a:lnTo>
                  <a:pt x="49530" y="28193"/>
                </a:lnTo>
                <a:lnTo>
                  <a:pt x="28194" y="49530"/>
                </a:lnTo>
                <a:lnTo>
                  <a:pt x="30480" y="51816"/>
                </a:lnTo>
                <a:lnTo>
                  <a:pt x="30480" y="56388"/>
                </a:lnTo>
                <a:lnTo>
                  <a:pt x="51816" y="35052"/>
                </a:lnTo>
                <a:close/>
              </a:path>
              <a:path w="56514" h="56514">
                <a:moveTo>
                  <a:pt x="51816" y="30480"/>
                </a:moveTo>
                <a:lnTo>
                  <a:pt x="51816" y="25908"/>
                </a:lnTo>
                <a:lnTo>
                  <a:pt x="49530" y="28193"/>
                </a:lnTo>
                <a:lnTo>
                  <a:pt x="51816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3869321" y="364235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3936377" y="3642359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3933329" y="3613403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3869321" y="3936491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3936377" y="3910584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3933329" y="3907535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6388"/>
                </a:moveTo>
                <a:lnTo>
                  <a:pt x="57912" y="53340"/>
                </a:lnTo>
                <a:lnTo>
                  <a:pt x="32004" y="1524"/>
                </a:lnTo>
                <a:lnTo>
                  <a:pt x="28956" y="0"/>
                </a:lnTo>
                <a:lnTo>
                  <a:pt x="25908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8382" y="51816"/>
                </a:lnTo>
                <a:lnTo>
                  <a:pt x="25908" y="16764"/>
                </a:lnTo>
                <a:lnTo>
                  <a:pt x="25908" y="4572"/>
                </a:lnTo>
                <a:lnTo>
                  <a:pt x="32004" y="4572"/>
                </a:lnTo>
                <a:lnTo>
                  <a:pt x="32004" y="16764"/>
                </a:lnTo>
                <a:lnTo>
                  <a:pt x="49530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20">
                <a:moveTo>
                  <a:pt x="8382" y="51816"/>
                </a:moveTo>
                <a:lnTo>
                  <a:pt x="3048" y="51816"/>
                </a:lnTo>
                <a:lnTo>
                  <a:pt x="6096" y="56388"/>
                </a:lnTo>
                <a:lnTo>
                  <a:pt x="8382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6388"/>
                </a:lnTo>
                <a:lnTo>
                  <a:pt x="49530" y="51816"/>
                </a:lnTo>
                <a:lnTo>
                  <a:pt x="8382" y="51816"/>
                </a:lnTo>
                <a:lnTo>
                  <a:pt x="6096" y="56388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20">
                <a:moveTo>
                  <a:pt x="32004" y="4572"/>
                </a:moveTo>
                <a:lnTo>
                  <a:pt x="25908" y="4572"/>
                </a:lnTo>
                <a:lnTo>
                  <a:pt x="28956" y="10668"/>
                </a:lnTo>
                <a:lnTo>
                  <a:pt x="32004" y="4572"/>
                </a:lnTo>
                <a:close/>
              </a:path>
              <a:path w="58420" h="58420">
                <a:moveTo>
                  <a:pt x="28956" y="10668"/>
                </a:moveTo>
                <a:lnTo>
                  <a:pt x="25908" y="4572"/>
                </a:lnTo>
                <a:lnTo>
                  <a:pt x="25908" y="16764"/>
                </a:lnTo>
                <a:lnTo>
                  <a:pt x="28956" y="10668"/>
                </a:lnTo>
                <a:close/>
              </a:path>
              <a:path w="58420" h="58420">
                <a:moveTo>
                  <a:pt x="32004" y="16764"/>
                </a:moveTo>
                <a:lnTo>
                  <a:pt x="32004" y="4572"/>
                </a:lnTo>
                <a:lnTo>
                  <a:pt x="28956" y="10668"/>
                </a:lnTo>
                <a:lnTo>
                  <a:pt x="32004" y="16764"/>
                </a:lnTo>
                <a:close/>
              </a:path>
              <a:path w="58420" h="58420">
                <a:moveTo>
                  <a:pt x="54864" y="51816"/>
                </a:moveTo>
                <a:lnTo>
                  <a:pt x="49530" y="51816"/>
                </a:lnTo>
                <a:lnTo>
                  <a:pt x="51816" y="56388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0" name="object 60"/>
          <p:cNvSpPr/>
          <p:nvPr/>
        </p:nvSpPr>
        <p:spPr>
          <a:xfrm>
            <a:off x="1048397" y="2767583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1" name="object 61"/>
          <p:cNvSpPr txBox="1"/>
          <p:nvPr/>
        </p:nvSpPr>
        <p:spPr>
          <a:xfrm>
            <a:off x="1724536" y="4360922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62" name="object 62"/>
          <p:cNvSpPr txBox="1"/>
          <p:nvPr/>
        </p:nvSpPr>
        <p:spPr>
          <a:xfrm>
            <a:off x="4050163" y="3285444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63" name="object 63"/>
          <p:cNvSpPr txBox="1"/>
          <p:nvPr/>
        </p:nvSpPr>
        <p:spPr>
          <a:xfrm>
            <a:off x="4050163" y="3585717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64" name="object 64"/>
          <p:cNvSpPr txBox="1"/>
          <p:nvPr/>
        </p:nvSpPr>
        <p:spPr>
          <a:xfrm>
            <a:off x="4050163" y="3879850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3955675" y="2879635"/>
            <a:ext cx="433705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1</a:t>
            </a:r>
            <a:r>
              <a:rPr sz="750" b="1" spc="-5" dirty="0">
                <a:latin typeface="Calibri"/>
                <a:cs typeface="Calibri"/>
              </a:rPr>
              <a:t>0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1140847" y="2829768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67" name="object 67"/>
          <p:cNvSpPr/>
          <p:nvPr/>
        </p:nvSpPr>
        <p:spPr>
          <a:xfrm>
            <a:off x="2758325" y="6054852"/>
            <a:ext cx="939165" cy="0"/>
          </a:xfrm>
          <a:custGeom>
            <a:avLst/>
            <a:gdLst/>
            <a:ahLst/>
            <a:cxnLst/>
            <a:rect l="l" t="t" r="r" b="b"/>
            <a:pathLst>
              <a:path w="939164">
                <a:moveTo>
                  <a:pt x="0" y="0"/>
                </a:moveTo>
                <a:lnTo>
                  <a:pt x="938784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8" name="object 68"/>
          <p:cNvSpPr/>
          <p:nvPr/>
        </p:nvSpPr>
        <p:spPr>
          <a:xfrm>
            <a:off x="1910981" y="6054852"/>
            <a:ext cx="786765" cy="0"/>
          </a:xfrm>
          <a:custGeom>
            <a:avLst/>
            <a:gdLst/>
            <a:ahLst/>
            <a:cxnLst/>
            <a:rect l="l" t="t" r="r" b="b"/>
            <a:pathLst>
              <a:path w="786764">
                <a:moveTo>
                  <a:pt x="0" y="0"/>
                </a:moveTo>
                <a:lnTo>
                  <a:pt x="786383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9" name="object 69"/>
          <p:cNvSpPr/>
          <p:nvPr/>
        </p:nvSpPr>
        <p:spPr>
          <a:xfrm>
            <a:off x="1731149" y="6054852"/>
            <a:ext cx="119380" cy="0"/>
          </a:xfrm>
          <a:custGeom>
            <a:avLst/>
            <a:gdLst/>
            <a:ahLst/>
            <a:cxnLst/>
            <a:rect l="l" t="t" r="r" b="b"/>
            <a:pathLst>
              <a:path w="119380">
                <a:moveTo>
                  <a:pt x="0" y="0"/>
                </a:moveTo>
                <a:lnTo>
                  <a:pt x="118871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0" name="object 70"/>
          <p:cNvSpPr/>
          <p:nvPr/>
        </p:nvSpPr>
        <p:spPr>
          <a:xfrm>
            <a:off x="2435237" y="5815584"/>
            <a:ext cx="1262380" cy="0"/>
          </a:xfrm>
          <a:custGeom>
            <a:avLst/>
            <a:gdLst/>
            <a:ahLst/>
            <a:cxnLst/>
            <a:rect l="l" t="t" r="r" b="b"/>
            <a:pathLst>
              <a:path w="1262379">
                <a:moveTo>
                  <a:pt x="0" y="0"/>
                </a:moveTo>
                <a:lnTo>
                  <a:pt x="1261871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1" name="object 71"/>
          <p:cNvSpPr/>
          <p:nvPr/>
        </p:nvSpPr>
        <p:spPr>
          <a:xfrm>
            <a:off x="1731149" y="5815584"/>
            <a:ext cx="643255" cy="0"/>
          </a:xfrm>
          <a:custGeom>
            <a:avLst/>
            <a:gdLst/>
            <a:ahLst/>
            <a:cxnLst/>
            <a:rect l="l" t="t" r="r" b="b"/>
            <a:pathLst>
              <a:path w="643255">
                <a:moveTo>
                  <a:pt x="0" y="0"/>
                </a:moveTo>
                <a:lnTo>
                  <a:pt x="643127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2" name="object 72"/>
          <p:cNvSpPr/>
          <p:nvPr/>
        </p:nvSpPr>
        <p:spPr>
          <a:xfrm>
            <a:off x="1731149" y="5576315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3" name="object 73"/>
          <p:cNvSpPr/>
          <p:nvPr/>
        </p:nvSpPr>
        <p:spPr>
          <a:xfrm>
            <a:off x="1731149" y="5337048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4" name="object 74"/>
          <p:cNvSpPr/>
          <p:nvPr/>
        </p:nvSpPr>
        <p:spPr>
          <a:xfrm>
            <a:off x="1731149" y="509777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5" name="object 75"/>
          <p:cNvSpPr/>
          <p:nvPr/>
        </p:nvSpPr>
        <p:spPr>
          <a:xfrm>
            <a:off x="1731149" y="48585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6" name="object 76"/>
          <p:cNvSpPr/>
          <p:nvPr/>
        </p:nvSpPr>
        <p:spPr>
          <a:xfrm>
            <a:off x="1758569" y="4858511"/>
            <a:ext cx="0" cy="1403985"/>
          </a:xfrm>
          <a:custGeom>
            <a:avLst/>
            <a:gdLst/>
            <a:ahLst/>
            <a:cxnLst/>
            <a:rect l="l" t="t" r="r" b="b"/>
            <a:pathLst>
              <a:path h="1403985">
                <a:moveTo>
                  <a:pt x="0" y="0"/>
                </a:moveTo>
                <a:lnTo>
                  <a:pt x="0" y="1403603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7" name="object 77"/>
          <p:cNvSpPr/>
          <p:nvPr/>
        </p:nvSpPr>
        <p:spPr>
          <a:xfrm>
            <a:off x="1789061" y="6294120"/>
            <a:ext cx="1908175" cy="0"/>
          </a:xfrm>
          <a:custGeom>
            <a:avLst/>
            <a:gdLst/>
            <a:ahLst/>
            <a:cxnLst/>
            <a:rect l="l" t="t" r="r" b="b"/>
            <a:pathLst>
              <a:path w="1908175">
                <a:moveTo>
                  <a:pt x="0" y="0"/>
                </a:moveTo>
                <a:lnTo>
                  <a:pt x="1908048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8" name="object 78"/>
          <p:cNvSpPr/>
          <p:nvPr/>
        </p:nvSpPr>
        <p:spPr>
          <a:xfrm>
            <a:off x="1718703" y="5063997"/>
            <a:ext cx="2019808" cy="1271905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9" name="object 79"/>
          <p:cNvSpPr txBox="1"/>
          <p:nvPr/>
        </p:nvSpPr>
        <p:spPr>
          <a:xfrm>
            <a:off x="1535563" y="5996684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0" name="object 80"/>
          <p:cNvSpPr txBox="1"/>
          <p:nvPr/>
        </p:nvSpPr>
        <p:spPr>
          <a:xfrm>
            <a:off x="1535563" y="5757415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1" name="object 81"/>
          <p:cNvSpPr txBox="1"/>
          <p:nvPr/>
        </p:nvSpPr>
        <p:spPr>
          <a:xfrm>
            <a:off x="1535563" y="5518146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2" name="object 82"/>
          <p:cNvSpPr txBox="1"/>
          <p:nvPr/>
        </p:nvSpPr>
        <p:spPr>
          <a:xfrm>
            <a:off x="1535563" y="5278877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3" name="object 83"/>
          <p:cNvSpPr txBox="1"/>
          <p:nvPr/>
        </p:nvSpPr>
        <p:spPr>
          <a:xfrm>
            <a:off x="1535563" y="5039607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4" name="object 84"/>
          <p:cNvSpPr txBox="1"/>
          <p:nvPr/>
        </p:nvSpPr>
        <p:spPr>
          <a:xfrm>
            <a:off x="1535563" y="4800338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5" name="object 85"/>
          <p:cNvSpPr/>
          <p:nvPr/>
        </p:nvSpPr>
        <p:spPr>
          <a:xfrm>
            <a:off x="3869321" y="532485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6" name="object 86"/>
          <p:cNvSpPr/>
          <p:nvPr/>
        </p:nvSpPr>
        <p:spPr>
          <a:xfrm>
            <a:off x="3936377" y="5298947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7" name="object 87"/>
          <p:cNvSpPr/>
          <p:nvPr/>
        </p:nvSpPr>
        <p:spPr>
          <a:xfrm>
            <a:off x="3933329" y="5297423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4" h="56514">
                <a:moveTo>
                  <a:pt x="56388" y="30480"/>
                </a:moveTo>
                <a:lnTo>
                  <a:pt x="56388" y="25908"/>
                </a:lnTo>
                <a:lnTo>
                  <a:pt x="30480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30480"/>
                </a:lnTo>
                <a:lnTo>
                  <a:pt x="4572" y="35052"/>
                </a:lnTo>
                <a:lnTo>
                  <a:pt x="4572" y="25908"/>
                </a:lnTo>
                <a:lnTo>
                  <a:pt x="6858" y="28193"/>
                </a:lnTo>
                <a:lnTo>
                  <a:pt x="25908" y="9143"/>
                </a:lnTo>
                <a:lnTo>
                  <a:pt x="25908" y="4572"/>
                </a:lnTo>
                <a:lnTo>
                  <a:pt x="30480" y="4572"/>
                </a:lnTo>
                <a:lnTo>
                  <a:pt x="30480" y="9144"/>
                </a:lnTo>
                <a:lnTo>
                  <a:pt x="49530" y="28194"/>
                </a:lnTo>
                <a:lnTo>
                  <a:pt x="51816" y="25908"/>
                </a:lnTo>
                <a:lnTo>
                  <a:pt x="51816" y="35052"/>
                </a:lnTo>
                <a:lnTo>
                  <a:pt x="56388" y="30480"/>
                </a:lnTo>
                <a:close/>
              </a:path>
              <a:path w="56514" h="56514">
                <a:moveTo>
                  <a:pt x="6858" y="28194"/>
                </a:moveTo>
                <a:lnTo>
                  <a:pt x="4572" y="25908"/>
                </a:lnTo>
                <a:lnTo>
                  <a:pt x="4572" y="30480"/>
                </a:lnTo>
                <a:lnTo>
                  <a:pt x="6858" y="28194"/>
                </a:lnTo>
                <a:close/>
              </a:path>
              <a:path w="56514" h="56514">
                <a:moveTo>
                  <a:pt x="28194" y="49530"/>
                </a:moveTo>
                <a:lnTo>
                  <a:pt x="6858" y="28194"/>
                </a:lnTo>
                <a:lnTo>
                  <a:pt x="4572" y="30480"/>
                </a:lnTo>
                <a:lnTo>
                  <a:pt x="4572" y="35052"/>
                </a:lnTo>
                <a:lnTo>
                  <a:pt x="25908" y="56388"/>
                </a:lnTo>
                <a:lnTo>
                  <a:pt x="25908" y="51816"/>
                </a:lnTo>
                <a:lnTo>
                  <a:pt x="28194" y="49530"/>
                </a:lnTo>
                <a:close/>
              </a:path>
              <a:path w="56514" h="56514">
                <a:moveTo>
                  <a:pt x="30480" y="4572"/>
                </a:moveTo>
                <a:lnTo>
                  <a:pt x="25908" y="4572"/>
                </a:lnTo>
                <a:lnTo>
                  <a:pt x="28194" y="6857"/>
                </a:lnTo>
                <a:lnTo>
                  <a:pt x="30480" y="4572"/>
                </a:lnTo>
                <a:close/>
              </a:path>
              <a:path w="56514" h="56514">
                <a:moveTo>
                  <a:pt x="28194" y="6858"/>
                </a:moveTo>
                <a:lnTo>
                  <a:pt x="25908" y="4572"/>
                </a:lnTo>
                <a:lnTo>
                  <a:pt x="25908" y="9143"/>
                </a:lnTo>
                <a:lnTo>
                  <a:pt x="28194" y="6858"/>
                </a:lnTo>
                <a:close/>
              </a:path>
              <a:path w="56514" h="56514">
                <a:moveTo>
                  <a:pt x="30480" y="51816"/>
                </a:moveTo>
                <a:lnTo>
                  <a:pt x="28194" y="49530"/>
                </a:lnTo>
                <a:lnTo>
                  <a:pt x="25908" y="51816"/>
                </a:lnTo>
                <a:lnTo>
                  <a:pt x="30480" y="51816"/>
                </a:lnTo>
                <a:close/>
              </a:path>
              <a:path w="56514" h="56514">
                <a:moveTo>
                  <a:pt x="30480" y="56388"/>
                </a:moveTo>
                <a:lnTo>
                  <a:pt x="30480" y="51816"/>
                </a:lnTo>
                <a:lnTo>
                  <a:pt x="25908" y="51816"/>
                </a:lnTo>
                <a:lnTo>
                  <a:pt x="25908" y="56388"/>
                </a:lnTo>
                <a:lnTo>
                  <a:pt x="30480" y="56388"/>
                </a:lnTo>
                <a:close/>
              </a:path>
              <a:path w="56514" h="56514">
                <a:moveTo>
                  <a:pt x="30480" y="9144"/>
                </a:moveTo>
                <a:lnTo>
                  <a:pt x="30480" y="4572"/>
                </a:lnTo>
                <a:lnTo>
                  <a:pt x="28194" y="6858"/>
                </a:lnTo>
                <a:lnTo>
                  <a:pt x="30480" y="9144"/>
                </a:lnTo>
                <a:close/>
              </a:path>
              <a:path w="56514" h="56514">
                <a:moveTo>
                  <a:pt x="51816" y="35052"/>
                </a:moveTo>
                <a:lnTo>
                  <a:pt x="51816" y="30480"/>
                </a:lnTo>
                <a:lnTo>
                  <a:pt x="49530" y="28193"/>
                </a:lnTo>
                <a:lnTo>
                  <a:pt x="28194" y="49530"/>
                </a:lnTo>
                <a:lnTo>
                  <a:pt x="30480" y="51816"/>
                </a:lnTo>
                <a:lnTo>
                  <a:pt x="30480" y="56388"/>
                </a:lnTo>
                <a:lnTo>
                  <a:pt x="51816" y="35052"/>
                </a:lnTo>
                <a:close/>
              </a:path>
              <a:path w="56514" h="56514">
                <a:moveTo>
                  <a:pt x="51816" y="30480"/>
                </a:moveTo>
                <a:lnTo>
                  <a:pt x="51816" y="25908"/>
                </a:lnTo>
                <a:lnTo>
                  <a:pt x="49530" y="28193"/>
                </a:lnTo>
                <a:lnTo>
                  <a:pt x="51816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8" name="object 88"/>
          <p:cNvSpPr txBox="1"/>
          <p:nvPr/>
        </p:nvSpPr>
        <p:spPr>
          <a:xfrm>
            <a:off x="4050163" y="5260548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9" name="object 89"/>
          <p:cNvSpPr/>
          <p:nvPr/>
        </p:nvSpPr>
        <p:spPr>
          <a:xfrm>
            <a:off x="3869321" y="5618988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0" name="object 90"/>
          <p:cNvSpPr/>
          <p:nvPr/>
        </p:nvSpPr>
        <p:spPr>
          <a:xfrm>
            <a:off x="3936377" y="5618988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1" name="object 91"/>
          <p:cNvSpPr/>
          <p:nvPr/>
        </p:nvSpPr>
        <p:spPr>
          <a:xfrm>
            <a:off x="3933329" y="5590032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2" name="object 92"/>
          <p:cNvSpPr txBox="1"/>
          <p:nvPr/>
        </p:nvSpPr>
        <p:spPr>
          <a:xfrm>
            <a:off x="4050163" y="5560821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93" name="object 93"/>
          <p:cNvSpPr/>
          <p:nvPr/>
        </p:nvSpPr>
        <p:spPr>
          <a:xfrm>
            <a:off x="3869321" y="5913120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4" name="object 94"/>
          <p:cNvSpPr/>
          <p:nvPr/>
        </p:nvSpPr>
        <p:spPr>
          <a:xfrm>
            <a:off x="3936377" y="5887211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5" name="object 95"/>
          <p:cNvSpPr/>
          <p:nvPr/>
        </p:nvSpPr>
        <p:spPr>
          <a:xfrm>
            <a:off x="3933329" y="5884164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6388"/>
                </a:moveTo>
                <a:lnTo>
                  <a:pt x="57912" y="53340"/>
                </a:lnTo>
                <a:lnTo>
                  <a:pt x="32004" y="1524"/>
                </a:lnTo>
                <a:lnTo>
                  <a:pt x="28956" y="0"/>
                </a:lnTo>
                <a:lnTo>
                  <a:pt x="25908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8382" y="51816"/>
                </a:lnTo>
                <a:lnTo>
                  <a:pt x="25908" y="16764"/>
                </a:lnTo>
                <a:lnTo>
                  <a:pt x="25908" y="4572"/>
                </a:lnTo>
                <a:lnTo>
                  <a:pt x="32004" y="4572"/>
                </a:lnTo>
                <a:lnTo>
                  <a:pt x="32004" y="16764"/>
                </a:lnTo>
                <a:lnTo>
                  <a:pt x="49530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20">
                <a:moveTo>
                  <a:pt x="8382" y="51816"/>
                </a:moveTo>
                <a:lnTo>
                  <a:pt x="3048" y="51816"/>
                </a:lnTo>
                <a:lnTo>
                  <a:pt x="6096" y="56388"/>
                </a:lnTo>
                <a:lnTo>
                  <a:pt x="8382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6388"/>
                </a:lnTo>
                <a:lnTo>
                  <a:pt x="49530" y="51816"/>
                </a:lnTo>
                <a:lnTo>
                  <a:pt x="8382" y="51816"/>
                </a:lnTo>
                <a:lnTo>
                  <a:pt x="6096" y="56388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20">
                <a:moveTo>
                  <a:pt x="32004" y="4572"/>
                </a:moveTo>
                <a:lnTo>
                  <a:pt x="25908" y="4572"/>
                </a:lnTo>
                <a:lnTo>
                  <a:pt x="28956" y="10668"/>
                </a:lnTo>
                <a:lnTo>
                  <a:pt x="32004" y="4572"/>
                </a:lnTo>
                <a:close/>
              </a:path>
              <a:path w="58420" h="58420">
                <a:moveTo>
                  <a:pt x="28956" y="10668"/>
                </a:moveTo>
                <a:lnTo>
                  <a:pt x="25908" y="4572"/>
                </a:lnTo>
                <a:lnTo>
                  <a:pt x="25908" y="16764"/>
                </a:lnTo>
                <a:lnTo>
                  <a:pt x="28956" y="10668"/>
                </a:lnTo>
                <a:close/>
              </a:path>
              <a:path w="58420" h="58420">
                <a:moveTo>
                  <a:pt x="32004" y="16764"/>
                </a:moveTo>
                <a:lnTo>
                  <a:pt x="32004" y="4572"/>
                </a:lnTo>
                <a:lnTo>
                  <a:pt x="28956" y="10668"/>
                </a:lnTo>
                <a:lnTo>
                  <a:pt x="32004" y="16764"/>
                </a:lnTo>
                <a:close/>
              </a:path>
              <a:path w="58420" h="58420">
                <a:moveTo>
                  <a:pt x="54864" y="51816"/>
                </a:moveTo>
                <a:lnTo>
                  <a:pt x="49530" y="51816"/>
                </a:lnTo>
                <a:lnTo>
                  <a:pt x="51816" y="56388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6" name="object 96"/>
          <p:cNvSpPr txBox="1"/>
          <p:nvPr/>
        </p:nvSpPr>
        <p:spPr>
          <a:xfrm>
            <a:off x="4050163" y="5854953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97" name="object 97"/>
          <p:cNvSpPr/>
          <p:nvPr/>
        </p:nvSpPr>
        <p:spPr>
          <a:xfrm>
            <a:off x="1048397" y="4742688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8" name="object 98"/>
          <p:cNvSpPr txBox="1"/>
          <p:nvPr/>
        </p:nvSpPr>
        <p:spPr>
          <a:xfrm>
            <a:off x="3955675" y="4854740"/>
            <a:ext cx="433705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1</a:t>
            </a:r>
            <a:r>
              <a:rPr sz="750" b="1" spc="-5" dirty="0">
                <a:latin typeface="Calibri"/>
                <a:cs typeface="Calibri"/>
              </a:rPr>
              <a:t>4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99" name="object 99"/>
          <p:cNvSpPr txBox="1"/>
          <p:nvPr/>
        </p:nvSpPr>
        <p:spPr>
          <a:xfrm>
            <a:off x="1140847" y="4804872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00" name="object 100"/>
          <p:cNvSpPr/>
          <p:nvPr/>
        </p:nvSpPr>
        <p:spPr>
          <a:xfrm>
            <a:off x="5861189" y="186537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1" name="object 101"/>
          <p:cNvSpPr/>
          <p:nvPr/>
        </p:nvSpPr>
        <p:spPr>
          <a:xfrm>
            <a:off x="6565277" y="1386839"/>
            <a:ext cx="1262380" cy="0"/>
          </a:xfrm>
          <a:custGeom>
            <a:avLst/>
            <a:gdLst/>
            <a:ahLst/>
            <a:cxnLst/>
            <a:rect l="l" t="t" r="r" b="b"/>
            <a:pathLst>
              <a:path w="1262379">
                <a:moveTo>
                  <a:pt x="0" y="0"/>
                </a:moveTo>
                <a:lnTo>
                  <a:pt x="1261872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2" name="object 102"/>
          <p:cNvSpPr/>
          <p:nvPr/>
        </p:nvSpPr>
        <p:spPr>
          <a:xfrm>
            <a:off x="5999873" y="1386839"/>
            <a:ext cx="504825" cy="0"/>
          </a:xfrm>
          <a:custGeom>
            <a:avLst/>
            <a:gdLst/>
            <a:ahLst/>
            <a:cxnLst/>
            <a:rect l="l" t="t" r="r" b="b"/>
            <a:pathLst>
              <a:path w="504825">
                <a:moveTo>
                  <a:pt x="0" y="0"/>
                </a:moveTo>
                <a:lnTo>
                  <a:pt x="504443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3" name="object 103"/>
          <p:cNvSpPr/>
          <p:nvPr/>
        </p:nvSpPr>
        <p:spPr>
          <a:xfrm>
            <a:off x="5861189" y="1386839"/>
            <a:ext cx="78105" cy="0"/>
          </a:xfrm>
          <a:custGeom>
            <a:avLst/>
            <a:gdLst/>
            <a:ahLst/>
            <a:cxnLst/>
            <a:rect l="l" t="t" r="r" b="b"/>
            <a:pathLst>
              <a:path w="78104">
                <a:moveTo>
                  <a:pt x="0" y="0"/>
                </a:moveTo>
                <a:lnTo>
                  <a:pt x="77723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4" name="object 104"/>
          <p:cNvSpPr/>
          <p:nvPr/>
        </p:nvSpPr>
        <p:spPr>
          <a:xfrm>
            <a:off x="5861189" y="908303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5" name="object 105"/>
          <p:cNvSpPr/>
          <p:nvPr/>
        </p:nvSpPr>
        <p:spPr>
          <a:xfrm>
            <a:off x="5888621" y="908303"/>
            <a:ext cx="0" cy="1466215"/>
          </a:xfrm>
          <a:custGeom>
            <a:avLst/>
            <a:gdLst/>
            <a:ahLst/>
            <a:cxnLst/>
            <a:rect l="l" t="t" r="r" b="b"/>
            <a:pathLst>
              <a:path h="1466214">
                <a:moveTo>
                  <a:pt x="0" y="0"/>
                </a:moveTo>
                <a:lnTo>
                  <a:pt x="0" y="1466087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6" name="object 106"/>
          <p:cNvSpPr/>
          <p:nvPr/>
        </p:nvSpPr>
        <p:spPr>
          <a:xfrm>
            <a:off x="5861189" y="23439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7" name="object 107"/>
          <p:cNvSpPr/>
          <p:nvPr/>
        </p:nvSpPr>
        <p:spPr>
          <a:xfrm>
            <a:off x="6047117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8" name="object 108"/>
          <p:cNvSpPr/>
          <p:nvPr/>
        </p:nvSpPr>
        <p:spPr>
          <a:xfrm>
            <a:off x="6208662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9" name="object 109"/>
          <p:cNvSpPr/>
          <p:nvPr/>
        </p:nvSpPr>
        <p:spPr>
          <a:xfrm>
            <a:off x="6370193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0" name="object 110"/>
          <p:cNvSpPr/>
          <p:nvPr/>
        </p:nvSpPr>
        <p:spPr>
          <a:xfrm>
            <a:off x="6531749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1" name="object 111"/>
          <p:cNvSpPr/>
          <p:nvPr/>
        </p:nvSpPr>
        <p:spPr>
          <a:xfrm>
            <a:off x="669328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2" name="object 112"/>
          <p:cNvSpPr/>
          <p:nvPr/>
        </p:nvSpPr>
        <p:spPr>
          <a:xfrm>
            <a:off x="6854825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3" name="object 113"/>
          <p:cNvSpPr/>
          <p:nvPr/>
        </p:nvSpPr>
        <p:spPr>
          <a:xfrm>
            <a:off x="701638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4" name="object 114"/>
          <p:cNvSpPr/>
          <p:nvPr/>
        </p:nvSpPr>
        <p:spPr>
          <a:xfrm>
            <a:off x="7177925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5" name="object 115"/>
          <p:cNvSpPr/>
          <p:nvPr/>
        </p:nvSpPr>
        <p:spPr>
          <a:xfrm>
            <a:off x="7339469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6" name="object 116"/>
          <p:cNvSpPr/>
          <p:nvPr/>
        </p:nvSpPr>
        <p:spPr>
          <a:xfrm>
            <a:off x="750100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7" name="object 117"/>
          <p:cNvSpPr/>
          <p:nvPr/>
        </p:nvSpPr>
        <p:spPr>
          <a:xfrm>
            <a:off x="7662557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8" name="object 118"/>
          <p:cNvSpPr/>
          <p:nvPr/>
        </p:nvSpPr>
        <p:spPr>
          <a:xfrm>
            <a:off x="782410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9" name="object 119"/>
          <p:cNvSpPr/>
          <p:nvPr/>
        </p:nvSpPr>
        <p:spPr>
          <a:xfrm>
            <a:off x="5889891" y="1214374"/>
            <a:ext cx="1978647" cy="568960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0" name="object 120"/>
          <p:cNvSpPr txBox="1"/>
          <p:nvPr/>
        </p:nvSpPr>
        <p:spPr>
          <a:xfrm>
            <a:off x="5752471" y="2285746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21" name="object 121"/>
          <p:cNvSpPr txBox="1"/>
          <p:nvPr/>
        </p:nvSpPr>
        <p:spPr>
          <a:xfrm>
            <a:off x="5708272" y="1807207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22" name="object 122"/>
          <p:cNvSpPr txBox="1"/>
          <p:nvPr/>
        </p:nvSpPr>
        <p:spPr>
          <a:xfrm>
            <a:off x="5665603" y="1328669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23" name="object 123"/>
          <p:cNvSpPr txBox="1"/>
          <p:nvPr/>
        </p:nvSpPr>
        <p:spPr>
          <a:xfrm>
            <a:off x="5621404" y="850131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24" name="object 124"/>
          <p:cNvSpPr/>
          <p:nvPr/>
        </p:nvSpPr>
        <p:spPr>
          <a:xfrm>
            <a:off x="7999361" y="1373124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5" name="object 125"/>
          <p:cNvSpPr/>
          <p:nvPr/>
        </p:nvSpPr>
        <p:spPr>
          <a:xfrm>
            <a:off x="8066405" y="1347216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6" name="object 126"/>
          <p:cNvSpPr/>
          <p:nvPr/>
        </p:nvSpPr>
        <p:spPr>
          <a:xfrm>
            <a:off x="8063369" y="1345691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5" h="56515">
                <a:moveTo>
                  <a:pt x="56387" y="30480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30480"/>
                </a:lnTo>
                <a:lnTo>
                  <a:pt x="4571" y="35052"/>
                </a:lnTo>
                <a:lnTo>
                  <a:pt x="4571" y="25908"/>
                </a:lnTo>
                <a:lnTo>
                  <a:pt x="6857" y="28193"/>
                </a:lnTo>
                <a:lnTo>
                  <a:pt x="25907" y="9143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9144"/>
                </a:lnTo>
                <a:lnTo>
                  <a:pt x="49529" y="28194"/>
                </a:lnTo>
                <a:lnTo>
                  <a:pt x="51815" y="25908"/>
                </a:lnTo>
                <a:lnTo>
                  <a:pt x="51815" y="35052"/>
                </a:lnTo>
                <a:lnTo>
                  <a:pt x="56387" y="30480"/>
                </a:lnTo>
                <a:close/>
              </a:path>
              <a:path w="56515" h="56515">
                <a:moveTo>
                  <a:pt x="6857" y="28194"/>
                </a:moveTo>
                <a:lnTo>
                  <a:pt x="4571" y="25908"/>
                </a:lnTo>
                <a:lnTo>
                  <a:pt x="4571" y="30480"/>
                </a:lnTo>
                <a:lnTo>
                  <a:pt x="6857" y="28194"/>
                </a:lnTo>
                <a:close/>
              </a:path>
              <a:path w="56515" h="56515">
                <a:moveTo>
                  <a:pt x="28193" y="49530"/>
                </a:moveTo>
                <a:lnTo>
                  <a:pt x="6857" y="28194"/>
                </a:lnTo>
                <a:lnTo>
                  <a:pt x="4571" y="30480"/>
                </a:lnTo>
                <a:lnTo>
                  <a:pt x="4571" y="35052"/>
                </a:lnTo>
                <a:lnTo>
                  <a:pt x="25907" y="56388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6515">
                <a:moveTo>
                  <a:pt x="30479" y="4572"/>
                </a:moveTo>
                <a:lnTo>
                  <a:pt x="25907" y="4572"/>
                </a:lnTo>
                <a:lnTo>
                  <a:pt x="28193" y="6857"/>
                </a:lnTo>
                <a:lnTo>
                  <a:pt x="30479" y="4572"/>
                </a:lnTo>
                <a:close/>
              </a:path>
              <a:path w="56515" h="56515">
                <a:moveTo>
                  <a:pt x="28193" y="6858"/>
                </a:moveTo>
                <a:lnTo>
                  <a:pt x="25907" y="4572"/>
                </a:lnTo>
                <a:lnTo>
                  <a:pt x="25907" y="9143"/>
                </a:lnTo>
                <a:lnTo>
                  <a:pt x="28193" y="6858"/>
                </a:lnTo>
                <a:close/>
              </a:path>
              <a:path w="56515" h="56515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6515">
                <a:moveTo>
                  <a:pt x="30479" y="56388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6388"/>
                </a:lnTo>
                <a:lnTo>
                  <a:pt x="30479" y="56388"/>
                </a:lnTo>
                <a:close/>
              </a:path>
              <a:path w="56515" h="56515">
                <a:moveTo>
                  <a:pt x="30479" y="9144"/>
                </a:moveTo>
                <a:lnTo>
                  <a:pt x="30479" y="4572"/>
                </a:lnTo>
                <a:lnTo>
                  <a:pt x="28193" y="6858"/>
                </a:lnTo>
                <a:lnTo>
                  <a:pt x="30479" y="9144"/>
                </a:lnTo>
                <a:close/>
              </a:path>
              <a:path w="56515" h="56515">
                <a:moveTo>
                  <a:pt x="51815" y="35052"/>
                </a:moveTo>
                <a:lnTo>
                  <a:pt x="51815" y="30480"/>
                </a:lnTo>
                <a:lnTo>
                  <a:pt x="49529" y="28193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6388"/>
                </a:lnTo>
                <a:lnTo>
                  <a:pt x="51815" y="35052"/>
                </a:lnTo>
                <a:close/>
              </a:path>
              <a:path w="56515" h="56515">
                <a:moveTo>
                  <a:pt x="51815" y="30480"/>
                </a:moveTo>
                <a:lnTo>
                  <a:pt x="51815" y="25908"/>
                </a:lnTo>
                <a:lnTo>
                  <a:pt x="49529" y="28193"/>
                </a:lnTo>
                <a:lnTo>
                  <a:pt x="51815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7" name="object 127"/>
          <p:cNvSpPr/>
          <p:nvPr/>
        </p:nvSpPr>
        <p:spPr>
          <a:xfrm>
            <a:off x="7999361" y="166725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8" name="object 128"/>
          <p:cNvSpPr/>
          <p:nvPr/>
        </p:nvSpPr>
        <p:spPr>
          <a:xfrm>
            <a:off x="8066417" y="1667255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9" name="object 129"/>
          <p:cNvSpPr/>
          <p:nvPr/>
        </p:nvSpPr>
        <p:spPr>
          <a:xfrm>
            <a:off x="8063369" y="1638300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19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19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19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19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19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19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0" name="object 130"/>
          <p:cNvSpPr/>
          <p:nvPr/>
        </p:nvSpPr>
        <p:spPr>
          <a:xfrm>
            <a:off x="7999361" y="1961388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1" name="object 131"/>
          <p:cNvSpPr/>
          <p:nvPr/>
        </p:nvSpPr>
        <p:spPr>
          <a:xfrm>
            <a:off x="8066405" y="1935479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2" name="object 132"/>
          <p:cNvSpPr/>
          <p:nvPr/>
        </p:nvSpPr>
        <p:spPr>
          <a:xfrm>
            <a:off x="8063369" y="1932432"/>
            <a:ext cx="56515" cy="58419"/>
          </a:xfrm>
          <a:custGeom>
            <a:avLst/>
            <a:gdLst/>
            <a:ahLst/>
            <a:cxnLst/>
            <a:rect l="l" t="t" r="r" b="b"/>
            <a:pathLst>
              <a:path w="56515" h="58419">
                <a:moveTo>
                  <a:pt x="54863" y="51816"/>
                </a:moveTo>
                <a:lnTo>
                  <a:pt x="28955" y="0"/>
                </a:lnTo>
                <a:lnTo>
                  <a:pt x="25907" y="3048"/>
                </a:lnTo>
                <a:lnTo>
                  <a:pt x="0" y="54864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6857" y="51816"/>
                </a:lnTo>
                <a:lnTo>
                  <a:pt x="25907" y="13716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13716"/>
                </a:lnTo>
                <a:lnTo>
                  <a:pt x="49529" y="51816"/>
                </a:lnTo>
                <a:lnTo>
                  <a:pt x="54863" y="51816"/>
                </a:lnTo>
                <a:close/>
              </a:path>
              <a:path w="56515" h="58419">
                <a:moveTo>
                  <a:pt x="6857" y="51816"/>
                </a:moveTo>
                <a:lnTo>
                  <a:pt x="3047" y="51816"/>
                </a:lnTo>
                <a:lnTo>
                  <a:pt x="4571" y="56388"/>
                </a:lnTo>
                <a:lnTo>
                  <a:pt x="6857" y="51816"/>
                </a:lnTo>
                <a:close/>
              </a:path>
              <a:path w="56515" h="58419">
                <a:moveTo>
                  <a:pt x="56387" y="56388"/>
                </a:moveTo>
                <a:lnTo>
                  <a:pt x="56387" y="54864"/>
                </a:lnTo>
                <a:lnTo>
                  <a:pt x="54863" y="51816"/>
                </a:lnTo>
                <a:lnTo>
                  <a:pt x="51815" y="56388"/>
                </a:lnTo>
                <a:lnTo>
                  <a:pt x="49529" y="51816"/>
                </a:lnTo>
                <a:lnTo>
                  <a:pt x="6857" y="51816"/>
                </a:lnTo>
                <a:lnTo>
                  <a:pt x="4571" y="56388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lnTo>
                  <a:pt x="56387" y="56388"/>
                </a:lnTo>
                <a:close/>
              </a:path>
              <a:path w="56515" h="58419">
                <a:moveTo>
                  <a:pt x="30479" y="4572"/>
                </a:moveTo>
                <a:lnTo>
                  <a:pt x="25907" y="4572"/>
                </a:lnTo>
                <a:lnTo>
                  <a:pt x="28193" y="9144"/>
                </a:lnTo>
                <a:lnTo>
                  <a:pt x="30479" y="4572"/>
                </a:lnTo>
                <a:close/>
              </a:path>
              <a:path w="56515" h="58419">
                <a:moveTo>
                  <a:pt x="28193" y="9144"/>
                </a:moveTo>
                <a:lnTo>
                  <a:pt x="25907" y="4572"/>
                </a:lnTo>
                <a:lnTo>
                  <a:pt x="25907" y="13716"/>
                </a:lnTo>
                <a:lnTo>
                  <a:pt x="28193" y="9144"/>
                </a:lnTo>
                <a:close/>
              </a:path>
              <a:path w="56515" h="58419">
                <a:moveTo>
                  <a:pt x="30479" y="13716"/>
                </a:moveTo>
                <a:lnTo>
                  <a:pt x="30479" y="4572"/>
                </a:lnTo>
                <a:lnTo>
                  <a:pt x="28193" y="9144"/>
                </a:lnTo>
                <a:lnTo>
                  <a:pt x="30479" y="13716"/>
                </a:lnTo>
                <a:close/>
              </a:path>
              <a:path w="56515" h="58419">
                <a:moveTo>
                  <a:pt x="54863" y="51816"/>
                </a:moveTo>
                <a:lnTo>
                  <a:pt x="49529" y="51816"/>
                </a:lnTo>
                <a:lnTo>
                  <a:pt x="51815" y="56388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3" name="object 133"/>
          <p:cNvSpPr/>
          <p:nvPr/>
        </p:nvSpPr>
        <p:spPr>
          <a:xfrm>
            <a:off x="5178437" y="792480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5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5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5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5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4" name="object 134"/>
          <p:cNvSpPr txBox="1"/>
          <p:nvPr/>
        </p:nvSpPr>
        <p:spPr>
          <a:xfrm>
            <a:off x="5854575" y="2385817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35" name="object 135"/>
          <p:cNvSpPr txBox="1"/>
          <p:nvPr/>
        </p:nvSpPr>
        <p:spPr>
          <a:xfrm>
            <a:off x="8180203" y="1310340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6" name="object 136"/>
          <p:cNvSpPr txBox="1"/>
          <p:nvPr/>
        </p:nvSpPr>
        <p:spPr>
          <a:xfrm>
            <a:off x="8180203" y="1610614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7" name="object 137"/>
          <p:cNvSpPr txBox="1"/>
          <p:nvPr/>
        </p:nvSpPr>
        <p:spPr>
          <a:xfrm>
            <a:off x="8180203" y="1904746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8" name="object 138"/>
          <p:cNvSpPr txBox="1"/>
          <p:nvPr/>
        </p:nvSpPr>
        <p:spPr>
          <a:xfrm>
            <a:off x="8085714" y="904532"/>
            <a:ext cx="433705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6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39" name="object 139"/>
          <p:cNvSpPr txBox="1"/>
          <p:nvPr/>
        </p:nvSpPr>
        <p:spPr>
          <a:xfrm>
            <a:off x="5270887" y="854664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40" name="object 140"/>
          <p:cNvSpPr/>
          <p:nvPr/>
        </p:nvSpPr>
        <p:spPr>
          <a:xfrm>
            <a:off x="5861189" y="3959352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1" name="object 141"/>
          <p:cNvSpPr/>
          <p:nvPr/>
        </p:nvSpPr>
        <p:spPr>
          <a:xfrm>
            <a:off x="5999873" y="3601211"/>
            <a:ext cx="1827530" cy="0"/>
          </a:xfrm>
          <a:custGeom>
            <a:avLst/>
            <a:gdLst/>
            <a:ahLst/>
            <a:cxnLst/>
            <a:rect l="l" t="t" r="r" b="b"/>
            <a:pathLst>
              <a:path w="1827529">
                <a:moveTo>
                  <a:pt x="0" y="0"/>
                </a:moveTo>
                <a:lnTo>
                  <a:pt x="1827275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2" name="object 142"/>
          <p:cNvSpPr/>
          <p:nvPr/>
        </p:nvSpPr>
        <p:spPr>
          <a:xfrm>
            <a:off x="5861189" y="3601211"/>
            <a:ext cx="78105" cy="0"/>
          </a:xfrm>
          <a:custGeom>
            <a:avLst/>
            <a:gdLst/>
            <a:ahLst/>
            <a:cxnLst/>
            <a:rect l="l" t="t" r="r" b="b"/>
            <a:pathLst>
              <a:path w="78104">
                <a:moveTo>
                  <a:pt x="0" y="0"/>
                </a:moveTo>
                <a:lnTo>
                  <a:pt x="77723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3" name="object 143"/>
          <p:cNvSpPr/>
          <p:nvPr/>
        </p:nvSpPr>
        <p:spPr>
          <a:xfrm>
            <a:off x="5861189" y="324154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4" name="object 144"/>
          <p:cNvSpPr/>
          <p:nvPr/>
        </p:nvSpPr>
        <p:spPr>
          <a:xfrm>
            <a:off x="5861189" y="288340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5" name="object 145"/>
          <p:cNvSpPr/>
          <p:nvPr/>
        </p:nvSpPr>
        <p:spPr>
          <a:xfrm>
            <a:off x="5888621" y="2883407"/>
            <a:ext cx="0" cy="1464945"/>
          </a:xfrm>
          <a:custGeom>
            <a:avLst/>
            <a:gdLst/>
            <a:ahLst/>
            <a:cxnLst/>
            <a:rect l="l" t="t" r="r" b="b"/>
            <a:pathLst>
              <a:path h="1464945">
                <a:moveTo>
                  <a:pt x="0" y="0"/>
                </a:moveTo>
                <a:lnTo>
                  <a:pt x="0" y="1464563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6" name="object 146"/>
          <p:cNvSpPr/>
          <p:nvPr/>
        </p:nvSpPr>
        <p:spPr>
          <a:xfrm>
            <a:off x="5861189" y="431749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7" name="object 147"/>
          <p:cNvSpPr/>
          <p:nvPr/>
        </p:nvSpPr>
        <p:spPr>
          <a:xfrm>
            <a:off x="6047117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8" name="object 148"/>
          <p:cNvSpPr/>
          <p:nvPr/>
        </p:nvSpPr>
        <p:spPr>
          <a:xfrm>
            <a:off x="6208662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9" name="object 149"/>
          <p:cNvSpPr/>
          <p:nvPr/>
        </p:nvSpPr>
        <p:spPr>
          <a:xfrm>
            <a:off x="6370193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0" name="object 150"/>
          <p:cNvSpPr/>
          <p:nvPr/>
        </p:nvSpPr>
        <p:spPr>
          <a:xfrm>
            <a:off x="6531749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1" name="object 151"/>
          <p:cNvSpPr/>
          <p:nvPr/>
        </p:nvSpPr>
        <p:spPr>
          <a:xfrm>
            <a:off x="6693281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2" name="object 152"/>
          <p:cNvSpPr/>
          <p:nvPr/>
        </p:nvSpPr>
        <p:spPr>
          <a:xfrm>
            <a:off x="6854825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3" name="object 153"/>
          <p:cNvSpPr/>
          <p:nvPr/>
        </p:nvSpPr>
        <p:spPr>
          <a:xfrm>
            <a:off x="7016381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4" name="object 154"/>
          <p:cNvSpPr/>
          <p:nvPr/>
        </p:nvSpPr>
        <p:spPr>
          <a:xfrm>
            <a:off x="7177925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5" name="object 155"/>
          <p:cNvSpPr/>
          <p:nvPr/>
        </p:nvSpPr>
        <p:spPr>
          <a:xfrm>
            <a:off x="7339469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6" name="object 156"/>
          <p:cNvSpPr/>
          <p:nvPr/>
        </p:nvSpPr>
        <p:spPr>
          <a:xfrm>
            <a:off x="7501001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7" name="object 157"/>
          <p:cNvSpPr/>
          <p:nvPr/>
        </p:nvSpPr>
        <p:spPr>
          <a:xfrm>
            <a:off x="7662557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8" name="object 158"/>
          <p:cNvSpPr/>
          <p:nvPr/>
        </p:nvSpPr>
        <p:spPr>
          <a:xfrm>
            <a:off x="7824101" y="431749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9" name="object 159"/>
          <p:cNvSpPr/>
          <p:nvPr/>
        </p:nvSpPr>
        <p:spPr>
          <a:xfrm>
            <a:off x="5889891" y="3197098"/>
            <a:ext cx="1978647" cy="709168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0" name="object 160"/>
          <p:cNvSpPr txBox="1"/>
          <p:nvPr/>
        </p:nvSpPr>
        <p:spPr>
          <a:xfrm>
            <a:off x="5752471" y="4260850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1" name="object 161"/>
          <p:cNvSpPr txBox="1"/>
          <p:nvPr/>
        </p:nvSpPr>
        <p:spPr>
          <a:xfrm>
            <a:off x="5708272" y="3902710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2" name="object 162"/>
          <p:cNvSpPr txBox="1"/>
          <p:nvPr/>
        </p:nvSpPr>
        <p:spPr>
          <a:xfrm>
            <a:off x="5665603" y="3543042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3" name="object 163"/>
          <p:cNvSpPr txBox="1"/>
          <p:nvPr/>
        </p:nvSpPr>
        <p:spPr>
          <a:xfrm>
            <a:off x="5621404" y="3184902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4" name="object 164"/>
          <p:cNvSpPr txBox="1"/>
          <p:nvPr/>
        </p:nvSpPr>
        <p:spPr>
          <a:xfrm>
            <a:off x="5577206" y="2825243"/>
            <a:ext cx="24511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5" name="object 165"/>
          <p:cNvSpPr/>
          <p:nvPr/>
        </p:nvSpPr>
        <p:spPr>
          <a:xfrm>
            <a:off x="7999361" y="3348228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6" name="object 166"/>
          <p:cNvSpPr/>
          <p:nvPr/>
        </p:nvSpPr>
        <p:spPr>
          <a:xfrm>
            <a:off x="8066405" y="3322320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7" name="object 167"/>
          <p:cNvSpPr/>
          <p:nvPr/>
        </p:nvSpPr>
        <p:spPr>
          <a:xfrm>
            <a:off x="8063369" y="3320796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5" h="56514">
                <a:moveTo>
                  <a:pt x="56387" y="30480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30480"/>
                </a:lnTo>
                <a:lnTo>
                  <a:pt x="4571" y="35052"/>
                </a:lnTo>
                <a:lnTo>
                  <a:pt x="4571" y="25908"/>
                </a:lnTo>
                <a:lnTo>
                  <a:pt x="6857" y="28193"/>
                </a:lnTo>
                <a:lnTo>
                  <a:pt x="25907" y="9143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9144"/>
                </a:lnTo>
                <a:lnTo>
                  <a:pt x="49529" y="28194"/>
                </a:lnTo>
                <a:lnTo>
                  <a:pt x="51815" y="25908"/>
                </a:lnTo>
                <a:lnTo>
                  <a:pt x="51815" y="35052"/>
                </a:lnTo>
                <a:lnTo>
                  <a:pt x="56387" y="30480"/>
                </a:lnTo>
                <a:close/>
              </a:path>
              <a:path w="56515" h="56514">
                <a:moveTo>
                  <a:pt x="6857" y="28194"/>
                </a:moveTo>
                <a:lnTo>
                  <a:pt x="4571" y="25908"/>
                </a:lnTo>
                <a:lnTo>
                  <a:pt x="4571" y="30480"/>
                </a:lnTo>
                <a:lnTo>
                  <a:pt x="6857" y="28194"/>
                </a:lnTo>
                <a:close/>
              </a:path>
              <a:path w="56515" h="56514">
                <a:moveTo>
                  <a:pt x="28193" y="49530"/>
                </a:moveTo>
                <a:lnTo>
                  <a:pt x="6857" y="28194"/>
                </a:lnTo>
                <a:lnTo>
                  <a:pt x="4571" y="30480"/>
                </a:lnTo>
                <a:lnTo>
                  <a:pt x="4571" y="35052"/>
                </a:lnTo>
                <a:lnTo>
                  <a:pt x="25907" y="56388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6514">
                <a:moveTo>
                  <a:pt x="30479" y="4572"/>
                </a:moveTo>
                <a:lnTo>
                  <a:pt x="25907" y="4572"/>
                </a:lnTo>
                <a:lnTo>
                  <a:pt x="28193" y="6857"/>
                </a:lnTo>
                <a:lnTo>
                  <a:pt x="30479" y="4572"/>
                </a:lnTo>
                <a:close/>
              </a:path>
              <a:path w="56515" h="56514">
                <a:moveTo>
                  <a:pt x="28193" y="6858"/>
                </a:moveTo>
                <a:lnTo>
                  <a:pt x="25907" y="4572"/>
                </a:lnTo>
                <a:lnTo>
                  <a:pt x="25907" y="9143"/>
                </a:lnTo>
                <a:lnTo>
                  <a:pt x="28193" y="6858"/>
                </a:lnTo>
                <a:close/>
              </a:path>
              <a:path w="56515" h="56514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6514">
                <a:moveTo>
                  <a:pt x="30479" y="56388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6388"/>
                </a:lnTo>
                <a:lnTo>
                  <a:pt x="30479" y="56388"/>
                </a:lnTo>
                <a:close/>
              </a:path>
              <a:path w="56515" h="56514">
                <a:moveTo>
                  <a:pt x="30479" y="9144"/>
                </a:moveTo>
                <a:lnTo>
                  <a:pt x="30479" y="4572"/>
                </a:lnTo>
                <a:lnTo>
                  <a:pt x="28193" y="6858"/>
                </a:lnTo>
                <a:lnTo>
                  <a:pt x="30479" y="9144"/>
                </a:lnTo>
                <a:close/>
              </a:path>
              <a:path w="56515" h="56514">
                <a:moveTo>
                  <a:pt x="51815" y="35052"/>
                </a:moveTo>
                <a:lnTo>
                  <a:pt x="51815" y="30480"/>
                </a:lnTo>
                <a:lnTo>
                  <a:pt x="49529" y="28193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6388"/>
                </a:lnTo>
                <a:lnTo>
                  <a:pt x="51815" y="35052"/>
                </a:lnTo>
                <a:close/>
              </a:path>
              <a:path w="56515" h="56514">
                <a:moveTo>
                  <a:pt x="51815" y="30480"/>
                </a:moveTo>
                <a:lnTo>
                  <a:pt x="51815" y="25908"/>
                </a:lnTo>
                <a:lnTo>
                  <a:pt x="49529" y="28193"/>
                </a:lnTo>
                <a:lnTo>
                  <a:pt x="51815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8" name="object 168"/>
          <p:cNvSpPr/>
          <p:nvPr/>
        </p:nvSpPr>
        <p:spPr>
          <a:xfrm>
            <a:off x="7999361" y="364235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9" name="object 169"/>
          <p:cNvSpPr/>
          <p:nvPr/>
        </p:nvSpPr>
        <p:spPr>
          <a:xfrm>
            <a:off x="8066417" y="3642359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0" name="object 170"/>
          <p:cNvSpPr/>
          <p:nvPr/>
        </p:nvSpPr>
        <p:spPr>
          <a:xfrm>
            <a:off x="8063369" y="3613403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1" name="object 171"/>
          <p:cNvSpPr/>
          <p:nvPr/>
        </p:nvSpPr>
        <p:spPr>
          <a:xfrm>
            <a:off x="7999361" y="3936491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2" name="object 172"/>
          <p:cNvSpPr/>
          <p:nvPr/>
        </p:nvSpPr>
        <p:spPr>
          <a:xfrm>
            <a:off x="8066405" y="3910584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3" name="object 173"/>
          <p:cNvSpPr/>
          <p:nvPr/>
        </p:nvSpPr>
        <p:spPr>
          <a:xfrm>
            <a:off x="8063369" y="3907535"/>
            <a:ext cx="56515" cy="58419"/>
          </a:xfrm>
          <a:custGeom>
            <a:avLst/>
            <a:gdLst/>
            <a:ahLst/>
            <a:cxnLst/>
            <a:rect l="l" t="t" r="r" b="b"/>
            <a:pathLst>
              <a:path w="56515" h="58420">
                <a:moveTo>
                  <a:pt x="56387" y="56388"/>
                </a:moveTo>
                <a:lnTo>
                  <a:pt x="56387" y="53340"/>
                </a:lnTo>
                <a:lnTo>
                  <a:pt x="30479" y="1524"/>
                </a:lnTo>
                <a:lnTo>
                  <a:pt x="28955" y="0"/>
                </a:lnTo>
                <a:lnTo>
                  <a:pt x="25907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6857" y="51816"/>
                </a:lnTo>
                <a:lnTo>
                  <a:pt x="25907" y="13716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13716"/>
                </a:lnTo>
                <a:lnTo>
                  <a:pt x="49529" y="51816"/>
                </a:lnTo>
                <a:lnTo>
                  <a:pt x="54863" y="51816"/>
                </a:lnTo>
                <a:lnTo>
                  <a:pt x="54863" y="57912"/>
                </a:lnTo>
                <a:lnTo>
                  <a:pt x="56387" y="56388"/>
                </a:lnTo>
                <a:close/>
              </a:path>
              <a:path w="56515" h="58420">
                <a:moveTo>
                  <a:pt x="6857" y="51816"/>
                </a:moveTo>
                <a:lnTo>
                  <a:pt x="3047" y="51816"/>
                </a:lnTo>
                <a:lnTo>
                  <a:pt x="4571" y="56388"/>
                </a:lnTo>
                <a:lnTo>
                  <a:pt x="6857" y="51816"/>
                </a:lnTo>
                <a:close/>
              </a:path>
              <a:path w="56515" h="58420">
                <a:moveTo>
                  <a:pt x="54863" y="57912"/>
                </a:moveTo>
                <a:lnTo>
                  <a:pt x="54863" y="51816"/>
                </a:lnTo>
                <a:lnTo>
                  <a:pt x="51815" y="56388"/>
                </a:lnTo>
                <a:lnTo>
                  <a:pt x="49529" y="51816"/>
                </a:lnTo>
                <a:lnTo>
                  <a:pt x="6857" y="51816"/>
                </a:lnTo>
                <a:lnTo>
                  <a:pt x="4571" y="56388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close/>
              </a:path>
              <a:path w="56515" h="58420">
                <a:moveTo>
                  <a:pt x="30479" y="4572"/>
                </a:moveTo>
                <a:lnTo>
                  <a:pt x="25907" y="4572"/>
                </a:lnTo>
                <a:lnTo>
                  <a:pt x="28193" y="9144"/>
                </a:lnTo>
                <a:lnTo>
                  <a:pt x="30479" y="4572"/>
                </a:lnTo>
                <a:close/>
              </a:path>
              <a:path w="56515" h="58420">
                <a:moveTo>
                  <a:pt x="28193" y="9144"/>
                </a:moveTo>
                <a:lnTo>
                  <a:pt x="25907" y="4572"/>
                </a:lnTo>
                <a:lnTo>
                  <a:pt x="25907" y="13716"/>
                </a:lnTo>
                <a:lnTo>
                  <a:pt x="28193" y="9144"/>
                </a:lnTo>
                <a:close/>
              </a:path>
              <a:path w="56515" h="58420">
                <a:moveTo>
                  <a:pt x="30479" y="13716"/>
                </a:moveTo>
                <a:lnTo>
                  <a:pt x="30479" y="4572"/>
                </a:lnTo>
                <a:lnTo>
                  <a:pt x="28193" y="9144"/>
                </a:lnTo>
                <a:lnTo>
                  <a:pt x="30479" y="13716"/>
                </a:lnTo>
                <a:close/>
              </a:path>
              <a:path w="56515" h="58420">
                <a:moveTo>
                  <a:pt x="54863" y="51816"/>
                </a:moveTo>
                <a:lnTo>
                  <a:pt x="49529" y="51816"/>
                </a:lnTo>
                <a:lnTo>
                  <a:pt x="51815" y="56388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4" name="object 174"/>
          <p:cNvSpPr/>
          <p:nvPr/>
        </p:nvSpPr>
        <p:spPr>
          <a:xfrm>
            <a:off x="5178437" y="2767583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5" name="object 175"/>
          <p:cNvSpPr txBox="1"/>
          <p:nvPr/>
        </p:nvSpPr>
        <p:spPr>
          <a:xfrm>
            <a:off x="5854575" y="4360930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76" name="object 176"/>
          <p:cNvSpPr txBox="1"/>
          <p:nvPr/>
        </p:nvSpPr>
        <p:spPr>
          <a:xfrm>
            <a:off x="8180203" y="3285444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77" name="object 177"/>
          <p:cNvSpPr txBox="1"/>
          <p:nvPr/>
        </p:nvSpPr>
        <p:spPr>
          <a:xfrm>
            <a:off x="8180203" y="3585717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78" name="object 178"/>
          <p:cNvSpPr txBox="1"/>
          <p:nvPr/>
        </p:nvSpPr>
        <p:spPr>
          <a:xfrm>
            <a:off x="8180203" y="3879850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79" name="object 179"/>
          <p:cNvSpPr txBox="1"/>
          <p:nvPr/>
        </p:nvSpPr>
        <p:spPr>
          <a:xfrm>
            <a:off x="8085714" y="2879635"/>
            <a:ext cx="448309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1</a:t>
            </a:r>
            <a:r>
              <a:rPr sz="750" b="1" spc="-5" dirty="0">
                <a:latin typeface="Calibri"/>
                <a:cs typeface="Calibri"/>
              </a:rPr>
              <a:t>0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80" name="object 180"/>
          <p:cNvSpPr txBox="1"/>
          <p:nvPr/>
        </p:nvSpPr>
        <p:spPr>
          <a:xfrm>
            <a:off x="5270887" y="2829768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81" name="object 181"/>
          <p:cNvSpPr/>
          <p:nvPr/>
        </p:nvSpPr>
        <p:spPr>
          <a:xfrm>
            <a:off x="5861189" y="581558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2" name="object 182"/>
          <p:cNvSpPr/>
          <p:nvPr/>
        </p:nvSpPr>
        <p:spPr>
          <a:xfrm>
            <a:off x="6888365" y="5337048"/>
            <a:ext cx="939165" cy="0"/>
          </a:xfrm>
          <a:custGeom>
            <a:avLst/>
            <a:gdLst/>
            <a:ahLst/>
            <a:cxnLst/>
            <a:rect l="l" t="t" r="r" b="b"/>
            <a:pathLst>
              <a:path w="939165">
                <a:moveTo>
                  <a:pt x="0" y="0"/>
                </a:moveTo>
                <a:lnTo>
                  <a:pt x="938783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3" name="object 183"/>
          <p:cNvSpPr/>
          <p:nvPr/>
        </p:nvSpPr>
        <p:spPr>
          <a:xfrm>
            <a:off x="6041021" y="5337048"/>
            <a:ext cx="786765" cy="0"/>
          </a:xfrm>
          <a:custGeom>
            <a:avLst/>
            <a:gdLst/>
            <a:ahLst/>
            <a:cxnLst/>
            <a:rect l="l" t="t" r="r" b="b"/>
            <a:pathLst>
              <a:path w="786765">
                <a:moveTo>
                  <a:pt x="0" y="0"/>
                </a:moveTo>
                <a:lnTo>
                  <a:pt x="786384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4" name="object 184"/>
          <p:cNvSpPr/>
          <p:nvPr/>
        </p:nvSpPr>
        <p:spPr>
          <a:xfrm>
            <a:off x="5861189" y="5337048"/>
            <a:ext cx="119380" cy="0"/>
          </a:xfrm>
          <a:custGeom>
            <a:avLst/>
            <a:gdLst/>
            <a:ahLst/>
            <a:cxnLst/>
            <a:rect l="l" t="t" r="r" b="b"/>
            <a:pathLst>
              <a:path w="119379">
                <a:moveTo>
                  <a:pt x="0" y="0"/>
                </a:moveTo>
                <a:lnTo>
                  <a:pt x="118871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5" name="object 185"/>
          <p:cNvSpPr/>
          <p:nvPr/>
        </p:nvSpPr>
        <p:spPr>
          <a:xfrm>
            <a:off x="5861189" y="48585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6" name="object 186"/>
          <p:cNvSpPr/>
          <p:nvPr/>
        </p:nvSpPr>
        <p:spPr>
          <a:xfrm>
            <a:off x="5888621" y="4858511"/>
            <a:ext cx="0" cy="1466215"/>
          </a:xfrm>
          <a:custGeom>
            <a:avLst/>
            <a:gdLst/>
            <a:ahLst/>
            <a:cxnLst/>
            <a:rect l="l" t="t" r="r" b="b"/>
            <a:pathLst>
              <a:path h="1466214">
                <a:moveTo>
                  <a:pt x="0" y="0"/>
                </a:moveTo>
                <a:lnTo>
                  <a:pt x="0" y="1466087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7" name="object 187"/>
          <p:cNvSpPr/>
          <p:nvPr/>
        </p:nvSpPr>
        <p:spPr>
          <a:xfrm>
            <a:off x="5861189" y="6294120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8" name="object 188"/>
          <p:cNvSpPr/>
          <p:nvPr/>
        </p:nvSpPr>
        <p:spPr>
          <a:xfrm>
            <a:off x="6047117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9" name="object 189"/>
          <p:cNvSpPr/>
          <p:nvPr/>
        </p:nvSpPr>
        <p:spPr>
          <a:xfrm>
            <a:off x="6208662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0" name="object 190"/>
          <p:cNvSpPr/>
          <p:nvPr/>
        </p:nvSpPr>
        <p:spPr>
          <a:xfrm>
            <a:off x="6370193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1" name="object 191"/>
          <p:cNvSpPr/>
          <p:nvPr/>
        </p:nvSpPr>
        <p:spPr>
          <a:xfrm>
            <a:off x="6531749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2" name="object 192"/>
          <p:cNvSpPr/>
          <p:nvPr/>
        </p:nvSpPr>
        <p:spPr>
          <a:xfrm>
            <a:off x="669328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3" name="object 193"/>
          <p:cNvSpPr/>
          <p:nvPr/>
        </p:nvSpPr>
        <p:spPr>
          <a:xfrm>
            <a:off x="6854825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4" name="object 194"/>
          <p:cNvSpPr/>
          <p:nvPr/>
        </p:nvSpPr>
        <p:spPr>
          <a:xfrm>
            <a:off x="701638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5" name="object 195"/>
          <p:cNvSpPr/>
          <p:nvPr/>
        </p:nvSpPr>
        <p:spPr>
          <a:xfrm>
            <a:off x="7177925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6" name="object 196"/>
          <p:cNvSpPr/>
          <p:nvPr/>
        </p:nvSpPr>
        <p:spPr>
          <a:xfrm>
            <a:off x="7339469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7" name="object 197"/>
          <p:cNvSpPr/>
          <p:nvPr/>
        </p:nvSpPr>
        <p:spPr>
          <a:xfrm>
            <a:off x="750100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8" name="object 198"/>
          <p:cNvSpPr/>
          <p:nvPr/>
        </p:nvSpPr>
        <p:spPr>
          <a:xfrm>
            <a:off x="7662557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9" name="object 199"/>
          <p:cNvSpPr/>
          <p:nvPr/>
        </p:nvSpPr>
        <p:spPr>
          <a:xfrm>
            <a:off x="782410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0" name="object 200"/>
          <p:cNvSpPr/>
          <p:nvPr/>
        </p:nvSpPr>
        <p:spPr>
          <a:xfrm>
            <a:off x="5889891" y="4963414"/>
            <a:ext cx="1978647" cy="796035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1" name="object 201"/>
          <p:cNvSpPr txBox="1"/>
          <p:nvPr/>
        </p:nvSpPr>
        <p:spPr>
          <a:xfrm>
            <a:off x="5708272" y="5757415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2" name="object 202"/>
          <p:cNvSpPr txBox="1"/>
          <p:nvPr/>
        </p:nvSpPr>
        <p:spPr>
          <a:xfrm>
            <a:off x="5665603" y="5278877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3" name="object 203"/>
          <p:cNvSpPr txBox="1"/>
          <p:nvPr/>
        </p:nvSpPr>
        <p:spPr>
          <a:xfrm>
            <a:off x="5621404" y="4800338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4" name="object 204"/>
          <p:cNvSpPr/>
          <p:nvPr/>
        </p:nvSpPr>
        <p:spPr>
          <a:xfrm>
            <a:off x="7999361" y="532485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5" name="object 205"/>
          <p:cNvSpPr/>
          <p:nvPr/>
        </p:nvSpPr>
        <p:spPr>
          <a:xfrm>
            <a:off x="8066405" y="5298947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6" name="object 206"/>
          <p:cNvSpPr/>
          <p:nvPr/>
        </p:nvSpPr>
        <p:spPr>
          <a:xfrm>
            <a:off x="8063369" y="5297423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5" h="56514">
                <a:moveTo>
                  <a:pt x="56387" y="30480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30480"/>
                </a:lnTo>
                <a:lnTo>
                  <a:pt x="4571" y="35052"/>
                </a:lnTo>
                <a:lnTo>
                  <a:pt x="4571" y="25908"/>
                </a:lnTo>
                <a:lnTo>
                  <a:pt x="6857" y="28193"/>
                </a:lnTo>
                <a:lnTo>
                  <a:pt x="25907" y="9143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9144"/>
                </a:lnTo>
                <a:lnTo>
                  <a:pt x="49529" y="28194"/>
                </a:lnTo>
                <a:lnTo>
                  <a:pt x="51815" y="25908"/>
                </a:lnTo>
                <a:lnTo>
                  <a:pt x="51815" y="35052"/>
                </a:lnTo>
                <a:lnTo>
                  <a:pt x="56387" y="30480"/>
                </a:lnTo>
                <a:close/>
              </a:path>
              <a:path w="56515" h="56514">
                <a:moveTo>
                  <a:pt x="6857" y="28194"/>
                </a:moveTo>
                <a:lnTo>
                  <a:pt x="4571" y="25908"/>
                </a:lnTo>
                <a:lnTo>
                  <a:pt x="4571" y="30480"/>
                </a:lnTo>
                <a:lnTo>
                  <a:pt x="6857" y="28194"/>
                </a:lnTo>
                <a:close/>
              </a:path>
              <a:path w="56515" h="56514">
                <a:moveTo>
                  <a:pt x="28193" y="49530"/>
                </a:moveTo>
                <a:lnTo>
                  <a:pt x="6857" y="28194"/>
                </a:lnTo>
                <a:lnTo>
                  <a:pt x="4571" y="30480"/>
                </a:lnTo>
                <a:lnTo>
                  <a:pt x="4571" y="35052"/>
                </a:lnTo>
                <a:lnTo>
                  <a:pt x="25907" y="56388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6514">
                <a:moveTo>
                  <a:pt x="30479" y="4572"/>
                </a:moveTo>
                <a:lnTo>
                  <a:pt x="25907" y="4572"/>
                </a:lnTo>
                <a:lnTo>
                  <a:pt x="28193" y="6857"/>
                </a:lnTo>
                <a:lnTo>
                  <a:pt x="30479" y="4572"/>
                </a:lnTo>
                <a:close/>
              </a:path>
              <a:path w="56515" h="56514">
                <a:moveTo>
                  <a:pt x="28193" y="6858"/>
                </a:moveTo>
                <a:lnTo>
                  <a:pt x="25907" y="4572"/>
                </a:lnTo>
                <a:lnTo>
                  <a:pt x="25907" y="9143"/>
                </a:lnTo>
                <a:lnTo>
                  <a:pt x="28193" y="6858"/>
                </a:lnTo>
                <a:close/>
              </a:path>
              <a:path w="56515" h="56514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6514">
                <a:moveTo>
                  <a:pt x="30479" y="56388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6388"/>
                </a:lnTo>
                <a:lnTo>
                  <a:pt x="30479" y="56388"/>
                </a:lnTo>
                <a:close/>
              </a:path>
              <a:path w="56515" h="56514">
                <a:moveTo>
                  <a:pt x="30479" y="9144"/>
                </a:moveTo>
                <a:lnTo>
                  <a:pt x="30479" y="4572"/>
                </a:lnTo>
                <a:lnTo>
                  <a:pt x="28193" y="6858"/>
                </a:lnTo>
                <a:lnTo>
                  <a:pt x="30479" y="9144"/>
                </a:lnTo>
                <a:close/>
              </a:path>
              <a:path w="56515" h="56514">
                <a:moveTo>
                  <a:pt x="51815" y="35052"/>
                </a:moveTo>
                <a:lnTo>
                  <a:pt x="51815" y="30480"/>
                </a:lnTo>
                <a:lnTo>
                  <a:pt x="49529" y="28193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6388"/>
                </a:lnTo>
                <a:lnTo>
                  <a:pt x="51815" y="35052"/>
                </a:lnTo>
                <a:close/>
              </a:path>
              <a:path w="56515" h="56514">
                <a:moveTo>
                  <a:pt x="51815" y="30480"/>
                </a:moveTo>
                <a:lnTo>
                  <a:pt x="51815" y="25908"/>
                </a:lnTo>
                <a:lnTo>
                  <a:pt x="49529" y="28193"/>
                </a:lnTo>
                <a:lnTo>
                  <a:pt x="51815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7" name="object 207"/>
          <p:cNvSpPr txBox="1"/>
          <p:nvPr/>
        </p:nvSpPr>
        <p:spPr>
          <a:xfrm>
            <a:off x="8180203" y="5260548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8" name="object 208"/>
          <p:cNvSpPr/>
          <p:nvPr/>
        </p:nvSpPr>
        <p:spPr>
          <a:xfrm>
            <a:off x="7999361" y="5618988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9" name="object 209"/>
          <p:cNvSpPr/>
          <p:nvPr/>
        </p:nvSpPr>
        <p:spPr>
          <a:xfrm>
            <a:off x="8066417" y="5618988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0" name="object 210"/>
          <p:cNvSpPr/>
          <p:nvPr/>
        </p:nvSpPr>
        <p:spPr>
          <a:xfrm>
            <a:off x="8063369" y="5590032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1" name="object 211"/>
          <p:cNvSpPr txBox="1"/>
          <p:nvPr/>
        </p:nvSpPr>
        <p:spPr>
          <a:xfrm>
            <a:off x="8180203" y="5560821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12" name="object 212"/>
          <p:cNvSpPr/>
          <p:nvPr/>
        </p:nvSpPr>
        <p:spPr>
          <a:xfrm>
            <a:off x="7999361" y="5913120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3" name="object 213"/>
          <p:cNvSpPr/>
          <p:nvPr/>
        </p:nvSpPr>
        <p:spPr>
          <a:xfrm>
            <a:off x="8066405" y="5887211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4" name="object 214"/>
          <p:cNvSpPr/>
          <p:nvPr/>
        </p:nvSpPr>
        <p:spPr>
          <a:xfrm>
            <a:off x="8063369" y="5884164"/>
            <a:ext cx="56515" cy="58419"/>
          </a:xfrm>
          <a:custGeom>
            <a:avLst/>
            <a:gdLst/>
            <a:ahLst/>
            <a:cxnLst/>
            <a:rect l="l" t="t" r="r" b="b"/>
            <a:pathLst>
              <a:path w="56515" h="58420">
                <a:moveTo>
                  <a:pt x="56387" y="56388"/>
                </a:moveTo>
                <a:lnTo>
                  <a:pt x="56387" y="53340"/>
                </a:lnTo>
                <a:lnTo>
                  <a:pt x="30479" y="1524"/>
                </a:lnTo>
                <a:lnTo>
                  <a:pt x="28955" y="0"/>
                </a:lnTo>
                <a:lnTo>
                  <a:pt x="25907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6857" y="51816"/>
                </a:lnTo>
                <a:lnTo>
                  <a:pt x="25907" y="13716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13716"/>
                </a:lnTo>
                <a:lnTo>
                  <a:pt x="49529" y="51816"/>
                </a:lnTo>
                <a:lnTo>
                  <a:pt x="54863" y="51816"/>
                </a:lnTo>
                <a:lnTo>
                  <a:pt x="54863" y="57912"/>
                </a:lnTo>
                <a:lnTo>
                  <a:pt x="56387" y="56388"/>
                </a:lnTo>
                <a:close/>
              </a:path>
              <a:path w="56515" h="58420">
                <a:moveTo>
                  <a:pt x="6857" y="51816"/>
                </a:moveTo>
                <a:lnTo>
                  <a:pt x="3047" y="51816"/>
                </a:lnTo>
                <a:lnTo>
                  <a:pt x="4571" y="56388"/>
                </a:lnTo>
                <a:lnTo>
                  <a:pt x="6857" y="51816"/>
                </a:lnTo>
                <a:close/>
              </a:path>
              <a:path w="56515" h="58420">
                <a:moveTo>
                  <a:pt x="54863" y="57912"/>
                </a:moveTo>
                <a:lnTo>
                  <a:pt x="54863" y="51816"/>
                </a:lnTo>
                <a:lnTo>
                  <a:pt x="51815" y="56388"/>
                </a:lnTo>
                <a:lnTo>
                  <a:pt x="49529" y="51816"/>
                </a:lnTo>
                <a:lnTo>
                  <a:pt x="6857" y="51816"/>
                </a:lnTo>
                <a:lnTo>
                  <a:pt x="4571" y="56388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close/>
              </a:path>
              <a:path w="56515" h="58420">
                <a:moveTo>
                  <a:pt x="30479" y="4572"/>
                </a:moveTo>
                <a:lnTo>
                  <a:pt x="25907" y="4572"/>
                </a:lnTo>
                <a:lnTo>
                  <a:pt x="28193" y="9144"/>
                </a:lnTo>
                <a:lnTo>
                  <a:pt x="30479" y="4572"/>
                </a:lnTo>
                <a:close/>
              </a:path>
              <a:path w="56515" h="58420">
                <a:moveTo>
                  <a:pt x="28193" y="9144"/>
                </a:moveTo>
                <a:lnTo>
                  <a:pt x="25907" y="4572"/>
                </a:lnTo>
                <a:lnTo>
                  <a:pt x="25907" y="13716"/>
                </a:lnTo>
                <a:lnTo>
                  <a:pt x="28193" y="9144"/>
                </a:lnTo>
                <a:close/>
              </a:path>
              <a:path w="56515" h="58420">
                <a:moveTo>
                  <a:pt x="30479" y="13716"/>
                </a:moveTo>
                <a:lnTo>
                  <a:pt x="30479" y="4572"/>
                </a:lnTo>
                <a:lnTo>
                  <a:pt x="28193" y="9144"/>
                </a:lnTo>
                <a:lnTo>
                  <a:pt x="30479" y="13716"/>
                </a:lnTo>
                <a:close/>
              </a:path>
              <a:path w="56515" h="58420">
                <a:moveTo>
                  <a:pt x="54863" y="51816"/>
                </a:moveTo>
                <a:lnTo>
                  <a:pt x="49529" y="51816"/>
                </a:lnTo>
                <a:lnTo>
                  <a:pt x="51815" y="56388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5" name="object 215"/>
          <p:cNvSpPr txBox="1"/>
          <p:nvPr/>
        </p:nvSpPr>
        <p:spPr>
          <a:xfrm>
            <a:off x="8180203" y="5854953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16" name="object 216"/>
          <p:cNvSpPr/>
          <p:nvPr/>
        </p:nvSpPr>
        <p:spPr>
          <a:xfrm>
            <a:off x="5178437" y="4742688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7" name="object 217"/>
          <p:cNvSpPr txBox="1"/>
          <p:nvPr/>
        </p:nvSpPr>
        <p:spPr>
          <a:xfrm>
            <a:off x="8085714" y="4854740"/>
            <a:ext cx="448309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1</a:t>
            </a:r>
            <a:r>
              <a:rPr sz="750" b="1" spc="-5" dirty="0">
                <a:latin typeface="Calibri"/>
                <a:cs typeface="Calibri"/>
              </a:rPr>
              <a:t>4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T</a:t>
            </a:r>
            <a:r>
              <a:rPr sz="750" b="1" spc="-10" dirty="0">
                <a:latin typeface="Calibri"/>
                <a:cs typeface="Calibri"/>
              </a:rPr>
              <a:t>1</a:t>
            </a:r>
            <a:r>
              <a:rPr sz="750" b="1" spc="-5" dirty="0">
                <a:latin typeface="Calibri"/>
                <a:cs typeface="Calibri"/>
              </a:rPr>
              <a:t>T2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219" name="object 219"/>
          <p:cNvSpPr txBox="1"/>
          <p:nvPr/>
        </p:nvSpPr>
        <p:spPr>
          <a:xfrm>
            <a:off x="1622431" y="6235953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20" name="object 220"/>
          <p:cNvSpPr txBox="1"/>
          <p:nvPr/>
        </p:nvSpPr>
        <p:spPr>
          <a:xfrm>
            <a:off x="5752471" y="6235953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21" name="object 221"/>
          <p:cNvSpPr txBox="1">
            <a:spLocks noGrp="1"/>
          </p:cNvSpPr>
          <p:nvPr>
            <p:ph type="ftr" sz="quarter" idx="5"/>
          </p:nvPr>
        </p:nvSpPr>
        <p:spPr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/>
              <a:t>6     </a:t>
            </a:r>
            <a:r>
              <a:rPr sz="650" spc="40" dirty="0"/>
              <a:t> </a:t>
            </a:r>
            <a:r>
              <a:rPr sz="650" spc="15" dirty="0"/>
              <a:t>7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8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9</a:t>
            </a:r>
            <a:r>
              <a:rPr sz="650" dirty="0"/>
              <a:t>    </a:t>
            </a:r>
            <a:r>
              <a:rPr sz="650" spc="20" dirty="0"/>
              <a:t> </a:t>
            </a:r>
            <a:r>
              <a:rPr sz="650" spc="15" dirty="0"/>
              <a:t>10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1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</a:t>
            </a:r>
            <a:r>
              <a:rPr sz="650" spc="30" dirty="0"/>
              <a:t>2</a:t>
            </a:r>
            <a:r>
              <a:rPr spc="-5" dirty="0"/>
              <a:t>t</a:t>
            </a:r>
            <a:r>
              <a:rPr spc="-10" dirty="0"/>
              <a:t>i</a:t>
            </a:r>
            <a:r>
              <a:rPr spc="-5" dirty="0"/>
              <a:t>me</a:t>
            </a:r>
            <a:r>
              <a:rPr dirty="0"/>
              <a:t> </a:t>
            </a:r>
            <a:r>
              <a:rPr spc="-5" dirty="0"/>
              <a:t>(h)</a:t>
            </a:r>
            <a:endParaRPr sz="650"/>
          </a:p>
        </p:txBody>
      </p:sp>
      <p:sp>
        <p:nvSpPr>
          <p:cNvPr id="222" name="object 222"/>
          <p:cNvSpPr txBox="1"/>
          <p:nvPr/>
        </p:nvSpPr>
        <p:spPr>
          <a:xfrm>
            <a:off x="6823918" y="6336026"/>
            <a:ext cx="137160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6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223" name="object 223"/>
          <p:cNvSpPr txBox="1">
            <a:spLocks noGrp="1"/>
          </p:cNvSpPr>
          <p:nvPr>
            <p:ph type="dt" sz="half" idx="6"/>
          </p:nvPr>
        </p:nvSpPr>
        <p:spPr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pc="15" dirty="0"/>
              <a:t>0     </a:t>
            </a:r>
            <a:r>
              <a:rPr spc="40" dirty="0"/>
              <a:t> </a:t>
            </a:r>
            <a:r>
              <a:rPr spc="15" dirty="0"/>
              <a:t>1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2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3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4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5</a:t>
            </a:r>
          </a:p>
        </p:txBody>
      </p:sp>
      <p:sp>
        <p:nvSpPr>
          <p:cNvPr id="224" name="object 224"/>
          <p:cNvSpPr txBox="1"/>
          <p:nvPr/>
        </p:nvSpPr>
        <p:spPr>
          <a:xfrm>
            <a:off x="5854575" y="6348726"/>
            <a:ext cx="877569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18" name="object 218"/>
          <p:cNvSpPr txBox="1"/>
          <p:nvPr/>
        </p:nvSpPr>
        <p:spPr>
          <a:xfrm>
            <a:off x="5270887" y="4804872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731149" y="216560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1731149" y="1985772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1731149" y="180593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1869833" y="1626107"/>
            <a:ext cx="1827530" cy="0"/>
          </a:xfrm>
          <a:custGeom>
            <a:avLst/>
            <a:gdLst/>
            <a:ahLst/>
            <a:cxnLst/>
            <a:rect l="l" t="t" r="r" b="b"/>
            <a:pathLst>
              <a:path w="1827529">
                <a:moveTo>
                  <a:pt x="0" y="0"/>
                </a:moveTo>
                <a:lnTo>
                  <a:pt x="1827275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731149" y="1626107"/>
            <a:ext cx="78105" cy="0"/>
          </a:xfrm>
          <a:custGeom>
            <a:avLst/>
            <a:gdLst/>
            <a:ahLst/>
            <a:cxnLst/>
            <a:rect l="l" t="t" r="r" b="b"/>
            <a:pathLst>
              <a:path w="78105">
                <a:moveTo>
                  <a:pt x="0" y="0"/>
                </a:moveTo>
                <a:lnTo>
                  <a:pt x="77724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1731149" y="144779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1731149" y="126796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1731149" y="108813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1731149" y="908303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1758569" y="908303"/>
            <a:ext cx="0" cy="1403985"/>
          </a:xfrm>
          <a:custGeom>
            <a:avLst/>
            <a:gdLst/>
            <a:ahLst/>
            <a:cxnLst/>
            <a:rect l="l" t="t" r="r" b="b"/>
            <a:pathLst>
              <a:path h="1403985">
                <a:moveTo>
                  <a:pt x="0" y="0"/>
                </a:moveTo>
                <a:lnTo>
                  <a:pt x="0" y="1403603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1789061" y="2343911"/>
            <a:ext cx="1908175" cy="0"/>
          </a:xfrm>
          <a:custGeom>
            <a:avLst/>
            <a:gdLst/>
            <a:ahLst/>
            <a:cxnLst/>
            <a:rect l="l" t="t" r="r" b="b"/>
            <a:pathLst>
              <a:path w="1908175">
                <a:moveTo>
                  <a:pt x="0" y="0"/>
                </a:moveTo>
                <a:lnTo>
                  <a:pt x="1908047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1718703" y="1028446"/>
            <a:ext cx="2019808" cy="1357249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" name="object 14"/>
          <p:cNvSpPr txBox="1"/>
          <p:nvPr/>
        </p:nvSpPr>
        <p:spPr>
          <a:xfrm>
            <a:off x="1535563" y="1927606"/>
            <a:ext cx="156845" cy="47561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ctr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marL="55244">
              <a:lnSpc>
                <a:spcPct val="100000"/>
              </a:lnSpc>
              <a:spcBef>
                <a:spcPts val="620"/>
              </a:spcBef>
            </a:pPr>
            <a:r>
              <a:rPr sz="650" spc="15" dirty="0">
                <a:latin typeface="Calibri"/>
                <a:cs typeface="Calibri"/>
              </a:rPr>
              <a:t>50</a:t>
            </a:r>
            <a:endParaRPr sz="650">
              <a:latin typeface="Calibri"/>
              <a:cs typeface="Calibri"/>
            </a:endParaRPr>
          </a:p>
          <a:p>
            <a:pPr>
              <a:lnSpc>
                <a:spcPts val="600"/>
              </a:lnSpc>
              <a:spcBef>
                <a:spcPts val="36"/>
              </a:spcBef>
            </a:pPr>
            <a:endParaRPr sz="600"/>
          </a:p>
          <a:p>
            <a:pPr marL="86360" algn="ctr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1535563" y="1747772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1535563" y="1567938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1535563" y="1389633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8" name="object 18"/>
          <p:cNvSpPr txBox="1"/>
          <p:nvPr/>
        </p:nvSpPr>
        <p:spPr>
          <a:xfrm>
            <a:off x="1535563" y="850131"/>
            <a:ext cx="156845" cy="47688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>
              <a:lnSpc>
                <a:spcPts val="600"/>
              </a:lnSpc>
              <a:spcBef>
                <a:spcPts val="36"/>
              </a:spcBef>
            </a:pPr>
            <a:endParaRPr sz="600"/>
          </a:p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>
              <a:lnSpc>
                <a:spcPts val="600"/>
              </a:lnSpc>
              <a:spcBef>
                <a:spcPts val="36"/>
              </a:spcBef>
            </a:pPr>
            <a:endParaRPr sz="600"/>
          </a:p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" name="object 19"/>
          <p:cNvSpPr/>
          <p:nvPr/>
        </p:nvSpPr>
        <p:spPr>
          <a:xfrm>
            <a:off x="3869321" y="1374647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" name="object 20"/>
          <p:cNvSpPr/>
          <p:nvPr/>
        </p:nvSpPr>
        <p:spPr>
          <a:xfrm>
            <a:off x="3936377" y="1348739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" name="object 21"/>
          <p:cNvSpPr/>
          <p:nvPr/>
        </p:nvSpPr>
        <p:spPr>
          <a:xfrm>
            <a:off x="3933329" y="1347216"/>
            <a:ext cx="56515" cy="55244"/>
          </a:xfrm>
          <a:custGeom>
            <a:avLst/>
            <a:gdLst/>
            <a:ahLst/>
            <a:cxnLst/>
            <a:rect l="l" t="t" r="r" b="b"/>
            <a:pathLst>
              <a:path w="56514" h="55244">
                <a:moveTo>
                  <a:pt x="56388" y="28956"/>
                </a:moveTo>
                <a:lnTo>
                  <a:pt x="56388" y="25908"/>
                </a:lnTo>
                <a:lnTo>
                  <a:pt x="30480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28956"/>
                </a:lnTo>
                <a:lnTo>
                  <a:pt x="4572" y="33528"/>
                </a:lnTo>
                <a:lnTo>
                  <a:pt x="4572" y="25908"/>
                </a:lnTo>
                <a:lnTo>
                  <a:pt x="6096" y="27432"/>
                </a:lnTo>
                <a:lnTo>
                  <a:pt x="25908" y="7620"/>
                </a:lnTo>
                <a:lnTo>
                  <a:pt x="25908" y="3048"/>
                </a:lnTo>
                <a:lnTo>
                  <a:pt x="30480" y="3047"/>
                </a:lnTo>
                <a:lnTo>
                  <a:pt x="30480" y="7619"/>
                </a:lnTo>
                <a:lnTo>
                  <a:pt x="50292" y="27432"/>
                </a:lnTo>
                <a:lnTo>
                  <a:pt x="51816" y="25908"/>
                </a:lnTo>
                <a:lnTo>
                  <a:pt x="51816" y="33528"/>
                </a:lnTo>
                <a:lnTo>
                  <a:pt x="56388" y="28956"/>
                </a:lnTo>
                <a:close/>
              </a:path>
              <a:path w="56514" h="55244">
                <a:moveTo>
                  <a:pt x="6096" y="27432"/>
                </a:moveTo>
                <a:lnTo>
                  <a:pt x="4572" y="25908"/>
                </a:lnTo>
                <a:lnTo>
                  <a:pt x="4572" y="28956"/>
                </a:lnTo>
                <a:lnTo>
                  <a:pt x="6096" y="27432"/>
                </a:lnTo>
                <a:close/>
              </a:path>
              <a:path w="56514" h="55244">
                <a:moveTo>
                  <a:pt x="28194" y="49530"/>
                </a:moveTo>
                <a:lnTo>
                  <a:pt x="6096" y="27432"/>
                </a:lnTo>
                <a:lnTo>
                  <a:pt x="4572" y="28956"/>
                </a:lnTo>
                <a:lnTo>
                  <a:pt x="4572" y="33528"/>
                </a:lnTo>
                <a:lnTo>
                  <a:pt x="25908" y="54864"/>
                </a:lnTo>
                <a:lnTo>
                  <a:pt x="25908" y="51816"/>
                </a:lnTo>
                <a:lnTo>
                  <a:pt x="28194" y="49530"/>
                </a:lnTo>
                <a:close/>
              </a:path>
              <a:path w="56514" h="55244">
                <a:moveTo>
                  <a:pt x="30480" y="3047"/>
                </a:moveTo>
                <a:lnTo>
                  <a:pt x="25908" y="3048"/>
                </a:lnTo>
                <a:lnTo>
                  <a:pt x="28194" y="5333"/>
                </a:lnTo>
                <a:lnTo>
                  <a:pt x="30480" y="3047"/>
                </a:lnTo>
                <a:close/>
              </a:path>
              <a:path w="56514" h="55244">
                <a:moveTo>
                  <a:pt x="28194" y="5334"/>
                </a:moveTo>
                <a:lnTo>
                  <a:pt x="25908" y="3048"/>
                </a:lnTo>
                <a:lnTo>
                  <a:pt x="25908" y="7620"/>
                </a:lnTo>
                <a:lnTo>
                  <a:pt x="28194" y="5334"/>
                </a:lnTo>
                <a:close/>
              </a:path>
              <a:path w="56514" h="55244">
                <a:moveTo>
                  <a:pt x="30480" y="51816"/>
                </a:moveTo>
                <a:lnTo>
                  <a:pt x="28194" y="49530"/>
                </a:lnTo>
                <a:lnTo>
                  <a:pt x="25908" y="51816"/>
                </a:lnTo>
                <a:lnTo>
                  <a:pt x="30480" y="51816"/>
                </a:lnTo>
                <a:close/>
              </a:path>
              <a:path w="56514" h="55244">
                <a:moveTo>
                  <a:pt x="30480" y="54864"/>
                </a:moveTo>
                <a:lnTo>
                  <a:pt x="30480" y="51816"/>
                </a:lnTo>
                <a:lnTo>
                  <a:pt x="25908" y="51816"/>
                </a:lnTo>
                <a:lnTo>
                  <a:pt x="25908" y="54864"/>
                </a:lnTo>
                <a:lnTo>
                  <a:pt x="30480" y="54864"/>
                </a:lnTo>
                <a:close/>
              </a:path>
              <a:path w="56514" h="55244">
                <a:moveTo>
                  <a:pt x="30480" y="7619"/>
                </a:moveTo>
                <a:lnTo>
                  <a:pt x="30480" y="3047"/>
                </a:lnTo>
                <a:lnTo>
                  <a:pt x="28194" y="5334"/>
                </a:lnTo>
                <a:lnTo>
                  <a:pt x="30480" y="7619"/>
                </a:lnTo>
                <a:close/>
              </a:path>
              <a:path w="56514" h="55244">
                <a:moveTo>
                  <a:pt x="51816" y="33528"/>
                </a:moveTo>
                <a:lnTo>
                  <a:pt x="51816" y="28956"/>
                </a:lnTo>
                <a:lnTo>
                  <a:pt x="50292" y="27432"/>
                </a:lnTo>
                <a:lnTo>
                  <a:pt x="28194" y="49530"/>
                </a:lnTo>
                <a:lnTo>
                  <a:pt x="30480" y="51816"/>
                </a:lnTo>
                <a:lnTo>
                  <a:pt x="30480" y="54864"/>
                </a:lnTo>
                <a:lnTo>
                  <a:pt x="51816" y="33528"/>
                </a:lnTo>
                <a:close/>
              </a:path>
              <a:path w="56514" h="55244">
                <a:moveTo>
                  <a:pt x="51816" y="28956"/>
                </a:moveTo>
                <a:lnTo>
                  <a:pt x="51816" y="25908"/>
                </a:lnTo>
                <a:lnTo>
                  <a:pt x="50292" y="27432"/>
                </a:lnTo>
                <a:lnTo>
                  <a:pt x="51816" y="28956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3869321" y="166877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3936377" y="1668779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3933329" y="1639823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19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19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19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19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19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19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3869321" y="1962911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3936377" y="1937004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3933329" y="1933955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6388"/>
                </a:moveTo>
                <a:lnTo>
                  <a:pt x="57912" y="53340"/>
                </a:lnTo>
                <a:lnTo>
                  <a:pt x="32004" y="1524"/>
                </a:lnTo>
                <a:lnTo>
                  <a:pt x="28956" y="0"/>
                </a:lnTo>
                <a:lnTo>
                  <a:pt x="25908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8382" y="51816"/>
                </a:lnTo>
                <a:lnTo>
                  <a:pt x="25908" y="16764"/>
                </a:lnTo>
                <a:lnTo>
                  <a:pt x="25908" y="4572"/>
                </a:lnTo>
                <a:lnTo>
                  <a:pt x="32004" y="4572"/>
                </a:lnTo>
                <a:lnTo>
                  <a:pt x="32004" y="16764"/>
                </a:lnTo>
                <a:lnTo>
                  <a:pt x="49530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19">
                <a:moveTo>
                  <a:pt x="8382" y="51816"/>
                </a:moveTo>
                <a:lnTo>
                  <a:pt x="3048" y="51816"/>
                </a:lnTo>
                <a:lnTo>
                  <a:pt x="6096" y="56388"/>
                </a:lnTo>
                <a:lnTo>
                  <a:pt x="8382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6388"/>
                </a:lnTo>
                <a:lnTo>
                  <a:pt x="49530" y="51816"/>
                </a:lnTo>
                <a:lnTo>
                  <a:pt x="8382" y="51816"/>
                </a:lnTo>
                <a:lnTo>
                  <a:pt x="6096" y="56388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19">
                <a:moveTo>
                  <a:pt x="32004" y="4572"/>
                </a:moveTo>
                <a:lnTo>
                  <a:pt x="25908" y="4572"/>
                </a:lnTo>
                <a:lnTo>
                  <a:pt x="28956" y="10668"/>
                </a:lnTo>
                <a:lnTo>
                  <a:pt x="32004" y="4572"/>
                </a:lnTo>
                <a:close/>
              </a:path>
              <a:path w="58420" h="58419">
                <a:moveTo>
                  <a:pt x="28956" y="10668"/>
                </a:moveTo>
                <a:lnTo>
                  <a:pt x="25908" y="4572"/>
                </a:lnTo>
                <a:lnTo>
                  <a:pt x="25908" y="16764"/>
                </a:lnTo>
                <a:lnTo>
                  <a:pt x="28956" y="10668"/>
                </a:lnTo>
                <a:close/>
              </a:path>
              <a:path w="58420" h="58419">
                <a:moveTo>
                  <a:pt x="32004" y="16764"/>
                </a:moveTo>
                <a:lnTo>
                  <a:pt x="32004" y="4572"/>
                </a:lnTo>
                <a:lnTo>
                  <a:pt x="28956" y="10668"/>
                </a:lnTo>
                <a:lnTo>
                  <a:pt x="32004" y="16764"/>
                </a:lnTo>
                <a:close/>
              </a:path>
              <a:path w="58420" h="58419">
                <a:moveTo>
                  <a:pt x="54864" y="51816"/>
                </a:moveTo>
                <a:lnTo>
                  <a:pt x="49530" y="51816"/>
                </a:lnTo>
                <a:lnTo>
                  <a:pt x="51816" y="56388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1048397" y="792480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5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5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5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5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9" name="object 29"/>
          <p:cNvSpPr txBox="1"/>
          <p:nvPr/>
        </p:nvSpPr>
        <p:spPr>
          <a:xfrm>
            <a:off x="1724536" y="2385817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30" name="object 30"/>
          <p:cNvSpPr txBox="1"/>
          <p:nvPr/>
        </p:nvSpPr>
        <p:spPr>
          <a:xfrm>
            <a:off x="4050163" y="1310340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4050163" y="1610614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4050163" y="1904746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3955675" y="904532"/>
            <a:ext cx="433070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5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1140847" y="854664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5" name="object 35"/>
          <p:cNvSpPr/>
          <p:nvPr/>
        </p:nvSpPr>
        <p:spPr>
          <a:xfrm>
            <a:off x="1869833" y="4079747"/>
            <a:ext cx="1827530" cy="0"/>
          </a:xfrm>
          <a:custGeom>
            <a:avLst/>
            <a:gdLst/>
            <a:ahLst/>
            <a:cxnLst/>
            <a:rect l="l" t="t" r="r" b="b"/>
            <a:pathLst>
              <a:path w="1827529">
                <a:moveTo>
                  <a:pt x="0" y="0"/>
                </a:moveTo>
                <a:lnTo>
                  <a:pt x="1827275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6" name="object 36"/>
          <p:cNvSpPr/>
          <p:nvPr/>
        </p:nvSpPr>
        <p:spPr>
          <a:xfrm>
            <a:off x="1731149" y="4079747"/>
            <a:ext cx="78105" cy="0"/>
          </a:xfrm>
          <a:custGeom>
            <a:avLst/>
            <a:gdLst/>
            <a:ahLst/>
            <a:cxnLst/>
            <a:rect l="l" t="t" r="r" b="b"/>
            <a:pathLst>
              <a:path w="78105">
                <a:moveTo>
                  <a:pt x="0" y="0"/>
                </a:moveTo>
                <a:lnTo>
                  <a:pt x="77724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7" name="object 37"/>
          <p:cNvSpPr/>
          <p:nvPr/>
        </p:nvSpPr>
        <p:spPr>
          <a:xfrm>
            <a:off x="1731149" y="384047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8" name="object 38"/>
          <p:cNvSpPr/>
          <p:nvPr/>
        </p:nvSpPr>
        <p:spPr>
          <a:xfrm>
            <a:off x="2031377" y="3601211"/>
            <a:ext cx="1666239" cy="0"/>
          </a:xfrm>
          <a:custGeom>
            <a:avLst/>
            <a:gdLst/>
            <a:ahLst/>
            <a:cxnLst/>
            <a:rect l="l" t="t" r="r" b="b"/>
            <a:pathLst>
              <a:path w="1666239">
                <a:moveTo>
                  <a:pt x="0" y="0"/>
                </a:moveTo>
                <a:lnTo>
                  <a:pt x="1665731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1731149" y="3601211"/>
            <a:ext cx="239395" cy="0"/>
          </a:xfrm>
          <a:custGeom>
            <a:avLst/>
            <a:gdLst/>
            <a:ahLst/>
            <a:cxnLst/>
            <a:rect l="l" t="t" r="r" b="b"/>
            <a:pathLst>
              <a:path w="239394">
                <a:moveTo>
                  <a:pt x="0" y="0"/>
                </a:moveTo>
                <a:lnTo>
                  <a:pt x="239268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1731149" y="336194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1" name="object 41"/>
          <p:cNvSpPr/>
          <p:nvPr/>
        </p:nvSpPr>
        <p:spPr>
          <a:xfrm>
            <a:off x="1731149" y="312267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2" name="object 42"/>
          <p:cNvSpPr/>
          <p:nvPr/>
        </p:nvSpPr>
        <p:spPr>
          <a:xfrm>
            <a:off x="1731149" y="288340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3" name="object 43"/>
          <p:cNvSpPr/>
          <p:nvPr/>
        </p:nvSpPr>
        <p:spPr>
          <a:xfrm>
            <a:off x="1758569" y="2883407"/>
            <a:ext cx="0" cy="1403985"/>
          </a:xfrm>
          <a:custGeom>
            <a:avLst/>
            <a:gdLst/>
            <a:ahLst/>
            <a:cxnLst/>
            <a:rect l="l" t="t" r="r" b="b"/>
            <a:pathLst>
              <a:path h="1403985">
                <a:moveTo>
                  <a:pt x="0" y="0"/>
                </a:moveTo>
                <a:lnTo>
                  <a:pt x="0" y="1403604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4" name="object 44"/>
          <p:cNvSpPr/>
          <p:nvPr/>
        </p:nvSpPr>
        <p:spPr>
          <a:xfrm>
            <a:off x="1789061" y="4319015"/>
            <a:ext cx="1908175" cy="0"/>
          </a:xfrm>
          <a:custGeom>
            <a:avLst/>
            <a:gdLst/>
            <a:ahLst/>
            <a:cxnLst/>
            <a:rect l="l" t="t" r="r" b="b"/>
            <a:pathLst>
              <a:path w="1908175">
                <a:moveTo>
                  <a:pt x="0" y="0"/>
                </a:moveTo>
                <a:lnTo>
                  <a:pt x="1908047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5" name="object 45"/>
          <p:cNvSpPr/>
          <p:nvPr/>
        </p:nvSpPr>
        <p:spPr>
          <a:xfrm>
            <a:off x="1718703" y="3043173"/>
            <a:ext cx="2019807" cy="1317625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6" name="object 46"/>
          <p:cNvSpPr txBox="1"/>
          <p:nvPr/>
        </p:nvSpPr>
        <p:spPr>
          <a:xfrm>
            <a:off x="1622431" y="4260850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1578232" y="4021580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5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1535563" y="3782311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1535563" y="3543042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50" name="object 50"/>
          <p:cNvSpPr txBox="1"/>
          <p:nvPr/>
        </p:nvSpPr>
        <p:spPr>
          <a:xfrm>
            <a:off x="1535563" y="3303773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1535563" y="3064504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52" name="object 52"/>
          <p:cNvSpPr txBox="1"/>
          <p:nvPr/>
        </p:nvSpPr>
        <p:spPr>
          <a:xfrm>
            <a:off x="1535563" y="2825234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53" name="object 53"/>
          <p:cNvSpPr/>
          <p:nvPr/>
        </p:nvSpPr>
        <p:spPr>
          <a:xfrm>
            <a:off x="3966857" y="3401567"/>
            <a:ext cx="182880" cy="0"/>
          </a:xfrm>
          <a:custGeom>
            <a:avLst/>
            <a:gdLst/>
            <a:ahLst/>
            <a:cxnLst/>
            <a:rect l="l" t="t" r="r" b="b"/>
            <a:pathLst>
              <a:path w="182879">
                <a:moveTo>
                  <a:pt x="0" y="0"/>
                </a:moveTo>
                <a:lnTo>
                  <a:pt x="182880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4032389" y="3375659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4030865" y="3374135"/>
            <a:ext cx="55244" cy="56515"/>
          </a:xfrm>
          <a:custGeom>
            <a:avLst/>
            <a:gdLst/>
            <a:ahLst/>
            <a:cxnLst/>
            <a:rect l="l" t="t" r="r" b="b"/>
            <a:pathLst>
              <a:path w="55245" h="56514">
                <a:moveTo>
                  <a:pt x="54864" y="30480"/>
                </a:moveTo>
                <a:lnTo>
                  <a:pt x="54864" y="25908"/>
                </a:lnTo>
                <a:lnTo>
                  <a:pt x="28956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30480"/>
                </a:lnTo>
                <a:lnTo>
                  <a:pt x="3048" y="33528"/>
                </a:lnTo>
                <a:lnTo>
                  <a:pt x="3048" y="25908"/>
                </a:lnTo>
                <a:lnTo>
                  <a:pt x="5334" y="28193"/>
                </a:lnTo>
                <a:lnTo>
                  <a:pt x="25908" y="7620"/>
                </a:lnTo>
                <a:lnTo>
                  <a:pt x="25908" y="4572"/>
                </a:lnTo>
                <a:lnTo>
                  <a:pt x="28956" y="4572"/>
                </a:lnTo>
                <a:lnTo>
                  <a:pt x="28956" y="7619"/>
                </a:lnTo>
                <a:lnTo>
                  <a:pt x="49530" y="28194"/>
                </a:lnTo>
                <a:lnTo>
                  <a:pt x="51816" y="25908"/>
                </a:lnTo>
                <a:lnTo>
                  <a:pt x="51816" y="33528"/>
                </a:lnTo>
                <a:lnTo>
                  <a:pt x="54864" y="30480"/>
                </a:lnTo>
                <a:close/>
              </a:path>
              <a:path w="55245" h="56514">
                <a:moveTo>
                  <a:pt x="5334" y="28194"/>
                </a:moveTo>
                <a:lnTo>
                  <a:pt x="3048" y="25908"/>
                </a:lnTo>
                <a:lnTo>
                  <a:pt x="3048" y="30480"/>
                </a:lnTo>
                <a:lnTo>
                  <a:pt x="5334" y="28194"/>
                </a:lnTo>
                <a:close/>
              </a:path>
              <a:path w="55245" h="56514">
                <a:moveTo>
                  <a:pt x="27432" y="50292"/>
                </a:moveTo>
                <a:lnTo>
                  <a:pt x="5334" y="28194"/>
                </a:lnTo>
                <a:lnTo>
                  <a:pt x="3048" y="30480"/>
                </a:lnTo>
                <a:lnTo>
                  <a:pt x="3048" y="33528"/>
                </a:lnTo>
                <a:lnTo>
                  <a:pt x="25908" y="56388"/>
                </a:lnTo>
                <a:lnTo>
                  <a:pt x="25908" y="51816"/>
                </a:lnTo>
                <a:lnTo>
                  <a:pt x="27432" y="50292"/>
                </a:lnTo>
                <a:close/>
              </a:path>
              <a:path w="55245" h="56514">
                <a:moveTo>
                  <a:pt x="28956" y="4572"/>
                </a:moveTo>
                <a:lnTo>
                  <a:pt x="25908" y="4572"/>
                </a:lnTo>
                <a:lnTo>
                  <a:pt x="27432" y="6095"/>
                </a:lnTo>
                <a:lnTo>
                  <a:pt x="28956" y="4572"/>
                </a:lnTo>
                <a:close/>
              </a:path>
              <a:path w="55245" h="56514">
                <a:moveTo>
                  <a:pt x="27432" y="6096"/>
                </a:moveTo>
                <a:lnTo>
                  <a:pt x="25908" y="4572"/>
                </a:lnTo>
                <a:lnTo>
                  <a:pt x="25908" y="7620"/>
                </a:lnTo>
                <a:lnTo>
                  <a:pt x="27432" y="6096"/>
                </a:lnTo>
                <a:close/>
              </a:path>
              <a:path w="55245" h="56514">
                <a:moveTo>
                  <a:pt x="28956" y="51816"/>
                </a:moveTo>
                <a:lnTo>
                  <a:pt x="27432" y="50292"/>
                </a:lnTo>
                <a:lnTo>
                  <a:pt x="25908" y="51816"/>
                </a:lnTo>
                <a:lnTo>
                  <a:pt x="28956" y="51816"/>
                </a:lnTo>
                <a:close/>
              </a:path>
              <a:path w="55245" h="56514">
                <a:moveTo>
                  <a:pt x="28956" y="56388"/>
                </a:moveTo>
                <a:lnTo>
                  <a:pt x="28956" y="51816"/>
                </a:lnTo>
                <a:lnTo>
                  <a:pt x="25908" y="51816"/>
                </a:lnTo>
                <a:lnTo>
                  <a:pt x="25908" y="56388"/>
                </a:lnTo>
                <a:lnTo>
                  <a:pt x="28956" y="56388"/>
                </a:lnTo>
                <a:close/>
              </a:path>
              <a:path w="55245" h="56514">
                <a:moveTo>
                  <a:pt x="28956" y="7619"/>
                </a:moveTo>
                <a:lnTo>
                  <a:pt x="28956" y="4572"/>
                </a:lnTo>
                <a:lnTo>
                  <a:pt x="27432" y="6096"/>
                </a:lnTo>
                <a:lnTo>
                  <a:pt x="28956" y="7619"/>
                </a:lnTo>
                <a:close/>
              </a:path>
              <a:path w="55245" h="56514">
                <a:moveTo>
                  <a:pt x="51816" y="33528"/>
                </a:moveTo>
                <a:lnTo>
                  <a:pt x="51816" y="30480"/>
                </a:lnTo>
                <a:lnTo>
                  <a:pt x="49530" y="28193"/>
                </a:lnTo>
                <a:lnTo>
                  <a:pt x="27432" y="50292"/>
                </a:lnTo>
                <a:lnTo>
                  <a:pt x="28956" y="51816"/>
                </a:lnTo>
                <a:lnTo>
                  <a:pt x="28956" y="56388"/>
                </a:lnTo>
                <a:lnTo>
                  <a:pt x="51816" y="33528"/>
                </a:lnTo>
                <a:close/>
              </a:path>
              <a:path w="55245" h="56514">
                <a:moveTo>
                  <a:pt x="51816" y="30480"/>
                </a:moveTo>
                <a:lnTo>
                  <a:pt x="51816" y="25908"/>
                </a:lnTo>
                <a:lnTo>
                  <a:pt x="49530" y="28193"/>
                </a:lnTo>
                <a:lnTo>
                  <a:pt x="51816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3966857" y="3695700"/>
            <a:ext cx="182880" cy="0"/>
          </a:xfrm>
          <a:custGeom>
            <a:avLst/>
            <a:gdLst/>
            <a:ahLst/>
            <a:cxnLst/>
            <a:rect l="l" t="t" r="r" b="b"/>
            <a:pathLst>
              <a:path w="182879">
                <a:moveTo>
                  <a:pt x="0" y="0"/>
                </a:moveTo>
                <a:lnTo>
                  <a:pt x="182880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4032389" y="3695700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4029341" y="3666744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3966857" y="3989832"/>
            <a:ext cx="182880" cy="0"/>
          </a:xfrm>
          <a:custGeom>
            <a:avLst/>
            <a:gdLst/>
            <a:ahLst/>
            <a:cxnLst/>
            <a:rect l="l" t="t" r="r" b="b"/>
            <a:pathLst>
              <a:path w="182879">
                <a:moveTo>
                  <a:pt x="0" y="0"/>
                </a:moveTo>
                <a:lnTo>
                  <a:pt x="182880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0" name="object 60"/>
          <p:cNvSpPr/>
          <p:nvPr/>
        </p:nvSpPr>
        <p:spPr>
          <a:xfrm>
            <a:off x="4032389" y="3963923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1" name="object 61"/>
          <p:cNvSpPr/>
          <p:nvPr/>
        </p:nvSpPr>
        <p:spPr>
          <a:xfrm>
            <a:off x="4029341" y="3960876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6388"/>
                </a:moveTo>
                <a:lnTo>
                  <a:pt x="57912" y="53340"/>
                </a:lnTo>
                <a:lnTo>
                  <a:pt x="32004" y="1524"/>
                </a:lnTo>
                <a:lnTo>
                  <a:pt x="28956" y="0"/>
                </a:lnTo>
                <a:lnTo>
                  <a:pt x="25908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8382" y="51816"/>
                </a:lnTo>
                <a:lnTo>
                  <a:pt x="25908" y="16764"/>
                </a:lnTo>
                <a:lnTo>
                  <a:pt x="25908" y="4572"/>
                </a:lnTo>
                <a:lnTo>
                  <a:pt x="32004" y="4572"/>
                </a:lnTo>
                <a:lnTo>
                  <a:pt x="32004" y="16764"/>
                </a:lnTo>
                <a:lnTo>
                  <a:pt x="49530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20">
                <a:moveTo>
                  <a:pt x="8382" y="51816"/>
                </a:moveTo>
                <a:lnTo>
                  <a:pt x="3048" y="51816"/>
                </a:lnTo>
                <a:lnTo>
                  <a:pt x="6096" y="56388"/>
                </a:lnTo>
                <a:lnTo>
                  <a:pt x="8382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6388"/>
                </a:lnTo>
                <a:lnTo>
                  <a:pt x="49530" y="51816"/>
                </a:lnTo>
                <a:lnTo>
                  <a:pt x="8382" y="51816"/>
                </a:lnTo>
                <a:lnTo>
                  <a:pt x="6096" y="56388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20">
                <a:moveTo>
                  <a:pt x="32004" y="4572"/>
                </a:moveTo>
                <a:lnTo>
                  <a:pt x="25908" y="4572"/>
                </a:lnTo>
                <a:lnTo>
                  <a:pt x="28956" y="10668"/>
                </a:lnTo>
                <a:lnTo>
                  <a:pt x="32004" y="4572"/>
                </a:lnTo>
                <a:close/>
              </a:path>
              <a:path w="58420" h="58420">
                <a:moveTo>
                  <a:pt x="28956" y="10668"/>
                </a:moveTo>
                <a:lnTo>
                  <a:pt x="25908" y="4572"/>
                </a:lnTo>
                <a:lnTo>
                  <a:pt x="25908" y="16764"/>
                </a:lnTo>
                <a:lnTo>
                  <a:pt x="28956" y="10668"/>
                </a:lnTo>
                <a:close/>
              </a:path>
              <a:path w="58420" h="58420">
                <a:moveTo>
                  <a:pt x="32004" y="16764"/>
                </a:moveTo>
                <a:lnTo>
                  <a:pt x="32004" y="4572"/>
                </a:lnTo>
                <a:lnTo>
                  <a:pt x="28956" y="10668"/>
                </a:lnTo>
                <a:lnTo>
                  <a:pt x="32004" y="16764"/>
                </a:lnTo>
                <a:close/>
              </a:path>
              <a:path w="58420" h="58420">
                <a:moveTo>
                  <a:pt x="54864" y="51816"/>
                </a:moveTo>
                <a:lnTo>
                  <a:pt x="49530" y="51816"/>
                </a:lnTo>
                <a:lnTo>
                  <a:pt x="51816" y="56388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2" name="object 62"/>
          <p:cNvSpPr/>
          <p:nvPr/>
        </p:nvSpPr>
        <p:spPr>
          <a:xfrm>
            <a:off x="1048397" y="2767583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3" name="object 63"/>
          <p:cNvSpPr txBox="1"/>
          <p:nvPr/>
        </p:nvSpPr>
        <p:spPr>
          <a:xfrm>
            <a:off x="1724536" y="4360922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64" name="object 64"/>
          <p:cNvSpPr txBox="1"/>
          <p:nvPr/>
        </p:nvSpPr>
        <p:spPr>
          <a:xfrm>
            <a:off x="4146175" y="3637534"/>
            <a:ext cx="32321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5" dirty="0">
                <a:latin typeface="Calibri"/>
                <a:cs typeface="Calibri"/>
              </a:rPr>
              <a:t>c</a:t>
            </a:r>
            <a:r>
              <a:rPr sz="650" dirty="0">
                <a:latin typeface="Calibri"/>
                <a:cs typeface="Calibri"/>
              </a:rPr>
              <a:t>[</a:t>
            </a:r>
            <a:r>
              <a:rPr sz="650" spc="10" dirty="0">
                <a:latin typeface="Calibri"/>
                <a:cs typeface="Calibri"/>
              </a:rPr>
              <a:t>ng/</a:t>
            </a:r>
            <a:r>
              <a:rPr sz="650" spc="15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]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4146175" y="3931665"/>
            <a:ext cx="32321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5" dirty="0">
                <a:latin typeface="Calibri"/>
                <a:cs typeface="Calibri"/>
              </a:rPr>
              <a:t>c</a:t>
            </a:r>
            <a:r>
              <a:rPr sz="650" dirty="0">
                <a:latin typeface="Calibri"/>
                <a:cs typeface="Calibri"/>
              </a:rPr>
              <a:t>[</a:t>
            </a:r>
            <a:r>
              <a:rPr sz="650" spc="10" dirty="0">
                <a:latin typeface="Calibri"/>
                <a:cs typeface="Calibri"/>
              </a:rPr>
              <a:t>ng/</a:t>
            </a:r>
            <a:r>
              <a:rPr sz="650" spc="15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]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3955675" y="2879635"/>
            <a:ext cx="433070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7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67" name="object 67"/>
          <p:cNvSpPr txBox="1"/>
          <p:nvPr/>
        </p:nvSpPr>
        <p:spPr>
          <a:xfrm>
            <a:off x="1140847" y="2829768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68" name="object 68"/>
          <p:cNvSpPr/>
          <p:nvPr/>
        </p:nvSpPr>
        <p:spPr>
          <a:xfrm>
            <a:off x="1731149" y="6134100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60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9" name="object 69"/>
          <p:cNvSpPr/>
          <p:nvPr/>
        </p:nvSpPr>
        <p:spPr>
          <a:xfrm>
            <a:off x="1731149" y="5975603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60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0" name="object 70"/>
          <p:cNvSpPr/>
          <p:nvPr/>
        </p:nvSpPr>
        <p:spPr>
          <a:xfrm>
            <a:off x="1731149" y="581558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1" name="object 71"/>
          <p:cNvSpPr/>
          <p:nvPr/>
        </p:nvSpPr>
        <p:spPr>
          <a:xfrm>
            <a:off x="1731149" y="565556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2" name="object 72"/>
          <p:cNvSpPr/>
          <p:nvPr/>
        </p:nvSpPr>
        <p:spPr>
          <a:xfrm>
            <a:off x="1731149" y="549706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3" name="object 73"/>
          <p:cNvSpPr/>
          <p:nvPr/>
        </p:nvSpPr>
        <p:spPr>
          <a:xfrm>
            <a:off x="1731149" y="5337048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4" name="object 74"/>
          <p:cNvSpPr/>
          <p:nvPr/>
        </p:nvSpPr>
        <p:spPr>
          <a:xfrm>
            <a:off x="1731149" y="517702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5" name="object 75"/>
          <p:cNvSpPr/>
          <p:nvPr/>
        </p:nvSpPr>
        <p:spPr>
          <a:xfrm>
            <a:off x="1731149" y="5018532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6" name="object 76"/>
          <p:cNvSpPr/>
          <p:nvPr/>
        </p:nvSpPr>
        <p:spPr>
          <a:xfrm>
            <a:off x="1731149" y="48585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7" name="object 77"/>
          <p:cNvSpPr/>
          <p:nvPr/>
        </p:nvSpPr>
        <p:spPr>
          <a:xfrm>
            <a:off x="1758569" y="4858511"/>
            <a:ext cx="0" cy="1403985"/>
          </a:xfrm>
          <a:custGeom>
            <a:avLst/>
            <a:gdLst/>
            <a:ahLst/>
            <a:cxnLst/>
            <a:rect l="l" t="t" r="r" b="b"/>
            <a:pathLst>
              <a:path h="1403985">
                <a:moveTo>
                  <a:pt x="0" y="0"/>
                </a:moveTo>
                <a:lnTo>
                  <a:pt x="0" y="1403603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8" name="object 78"/>
          <p:cNvSpPr/>
          <p:nvPr/>
        </p:nvSpPr>
        <p:spPr>
          <a:xfrm>
            <a:off x="1789061" y="6294120"/>
            <a:ext cx="1908175" cy="0"/>
          </a:xfrm>
          <a:custGeom>
            <a:avLst/>
            <a:gdLst/>
            <a:ahLst/>
            <a:cxnLst/>
            <a:rect l="l" t="t" r="r" b="b"/>
            <a:pathLst>
              <a:path w="1908175">
                <a:moveTo>
                  <a:pt x="0" y="0"/>
                </a:moveTo>
                <a:lnTo>
                  <a:pt x="1908048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9" name="object 79"/>
          <p:cNvSpPr/>
          <p:nvPr/>
        </p:nvSpPr>
        <p:spPr>
          <a:xfrm>
            <a:off x="1718703" y="4955794"/>
            <a:ext cx="2019808" cy="1380109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0" name="object 80"/>
          <p:cNvSpPr txBox="1"/>
          <p:nvPr/>
        </p:nvSpPr>
        <p:spPr>
          <a:xfrm>
            <a:off x="1535563" y="4800338"/>
            <a:ext cx="156845" cy="13944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80"/>
              </a:spcBef>
            </a:pP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80"/>
              </a:spcBef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65"/>
              </a:spcBef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80"/>
              </a:spcBef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80"/>
              </a:spcBef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65"/>
              </a:spcBef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80"/>
              </a:spcBef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marL="55244">
              <a:lnSpc>
                <a:spcPct val="100000"/>
              </a:lnSpc>
              <a:spcBef>
                <a:spcPts val="480"/>
              </a:spcBef>
            </a:pPr>
            <a:r>
              <a:rPr sz="650" spc="15" dirty="0">
                <a:latin typeface="Calibri"/>
                <a:cs typeface="Calibri"/>
              </a:rPr>
              <a:t>5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1" name="object 81"/>
          <p:cNvSpPr/>
          <p:nvPr/>
        </p:nvSpPr>
        <p:spPr>
          <a:xfrm>
            <a:off x="3869321" y="532485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2" name="object 82"/>
          <p:cNvSpPr/>
          <p:nvPr/>
        </p:nvSpPr>
        <p:spPr>
          <a:xfrm>
            <a:off x="3936377" y="5298947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3" name="object 83"/>
          <p:cNvSpPr/>
          <p:nvPr/>
        </p:nvSpPr>
        <p:spPr>
          <a:xfrm>
            <a:off x="3933329" y="5295900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4" h="56514">
                <a:moveTo>
                  <a:pt x="56388" y="30480"/>
                </a:moveTo>
                <a:lnTo>
                  <a:pt x="56388" y="25908"/>
                </a:lnTo>
                <a:lnTo>
                  <a:pt x="30480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30480"/>
                </a:lnTo>
                <a:lnTo>
                  <a:pt x="4572" y="35052"/>
                </a:lnTo>
                <a:lnTo>
                  <a:pt x="4572" y="25908"/>
                </a:lnTo>
                <a:lnTo>
                  <a:pt x="6858" y="28193"/>
                </a:lnTo>
                <a:lnTo>
                  <a:pt x="25908" y="9143"/>
                </a:lnTo>
                <a:lnTo>
                  <a:pt x="25908" y="4572"/>
                </a:lnTo>
                <a:lnTo>
                  <a:pt x="30480" y="4572"/>
                </a:lnTo>
                <a:lnTo>
                  <a:pt x="30480" y="9144"/>
                </a:lnTo>
                <a:lnTo>
                  <a:pt x="49530" y="28194"/>
                </a:lnTo>
                <a:lnTo>
                  <a:pt x="51816" y="25908"/>
                </a:lnTo>
                <a:lnTo>
                  <a:pt x="51816" y="35052"/>
                </a:lnTo>
                <a:lnTo>
                  <a:pt x="56388" y="30480"/>
                </a:lnTo>
                <a:close/>
              </a:path>
              <a:path w="56514" h="56514">
                <a:moveTo>
                  <a:pt x="6858" y="28194"/>
                </a:moveTo>
                <a:lnTo>
                  <a:pt x="4572" y="25908"/>
                </a:lnTo>
                <a:lnTo>
                  <a:pt x="4572" y="30480"/>
                </a:lnTo>
                <a:lnTo>
                  <a:pt x="6858" y="28194"/>
                </a:lnTo>
                <a:close/>
              </a:path>
              <a:path w="56514" h="56514">
                <a:moveTo>
                  <a:pt x="28194" y="49530"/>
                </a:moveTo>
                <a:lnTo>
                  <a:pt x="6858" y="28194"/>
                </a:lnTo>
                <a:lnTo>
                  <a:pt x="4572" y="30480"/>
                </a:lnTo>
                <a:lnTo>
                  <a:pt x="4572" y="35052"/>
                </a:lnTo>
                <a:lnTo>
                  <a:pt x="25908" y="56388"/>
                </a:lnTo>
                <a:lnTo>
                  <a:pt x="25908" y="51816"/>
                </a:lnTo>
                <a:lnTo>
                  <a:pt x="28194" y="49530"/>
                </a:lnTo>
                <a:close/>
              </a:path>
              <a:path w="56514" h="56514">
                <a:moveTo>
                  <a:pt x="30480" y="4572"/>
                </a:moveTo>
                <a:lnTo>
                  <a:pt x="25908" y="4572"/>
                </a:lnTo>
                <a:lnTo>
                  <a:pt x="28194" y="6857"/>
                </a:lnTo>
                <a:lnTo>
                  <a:pt x="30480" y="4572"/>
                </a:lnTo>
                <a:close/>
              </a:path>
              <a:path w="56514" h="56514">
                <a:moveTo>
                  <a:pt x="28194" y="6858"/>
                </a:moveTo>
                <a:lnTo>
                  <a:pt x="25908" y="4572"/>
                </a:lnTo>
                <a:lnTo>
                  <a:pt x="25908" y="9143"/>
                </a:lnTo>
                <a:lnTo>
                  <a:pt x="28194" y="6858"/>
                </a:lnTo>
                <a:close/>
              </a:path>
              <a:path w="56514" h="56514">
                <a:moveTo>
                  <a:pt x="30480" y="51816"/>
                </a:moveTo>
                <a:lnTo>
                  <a:pt x="28194" y="49530"/>
                </a:lnTo>
                <a:lnTo>
                  <a:pt x="25908" y="51816"/>
                </a:lnTo>
                <a:lnTo>
                  <a:pt x="30480" y="51816"/>
                </a:lnTo>
                <a:close/>
              </a:path>
              <a:path w="56514" h="56514">
                <a:moveTo>
                  <a:pt x="30480" y="56388"/>
                </a:moveTo>
                <a:lnTo>
                  <a:pt x="30480" y="51816"/>
                </a:lnTo>
                <a:lnTo>
                  <a:pt x="25908" y="51816"/>
                </a:lnTo>
                <a:lnTo>
                  <a:pt x="25908" y="56388"/>
                </a:lnTo>
                <a:lnTo>
                  <a:pt x="30480" y="56388"/>
                </a:lnTo>
                <a:close/>
              </a:path>
              <a:path w="56514" h="56514">
                <a:moveTo>
                  <a:pt x="30480" y="9144"/>
                </a:moveTo>
                <a:lnTo>
                  <a:pt x="30480" y="4572"/>
                </a:lnTo>
                <a:lnTo>
                  <a:pt x="28194" y="6858"/>
                </a:lnTo>
                <a:lnTo>
                  <a:pt x="30480" y="9144"/>
                </a:lnTo>
                <a:close/>
              </a:path>
              <a:path w="56514" h="56514">
                <a:moveTo>
                  <a:pt x="51816" y="35052"/>
                </a:moveTo>
                <a:lnTo>
                  <a:pt x="51816" y="30480"/>
                </a:lnTo>
                <a:lnTo>
                  <a:pt x="49530" y="28193"/>
                </a:lnTo>
                <a:lnTo>
                  <a:pt x="28194" y="49530"/>
                </a:lnTo>
                <a:lnTo>
                  <a:pt x="30480" y="51816"/>
                </a:lnTo>
                <a:lnTo>
                  <a:pt x="30480" y="56388"/>
                </a:lnTo>
                <a:lnTo>
                  <a:pt x="51816" y="35052"/>
                </a:lnTo>
                <a:close/>
              </a:path>
              <a:path w="56514" h="56514">
                <a:moveTo>
                  <a:pt x="51816" y="30480"/>
                </a:moveTo>
                <a:lnTo>
                  <a:pt x="51816" y="25908"/>
                </a:lnTo>
                <a:lnTo>
                  <a:pt x="49530" y="28193"/>
                </a:lnTo>
                <a:lnTo>
                  <a:pt x="51816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4" name="object 84"/>
          <p:cNvSpPr txBox="1"/>
          <p:nvPr/>
        </p:nvSpPr>
        <p:spPr>
          <a:xfrm>
            <a:off x="4050163" y="5260548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5" name="object 85"/>
          <p:cNvSpPr/>
          <p:nvPr/>
        </p:nvSpPr>
        <p:spPr>
          <a:xfrm>
            <a:off x="3869321" y="5618988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6" name="object 86"/>
          <p:cNvSpPr/>
          <p:nvPr/>
        </p:nvSpPr>
        <p:spPr>
          <a:xfrm>
            <a:off x="3936377" y="5618988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7" name="object 87"/>
          <p:cNvSpPr/>
          <p:nvPr/>
        </p:nvSpPr>
        <p:spPr>
          <a:xfrm>
            <a:off x="3933329" y="5590032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8" name="object 88"/>
          <p:cNvSpPr txBox="1"/>
          <p:nvPr/>
        </p:nvSpPr>
        <p:spPr>
          <a:xfrm>
            <a:off x="4050163" y="5560821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9" name="object 89"/>
          <p:cNvSpPr/>
          <p:nvPr/>
        </p:nvSpPr>
        <p:spPr>
          <a:xfrm>
            <a:off x="3869321" y="5913120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0" name="object 90"/>
          <p:cNvSpPr/>
          <p:nvPr/>
        </p:nvSpPr>
        <p:spPr>
          <a:xfrm>
            <a:off x="3936377" y="5887211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1" name="object 91"/>
          <p:cNvSpPr/>
          <p:nvPr/>
        </p:nvSpPr>
        <p:spPr>
          <a:xfrm>
            <a:off x="3933329" y="5884164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6388"/>
                </a:moveTo>
                <a:lnTo>
                  <a:pt x="57912" y="53340"/>
                </a:lnTo>
                <a:lnTo>
                  <a:pt x="32004" y="1524"/>
                </a:lnTo>
                <a:lnTo>
                  <a:pt x="28956" y="0"/>
                </a:lnTo>
                <a:lnTo>
                  <a:pt x="25908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8382" y="51816"/>
                </a:lnTo>
                <a:lnTo>
                  <a:pt x="25908" y="16764"/>
                </a:lnTo>
                <a:lnTo>
                  <a:pt x="25908" y="4572"/>
                </a:lnTo>
                <a:lnTo>
                  <a:pt x="32004" y="4572"/>
                </a:lnTo>
                <a:lnTo>
                  <a:pt x="32004" y="16764"/>
                </a:lnTo>
                <a:lnTo>
                  <a:pt x="49530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20">
                <a:moveTo>
                  <a:pt x="8382" y="51816"/>
                </a:moveTo>
                <a:lnTo>
                  <a:pt x="3048" y="51816"/>
                </a:lnTo>
                <a:lnTo>
                  <a:pt x="6096" y="56388"/>
                </a:lnTo>
                <a:lnTo>
                  <a:pt x="8382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6388"/>
                </a:lnTo>
                <a:lnTo>
                  <a:pt x="49530" y="51816"/>
                </a:lnTo>
                <a:lnTo>
                  <a:pt x="8382" y="51816"/>
                </a:lnTo>
                <a:lnTo>
                  <a:pt x="6096" y="56388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20">
                <a:moveTo>
                  <a:pt x="32004" y="4572"/>
                </a:moveTo>
                <a:lnTo>
                  <a:pt x="25908" y="4572"/>
                </a:lnTo>
                <a:lnTo>
                  <a:pt x="28956" y="10668"/>
                </a:lnTo>
                <a:lnTo>
                  <a:pt x="32004" y="4572"/>
                </a:lnTo>
                <a:close/>
              </a:path>
              <a:path w="58420" h="58420">
                <a:moveTo>
                  <a:pt x="28956" y="10668"/>
                </a:moveTo>
                <a:lnTo>
                  <a:pt x="25908" y="4572"/>
                </a:lnTo>
                <a:lnTo>
                  <a:pt x="25908" y="16764"/>
                </a:lnTo>
                <a:lnTo>
                  <a:pt x="28956" y="10668"/>
                </a:lnTo>
                <a:close/>
              </a:path>
              <a:path w="58420" h="58420">
                <a:moveTo>
                  <a:pt x="32004" y="16764"/>
                </a:moveTo>
                <a:lnTo>
                  <a:pt x="32004" y="4572"/>
                </a:lnTo>
                <a:lnTo>
                  <a:pt x="28956" y="10668"/>
                </a:lnTo>
                <a:lnTo>
                  <a:pt x="32004" y="16764"/>
                </a:lnTo>
                <a:close/>
              </a:path>
              <a:path w="58420" h="58420">
                <a:moveTo>
                  <a:pt x="54864" y="51816"/>
                </a:moveTo>
                <a:lnTo>
                  <a:pt x="49530" y="51816"/>
                </a:lnTo>
                <a:lnTo>
                  <a:pt x="51816" y="56388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2" name="object 92"/>
          <p:cNvSpPr txBox="1"/>
          <p:nvPr/>
        </p:nvSpPr>
        <p:spPr>
          <a:xfrm>
            <a:off x="4050163" y="5854953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93" name="object 93"/>
          <p:cNvSpPr/>
          <p:nvPr/>
        </p:nvSpPr>
        <p:spPr>
          <a:xfrm>
            <a:off x="1048397" y="4742688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4" name="object 94"/>
          <p:cNvSpPr txBox="1"/>
          <p:nvPr/>
        </p:nvSpPr>
        <p:spPr>
          <a:xfrm>
            <a:off x="3955675" y="4854740"/>
            <a:ext cx="433070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8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95" name="object 95"/>
          <p:cNvSpPr txBox="1"/>
          <p:nvPr/>
        </p:nvSpPr>
        <p:spPr>
          <a:xfrm>
            <a:off x="1140847" y="4804872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96" name="object 96"/>
          <p:cNvSpPr/>
          <p:nvPr/>
        </p:nvSpPr>
        <p:spPr>
          <a:xfrm>
            <a:off x="5861189" y="186537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7" name="object 97"/>
          <p:cNvSpPr/>
          <p:nvPr/>
        </p:nvSpPr>
        <p:spPr>
          <a:xfrm>
            <a:off x="5861189" y="138683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8" name="object 98"/>
          <p:cNvSpPr/>
          <p:nvPr/>
        </p:nvSpPr>
        <p:spPr>
          <a:xfrm>
            <a:off x="5861189" y="908303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9" name="object 99"/>
          <p:cNvSpPr/>
          <p:nvPr/>
        </p:nvSpPr>
        <p:spPr>
          <a:xfrm>
            <a:off x="5888621" y="908303"/>
            <a:ext cx="0" cy="1466215"/>
          </a:xfrm>
          <a:custGeom>
            <a:avLst/>
            <a:gdLst/>
            <a:ahLst/>
            <a:cxnLst/>
            <a:rect l="l" t="t" r="r" b="b"/>
            <a:pathLst>
              <a:path h="1466214">
                <a:moveTo>
                  <a:pt x="0" y="0"/>
                </a:moveTo>
                <a:lnTo>
                  <a:pt x="0" y="1466087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0" name="object 100"/>
          <p:cNvSpPr/>
          <p:nvPr/>
        </p:nvSpPr>
        <p:spPr>
          <a:xfrm>
            <a:off x="5861189" y="23439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1" name="object 101"/>
          <p:cNvSpPr/>
          <p:nvPr/>
        </p:nvSpPr>
        <p:spPr>
          <a:xfrm>
            <a:off x="6047117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2" name="object 102"/>
          <p:cNvSpPr/>
          <p:nvPr/>
        </p:nvSpPr>
        <p:spPr>
          <a:xfrm>
            <a:off x="6208662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3" name="object 103"/>
          <p:cNvSpPr/>
          <p:nvPr/>
        </p:nvSpPr>
        <p:spPr>
          <a:xfrm>
            <a:off x="6370193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4" name="object 104"/>
          <p:cNvSpPr/>
          <p:nvPr/>
        </p:nvSpPr>
        <p:spPr>
          <a:xfrm>
            <a:off x="6531749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5" name="object 105"/>
          <p:cNvSpPr/>
          <p:nvPr/>
        </p:nvSpPr>
        <p:spPr>
          <a:xfrm>
            <a:off x="669328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6" name="object 106"/>
          <p:cNvSpPr/>
          <p:nvPr/>
        </p:nvSpPr>
        <p:spPr>
          <a:xfrm>
            <a:off x="6854825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7" name="object 107"/>
          <p:cNvSpPr/>
          <p:nvPr/>
        </p:nvSpPr>
        <p:spPr>
          <a:xfrm>
            <a:off x="701638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8" name="object 108"/>
          <p:cNvSpPr/>
          <p:nvPr/>
        </p:nvSpPr>
        <p:spPr>
          <a:xfrm>
            <a:off x="7177925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9" name="object 109"/>
          <p:cNvSpPr/>
          <p:nvPr/>
        </p:nvSpPr>
        <p:spPr>
          <a:xfrm>
            <a:off x="7339469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0" name="object 110"/>
          <p:cNvSpPr/>
          <p:nvPr/>
        </p:nvSpPr>
        <p:spPr>
          <a:xfrm>
            <a:off x="750100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1" name="object 111"/>
          <p:cNvSpPr/>
          <p:nvPr/>
        </p:nvSpPr>
        <p:spPr>
          <a:xfrm>
            <a:off x="7662557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2" name="object 112"/>
          <p:cNvSpPr/>
          <p:nvPr/>
        </p:nvSpPr>
        <p:spPr>
          <a:xfrm>
            <a:off x="782410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3" name="object 113"/>
          <p:cNvSpPr/>
          <p:nvPr/>
        </p:nvSpPr>
        <p:spPr>
          <a:xfrm>
            <a:off x="5889891" y="1083310"/>
            <a:ext cx="1978647" cy="866140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4" name="object 114"/>
          <p:cNvSpPr txBox="1"/>
          <p:nvPr/>
        </p:nvSpPr>
        <p:spPr>
          <a:xfrm>
            <a:off x="5752471" y="2285746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15" name="object 115"/>
          <p:cNvSpPr txBox="1"/>
          <p:nvPr/>
        </p:nvSpPr>
        <p:spPr>
          <a:xfrm>
            <a:off x="5708272" y="1807207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16" name="object 116"/>
          <p:cNvSpPr txBox="1"/>
          <p:nvPr/>
        </p:nvSpPr>
        <p:spPr>
          <a:xfrm>
            <a:off x="5665603" y="1328669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17" name="object 117"/>
          <p:cNvSpPr txBox="1"/>
          <p:nvPr/>
        </p:nvSpPr>
        <p:spPr>
          <a:xfrm>
            <a:off x="5621404" y="850131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18" name="object 118"/>
          <p:cNvSpPr/>
          <p:nvPr/>
        </p:nvSpPr>
        <p:spPr>
          <a:xfrm>
            <a:off x="7999361" y="1374647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9" name="object 119"/>
          <p:cNvSpPr/>
          <p:nvPr/>
        </p:nvSpPr>
        <p:spPr>
          <a:xfrm>
            <a:off x="8066405" y="1348739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0" name="object 120"/>
          <p:cNvSpPr/>
          <p:nvPr/>
        </p:nvSpPr>
        <p:spPr>
          <a:xfrm>
            <a:off x="8063369" y="1347216"/>
            <a:ext cx="56515" cy="55244"/>
          </a:xfrm>
          <a:custGeom>
            <a:avLst/>
            <a:gdLst/>
            <a:ahLst/>
            <a:cxnLst/>
            <a:rect l="l" t="t" r="r" b="b"/>
            <a:pathLst>
              <a:path w="56515" h="55244">
                <a:moveTo>
                  <a:pt x="56387" y="28956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28956"/>
                </a:lnTo>
                <a:lnTo>
                  <a:pt x="4571" y="33528"/>
                </a:lnTo>
                <a:lnTo>
                  <a:pt x="4571" y="25908"/>
                </a:lnTo>
                <a:lnTo>
                  <a:pt x="6095" y="27432"/>
                </a:lnTo>
                <a:lnTo>
                  <a:pt x="25907" y="7620"/>
                </a:lnTo>
                <a:lnTo>
                  <a:pt x="25907" y="3048"/>
                </a:lnTo>
                <a:lnTo>
                  <a:pt x="30479" y="3047"/>
                </a:lnTo>
                <a:lnTo>
                  <a:pt x="30479" y="7619"/>
                </a:lnTo>
                <a:lnTo>
                  <a:pt x="50291" y="27432"/>
                </a:lnTo>
                <a:lnTo>
                  <a:pt x="51815" y="25908"/>
                </a:lnTo>
                <a:lnTo>
                  <a:pt x="51815" y="33528"/>
                </a:lnTo>
                <a:lnTo>
                  <a:pt x="56387" y="28956"/>
                </a:lnTo>
                <a:close/>
              </a:path>
              <a:path w="56515" h="55244">
                <a:moveTo>
                  <a:pt x="6095" y="27432"/>
                </a:moveTo>
                <a:lnTo>
                  <a:pt x="4571" y="25908"/>
                </a:lnTo>
                <a:lnTo>
                  <a:pt x="4571" y="28956"/>
                </a:lnTo>
                <a:lnTo>
                  <a:pt x="6095" y="27432"/>
                </a:lnTo>
                <a:close/>
              </a:path>
              <a:path w="56515" h="55244">
                <a:moveTo>
                  <a:pt x="28193" y="49530"/>
                </a:moveTo>
                <a:lnTo>
                  <a:pt x="6095" y="27432"/>
                </a:lnTo>
                <a:lnTo>
                  <a:pt x="4571" y="28956"/>
                </a:lnTo>
                <a:lnTo>
                  <a:pt x="4571" y="33528"/>
                </a:lnTo>
                <a:lnTo>
                  <a:pt x="25907" y="54864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5244">
                <a:moveTo>
                  <a:pt x="30479" y="3047"/>
                </a:moveTo>
                <a:lnTo>
                  <a:pt x="25907" y="3048"/>
                </a:lnTo>
                <a:lnTo>
                  <a:pt x="28193" y="5333"/>
                </a:lnTo>
                <a:lnTo>
                  <a:pt x="30479" y="3047"/>
                </a:lnTo>
                <a:close/>
              </a:path>
              <a:path w="56515" h="55244">
                <a:moveTo>
                  <a:pt x="28193" y="5334"/>
                </a:moveTo>
                <a:lnTo>
                  <a:pt x="25907" y="3048"/>
                </a:lnTo>
                <a:lnTo>
                  <a:pt x="25907" y="7620"/>
                </a:lnTo>
                <a:lnTo>
                  <a:pt x="28193" y="5334"/>
                </a:lnTo>
                <a:close/>
              </a:path>
              <a:path w="56515" h="55244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5244">
                <a:moveTo>
                  <a:pt x="30479" y="54864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4864"/>
                </a:lnTo>
                <a:lnTo>
                  <a:pt x="30479" y="54864"/>
                </a:lnTo>
                <a:close/>
              </a:path>
              <a:path w="56515" h="55244">
                <a:moveTo>
                  <a:pt x="30479" y="7619"/>
                </a:moveTo>
                <a:lnTo>
                  <a:pt x="30479" y="3047"/>
                </a:lnTo>
                <a:lnTo>
                  <a:pt x="28193" y="5334"/>
                </a:lnTo>
                <a:lnTo>
                  <a:pt x="30479" y="7619"/>
                </a:lnTo>
                <a:close/>
              </a:path>
              <a:path w="56515" h="55244">
                <a:moveTo>
                  <a:pt x="51815" y="33528"/>
                </a:moveTo>
                <a:lnTo>
                  <a:pt x="51815" y="28956"/>
                </a:lnTo>
                <a:lnTo>
                  <a:pt x="50291" y="27432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4864"/>
                </a:lnTo>
                <a:lnTo>
                  <a:pt x="51815" y="33528"/>
                </a:lnTo>
                <a:close/>
              </a:path>
              <a:path w="56515" h="55244">
                <a:moveTo>
                  <a:pt x="51815" y="28956"/>
                </a:moveTo>
                <a:lnTo>
                  <a:pt x="51815" y="25908"/>
                </a:lnTo>
                <a:lnTo>
                  <a:pt x="50291" y="27432"/>
                </a:lnTo>
                <a:lnTo>
                  <a:pt x="51815" y="28956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1" name="object 121"/>
          <p:cNvSpPr/>
          <p:nvPr/>
        </p:nvSpPr>
        <p:spPr>
          <a:xfrm>
            <a:off x="7999361" y="166877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2" name="object 122"/>
          <p:cNvSpPr/>
          <p:nvPr/>
        </p:nvSpPr>
        <p:spPr>
          <a:xfrm>
            <a:off x="8066417" y="1668779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3" name="object 123"/>
          <p:cNvSpPr/>
          <p:nvPr/>
        </p:nvSpPr>
        <p:spPr>
          <a:xfrm>
            <a:off x="8063369" y="1639823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19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19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19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19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19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19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4" name="object 124"/>
          <p:cNvSpPr/>
          <p:nvPr/>
        </p:nvSpPr>
        <p:spPr>
          <a:xfrm>
            <a:off x="7999361" y="1962911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5" name="object 125"/>
          <p:cNvSpPr/>
          <p:nvPr/>
        </p:nvSpPr>
        <p:spPr>
          <a:xfrm>
            <a:off x="8066405" y="1937004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6" name="object 126"/>
          <p:cNvSpPr/>
          <p:nvPr/>
        </p:nvSpPr>
        <p:spPr>
          <a:xfrm>
            <a:off x="8063369" y="1933955"/>
            <a:ext cx="56515" cy="58419"/>
          </a:xfrm>
          <a:custGeom>
            <a:avLst/>
            <a:gdLst/>
            <a:ahLst/>
            <a:cxnLst/>
            <a:rect l="l" t="t" r="r" b="b"/>
            <a:pathLst>
              <a:path w="56515" h="58419">
                <a:moveTo>
                  <a:pt x="56387" y="56388"/>
                </a:moveTo>
                <a:lnTo>
                  <a:pt x="56387" y="53340"/>
                </a:lnTo>
                <a:lnTo>
                  <a:pt x="30479" y="1524"/>
                </a:lnTo>
                <a:lnTo>
                  <a:pt x="28955" y="0"/>
                </a:lnTo>
                <a:lnTo>
                  <a:pt x="25907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6857" y="51816"/>
                </a:lnTo>
                <a:lnTo>
                  <a:pt x="25907" y="13716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13716"/>
                </a:lnTo>
                <a:lnTo>
                  <a:pt x="49529" y="51816"/>
                </a:lnTo>
                <a:lnTo>
                  <a:pt x="54863" y="51816"/>
                </a:lnTo>
                <a:lnTo>
                  <a:pt x="54863" y="57912"/>
                </a:lnTo>
                <a:lnTo>
                  <a:pt x="56387" y="56388"/>
                </a:lnTo>
                <a:close/>
              </a:path>
              <a:path w="56515" h="58419">
                <a:moveTo>
                  <a:pt x="6857" y="51816"/>
                </a:moveTo>
                <a:lnTo>
                  <a:pt x="3047" y="51816"/>
                </a:lnTo>
                <a:lnTo>
                  <a:pt x="4571" y="56388"/>
                </a:lnTo>
                <a:lnTo>
                  <a:pt x="6857" y="51816"/>
                </a:lnTo>
                <a:close/>
              </a:path>
              <a:path w="56515" h="58419">
                <a:moveTo>
                  <a:pt x="54863" y="57912"/>
                </a:moveTo>
                <a:lnTo>
                  <a:pt x="54863" y="51816"/>
                </a:lnTo>
                <a:lnTo>
                  <a:pt x="51815" y="56388"/>
                </a:lnTo>
                <a:lnTo>
                  <a:pt x="49529" y="51816"/>
                </a:lnTo>
                <a:lnTo>
                  <a:pt x="6857" y="51816"/>
                </a:lnTo>
                <a:lnTo>
                  <a:pt x="4571" y="56388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close/>
              </a:path>
              <a:path w="56515" h="58419">
                <a:moveTo>
                  <a:pt x="30479" y="4572"/>
                </a:moveTo>
                <a:lnTo>
                  <a:pt x="25907" y="4572"/>
                </a:lnTo>
                <a:lnTo>
                  <a:pt x="28193" y="9144"/>
                </a:lnTo>
                <a:lnTo>
                  <a:pt x="30479" y="4572"/>
                </a:lnTo>
                <a:close/>
              </a:path>
              <a:path w="56515" h="58419">
                <a:moveTo>
                  <a:pt x="28193" y="9144"/>
                </a:moveTo>
                <a:lnTo>
                  <a:pt x="25907" y="4572"/>
                </a:lnTo>
                <a:lnTo>
                  <a:pt x="25907" y="13716"/>
                </a:lnTo>
                <a:lnTo>
                  <a:pt x="28193" y="9144"/>
                </a:lnTo>
                <a:close/>
              </a:path>
              <a:path w="56515" h="58419">
                <a:moveTo>
                  <a:pt x="30479" y="13716"/>
                </a:moveTo>
                <a:lnTo>
                  <a:pt x="30479" y="4572"/>
                </a:lnTo>
                <a:lnTo>
                  <a:pt x="28193" y="9144"/>
                </a:lnTo>
                <a:lnTo>
                  <a:pt x="30479" y="13716"/>
                </a:lnTo>
                <a:close/>
              </a:path>
              <a:path w="56515" h="58419">
                <a:moveTo>
                  <a:pt x="54863" y="51816"/>
                </a:moveTo>
                <a:lnTo>
                  <a:pt x="49529" y="51816"/>
                </a:lnTo>
                <a:lnTo>
                  <a:pt x="51815" y="56388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7" name="object 127"/>
          <p:cNvSpPr/>
          <p:nvPr/>
        </p:nvSpPr>
        <p:spPr>
          <a:xfrm>
            <a:off x="5178437" y="792480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5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5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5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5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8" name="object 128"/>
          <p:cNvSpPr txBox="1"/>
          <p:nvPr/>
        </p:nvSpPr>
        <p:spPr>
          <a:xfrm>
            <a:off x="5854575" y="2385817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29" name="object 129"/>
          <p:cNvSpPr txBox="1"/>
          <p:nvPr/>
        </p:nvSpPr>
        <p:spPr>
          <a:xfrm>
            <a:off x="8180203" y="1310340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0" name="object 130"/>
          <p:cNvSpPr txBox="1"/>
          <p:nvPr/>
        </p:nvSpPr>
        <p:spPr>
          <a:xfrm>
            <a:off x="8180203" y="1610614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1" name="object 131"/>
          <p:cNvSpPr txBox="1"/>
          <p:nvPr/>
        </p:nvSpPr>
        <p:spPr>
          <a:xfrm>
            <a:off x="8180203" y="1904746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2" name="object 132"/>
          <p:cNvSpPr txBox="1"/>
          <p:nvPr/>
        </p:nvSpPr>
        <p:spPr>
          <a:xfrm>
            <a:off x="8085714" y="904532"/>
            <a:ext cx="433070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5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33" name="object 133"/>
          <p:cNvSpPr txBox="1"/>
          <p:nvPr/>
        </p:nvSpPr>
        <p:spPr>
          <a:xfrm>
            <a:off x="5270887" y="854664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4" name="object 134"/>
          <p:cNvSpPr/>
          <p:nvPr/>
        </p:nvSpPr>
        <p:spPr>
          <a:xfrm>
            <a:off x="5861189" y="384047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5" name="object 135"/>
          <p:cNvSpPr/>
          <p:nvPr/>
        </p:nvSpPr>
        <p:spPr>
          <a:xfrm>
            <a:off x="5861189" y="336194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6" name="object 136"/>
          <p:cNvSpPr/>
          <p:nvPr/>
        </p:nvSpPr>
        <p:spPr>
          <a:xfrm>
            <a:off x="5861189" y="288340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7" name="object 137"/>
          <p:cNvSpPr/>
          <p:nvPr/>
        </p:nvSpPr>
        <p:spPr>
          <a:xfrm>
            <a:off x="5888621" y="2883407"/>
            <a:ext cx="0" cy="1466215"/>
          </a:xfrm>
          <a:custGeom>
            <a:avLst/>
            <a:gdLst/>
            <a:ahLst/>
            <a:cxnLst/>
            <a:rect l="l" t="t" r="r" b="b"/>
            <a:pathLst>
              <a:path h="1466214">
                <a:moveTo>
                  <a:pt x="0" y="0"/>
                </a:moveTo>
                <a:lnTo>
                  <a:pt x="0" y="1466087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8" name="object 138"/>
          <p:cNvSpPr/>
          <p:nvPr/>
        </p:nvSpPr>
        <p:spPr>
          <a:xfrm>
            <a:off x="5861189" y="4319015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9" name="object 139"/>
          <p:cNvSpPr/>
          <p:nvPr/>
        </p:nvSpPr>
        <p:spPr>
          <a:xfrm>
            <a:off x="6047117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0" name="object 140"/>
          <p:cNvSpPr/>
          <p:nvPr/>
        </p:nvSpPr>
        <p:spPr>
          <a:xfrm>
            <a:off x="6208662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1" name="object 141"/>
          <p:cNvSpPr/>
          <p:nvPr/>
        </p:nvSpPr>
        <p:spPr>
          <a:xfrm>
            <a:off x="6370193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2" name="object 142"/>
          <p:cNvSpPr/>
          <p:nvPr/>
        </p:nvSpPr>
        <p:spPr>
          <a:xfrm>
            <a:off x="6531749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3" name="object 143"/>
          <p:cNvSpPr/>
          <p:nvPr/>
        </p:nvSpPr>
        <p:spPr>
          <a:xfrm>
            <a:off x="6693281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4" name="object 144"/>
          <p:cNvSpPr/>
          <p:nvPr/>
        </p:nvSpPr>
        <p:spPr>
          <a:xfrm>
            <a:off x="6854825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5" name="object 145"/>
          <p:cNvSpPr/>
          <p:nvPr/>
        </p:nvSpPr>
        <p:spPr>
          <a:xfrm>
            <a:off x="7016381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6" name="object 146"/>
          <p:cNvSpPr/>
          <p:nvPr/>
        </p:nvSpPr>
        <p:spPr>
          <a:xfrm>
            <a:off x="7177925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7" name="object 147"/>
          <p:cNvSpPr/>
          <p:nvPr/>
        </p:nvSpPr>
        <p:spPr>
          <a:xfrm>
            <a:off x="7339469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8" name="object 148"/>
          <p:cNvSpPr/>
          <p:nvPr/>
        </p:nvSpPr>
        <p:spPr>
          <a:xfrm>
            <a:off x="7501001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9" name="object 149"/>
          <p:cNvSpPr/>
          <p:nvPr/>
        </p:nvSpPr>
        <p:spPr>
          <a:xfrm>
            <a:off x="7662557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0" name="object 150"/>
          <p:cNvSpPr/>
          <p:nvPr/>
        </p:nvSpPr>
        <p:spPr>
          <a:xfrm>
            <a:off x="7824101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1" name="object 151"/>
          <p:cNvSpPr/>
          <p:nvPr/>
        </p:nvSpPr>
        <p:spPr>
          <a:xfrm>
            <a:off x="5889891" y="3123945"/>
            <a:ext cx="1978647" cy="582676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2" name="object 152"/>
          <p:cNvSpPr txBox="1"/>
          <p:nvPr/>
        </p:nvSpPr>
        <p:spPr>
          <a:xfrm>
            <a:off x="5752471" y="4260850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53" name="object 153"/>
          <p:cNvSpPr txBox="1"/>
          <p:nvPr/>
        </p:nvSpPr>
        <p:spPr>
          <a:xfrm>
            <a:off x="5708272" y="3782311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54" name="object 154"/>
          <p:cNvSpPr txBox="1"/>
          <p:nvPr/>
        </p:nvSpPr>
        <p:spPr>
          <a:xfrm>
            <a:off x="5665603" y="3303773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55" name="object 155"/>
          <p:cNvSpPr txBox="1"/>
          <p:nvPr/>
        </p:nvSpPr>
        <p:spPr>
          <a:xfrm>
            <a:off x="5621404" y="2825234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56" name="object 156"/>
          <p:cNvSpPr/>
          <p:nvPr/>
        </p:nvSpPr>
        <p:spPr>
          <a:xfrm>
            <a:off x="8095374" y="3401567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7" name="object 157"/>
          <p:cNvSpPr/>
          <p:nvPr/>
        </p:nvSpPr>
        <p:spPr>
          <a:xfrm>
            <a:off x="8162417" y="3375659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8" name="object 158"/>
          <p:cNvSpPr/>
          <p:nvPr/>
        </p:nvSpPr>
        <p:spPr>
          <a:xfrm>
            <a:off x="8159368" y="3374135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5" h="56514">
                <a:moveTo>
                  <a:pt x="56387" y="30480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30480"/>
                </a:lnTo>
                <a:lnTo>
                  <a:pt x="4571" y="35052"/>
                </a:lnTo>
                <a:lnTo>
                  <a:pt x="4571" y="25908"/>
                </a:lnTo>
                <a:lnTo>
                  <a:pt x="6857" y="28193"/>
                </a:lnTo>
                <a:lnTo>
                  <a:pt x="25907" y="9143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9144"/>
                </a:lnTo>
                <a:lnTo>
                  <a:pt x="49529" y="28194"/>
                </a:lnTo>
                <a:lnTo>
                  <a:pt x="51815" y="25908"/>
                </a:lnTo>
                <a:lnTo>
                  <a:pt x="51815" y="35052"/>
                </a:lnTo>
                <a:lnTo>
                  <a:pt x="56387" y="30480"/>
                </a:lnTo>
                <a:close/>
              </a:path>
              <a:path w="56515" h="56514">
                <a:moveTo>
                  <a:pt x="6857" y="28194"/>
                </a:moveTo>
                <a:lnTo>
                  <a:pt x="4571" y="25908"/>
                </a:lnTo>
                <a:lnTo>
                  <a:pt x="4571" y="30480"/>
                </a:lnTo>
                <a:lnTo>
                  <a:pt x="6857" y="28194"/>
                </a:lnTo>
                <a:close/>
              </a:path>
              <a:path w="56515" h="56514">
                <a:moveTo>
                  <a:pt x="28193" y="49530"/>
                </a:moveTo>
                <a:lnTo>
                  <a:pt x="6857" y="28194"/>
                </a:lnTo>
                <a:lnTo>
                  <a:pt x="4571" y="30480"/>
                </a:lnTo>
                <a:lnTo>
                  <a:pt x="4571" y="35052"/>
                </a:lnTo>
                <a:lnTo>
                  <a:pt x="25907" y="56388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6514">
                <a:moveTo>
                  <a:pt x="30479" y="4572"/>
                </a:moveTo>
                <a:lnTo>
                  <a:pt x="25907" y="4572"/>
                </a:lnTo>
                <a:lnTo>
                  <a:pt x="28193" y="6857"/>
                </a:lnTo>
                <a:lnTo>
                  <a:pt x="30479" y="4572"/>
                </a:lnTo>
                <a:close/>
              </a:path>
              <a:path w="56515" h="56514">
                <a:moveTo>
                  <a:pt x="28193" y="6858"/>
                </a:moveTo>
                <a:lnTo>
                  <a:pt x="25907" y="4572"/>
                </a:lnTo>
                <a:lnTo>
                  <a:pt x="25907" y="9143"/>
                </a:lnTo>
                <a:lnTo>
                  <a:pt x="28193" y="6858"/>
                </a:lnTo>
                <a:close/>
              </a:path>
              <a:path w="56515" h="56514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6514">
                <a:moveTo>
                  <a:pt x="30479" y="56388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6388"/>
                </a:lnTo>
                <a:lnTo>
                  <a:pt x="30479" y="56388"/>
                </a:lnTo>
                <a:close/>
              </a:path>
              <a:path w="56515" h="56514">
                <a:moveTo>
                  <a:pt x="30479" y="9144"/>
                </a:moveTo>
                <a:lnTo>
                  <a:pt x="30479" y="4572"/>
                </a:lnTo>
                <a:lnTo>
                  <a:pt x="28193" y="6858"/>
                </a:lnTo>
                <a:lnTo>
                  <a:pt x="30479" y="9144"/>
                </a:lnTo>
                <a:close/>
              </a:path>
              <a:path w="56515" h="56514">
                <a:moveTo>
                  <a:pt x="51815" y="35052"/>
                </a:moveTo>
                <a:lnTo>
                  <a:pt x="51815" y="30480"/>
                </a:lnTo>
                <a:lnTo>
                  <a:pt x="49529" y="28193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6388"/>
                </a:lnTo>
                <a:lnTo>
                  <a:pt x="51815" y="35052"/>
                </a:lnTo>
                <a:close/>
              </a:path>
              <a:path w="56515" h="56514">
                <a:moveTo>
                  <a:pt x="51815" y="30480"/>
                </a:moveTo>
                <a:lnTo>
                  <a:pt x="51815" y="25908"/>
                </a:lnTo>
                <a:lnTo>
                  <a:pt x="49529" y="28193"/>
                </a:lnTo>
                <a:lnTo>
                  <a:pt x="51815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9" name="object 159"/>
          <p:cNvSpPr/>
          <p:nvPr/>
        </p:nvSpPr>
        <p:spPr>
          <a:xfrm>
            <a:off x="8095374" y="3695700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0" name="object 160"/>
          <p:cNvSpPr/>
          <p:nvPr/>
        </p:nvSpPr>
        <p:spPr>
          <a:xfrm>
            <a:off x="8162429" y="3695700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1" name="object 161"/>
          <p:cNvSpPr/>
          <p:nvPr/>
        </p:nvSpPr>
        <p:spPr>
          <a:xfrm>
            <a:off x="8159381" y="3666744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2" name="object 162"/>
          <p:cNvSpPr/>
          <p:nvPr/>
        </p:nvSpPr>
        <p:spPr>
          <a:xfrm>
            <a:off x="8095374" y="3989832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3" name="object 163"/>
          <p:cNvSpPr/>
          <p:nvPr/>
        </p:nvSpPr>
        <p:spPr>
          <a:xfrm>
            <a:off x="8162417" y="3963923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4" name="object 164"/>
          <p:cNvSpPr/>
          <p:nvPr/>
        </p:nvSpPr>
        <p:spPr>
          <a:xfrm>
            <a:off x="8159368" y="3960876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1" y="56388"/>
                </a:moveTo>
                <a:lnTo>
                  <a:pt x="57911" y="53340"/>
                </a:lnTo>
                <a:lnTo>
                  <a:pt x="32003" y="1524"/>
                </a:lnTo>
                <a:lnTo>
                  <a:pt x="28955" y="0"/>
                </a:lnTo>
                <a:lnTo>
                  <a:pt x="25907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8381" y="51816"/>
                </a:lnTo>
                <a:lnTo>
                  <a:pt x="25907" y="16764"/>
                </a:lnTo>
                <a:lnTo>
                  <a:pt x="25907" y="4572"/>
                </a:lnTo>
                <a:lnTo>
                  <a:pt x="32003" y="4572"/>
                </a:lnTo>
                <a:lnTo>
                  <a:pt x="32003" y="16764"/>
                </a:lnTo>
                <a:lnTo>
                  <a:pt x="49529" y="51816"/>
                </a:lnTo>
                <a:lnTo>
                  <a:pt x="54863" y="51816"/>
                </a:lnTo>
                <a:lnTo>
                  <a:pt x="54863" y="57912"/>
                </a:lnTo>
                <a:lnTo>
                  <a:pt x="57911" y="56388"/>
                </a:lnTo>
                <a:close/>
              </a:path>
              <a:path w="58420" h="58420">
                <a:moveTo>
                  <a:pt x="8381" y="51816"/>
                </a:moveTo>
                <a:lnTo>
                  <a:pt x="3047" y="51816"/>
                </a:lnTo>
                <a:lnTo>
                  <a:pt x="6095" y="56388"/>
                </a:lnTo>
                <a:lnTo>
                  <a:pt x="8381" y="51816"/>
                </a:lnTo>
                <a:close/>
              </a:path>
              <a:path w="58420" h="58420">
                <a:moveTo>
                  <a:pt x="54863" y="57912"/>
                </a:moveTo>
                <a:lnTo>
                  <a:pt x="54863" y="51816"/>
                </a:lnTo>
                <a:lnTo>
                  <a:pt x="51815" y="56388"/>
                </a:lnTo>
                <a:lnTo>
                  <a:pt x="49529" y="51816"/>
                </a:lnTo>
                <a:lnTo>
                  <a:pt x="8381" y="51816"/>
                </a:lnTo>
                <a:lnTo>
                  <a:pt x="6095" y="56388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close/>
              </a:path>
              <a:path w="58420" h="58420">
                <a:moveTo>
                  <a:pt x="32003" y="4572"/>
                </a:moveTo>
                <a:lnTo>
                  <a:pt x="25907" y="4572"/>
                </a:lnTo>
                <a:lnTo>
                  <a:pt x="28955" y="10668"/>
                </a:lnTo>
                <a:lnTo>
                  <a:pt x="32003" y="4572"/>
                </a:lnTo>
                <a:close/>
              </a:path>
              <a:path w="58420" h="58420">
                <a:moveTo>
                  <a:pt x="28955" y="10668"/>
                </a:moveTo>
                <a:lnTo>
                  <a:pt x="25907" y="4572"/>
                </a:lnTo>
                <a:lnTo>
                  <a:pt x="25907" y="16764"/>
                </a:lnTo>
                <a:lnTo>
                  <a:pt x="28955" y="10668"/>
                </a:lnTo>
                <a:close/>
              </a:path>
              <a:path w="58420" h="58420">
                <a:moveTo>
                  <a:pt x="32003" y="16764"/>
                </a:moveTo>
                <a:lnTo>
                  <a:pt x="32003" y="4572"/>
                </a:lnTo>
                <a:lnTo>
                  <a:pt x="28955" y="10668"/>
                </a:lnTo>
                <a:lnTo>
                  <a:pt x="32003" y="16764"/>
                </a:lnTo>
                <a:close/>
              </a:path>
              <a:path w="58420" h="58420">
                <a:moveTo>
                  <a:pt x="54863" y="51816"/>
                </a:moveTo>
                <a:lnTo>
                  <a:pt x="49529" y="51816"/>
                </a:lnTo>
                <a:lnTo>
                  <a:pt x="51815" y="56388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5" name="object 165"/>
          <p:cNvSpPr/>
          <p:nvPr/>
        </p:nvSpPr>
        <p:spPr>
          <a:xfrm>
            <a:off x="5178437" y="2767583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6" name="object 166"/>
          <p:cNvSpPr txBox="1"/>
          <p:nvPr/>
        </p:nvSpPr>
        <p:spPr>
          <a:xfrm>
            <a:off x="5854575" y="4360922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67" name="object 167"/>
          <p:cNvSpPr txBox="1"/>
          <p:nvPr/>
        </p:nvSpPr>
        <p:spPr>
          <a:xfrm>
            <a:off x="8276214" y="3637534"/>
            <a:ext cx="32321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5" dirty="0">
                <a:latin typeface="Calibri"/>
                <a:cs typeface="Calibri"/>
              </a:rPr>
              <a:t>c</a:t>
            </a:r>
            <a:r>
              <a:rPr sz="650" dirty="0">
                <a:latin typeface="Calibri"/>
                <a:cs typeface="Calibri"/>
              </a:rPr>
              <a:t>[</a:t>
            </a:r>
            <a:r>
              <a:rPr sz="650" spc="10" dirty="0">
                <a:latin typeface="Calibri"/>
                <a:cs typeface="Calibri"/>
              </a:rPr>
              <a:t>ng/</a:t>
            </a:r>
            <a:r>
              <a:rPr sz="650" spc="15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]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8" name="object 168"/>
          <p:cNvSpPr txBox="1"/>
          <p:nvPr/>
        </p:nvSpPr>
        <p:spPr>
          <a:xfrm>
            <a:off x="8276214" y="3931665"/>
            <a:ext cx="32321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5" dirty="0">
                <a:latin typeface="Calibri"/>
                <a:cs typeface="Calibri"/>
              </a:rPr>
              <a:t>c</a:t>
            </a:r>
            <a:r>
              <a:rPr sz="650" dirty="0">
                <a:latin typeface="Calibri"/>
                <a:cs typeface="Calibri"/>
              </a:rPr>
              <a:t>[</a:t>
            </a:r>
            <a:r>
              <a:rPr sz="650" spc="10" dirty="0">
                <a:latin typeface="Calibri"/>
                <a:cs typeface="Calibri"/>
              </a:rPr>
              <a:t>ng/</a:t>
            </a:r>
            <a:r>
              <a:rPr sz="650" spc="15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]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9" name="object 169"/>
          <p:cNvSpPr txBox="1"/>
          <p:nvPr/>
        </p:nvSpPr>
        <p:spPr>
          <a:xfrm>
            <a:off x="8085714" y="2879635"/>
            <a:ext cx="433070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7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70" name="object 170"/>
          <p:cNvSpPr txBox="1"/>
          <p:nvPr/>
        </p:nvSpPr>
        <p:spPr>
          <a:xfrm>
            <a:off x="5270887" y="2829768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71" name="object 171"/>
          <p:cNvSpPr/>
          <p:nvPr/>
        </p:nvSpPr>
        <p:spPr>
          <a:xfrm>
            <a:off x="5861189" y="5815584"/>
            <a:ext cx="1935480" cy="0"/>
          </a:xfrm>
          <a:custGeom>
            <a:avLst/>
            <a:gdLst/>
            <a:ahLst/>
            <a:cxnLst/>
            <a:rect l="l" t="t" r="r" b="b"/>
            <a:pathLst>
              <a:path w="1935479">
                <a:moveTo>
                  <a:pt x="0" y="0"/>
                </a:moveTo>
                <a:lnTo>
                  <a:pt x="193547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2" name="object 172"/>
          <p:cNvSpPr/>
          <p:nvPr/>
        </p:nvSpPr>
        <p:spPr>
          <a:xfrm>
            <a:off x="6565277" y="5337048"/>
            <a:ext cx="1262380" cy="0"/>
          </a:xfrm>
          <a:custGeom>
            <a:avLst/>
            <a:gdLst/>
            <a:ahLst/>
            <a:cxnLst/>
            <a:rect l="l" t="t" r="r" b="b"/>
            <a:pathLst>
              <a:path w="1262379">
                <a:moveTo>
                  <a:pt x="0" y="0"/>
                </a:moveTo>
                <a:lnTo>
                  <a:pt x="1261872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3" name="object 173"/>
          <p:cNvSpPr/>
          <p:nvPr/>
        </p:nvSpPr>
        <p:spPr>
          <a:xfrm>
            <a:off x="5861189" y="5337048"/>
            <a:ext cx="643255" cy="0"/>
          </a:xfrm>
          <a:custGeom>
            <a:avLst/>
            <a:gdLst/>
            <a:ahLst/>
            <a:cxnLst/>
            <a:rect l="l" t="t" r="r" b="b"/>
            <a:pathLst>
              <a:path w="643254">
                <a:moveTo>
                  <a:pt x="0" y="0"/>
                </a:moveTo>
                <a:lnTo>
                  <a:pt x="643127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4" name="object 174"/>
          <p:cNvSpPr/>
          <p:nvPr/>
        </p:nvSpPr>
        <p:spPr>
          <a:xfrm>
            <a:off x="5861189" y="48585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5" name="object 175"/>
          <p:cNvSpPr/>
          <p:nvPr/>
        </p:nvSpPr>
        <p:spPr>
          <a:xfrm>
            <a:off x="5888621" y="4858511"/>
            <a:ext cx="0" cy="1466215"/>
          </a:xfrm>
          <a:custGeom>
            <a:avLst/>
            <a:gdLst/>
            <a:ahLst/>
            <a:cxnLst/>
            <a:rect l="l" t="t" r="r" b="b"/>
            <a:pathLst>
              <a:path h="1466214">
                <a:moveTo>
                  <a:pt x="0" y="0"/>
                </a:moveTo>
                <a:lnTo>
                  <a:pt x="0" y="1466087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6" name="object 176"/>
          <p:cNvSpPr/>
          <p:nvPr/>
        </p:nvSpPr>
        <p:spPr>
          <a:xfrm>
            <a:off x="5861189" y="6294120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7" name="object 177"/>
          <p:cNvSpPr/>
          <p:nvPr/>
        </p:nvSpPr>
        <p:spPr>
          <a:xfrm>
            <a:off x="6047117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8" name="object 178"/>
          <p:cNvSpPr/>
          <p:nvPr/>
        </p:nvSpPr>
        <p:spPr>
          <a:xfrm>
            <a:off x="6208662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9" name="object 179"/>
          <p:cNvSpPr/>
          <p:nvPr/>
        </p:nvSpPr>
        <p:spPr>
          <a:xfrm>
            <a:off x="6370193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0" name="object 180"/>
          <p:cNvSpPr/>
          <p:nvPr/>
        </p:nvSpPr>
        <p:spPr>
          <a:xfrm>
            <a:off x="6531749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1" name="object 181"/>
          <p:cNvSpPr/>
          <p:nvPr/>
        </p:nvSpPr>
        <p:spPr>
          <a:xfrm>
            <a:off x="669328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2" name="object 182"/>
          <p:cNvSpPr/>
          <p:nvPr/>
        </p:nvSpPr>
        <p:spPr>
          <a:xfrm>
            <a:off x="6854825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3" name="object 183"/>
          <p:cNvSpPr/>
          <p:nvPr/>
        </p:nvSpPr>
        <p:spPr>
          <a:xfrm>
            <a:off x="701638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4" name="object 184"/>
          <p:cNvSpPr/>
          <p:nvPr/>
        </p:nvSpPr>
        <p:spPr>
          <a:xfrm>
            <a:off x="7177925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5" name="object 185"/>
          <p:cNvSpPr/>
          <p:nvPr/>
        </p:nvSpPr>
        <p:spPr>
          <a:xfrm>
            <a:off x="7339469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6" name="object 186"/>
          <p:cNvSpPr/>
          <p:nvPr/>
        </p:nvSpPr>
        <p:spPr>
          <a:xfrm>
            <a:off x="750100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7" name="object 187"/>
          <p:cNvSpPr/>
          <p:nvPr/>
        </p:nvSpPr>
        <p:spPr>
          <a:xfrm>
            <a:off x="7662557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8" name="object 188"/>
          <p:cNvSpPr/>
          <p:nvPr/>
        </p:nvSpPr>
        <p:spPr>
          <a:xfrm>
            <a:off x="782410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9" name="object 189"/>
          <p:cNvSpPr/>
          <p:nvPr/>
        </p:nvSpPr>
        <p:spPr>
          <a:xfrm>
            <a:off x="5889891" y="5004561"/>
            <a:ext cx="1978647" cy="863092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0" name="object 190"/>
          <p:cNvSpPr txBox="1"/>
          <p:nvPr/>
        </p:nvSpPr>
        <p:spPr>
          <a:xfrm>
            <a:off x="5708272" y="5757415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1" name="object 191"/>
          <p:cNvSpPr txBox="1"/>
          <p:nvPr/>
        </p:nvSpPr>
        <p:spPr>
          <a:xfrm>
            <a:off x="5665603" y="5278877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2" name="object 192"/>
          <p:cNvSpPr txBox="1"/>
          <p:nvPr/>
        </p:nvSpPr>
        <p:spPr>
          <a:xfrm>
            <a:off x="5621404" y="4800338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3" name="object 193"/>
          <p:cNvSpPr/>
          <p:nvPr/>
        </p:nvSpPr>
        <p:spPr>
          <a:xfrm>
            <a:off x="7999361" y="532485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4" name="object 194"/>
          <p:cNvSpPr/>
          <p:nvPr/>
        </p:nvSpPr>
        <p:spPr>
          <a:xfrm>
            <a:off x="8066405" y="5298947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5" name="object 195"/>
          <p:cNvSpPr/>
          <p:nvPr/>
        </p:nvSpPr>
        <p:spPr>
          <a:xfrm>
            <a:off x="8063369" y="5295900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5" h="56514">
                <a:moveTo>
                  <a:pt x="56387" y="30480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30480"/>
                </a:lnTo>
                <a:lnTo>
                  <a:pt x="4571" y="35052"/>
                </a:lnTo>
                <a:lnTo>
                  <a:pt x="4571" y="25908"/>
                </a:lnTo>
                <a:lnTo>
                  <a:pt x="6857" y="28193"/>
                </a:lnTo>
                <a:lnTo>
                  <a:pt x="25907" y="9143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9144"/>
                </a:lnTo>
                <a:lnTo>
                  <a:pt x="49529" y="28194"/>
                </a:lnTo>
                <a:lnTo>
                  <a:pt x="51815" y="25908"/>
                </a:lnTo>
                <a:lnTo>
                  <a:pt x="51815" y="35052"/>
                </a:lnTo>
                <a:lnTo>
                  <a:pt x="56387" y="30480"/>
                </a:lnTo>
                <a:close/>
              </a:path>
              <a:path w="56515" h="56514">
                <a:moveTo>
                  <a:pt x="6857" y="28194"/>
                </a:moveTo>
                <a:lnTo>
                  <a:pt x="4571" y="25908"/>
                </a:lnTo>
                <a:lnTo>
                  <a:pt x="4571" y="30480"/>
                </a:lnTo>
                <a:lnTo>
                  <a:pt x="6857" y="28194"/>
                </a:lnTo>
                <a:close/>
              </a:path>
              <a:path w="56515" h="56514">
                <a:moveTo>
                  <a:pt x="28193" y="49530"/>
                </a:moveTo>
                <a:lnTo>
                  <a:pt x="6857" y="28194"/>
                </a:lnTo>
                <a:lnTo>
                  <a:pt x="4571" y="30480"/>
                </a:lnTo>
                <a:lnTo>
                  <a:pt x="4571" y="35052"/>
                </a:lnTo>
                <a:lnTo>
                  <a:pt x="25907" y="56388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6514">
                <a:moveTo>
                  <a:pt x="30479" y="4572"/>
                </a:moveTo>
                <a:lnTo>
                  <a:pt x="25907" y="4572"/>
                </a:lnTo>
                <a:lnTo>
                  <a:pt x="28193" y="6857"/>
                </a:lnTo>
                <a:lnTo>
                  <a:pt x="30479" y="4572"/>
                </a:lnTo>
                <a:close/>
              </a:path>
              <a:path w="56515" h="56514">
                <a:moveTo>
                  <a:pt x="28193" y="6858"/>
                </a:moveTo>
                <a:lnTo>
                  <a:pt x="25907" y="4572"/>
                </a:lnTo>
                <a:lnTo>
                  <a:pt x="25907" y="9143"/>
                </a:lnTo>
                <a:lnTo>
                  <a:pt x="28193" y="6858"/>
                </a:lnTo>
                <a:close/>
              </a:path>
              <a:path w="56515" h="56514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6514">
                <a:moveTo>
                  <a:pt x="30479" y="56388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6388"/>
                </a:lnTo>
                <a:lnTo>
                  <a:pt x="30479" y="56388"/>
                </a:lnTo>
                <a:close/>
              </a:path>
              <a:path w="56515" h="56514">
                <a:moveTo>
                  <a:pt x="30479" y="9144"/>
                </a:moveTo>
                <a:lnTo>
                  <a:pt x="30479" y="4572"/>
                </a:lnTo>
                <a:lnTo>
                  <a:pt x="28193" y="6858"/>
                </a:lnTo>
                <a:lnTo>
                  <a:pt x="30479" y="9144"/>
                </a:lnTo>
                <a:close/>
              </a:path>
              <a:path w="56515" h="56514">
                <a:moveTo>
                  <a:pt x="51815" y="35052"/>
                </a:moveTo>
                <a:lnTo>
                  <a:pt x="51815" y="30480"/>
                </a:lnTo>
                <a:lnTo>
                  <a:pt x="49529" y="28193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6388"/>
                </a:lnTo>
                <a:lnTo>
                  <a:pt x="51815" y="35052"/>
                </a:lnTo>
                <a:close/>
              </a:path>
              <a:path w="56515" h="56514">
                <a:moveTo>
                  <a:pt x="51815" y="30480"/>
                </a:moveTo>
                <a:lnTo>
                  <a:pt x="51815" y="25908"/>
                </a:lnTo>
                <a:lnTo>
                  <a:pt x="49529" y="28193"/>
                </a:lnTo>
                <a:lnTo>
                  <a:pt x="51815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6" name="object 196"/>
          <p:cNvSpPr txBox="1"/>
          <p:nvPr/>
        </p:nvSpPr>
        <p:spPr>
          <a:xfrm>
            <a:off x="8180203" y="5260548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7" name="object 197"/>
          <p:cNvSpPr/>
          <p:nvPr/>
        </p:nvSpPr>
        <p:spPr>
          <a:xfrm>
            <a:off x="7999361" y="5618988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8" name="object 198"/>
          <p:cNvSpPr/>
          <p:nvPr/>
        </p:nvSpPr>
        <p:spPr>
          <a:xfrm>
            <a:off x="8066417" y="5618988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9" name="object 199"/>
          <p:cNvSpPr/>
          <p:nvPr/>
        </p:nvSpPr>
        <p:spPr>
          <a:xfrm>
            <a:off x="8063369" y="5590032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0" name="object 200"/>
          <p:cNvSpPr txBox="1"/>
          <p:nvPr/>
        </p:nvSpPr>
        <p:spPr>
          <a:xfrm>
            <a:off x="8180203" y="5560821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1" name="object 201"/>
          <p:cNvSpPr/>
          <p:nvPr/>
        </p:nvSpPr>
        <p:spPr>
          <a:xfrm>
            <a:off x="7999361" y="5913120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2" name="object 202"/>
          <p:cNvSpPr/>
          <p:nvPr/>
        </p:nvSpPr>
        <p:spPr>
          <a:xfrm>
            <a:off x="8066405" y="5887211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3" name="object 203"/>
          <p:cNvSpPr/>
          <p:nvPr/>
        </p:nvSpPr>
        <p:spPr>
          <a:xfrm>
            <a:off x="8063369" y="5884164"/>
            <a:ext cx="56515" cy="58419"/>
          </a:xfrm>
          <a:custGeom>
            <a:avLst/>
            <a:gdLst/>
            <a:ahLst/>
            <a:cxnLst/>
            <a:rect l="l" t="t" r="r" b="b"/>
            <a:pathLst>
              <a:path w="56515" h="58420">
                <a:moveTo>
                  <a:pt x="56387" y="56388"/>
                </a:moveTo>
                <a:lnTo>
                  <a:pt x="56387" y="53340"/>
                </a:lnTo>
                <a:lnTo>
                  <a:pt x="30479" y="1524"/>
                </a:lnTo>
                <a:lnTo>
                  <a:pt x="28955" y="0"/>
                </a:lnTo>
                <a:lnTo>
                  <a:pt x="25907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6857" y="51816"/>
                </a:lnTo>
                <a:lnTo>
                  <a:pt x="25907" y="13716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13716"/>
                </a:lnTo>
                <a:lnTo>
                  <a:pt x="49529" y="51816"/>
                </a:lnTo>
                <a:lnTo>
                  <a:pt x="54863" y="51816"/>
                </a:lnTo>
                <a:lnTo>
                  <a:pt x="54863" y="57912"/>
                </a:lnTo>
                <a:lnTo>
                  <a:pt x="56387" y="56388"/>
                </a:lnTo>
                <a:close/>
              </a:path>
              <a:path w="56515" h="58420">
                <a:moveTo>
                  <a:pt x="6857" y="51816"/>
                </a:moveTo>
                <a:lnTo>
                  <a:pt x="3047" y="51816"/>
                </a:lnTo>
                <a:lnTo>
                  <a:pt x="4571" y="56388"/>
                </a:lnTo>
                <a:lnTo>
                  <a:pt x="6857" y="51816"/>
                </a:lnTo>
                <a:close/>
              </a:path>
              <a:path w="56515" h="58420">
                <a:moveTo>
                  <a:pt x="54863" y="57912"/>
                </a:moveTo>
                <a:lnTo>
                  <a:pt x="54863" y="51816"/>
                </a:lnTo>
                <a:lnTo>
                  <a:pt x="51815" y="56388"/>
                </a:lnTo>
                <a:lnTo>
                  <a:pt x="49529" y="51816"/>
                </a:lnTo>
                <a:lnTo>
                  <a:pt x="6857" y="51816"/>
                </a:lnTo>
                <a:lnTo>
                  <a:pt x="4571" y="56388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close/>
              </a:path>
              <a:path w="56515" h="58420">
                <a:moveTo>
                  <a:pt x="30479" y="4572"/>
                </a:moveTo>
                <a:lnTo>
                  <a:pt x="25907" y="4572"/>
                </a:lnTo>
                <a:lnTo>
                  <a:pt x="28193" y="9144"/>
                </a:lnTo>
                <a:lnTo>
                  <a:pt x="30479" y="4572"/>
                </a:lnTo>
                <a:close/>
              </a:path>
              <a:path w="56515" h="58420">
                <a:moveTo>
                  <a:pt x="28193" y="9144"/>
                </a:moveTo>
                <a:lnTo>
                  <a:pt x="25907" y="4572"/>
                </a:lnTo>
                <a:lnTo>
                  <a:pt x="25907" y="13716"/>
                </a:lnTo>
                <a:lnTo>
                  <a:pt x="28193" y="9144"/>
                </a:lnTo>
                <a:close/>
              </a:path>
              <a:path w="56515" h="58420">
                <a:moveTo>
                  <a:pt x="30479" y="13716"/>
                </a:moveTo>
                <a:lnTo>
                  <a:pt x="30479" y="4572"/>
                </a:lnTo>
                <a:lnTo>
                  <a:pt x="28193" y="9144"/>
                </a:lnTo>
                <a:lnTo>
                  <a:pt x="30479" y="13716"/>
                </a:lnTo>
                <a:close/>
              </a:path>
              <a:path w="56515" h="58420">
                <a:moveTo>
                  <a:pt x="54863" y="51816"/>
                </a:moveTo>
                <a:lnTo>
                  <a:pt x="49529" y="51816"/>
                </a:lnTo>
                <a:lnTo>
                  <a:pt x="51815" y="56388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4" name="object 204"/>
          <p:cNvSpPr txBox="1"/>
          <p:nvPr/>
        </p:nvSpPr>
        <p:spPr>
          <a:xfrm>
            <a:off x="8180203" y="5854953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5" name="object 205"/>
          <p:cNvSpPr/>
          <p:nvPr/>
        </p:nvSpPr>
        <p:spPr>
          <a:xfrm>
            <a:off x="5178437" y="4742688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6" name="object 206"/>
          <p:cNvSpPr txBox="1"/>
          <p:nvPr/>
        </p:nvSpPr>
        <p:spPr>
          <a:xfrm>
            <a:off x="8085714" y="4854740"/>
            <a:ext cx="433070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</a:t>
            </a:r>
            <a:r>
              <a:rPr sz="750" b="1" spc="-5" dirty="0">
                <a:latin typeface="Calibri"/>
                <a:cs typeface="Calibri"/>
              </a:rPr>
              <a:t>8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208" name="object 208"/>
          <p:cNvSpPr txBox="1"/>
          <p:nvPr/>
        </p:nvSpPr>
        <p:spPr>
          <a:xfrm>
            <a:off x="1622431" y="6235953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9" name="object 209"/>
          <p:cNvSpPr txBox="1"/>
          <p:nvPr/>
        </p:nvSpPr>
        <p:spPr>
          <a:xfrm>
            <a:off x="5752471" y="6235953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10" name="object 210"/>
          <p:cNvSpPr txBox="1">
            <a:spLocks noGrp="1"/>
          </p:cNvSpPr>
          <p:nvPr>
            <p:ph type="ftr" sz="quarter" idx="5"/>
          </p:nvPr>
        </p:nvSpPr>
        <p:spPr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/>
              <a:t>6     </a:t>
            </a:r>
            <a:r>
              <a:rPr sz="650" spc="40" dirty="0"/>
              <a:t> </a:t>
            </a:r>
            <a:r>
              <a:rPr sz="650" spc="15" dirty="0"/>
              <a:t>7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8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9</a:t>
            </a:r>
            <a:r>
              <a:rPr sz="650" dirty="0"/>
              <a:t>    </a:t>
            </a:r>
            <a:r>
              <a:rPr sz="650" spc="20" dirty="0"/>
              <a:t> </a:t>
            </a:r>
            <a:r>
              <a:rPr sz="650" spc="15" dirty="0"/>
              <a:t>10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1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</a:t>
            </a:r>
            <a:r>
              <a:rPr sz="650" spc="30" dirty="0"/>
              <a:t>2</a:t>
            </a:r>
            <a:r>
              <a:rPr spc="-5" dirty="0"/>
              <a:t>t</a:t>
            </a:r>
            <a:r>
              <a:rPr spc="-10" dirty="0"/>
              <a:t>i</a:t>
            </a:r>
            <a:r>
              <a:rPr spc="-5" dirty="0"/>
              <a:t>me</a:t>
            </a:r>
            <a:r>
              <a:rPr dirty="0"/>
              <a:t> </a:t>
            </a:r>
            <a:r>
              <a:rPr spc="-5" dirty="0"/>
              <a:t>(h)</a:t>
            </a:r>
            <a:endParaRPr sz="650"/>
          </a:p>
        </p:txBody>
      </p:sp>
      <p:sp>
        <p:nvSpPr>
          <p:cNvPr id="211" name="object 211"/>
          <p:cNvSpPr txBox="1"/>
          <p:nvPr/>
        </p:nvSpPr>
        <p:spPr>
          <a:xfrm>
            <a:off x="6823918" y="6336026"/>
            <a:ext cx="137160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6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212" name="object 212"/>
          <p:cNvSpPr txBox="1">
            <a:spLocks noGrp="1"/>
          </p:cNvSpPr>
          <p:nvPr>
            <p:ph type="dt" sz="half" idx="6"/>
          </p:nvPr>
        </p:nvSpPr>
        <p:spPr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pc="15" dirty="0"/>
              <a:t>0     </a:t>
            </a:r>
            <a:r>
              <a:rPr spc="40" dirty="0"/>
              <a:t> </a:t>
            </a:r>
            <a:r>
              <a:rPr spc="15" dirty="0"/>
              <a:t>1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2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3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4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5</a:t>
            </a:r>
          </a:p>
        </p:txBody>
      </p:sp>
      <p:sp>
        <p:nvSpPr>
          <p:cNvPr id="213" name="object 213"/>
          <p:cNvSpPr txBox="1"/>
          <p:nvPr/>
        </p:nvSpPr>
        <p:spPr>
          <a:xfrm>
            <a:off x="5854575" y="6348726"/>
            <a:ext cx="877569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7" name="object 207"/>
          <p:cNvSpPr txBox="1"/>
          <p:nvPr/>
        </p:nvSpPr>
        <p:spPr>
          <a:xfrm>
            <a:off x="5270887" y="4804872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869833" y="2164079"/>
            <a:ext cx="1827530" cy="0"/>
          </a:xfrm>
          <a:custGeom>
            <a:avLst/>
            <a:gdLst/>
            <a:ahLst/>
            <a:cxnLst/>
            <a:rect l="l" t="t" r="r" b="b"/>
            <a:pathLst>
              <a:path w="1827529">
                <a:moveTo>
                  <a:pt x="0" y="0"/>
                </a:moveTo>
                <a:lnTo>
                  <a:pt x="1827275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1731149" y="2164079"/>
            <a:ext cx="78105" cy="0"/>
          </a:xfrm>
          <a:custGeom>
            <a:avLst/>
            <a:gdLst/>
            <a:ahLst/>
            <a:cxnLst/>
            <a:rect l="l" t="t" r="r" b="b"/>
            <a:pathLst>
              <a:path w="78105">
                <a:moveTo>
                  <a:pt x="0" y="0"/>
                </a:moveTo>
                <a:lnTo>
                  <a:pt x="77724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1950605" y="1984248"/>
            <a:ext cx="1746885" cy="0"/>
          </a:xfrm>
          <a:custGeom>
            <a:avLst/>
            <a:gdLst/>
            <a:ahLst/>
            <a:cxnLst/>
            <a:rect l="l" t="t" r="r" b="b"/>
            <a:pathLst>
              <a:path w="1746885">
                <a:moveTo>
                  <a:pt x="0" y="0"/>
                </a:moveTo>
                <a:lnTo>
                  <a:pt x="1746503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1731149" y="1984248"/>
            <a:ext cx="158750" cy="0"/>
          </a:xfrm>
          <a:custGeom>
            <a:avLst/>
            <a:gdLst/>
            <a:ahLst/>
            <a:cxnLst/>
            <a:rect l="l" t="t" r="r" b="b"/>
            <a:pathLst>
              <a:path w="158750">
                <a:moveTo>
                  <a:pt x="0" y="0"/>
                </a:moveTo>
                <a:lnTo>
                  <a:pt x="158495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731149" y="180593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1731149" y="162610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1731149" y="1446275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1731149" y="126796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1731149" y="108813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1731149" y="908303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1758569" y="908303"/>
            <a:ext cx="0" cy="1403985"/>
          </a:xfrm>
          <a:custGeom>
            <a:avLst/>
            <a:gdLst/>
            <a:ahLst/>
            <a:cxnLst/>
            <a:rect l="l" t="t" r="r" b="b"/>
            <a:pathLst>
              <a:path h="1403985">
                <a:moveTo>
                  <a:pt x="0" y="0"/>
                </a:moveTo>
                <a:lnTo>
                  <a:pt x="0" y="1403603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1789061" y="2343911"/>
            <a:ext cx="1908175" cy="0"/>
          </a:xfrm>
          <a:custGeom>
            <a:avLst/>
            <a:gdLst/>
            <a:ahLst/>
            <a:cxnLst/>
            <a:rect l="l" t="t" r="r" b="b"/>
            <a:pathLst>
              <a:path w="1908175">
                <a:moveTo>
                  <a:pt x="0" y="0"/>
                </a:moveTo>
                <a:lnTo>
                  <a:pt x="1908047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1718703" y="1007110"/>
            <a:ext cx="2019808" cy="1378585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" name="object 15"/>
          <p:cNvSpPr txBox="1"/>
          <p:nvPr/>
        </p:nvSpPr>
        <p:spPr>
          <a:xfrm>
            <a:off x="1535563" y="1927606"/>
            <a:ext cx="156845" cy="47561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ctr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 marL="55244">
              <a:lnSpc>
                <a:spcPct val="100000"/>
              </a:lnSpc>
              <a:spcBef>
                <a:spcPts val="620"/>
              </a:spcBef>
            </a:pPr>
            <a:r>
              <a:rPr sz="650" spc="15" dirty="0">
                <a:latin typeface="Calibri"/>
                <a:cs typeface="Calibri"/>
              </a:rPr>
              <a:t>50</a:t>
            </a:r>
            <a:endParaRPr sz="650">
              <a:latin typeface="Calibri"/>
              <a:cs typeface="Calibri"/>
            </a:endParaRPr>
          </a:p>
          <a:p>
            <a:pPr>
              <a:lnSpc>
                <a:spcPts val="600"/>
              </a:lnSpc>
              <a:spcBef>
                <a:spcPts val="36"/>
              </a:spcBef>
            </a:pPr>
            <a:endParaRPr sz="600"/>
          </a:p>
          <a:p>
            <a:pPr marL="86360" algn="ctr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1535563" y="1747772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1535563" y="1567938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8" name="object 18"/>
          <p:cNvSpPr txBox="1"/>
          <p:nvPr/>
        </p:nvSpPr>
        <p:spPr>
          <a:xfrm>
            <a:off x="1535563" y="1389633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" name="object 19"/>
          <p:cNvSpPr txBox="1"/>
          <p:nvPr/>
        </p:nvSpPr>
        <p:spPr>
          <a:xfrm>
            <a:off x="1535563" y="850131"/>
            <a:ext cx="156845" cy="47688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>
              <a:lnSpc>
                <a:spcPts val="600"/>
              </a:lnSpc>
              <a:spcBef>
                <a:spcPts val="36"/>
              </a:spcBef>
            </a:pPr>
            <a:endParaRPr sz="600"/>
          </a:p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  <a:p>
            <a:pPr>
              <a:lnSpc>
                <a:spcPts val="600"/>
              </a:lnSpc>
              <a:spcBef>
                <a:spcPts val="36"/>
              </a:spcBef>
            </a:pPr>
            <a:endParaRPr sz="600"/>
          </a:p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" name="object 20"/>
          <p:cNvSpPr/>
          <p:nvPr/>
        </p:nvSpPr>
        <p:spPr>
          <a:xfrm>
            <a:off x="3869321" y="1374647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" name="object 21"/>
          <p:cNvSpPr/>
          <p:nvPr/>
        </p:nvSpPr>
        <p:spPr>
          <a:xfrm>
            <a:off x="3936377" y="1348739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3933329" y="1345691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4" h="56515">
                <a:moveTo>
                  <a:pt x="56388" y="30480"/>
                </a:moveTo>
                <a:lnTo>
                  <a:pt x="56388" y="25908"/>
                </a:lnTo>
                <a:lnTo>
                  <a:pt x="30480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30480"/>
                </a:lnTo>
                <a:lnTo>
                  <a:pt x="4572" y="35052"/>
                </a:lnTo>
                <a:lnTo>
                  <a:pt x="4572" y="25908"/>
                </a:lnTo>
                <a:lnTo>
                  <a:pt x="6858" y="28193"/>
                </a:lnTo>
                <a:lnTo>
                  <a:pt x="25908" y="9143"/>
                </a:lnTo>
                <a:lnTo>
                  <a:pt x="25908" y="4572"/>
                </a:lnTo>
                <a:lnTo>
                  <a:pt x="30480" y="4572"/>
                </a:lnTo>
                <a:lnTo>
                  <a:pt x="30480" y="9144"/>
                </a:lnTo>
                <a:lnTo>
                  <a:pt x="49530" y="28194"/>
                </a:lnTo>
                <a:lnTo>
                  <a:pt x="51816" y="25908"/>
                </a:lnTo>
                <a:lnTo>
                  <a:pt x="51816" y="35052"/>
                </a:lnTo>
                <a:lnTo>
                  <a:pt x="56388" y="30480"/>
                </a:lnTo>
                <a:close/>
              </a:path>
              <a:path w="56514" h="56515">
                <a:moveTo>
                  <a:pt x="6858" y="28194"/>
                </a:moveTo>
                <a:lnTo>
                  <a:pt x="4572" y="25908"/>
                </a:lnTo>
                <a:lnTo>
                  <a:pt x="4572" y="30480"/>
                </a:lnTo>
                <a:lnTo>
                  <a:pt x="6858" y="28194"/>
                </a:lnTo>
                <a:close/>
              </a:path>
              <a:path w="56514" h="56515">
                <a:moveTo>
                  <a:pt x="28194" y="49530"/>
                </a:moveTo>
                <a:lnTo>
                  <a:pt x="6858" y="28194"/>
                </a:lnTo>
                <a:lnTo>
                  <a:pt x="4572" y="30480"/>
                </a:lnTo>
                <a:lnTo>
                  <a:pt x="4572" y="35052"/>
                </a:lnTo>
                <a:lnTo>
                  <a:pt x="25908" y="56388"/>
                </a:lnTo>
                <a:lnTo>
                  <a:pt x="25908" y="51816"/>
                </a:lnTo>
                <a:lnTo>
                  <a:pt x="28194" y="49530"/>
                </a:lnTo>
                <a:close/>
              </a:path>
              <a:path w="56514" h="56515">
                <a:moveTo>
                  <a:pt x="30480" y="4572"/>
                </a:moveTo>
                <a:lnTo>
                  <a:pt x="25908" y="4572"/>
                </a:lnTo>
                <a:lnTo>
                  <a:pt x="28194" y="6857"/>
                </a:lnTo>
                <a:lnTo>
                  <a:pt x="30480" y="4572"/>
                </a:lnTo>
                <a:close/>
              </a:path>
              <a:path w="56514" h="56515">
                <a:moveTo>
                  <a:pt x="28194" y="6858"/>
                </a:moveTo>
                <a:lnTo>
                  <a:pt x="25908" y="4572"/>
                </a:lnTo>
                <a:lnTo>
                  <a:pt x="25908" y="9143"/>
                </a:lnTo>
                <a:lnTo>
                  <a:pt x="28194" y="6858"/>
                </a:lnTo>
                <a:close/>
              </a:path>
              <a:path w="56514" h="56515">
                <a:moveTo>
                  <a:pt x="30480" y="51816"/>
                </a:moveTo>
                <a:lnTo>
                  <a:pt x="28194" y="49530"/>
                </a:lnTo>
                <a:lnTo>
                  <a:pt x="25908" y="51816"/>
                </a:lnTo>
                <a:lnTo>
                  <a:pt x="30480" y="51816"/>
                </a:lnTo>
                <a:close/>
              </a:path>
              <a:path w="56514" h="56515">
                <a:moveTo>
                  <a:pt x="30480" y="56388"/>
                </a:moveTo>
                <a:lnTo>
                  <a:pt x="30480" y="51816"/>
                </a:lnTo>
                <a:lnTo>
                  <a:pt x="25908" y="51816"/>
                </a:lnTo>
                <a:lnTo>
                  <a:pt x="25908" y="56388"/>
                </a:lnTo>
                <a:lnTo>
                  <a:pt x="30480" y="56388"/>
                </a:lnTo>
                <a:close/>
              </a:path>
              <a:path w="56514" h="56515">
                <a:moveTo>
                  <a:pt x="30480" y="9144"/>
                </a:moveTo>
                <a:lnTo>
                  <a:pt x="30480" y="4572"/>
                </a:lnTo>
                <a:lnTo>
                  <a:pt x="28194" y="6858"/>
                </a:lnTo>
                <a:lnTo>
                  <a:pt x="30480" y="9144"/>
                </a:lnTo>
                <a:close/>
              </a:path>
              <a:path w="56514" h="56515">
                <a:moveTo>
                  <a:pt x="51816" y="35052"/>
                </a:moveTo>
                <a:lnTo>
                  <a:pt x="51816" y="30480"/>
                </a:lnTo>
                <a:lnTo>
                  <a:pt x="49530" y="28193"/>
                </a:lnTo>
                <a:lnTo>
                  <a:pt x="28194" y="49530"/>
                </a:lnTo>
                <a:lnTo>
                  <a:pt x="30480" y="51816"/>
                </a:lnTo>
                <a:lnTo>
                  <a:pt x="30480" y="56388"/>
                </a:lnTo>
                <a:lnTo>
                  <a:pt x="51816" y="35052"/>
                </a:lnTo>
                <a:close/>
              </a:path>
              <a:path w="56514" h="56515">
                <a:moveTo>
                  <a:pt x="51816" y="30480"/>
                </a:moveTo>
                <a:lnTo>
                  <a:pt x="51816" y="25908"/>
                </a:lnTo>
                <a:lnTo>
                  <a:pt x="49530" y="28193"/>
                </a:lnTo>
                <a:lnTo>
                  <a:pt x="51816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3869321" y="166877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3936377" y="1668779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3933329" y="1639823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19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19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19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19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19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19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3869321" y="1962911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3936377" y="1937004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3933329" y="1933955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6388"/>
                </a:moveTo>
                <a:lnTo>
                  <a:pt x="57912" y="53340"/>
                </a:lnTo>
                <a:lnTo>
                  <a:pt x="32004" y="1524"/>
                </a:lnTo>
                <a:lnTo>
                  <a:pt x="28956" y="0"/>
                </a:lnTo>
                <a:lnTo>
                  <a:pt x="25908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8382" y="51816"/>
                </a:lnTo>
                <a:lnTo>
                  <a:pt x="25908" y="16764"/>
                </a:lnTo>
                <a:lnTo>
                  <a:pt x="25908" y="4572"/>
                </a:lnTo>
                <a:lnTo>
                  <a:pt x="32004" y="4572"/>
                </a:lnTo>
                <a:lnTo>
                  <a:pt x="32004" y="16764"/>
                </a:lnTo>
                <a:lnTo>
                  <a:pt x="49530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19">
                <a:moveTo>
                  <a:pt x="8382" y="51816"/>
                </a:moveTo>
                <a:lnTo>
                  <a:pt x="3048" y="51816"/>
                </a:lnTo>
                <a:lnTo>
                  <a:pt x="6096" y="56388"/>
                </a:lnTo>
                <a:lnTo>
                  <a:pt x="8382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6388"/>
                </a:lnTo>
                <a:lnTo>
                  <a:pt x="49530" y="51816"/>
                </a:lnTo>
                <a:lnTo>
                  <a:pt x="8382" y="51816"/>
                </a:lnTo>
                <a:lnTo>
                  <a:pt x="6096" y="56388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19">
                <a:moveTo>
                  <a:pt x="32004" y="4572"/>
                </a:moveTo>
                <a:lnTo>
                  <a:pt x="25908" y="4572"/>
                </a:lnTo>
                <a:lnTo>
                  <a:pt x="28956" y="10668"/>
                </a:lnTo>
                <a:lnTo>
                  <a:pt x="32004" y="4572"/>
                </a:lnTo>
                <a:close/>
              </a:path>
              <a:path w="58420" h="58419">
                <a:moveTo>
                  <a:pt x="28956" y="10668"/>
                </a:moveTo>
                <a:lnTo>
                  <a:pt x="25908" y="4572"/>
                </a:lnTo>
                <a:lnTo>
                  <a:pt x="25908" y="16764"/>
                </a:lnTo>
                <a:lnTo>
                  <a:pt x="28956" y="10668"/>
                </a:lnTo>
                <a:close/>
              </a:path>
              <a:path w="58420" h="58419">
                <a:moveTo>
                  <a:pt x="32004" y="16764"/>
                </a:moveTo>
                <a:lnTo>
                  <a:pt x="32004" y="4572"/>
                </a:lnTo>
                <a:lnTo>
                  <a:pt x="28956" y="10668"/>
                </a:lnTo>
                <a:lnTo>
                  <a:pt x="32004" y="16764"/>
                </a:lnTo>
                <a:close/>
              </a:path>
              <a:path w="58420" h="58419">
                <a:moveTo>
                  <a:pt x="54864" y="51816"/>
                </a:moveTo>
                <a:lnTo>
                  <a:pt x="49530" y="51816"/>
                </a:lnTo>
                <a:lnTo>
                  <a:pt x="51816" y="56388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1048397" y="792480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5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5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5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5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0" name="object 30"/>
          <p:cNvSpPr txBox="1"/>
          <p:nvPr/>
        </p:nvSpPr>
        <p:spPr>
          <a:xfrm>
            <a:off x="1724536" y="2385817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4050163" y="1310340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4050163" y="1610614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4050163" y="1904746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3955675" y="904532"/>
            <a:ext cx="433070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1</a:t>
            </a:r>
            <a:r>
              <a:rPr sz="750" b="1" spc="-5" dirty="0">
                <a:latin typeface="Calibri"/>
                <a:cs typeface="Calibri"/>
              </a:rPr>
              <a:t>1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1140847" y="854664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36" name="object 36"/>
          <p:cNvSpPr/>
          <p:nvPr/>
        </p:nvSpPr>
        <p:spPr>
          <a:xfrm>
            <a:off x="2758325" y="4079747"/>
            <a:ext cx="939165" cy="0"/>
          </a:xfrm>
          <a:custGeom>
            <a:avLst/>
            <a:gdLst/>
            <a:ahLst/>
            <a:cxnLst/>
            <a:rect l="l" t="t" r="r" b="b"/>
            <a:pathLst>
              <a:path w="939164">
                <a:moveTo>
                  <a:pt x="0" y="0"/>
                </a:moveTo>
                <a:lnTo>
                  <a:pt x="938783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7" name="object 37"/>
          <p:cNvSpPr/>
          <p:nvPr/>
        </p:nvSpPr>
        <p:spPr>
          <a:xfrm>
            <a:off x="1731149" y="4079747"/>
            <a:ext cx="966469" cy="0"/>
          </a:xfrm>
          <a:custGeom>
            <a:avLst/>
            <a:gdLst/>
            <a:ahLst/>
            <a:cxnLst/>
            <a:rect l="l" t="t" r="r" b="b"/>
            <a:pathLst>
              <a:path w="966469">
                <a:moveTo>
                  <a:pt x="0" y="0"/>
                </a:moveTo>
                <a:lnTo>
                  <a:pt x="966215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8" name="object 38"/>
          <p:cNvSpPr/>
          <p:nvPr/>
        </p:nvSpPr>
        <p:spPr>
          <a:xfrm>
            <a:off x="1731149" y="384047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1731149" y="36012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1731149" y="336194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1" name="object 41"/>
          <p:cNvSpPr/>
          <p:nvPr/>
        </p:nvSpPr>
        <p:spPr>
          <a:xfrm>
            <a:off x="1731149" y="312267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2" name="object 42"/>
          <p:cNvSpPr/>
          <p:nvPr/>
        </p:nvSpPr>
        <p:spPr>
          <a:xfrm>
            <a:off x="1731149" y="288340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3" name="object 43"/>
          <p:cNvSpPr/>
          <p:nvPr/>
        </p:nvSpPr>
        <p:spPr>
          <a:xfrm>
            <a:off x="1758569" y="2883407"/>
            <a:ext cx="0" cy="1403985"/>
          </a:xfrm>
          <a:custGeom>
            <a:avLst/>
            <a:gdLst/>
            <a:ahLst/>
            <a:cxnLst/>
            <a:rect l="l" t="t" r="r" b="b"/>
            <a:pathLst>
              <a:path h="1403985">
                <a:moveTo>
                  <a:pt x="0" y="0"/>
                </a:moveTo>
                <a:lnTo>
                  <a:pt x="0" y="1403604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4" name="object 44"/>
          <p:cNvSpPr/>
          <p:nvPr/>
        </p:nvSpPr>
        <p:spPr>
          <a:xfrm>
            <a:off x="1789061" y="4319015"/>
            <a:ext cx="1908175" cy="0"/>
          </a:xfrm>
          <a:custGeom>
            <a:avLst/>
            <a:gdLst/>
            <a:ahLst/>
            <a:cxnLst/>
            <a:rect l="l" t="t" r="r" b="b"/>
            <a:pathLst>
              <a:path w="1908175">
                <a:moveTo>
                  <a:pt x="0" y="0"/>
                </a:moveTo>
                <a:lnTo>
                  <a:pt x="1908047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5" name="object 45"/>
          <p:cNvSpPr/>
          <p:nvPr/>
        </p:nvSpPr>
        <p:spPr>
          <a:xfrm>
            <a:off x="1718703" y="2957829"/>
            <a:ext cx="2019807" cy="1402969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46" name="object 46"/>
          <p:cNvSpPr txBox="1"/>
          <p:nvPr/>
        </p:nvSpPr>
        <p:spPr>
          <a:xfrm>
            <a:off x="1622431" y="4260850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1578232" y="4021580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5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1535563" y="3782311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1535563" y="3543042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50" name="object 50"/>
          <p:cNvSpPr txBox="1"/>
          <p:nvPr/>
        </p:nvSpPr>
        <p:spPr>
          <a:xfrm>
            <a:off x="1535563" y="3303773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1535563" y="3064504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52" name="object 52"/>
          <p:cNvSpPr txBox="1"/>
          <p:nvPr/>
        </p:nvSpPr>
        <p:spPr>
          <a:xfrm>
            <a:off x="1535563" y="2825234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53" name="object 53"/>
          <p:cNvSpPr/>
          <p:nvPr/>
        </p:nvSpPr>
        <p:spPr>
          <a:xfrm>
            <a:off x="3869321" y="3349752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3936377" y="3323844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3933329" y="3320796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4" h="56514">
                <a:moveTo>
                  <a:pt x="56388" y="30480"/>
                </a:moveTo>
                <a:lnTo>
                  <a:pt x="56388" y="25908"/>
                </a:lnTo>
                <a:lnTo>
                  <a:pt x="30480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30480"/>
                </a:lnTo>
                <a:lnTo>
                  <a:pt x="4572" y="35052"/>
                </a:lnTo>
                <a:lnTo>
                  <a:pt x="4572" y="25908"/>
                </a:lnTo>
                <a:lnTo>
                  <a:pt x="6858" y="28193"/>
                </a:lnTo>
                <a:lnTo>
                  <a:pt x="25908" y="9143"/>
                </a:lnTo>
                <a:lnTo>
                  <a:pt x="25908" y="4572"/>
                </a:lnTo>
                <a:lnTo>
                  <a:pt x="30480" y="4572"/>
                </a:lnTo>
                <a:lnTo>
                  <a:pt x="30480" y="9144"/>
                </a:lnTo>
                <a:lnTo>
                  <a:pt x="49530" y="28194"/>
                </a:lnTo>
                <a:lnTo>
                  <a:pt x="51816" y="25908"/>
                </a:lnTo>
                <a:lnTo>
                  <a:pt x="51816" y="35052"/>
                </a:lnTo>
                <a:lnTo>
                  <a:pt x="56388" y="30480"/>
                </a:lnTo>
                <a:close/>
              </a:path>
              <a:path w="56514" h="56514">
                <a:moveTo>
                  <a:pt x="6858" y="28194"/>
                </a:moveTo>
                <a:lnTo>
                  <a:pt x="4572" y="25908"/>
                </a:lnTo>
                <a:lnTo>
                  <a:pt x="4572" y="30480"/>
                </a:lnTo>
                <a:lnTo>
                  <a:pt x="6858" y="28194"/>
                </a:lnTo>
                <a:close/>
              </a:path>
              <a:path w="56514" h="56514">
                <a:moveTo>
                  <a:pt x="28194" y="49530"/>
                </a:moveTo>
                <a:lnTo>
                  <a:pt x="6858" y="28194"/>
                </a:lnTo>
                <a:lnTo>
                  <a:pt x="4572" y="30480"/>
                </a:lnTo>
                <a:lnTo>
                  <a:pt x="4572" y="35052"/>
                </a:lnTo>
                <a:lnTo>
                  <a:pt x="25908" y="56388"/>
                </a:lnTo>
                <a:lnTo>
                  <a:pt x="25908" y="51816"/>
                </a:lnTo>
                <a:lnTo>
                  <a:pt x="28194" y="49530"/>
                </a:lnTo>
                <a:close/>
              </a:path>
              <a:path w="56514" h="56514">
                <a:moveTo>
                  <a:pt x="30480" y="4572"/>
                </a:moveTo>
                <a:lnTo>
                  <a:pt x="25908" y="4572"/>
                </a:lnTo>
                <a:lnTo>
                  <a:pt x="28194" y="6857"/>
                </a:lnTo>
                <a:lnTo>
                  <a:pt x="30480" y="4572"/>
                </a:lnTo>
                <a:close/>
              </a:path>
              <a:path w="56514" h="56514">
                <a:moveTo>
                  <a:pt x="28194" y="6858"/>
                </a:moveTo>
                <a:lnTo>
                  <a:pt x="25908" y="4572"/>
                </a:lnTo>
                <a:lnTo>
                  <a:pt x="25908" y="9143"/>
                </a:lnTo>
                <a:lnTo>
                  <a:pt x="28194" y="6858"/>
                </a:lnTo>
                <a:close/>
              </a:path>
              <a:path w="56514" h="56514">
                <a:moveTo>
                  <a:pt x="30480" y="51816"/>
                </a:moveTo>
                <a:lnTo>
                  <a:pt x="28194" y="49530"/>
                </a:lnTo>
                <a:lnTo>
                  <a:pt x="25908" y="51816"/>
                </a:lnTo>
                <a:lnTo>
                  <a:pt x="30480" y="51816"/>
                </a:lnTo>
                <a:close/>
              </a:path>
              <a:path w="56514" h="56514">
                <a:moveTo>
                  <a:pt x="30480" y="56388"/>
                </a:moveTo>
                <a:lnTo>
                  <a:pt x="30480" y="51816"/>
                </a:lnTo>
                <a:lnTo>
                  <a:pt x="25908" y="51816"/>
                </a:lnTo>
                <a:lnTo>
                  <a:pt x="25908" y="56388"/>
                </a:lnTo>
                <a:lnTo>
                  <a:pt x="30480" y="56388"/>
                </a:lnTo>
                <a:close/>
              </a:path>
              <a:path w="56514" h="56514">
                <a:moveTo>
                  <a:pt x="30480" y="9144"/>
                </a:moveTo>
                <a:lnTo>
                  <a:pt x="30480" y="4572"/>
                </a:lnTo>
                <a:lnTo>
                  <a:pt x="28194" y="6858"/>
                </a:lnTo>
                <a:lnTo>
                  <a:pt x="30480" y="9144"/>
                </a:lnTo>
                <a:close/>
              </a:path>
              <a:path w="56514" h="56514">
                <a:moveTo>
                  <a:pt x="51816" y="35052"/>
                </a:moveTo>
                <a:lnTo>
                  <a:pt x="51816" y="30480"/>
                </a:lnTo>
                <a:lnTo>
                  <a:pt x="49530" y="28193"/>
                </a:lnTo>
                <a:lnTo>
                  <a:pt x="28194" y="49530"/>
                </a:lnTo>
                <a:lnTo>
                  <a:pt x="30480" y="51816"/>
                </a:lnTo>
                <a:lnTo>
                  <a:pt x="30480" y="56388"/>
                </a:lnTo>
                <a:lnTo>
                  <a:pt x="51816" y="35052"/>
                </a:lnTo>
                <a:close/>
              </a:path>
              <a:path w="56514" h="56514">
                <a:moveTo>
                  <a:pt x="51816" y="30480"/>
                </a:moveTo>
                <a:lnTo>
                  <a:pt x="51816" y="25908"/>
                </a:lnTo>
                <a:lnTo>
                  <a:pt x="49530" y="28193"/>
                </a:lnTo>
                <a:lnTo>
                  <a:pt x="51816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3869321" y="3643884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3936377" y="3643884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3933329" y="3614928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3869321" y="393801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0" name="object 60"/>
          <p:cNvSpPr/>
          <p:nvPr/>
        </p:nvSpPr>
        <p:spPr>
          <a:xfrm>
            <a:off x="3936377" y="3912108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1" name="object 61"/>
          <p:cNvSpPr/>
          <p:nvPr/>
        </p:nvSpPr>
        <p:spPr>
          <a:xfrm>
            <a:off x="3933329" y="3909059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6388"/>
                </a:moveTo>
                <a:lnTo>
                  <a:pt x="57912" y="53340"/>
                </a:lnTo>
                <a:lnTo>
                  <a:pt x="32004" y="1524"/>
                </a:lnTo>
                <a:lnTo>
                  <a:pt x="28956" y="0"/>
                </a:lnTo>
                <a:lnTo>
                  <a:pt x="25908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8382" y="51816"/>
                </a:lnTo>
                <a:lnTo>
                  <a:pt x="25908" y="16764"/>
                </a:lnTo>
                <a:lnTo>
                  <a:pt x="25908" y="4572"/>
                </a:lnTo>
                <a:lnTo>
                  <a:pt x="32004" y="4572"/>
                </a:lnTo>
                <a:lnTo>
                  <a:pt x="32004" y="16764"/>
                </a:lnTo>
                <a:lnTo>
                  <a:pt x="49530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20">
                <a:moveTo>
                  <a:pt x="8382" y="51816"/>
                </a:moveTo>
                <a:lnTo>
                  <a:pt x="3048" y="51816"/>
                </a:lnTo>
                <a:lnTo>
                  <a:pt x="6096" y="56388"/>
                </a:lnTo>
                <a:lnTo>
                  <a:pt x="8382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6388"/>
                </a:lnTo>
                <a:lnTo>
                  <a:pt x="49530" y="51816"/>
                </a:lnTo>
                <a:lnTo>
                  <a:pt x="8382" y="51816"/>
                </a:lnTo>
                <a:lnTo>
                  <a:pt x="6096" y="56388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20">
                <a:moveTo>
                  <a:pt x="32004" y="4572"/>
                </a:moveTo>
                <a:lnTo>
                  <a:pt x="25908" y="4572"/>
                </a:lnTo>
                <a:lnTo>
                  <a:pt x="28956" y="10668"/>
                </a:lnTo>
                <a:lnTo>
                  <a:pt x="32004" y="4572"/>
                </a:lnTo>
                <a:close/>
              </a:path>
              <a:path w="58420" h="58420">
                <a:moveTo>
                  <a:pt x="28956" y="10668"/>
                </a:moveTo>
                <a:lnTo>
                  <a:pt x="25908" y="4572"/>
                </a:lnTo>
                <a:lnTo>
                  <a:pt x="25908" y="16764"/>
                </a:lnTo>
                <a:lnTo>
                  <a:pt x="28956" y="10668"/>
                </a:lnTo>
                <a:close/>
              </a:path>
              <a:path w="58420" h="58420">
                <a:moveTo>
                  <a:pt x="32004" y="16764"/>
                </a:moveTo>
                <a:lnTo>
                  <a:pt x="32004" y="4572"/>
                </a:lnTo>
                <a:lnTo>
                  <a:pt x="28956" y="10668"/>
                </a:lnTo>
                <a:lnTo>
                  <a:pt x="32004" y="16764"/>
                </a:lnTo>
                <a:close/>
              </a:path>
              <a:path w="58420" h="58420">
                <a:moveTo>
                  <a:pt x="54864" y="51816"/>
                </a:moveTo>
                <a:lnTo>
                  <a:pt x="49530" y="51816"/>
                </a:lnTo>
                <a:lnTo>
                  <a:pt x="51816" y="56388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2" name="object 62"/>
          <p:cNvSpPr/>
          <p:nvPr/>
        </p:nvSpPr>
        <p:spPr>
          <a:xfrm>
            <a:off x="1048397" y="2767583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63" name="object 63"/>
          <p:cNvSpPr txBox="1"/>
          <p:nvPr/>
        </p:nvSpPr>
        <p:spPr>
          <a:xfrm>
            <a:off x="1724536" y="4360922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64" name="object 64"/>
          <p:cNvSpPr txBox="1"/>
          <p:nvPr/>
        </p:nvSpPr>
        <p:spPr>
          <a:xfrm>
            <a:off x="4050163" y="3285444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4050163" y="3585717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4050163" y="3879850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67" name="object 67"/>
          <p:cNvSpPr txBox="1"/>
          <p:nvPr/>
        </p:nvSpPr>
        <p:spPr>
          <a:xfrm>
            <a:off x="3955675" y="2879635"/>
            <a:ext cx="433070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1</a:t>
            </a:r>
            <a:r>
              <a:rPr sz="750" b="1" spc="-5" dirty="0">
                <a:latin typeface="Calibri"/>
                <a:cs typeface="Calibri"/>
              </a:rPr>
              <a:t>2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68" name="object 68"/>
          <p:cNvSpPr txBox="1"/>
          <p:nvPr/>
        </p:nvSpPr>
        <p:spPr>
          <a:xfrm>
            <a:off x="1140847" y="2829768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69" name="object 69"/>
          <p:cNvSpPr/>
          <p:nvPr/>
        </p:nvSpPr>
        <p:spPr>
          <a:xfrm>
            <a:off x="1731149" y="6054852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60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0" name="object 70"/>
          <p:cNvSpPr/>
          <p:nvPr/>
        </p:nvSpPr>
        <p:spPr>
          <a:xfrm>
            <a:off x="2273693" y="5815584"/>
            <a:ext cx="1423670" cy="0"/>
          </a:xfrm>
          <a:custGeom>
            <a:avLst/>
            <a:gdLst/>
            <a:ahLst/>
            <a:cxnLst/>
            <a:rect l="l" t="t" r="r" b="b"/>
            <a:pathLst>
              <a:path w="1423670">
                <a:moveTo>
                  <a:pt x="0" y="0"/>
                </a:moveTo>
                <a:lnTo>
                  <a:pt x="1423415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1" name="object 71"/>
          <p:cNvSpPr/>
          <p:nvPr/>
        </p:nvSpPr>
        <p:spPr>
          <a:xfrm>
            <a:off x="1731149" y="5815584"/>
            <a:ext cx="481965" cy="0"/>
          </a:xfrm>
          <a:custGeom>
            <a:avLst/>
            <a:gdLst/>
            <a:ahLst/>
            <a:cxnLst/>
            <a:rect l="l" t="t" r="r" b="b"/>
            <a:pathLst>
              <a:path w="481964">
                <a:moveTo>
                  <a:pt x="0" y="0"/>
                </a:moveTo>
                <a:lnTo>
                  <a:pt x="481583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2" name="object 72"/>
          <p:cNvSpPr/>
          <p:nvPr/>
        </p:nvSpPr>
        <p:spPr>
          <a:xfrm>
            <a:off x="1731149" y="5576315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3" name="object 73"/>
          <p:cNvSpPr/>
          <p:nvPr/>
        </p:nvSpPr>
        <p:spPr>
          <a:xfrm>
            <a:off x="1731149" y="5337048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4" name="object 74"/>
          <p:cNvSpPr/>
          <p:nvPr/>
        </p:nvSpPr>
        <p:spPr>
          <a:xfrm>
            <a:off x="1731149" y="509777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5" name="object 75"/>
          <p:cNvSpPr/>
          <p:nvPr/>
        </p:nvSpPr>
        <p:spPr>
          <a:xfrm>
            <a:off x="1731149" y="48585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60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6" name="object 76"/>
          <p:cNvSpPr/>
          <p:nvPr/>
        </p:nvSpPr>
        <p:spPr>
          <a:xfrm>
            <a:off x="1758569" y="4858511"/>
            <a:ext cx="0" cy="1403985"/>
          </a:xfrm>
          <a:custGeom>
            <a:avLst/>
            <a:gdLst/>
            <a:ahLst/>
            <a:cxnLst/>
            <a:rect l="l" t="t" r="r" b="b"/>
            <a:pathLst>
              <a:path h="1403985">
                <a:moveTo>
                  <a:pt x="0" y="0"/>
                </a:moveTo>
                <a:lnTo>
                  <a:pt x="0" y="1403603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7" name="object 77"/>
          <p:cNvSpPr/>
          <p:nvPr/>
        </p:nvSpPr>
        <p:spPr>
          <a:xfrm>
            <a:off x="1789061" y="6294120"/>
            <a:ext cx="1908175" cy="0"/>
          </a:xfrm>
          <a:custGeom>
            <a:avLst/>
            <a:gdLst/>
            <a:ahLst/>
            <a:cxnLst/>
            <a:rect l="l" t="t" r="r" b="b"/>
            <a:pathLst>
              <a:path w="1908175">
                <a:moveTo>
                  <a:pt x="0" y="0"/>
                </a:moveTo>
                <a:lnTo>
                  <a:pt x="1908048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8" name="object 78"/>
          <p:cNvSpPr/>
          <p:nvPr/>
        </p:nvSpPr>
        <p:spPr>
          <a:xfrm>
            <a:off x="1718703" y="4894834"/>
            <a:ext cx="2019808" cy="1441069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79" name="object 79"/>
          <p:cNvSpPr txBox="1"/>
          <p:nvPr/>
        </p:nvSpPr>
        <p:spPr>
          <a:xfrm>
            <a:off x="1578232" y="5996684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5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0" name="object 80"/>
          <p:cNvSpPr txBox="1"/>
          <p:nvPr/>
        </p:nvSpPr>
        <p:spPr>
          <a:xfrm>
            <a:off x="1535563" y="5757415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1" name="object 81"/>
          <p:cNvSpPr txBox="1"/>
          <p:nvPr/>
        </p:nvSpPr>
        <p:spPr>
          <a:xfrm>
            <a:off x="1535563" y="5518146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2" name="object 82"/>
          <p:cNvSpPr txBox="1"/>
          <p:nvPr/>
        </p:nvSpPr>
        <p:spPr>
          <a:xfrm>
            <a:off x="1535563" y="5278877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3" name="object 83"/>
          <p:cNvSpPr txBox="1"/>
          <p:nvPr/>
        </p:nvSpPr>
        <p:spPr>
          <a:xfrm>
            <a:off x="1535563" y="5039607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5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4" name="object 84"/>
          <p:cNvSpPr txBox="1"/>
          <p:nvPr/>
        </p:nvSpPr>
        <p:spPr>
          <a:xfrm>
            <a:off x="1535563" y="4800338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5" name="object 85"/>
          <p:cNvSpPr/>
          <p:nvPr/>
        </p:nvSpPr>
        <p:spPr>
          <a:xfrm>
            <a:off x="3869321" y="532485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6" name="object 86"/>
          <p:cNvSpPr/>
          <p:nvPr/>
        </p:nvSpPr>
        <p:spPr>
          <a:xfrm>
            <a:off x="3936377" y="5298947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25908"/>
                </a:moveTo>
                <a:lnTo>
                  <a:pt x="25908" y="0"/>
                </a:lnTo>
                <a:lnTo>
                  <a:pt x="0" y="25908"/>
                </a:lnTo>
                <a:lnTo>
                  <a:pt x="25908" y="51816"/>
                </a:lnTo>
                <a:lnTo>
                  <a:pt x="51816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7" name="object 87"/>
          <p:cNvSpPr/>
          <p:nvPr/>
        </p:nvSpPr>
        <p:spPr>
          <a:xfrm>
            <a:off x="3933329" y="5295900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4" h="56514">
                <a:moveTo>
                  <a:pt x="56388" y="30480"/>
                </a:moveTo>
                <a:lnTo>
                  <a:pt x="56388" y="25908"/>
                </a:lnTo>
                <a:lnTo>
                  <a:pt x="30480" y="0"/>
                </a:lnTo>
                <a:lnTo>
                  <a:pt x="25908" y="0"/>
                </a:lnTo>
                <a:lnTo>
                  <a:pt x="0" y="25908"/>
                </a:lnTo>
                <a:lnTo>
                  <a:pt x="0" y="30480"/>
                </a:lnTo>
                <a:lnTo>
                  <a:pt x="4572" y="35052"/>
                </a:lnTo>
                <a:lnTo>
                  <a:pt x="4572" y="25908"/>
                </a:lnTo>
                <a:lnTo>
                  <a:pt x="6858" y="28193"/>
                </a:lnTo>
                <a:lnTo>
                  <a:pt x="25908" y="9143"/>
                </a:lnTo>
                <a:lnTo>
                  <a:pt x="25908" y="4572"/>
                </a:lnTo>
                <a:lnTo>
                  <a:pt x="30480" y="4572"/>
                </a:lnTo>
                <a:lnTo>
                  <a:pt x="30480" y="9144"/>
                </a:lnTo>
                <a:lnTo>
                  <a:pt x="49530" y="28194"/>
                </a:lnTo>
                <a:lnTo>
                  <a:pt x="51816" y="25908"/>
                </a:lnTo>
                <a:lnTo>
                  <a:pt x="51816" y="35052"/>
                </a:lnTo>
                <a:lnTo>
                  <a:pt x="56388" y="30480"/>
                </a:lnTo>
                <a:close/>
              </a:path>
              <a:path w="56514" h="56514">
                <a:moveTo>
                  <a:pt x="6858" y="28194"/>
                </a:moveTo>
                <a:lnTo>
                  <a:pt x="4572" y="25908"/>
                </a:lnTo>
                <a:lnTo>
                  <a:pt x="4572" y="30480"/>
                </a:lnTo>
                <a:lnTo>
                  <a:pt x="6858" y="28194"/>
                </a:lnTo>
                <a:close/>
              </a:path>
              <a:path w="56514" h="56514">
                <a:moveTo>
                  <a:pt x="28194" y="49530"/>
                </a:moveTo>
                <a:lnTo>
                  <a:pt x="6858" y="28194"/>
                </a:lnTo>
                <a:lnTo>
                  <a:pt x="4572" y="30480"/>
                </a:lnTo>
                <a:lnTo>
                  <a:pt x="4572" y="35052"/>
                </a:lnTo>
                <a:lnTo>
                  <a:pt x="25908" y="56388"/>
                </a:lnTo>
                <a:lnTo>
                  <a:pt x="25908" y="51816"/>
                </a:lnTo>
                <a:lnTo>
                  <a:pt x="28194" y="49530"/>
                </a:lnTo>
                <a:close/>
              </a:path>
              <a:path w="56514" h="56514">
                <a:moveTo>
                  <a:pt x="30480" y="4572"/>
                </a:moveTo>
                <a:lnTo>
                  <a:pt x="25908" y="4572"/>
                </a:lnTo>
                <a:lnTo>
                  <a:pt x="28194" y="6857"/>
                </a:lnTo>
                <a:lnTo>
                  <a:pt x="30480" y="4572"/>
                </a:lnTo>
                <a:close/>
              </a:path>
              <a:path w="56514" h="56514">
                <a:moveTo>
                  <a:pt x="28194" y="6858"/>
                </a:moveTo>
                <a:lnTo>
                  <a:pt x="25908" y="4572"/>
                </a:lnTo>
                <a:lnTo>
                  <a:pt x="25908" y="9143"/>
                </a:lnTo>
                <a:lnTo>
                  <a:pt x="28194" y="6858"/>
                </a:lnTo>
                <a:close/>
              </a:path>
              <a:path w="56514" h="56514">
                <a:moveTo>
                  <a:pt x="30480" y="51816"/>
                </a:moveTo>
                <a:lnTo>
                  <a:pt x="28194" y="49530"/>
                </a:lnTo>
                <a:lnTo>
                  <a:pt x="25908" y="51816"/>
                </a:lnTo>
                <a:lnTo>
                  <a:pt x="30480" y="51816"/>
                </a:lnTo>
                <a:close/>
              </a:path>
              <a:path w="56514" h="56514">
                <a:moveTo>
                  <a:pt x="30480" y="56388"/>
                </a:moveTo>
                <a:lnTo>
                  <a:pt x="30480" y="51816"/>
                </a:lnTo>
                <a:lnTo>
                  <a:pt x="25908" y="51816"/>
                </a:lnTo>
                <a:lnTo>
                  <a:pt x="25908" y="56388"/>
                </a:lnTo>
                <a:lnTo>
                  <a:pt x="30480" y="56388"/>
                </a:lnTo>
                <a:close/>
              </a:path>
              <a:path w="56514" h="56514">
                <a:moveTo>
                  <a:pt x="30480" y="9144"/>
                </a:moveTo>
                <a:lnTo>
                  <a:pt x="30480" y="4572"/>
                </a:lnTo>
                <a:lnTo>
                  <a:pt x="28194" y="6858"/>
                </a:lnTo>
                <a:lnTo>
                  <a:pt x="30480" y="9144"/>
                </a:lnTo>
                <a:close/>
              </a:path>
              <a:path w="56514" h="56514">
                <a:moveTo>
                  <a:pt x="51816" y="35052"/>
                </a:moveTo>
                <a:lnTo>
                  <a:pt x="51816" y="30480"/>
                </a:lnTo>
                <a:lnTo>
                  <a:pt x="49530" y="28193"/>
                </a:lnTo>
                <a:lnTo>
                  <a:pt x="28194" y="49530"/>
                </a:lnTo>
                <a:lnTo>
                  <a:pt x="30480" y="51816"/>
                </a:lnTo>
                <a:lnTo>
                  <a:pt x="30480" y="56388"/>
                </a:lnTo>
                <a:lnTo>
                  <a:pt x="51816" y="35052"/>
                </a:lnTo>
                <a:close/>
              </a:path>
              <a:path w="56514" h="56514">
                <a:moveTo>
                  <a:pt x="51816" y="30480"/>
                </a:moveTo>
                <a:lnTo>
                  <a:pt x="51816" y="25908"/>
                </a:lnTo>
                <a:lnTo>
                  <a:pt x="49530" y="28193"/>
                </a:lnTo>
                <a:lnTo>
                  <a:pt x="51816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88" name="object 88"/>
          <p:cNvSpPr txBox="1"/>
          <p:nvPr/>
        </p:nvSpPr>
        <p:spPr>
          <a:xfrm>
            <a:off x="4050163" y="5260548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89" name="object 89"/>
          <p:cNvSpPr/>
          <p:nvPr/>
        </p:nvSpPr>
        <p:spPr>
          <a:xfrm>
            <a:off x="3869321" y="5618988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0" name="object 90"/>
          <p:cNvSpPr/>
          <p:nvPr/>
        </p:nvSpPr>
        <p:spPr>
          <a:xfrm>
            <a:off x="3936377" y="5618988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5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1" name="object 91"/>
          <p:cNvSpPr/>
          <p:nvPr/>
        </p:nvSpPr>
        <p:spPr>
          <a:xfrm>
            <a:off x="3933329" y="5590032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2" name="object 92"/>
          <p:cNvSpPr txBox="1"/>
          <p:nvPr/>
        </p:nvSpPr>
        <p:spPr>
          <a:xfrm>
            <a:off x="4050163" y="5560821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93" name="object 93"/>
          <p:cNvSpPr/>
          <p:nvPr/>
        </p:nvSpPr>
        <p:spPr>
          <a:xfrm>
            <a:off x="3869321" y="5913120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5">
                <a:moveTo>
                  <a:pt x="0" y="0"/>
                </a:moveTo>
                <a:lnTo>
                  <a:pt x="184404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4" name="object 94"/>
          <p:cNvSpPr/>
          <p:nvPr/>
        </p:nvSpPr>
        <p:spPr>
          <a:xfrm>
            <a:off x="3936377" y="5887211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6" y="51816"/>
                </a:moveTo>
                <a:lnTo>
                  <a:pt x="25908" y="0"/>
                </a:lnTo>
                <a:lnTo>
                  <a:pt x="0" y="51816"/>
                </a:lnTo>
                <a:lnTo>
                  <a:pt x="51816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5" name="object 95"/>
          <p:cNvSpPr/>
          <p:nvPr/>
        </p:nvSpPr>
        <p:spPr>
          <a:xfrm>
            <a:off x="3933329" y="5884164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6388"/>
                </a:moveTo>
                <a:lnTo>
                  <a:pt x="57912" y="53340"/>
                </a:lnTo>
                <a:lnTo>
                  <a:pt x="32004" y="1524"/>
                </a:lnTo>
                <a:lnTo>
                  <a:pt x="28956" y="0"/>
                </a:lnTo>
                <a:lnTo>
                  <a:pt x="25908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8" y="57912"/>
                </a:lnTo>
                <a:lnTo>
                  <a:pt x="3048" y="51816"/>
                </a:lnTo>
                <a:lnTo>
                  <a:pt x="7620" y="51816"/>
                </a:lnTo>
                <a:lnTo>
                  <a:pt x="25908" y="15240"/>
                </a:lnTo>
                <a:lnTo>
                  <a:pt x="25908" y="3048"/>
                </a:lnTo>
                <a:lnTo>
                  <a:pt x="32004" y="3048"/>
                </a:lnTo>
                <a:lnTo>
                  <a:pt x="32004" y="15240"/>
                </a:lnTo>
                <a:lnTo>
                  <a:pt x="50292" y="51816"/>
                </a:lnTo>
                <a:lnTo>
                  <a:pt x="54864" y="51816"/>
                </a:lnTo>
                <a:lnTo>
                  <a:pt x="54864" y="57912"/>
                </a:lnTo>
                <a:lnTo>
                  <a:pt x="57912" y="56388"/>
                </a:lnTo>
                <a:close/>
              </a:path>
              <a:path w="58420" h="58420">
                <a:moveTo>
                  <a:pt x="7620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7620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0292" y="51816"/>
                </a:lnTo>
                <a:lnTo>
                  <a:pt x="7620" y="51816"/>
                </a:ln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54864" y="57912"/>
                </a:lnTo>
                <a:close/>
              </a:path>
              <a:path w="58420" h="58420">
                <a:moveTo>
                  <a:pt x="32004" y="3048"/>
                </a:moveTo>
                <a:lnTo>
                  <a:pt x="25908" y="3048"/>
                </a:lnTo>
                <a:lnTo>
                  <a:pt x="28956" y="9144"/>
                </a:lnTo>
                <a:lnTo>
                  <a:pt x="32004" y="3048"/>
                </a:lnTo>
                <a:close/>
              </a:path>
              <a:path w="58420" h="58420">
                <a:moveTo>
                  <a:pt x="28956" y="9144"/>
                </a:moveTo>
                <a:lnTo>
                  <a:pt x="25908" y="3048"/>
                </a:lnTo>
                <a:lnTo>
                  <a:pt x="25908" y="15240"/>
                </a:lnTo>
                <a:lnTo>
                  <a:pt x="28956" y="9144"/>
                </a:lnTo>
                <a:close/>
              </a:path>
              <a:path w="58420" h="58420">
                <a:moveTo>
                  <a:pt x="32004" y="15240"/>
                </a:moveTo>
                <a:lnTo>
                  <a:pt x="32004" y="3048"/>
                </a:lnTo>
                <a:lnTo>
                  <a:pt x="28956" y="9144"/>
                </a:lnTo>
                <a:lnTo>
                  <a:pt x="32004" y="15240"/>
                </a:lnTo>
                <a:close/>
              </a:path>
              <a:path w="58420" h="58420">
                <a:moveTo>
                  <a:pt x="54864" y="51816"/>
                </a:moveTo>
                <a:lnTo>
                  <a:pt x="50292" y="51816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6" name="object 96"/>
          <p:cNvSpPr txBox="1"/>
          <p:nvPr/>
        </p:nvSpPr>
        <p:spPr>
          <a:xfrm>
            <a:off x="4050163" y="5854953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97" name="object 97"/>
          <p:cNvSpPr/>
          <p:nvPr/>
        </p:nvSpPr>
        <p:spPr>
          <a:xfrm>
            <a:off x="1048397" y="4742688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98" name="object 98"/>
          <p:cNvSpPr txBox="1"/>
          <p:nvPr/>
        </p:nvSpPr>
        <p:spPr>
          <a:xfrm>
            <a:off x="3955675" y="4854740"/>
            <a:ext cx="433070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1</a:t>
            </a:r>
            <a:r>
              <a:rPr sz="750" b="1" spc="-5" dirty="0">
                <a:latin typeface="Calibri"/>
                <a:cs typeface="Calibri"/>
              </a:rPr>
              <a:t>3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ine</a:t>
            </a:r>
            <a:r>
              <a:rPr sz="750" b="1" spc="-5" dirty="0">
                <a:latin typeface="Calibri"/>
                <a:cs typeface="Calibri"/>
              </a:rPr>
              <a:t>ar </a:t>
            </a:r>
            <a:r>
              <a:rPr sz="750" b="1" spc="-10" dirty="0">
                <a:latin typeface="Calibri"/>
                <a:cs typeface="Calibri"/>
              </a:rPr>
              <a:t>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99" name="object 99"/>
          <p:cNvSpPr txBox="1"/>
          <p:nvPr/>
        </p:nvSpPr>
        <p:spPr>
          <a:xfrm>
            <a:off x="1140847" y="4804872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00" name="object 100"/>
          <p:cNvSpPr/>
          <p:nvPr/>
        </p:nvSpPr>
        <p:spPr>
          <a:xfrm>
            <a:off x="5861189" y="1865376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1" name="object 101"/>
          <p:cNvSpPr/>
          <p:nvPr/>
        </p:nvSpPr>
        <p:spPr>
          <a:xfrm>
            <a:off x="6080645" y="1386839"/>
            <a:ext cx="1746885" cy="0"/>
          </a:xfrm>
          <a:custGeom>
            <a:avLst/>
            <a:gdLst/>
            <a:ahLst/>
            <a:cxnLst/>
            <a:rect l="l" t="t" r="r" b="b"/>
            <a:pathLst>
              <a:path w="1746884">
                <a:moveTo>
                  <a:pt x="0" y="0"/>
                </a:moveTo>
                <a:lnTo>
                  <a:pt x="1746503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2" name="object 102"/>
          <p:cNvSpPr/>
          <p:nvPr/>
        </p:nvSpPr>
        <p:spPr>
          <a:xfrm>
            <a:off x="5861189" y="1386839"/>
            <a:ext cx="158750" cy="0"/>
          </a:xfrm>
          <a:custGeom>
            <a:avLst/>
            <a:gdLst/>
            <a:ahLst/>
            <a:cxnLst/>
            <a:rect l="l" t="t" r="r" b="b"/>
            <a:pathLst>
              <a:path w="158750">
                <a:moveTo>
                  <a:pt x="0" y="0"/>
                </a:moveTo>
                <a:lnTo>
                  <a:pt x="158495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3" name="object 103"/>
          <p:cNvSpPr/>
          <p:nvPr/>
        </p:nvSpPr>
        <p:spPr>
          <a:xfrm>
            <a:off x="5861189" y="908303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4" name="object 104"/>
          <p:cNvSpPr/>
          <p:nvPr/>
        </p:nvSpPr>
        <p:spPr>
          <a:xfrm>
            <a:off x="5888621" y="908303"/>
            <a:ext cx="0" cy="1466215"/>
          </a:xfrm>
          <a:custGeom>
            <a:avLst/>
            <a:gdLst/>
            <a:ahLst/>
            <a:cxnLst/>
            <a:rect l="l" t="t" r="r" b="b"/>
            <a:pathLst>
              <a:path h="1466214">
                <a:moveTo>
                  <a:pt x="0" y="0"/>
                </a:moveTo>
                <a:lnTo>
                  <a:pt x="0" y="1466087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5" name="object 105"/>
          <p:cNvSpPr/>
          <p:nvPr/>
        </p:nvSpPr>
        <p:spPr>
          <a:xfrm>
            <a:off x="5861189" y="23439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6" name="object 106"/>
          <p:cNvSpPr/>
          <p:nvPr/>
        </p:nvSpPr>
        <p:spPr>
          <a:xfrm>
            <a:off x="6047117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7" name="object 107"/>
          <p:cNvSpPr/>
          <p:nvPr/>
        </p:nvSpPr>
        <p:spPr>
          <a:xfrm>
            <a:off x="6208662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8" name="object 108"/>
          <p:cNvSpPr/>
          <p:nvPr/>
        </p:nvSpPr>
        <p:spPr>
          <a:xfrm>
            <a:off x="6370193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09" name="object 109"/>
          <p:cNvSpPr/>
          <p:nvPr/>
        </p:nvSpPr>
        <p:spPr>
          <a:xfrm>
            <a:off x="6531749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0" name="object 110"/>
          <p:cNvSpPr/>
          <p:nvPr/>
        </p:nvSpPr>
        <p:spPr>
          <a:xfrm>
            <a:off x="669328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1" name="object 111"/>
          <p:cNvSpPr/>
          <p:nvPr/>
        </p:nvSpPr>
        <p:spPr>
          <a:xfrm>
            <a:off x="6854825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2" name="object 112"/>
          <p:cNvSpPr/>
          <p:nvPr/>
        </p:nvSpPr>
        <p:spPr>
          <a:xfrm>
            <a:off x="701638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3" name="object 113"/>
          <p:cNvSpPr/>
          <p:nvPr/>
        </p:nvSpPr>
        <p:spPr>
          <a:xfrm>
            <a:off x="7177925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4" name="object 114"/>
          <p:cNvSpPr/>
          <p:nvPr/>
        </p:nvSpPr>
        <p:spPr>
          <a:xfrm>
            <a:off x="7339469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5" name="object 115"/>
          <p:cNvSpPr/>
          <p:nvPr/>
        </p:nvSpPr>
        <p:spPr>
          <a:xfrm>
            <a:off x="750100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6" name="object 116"/>
          <p:cNvSpPr/>
          <p:nvPr/>
        </p:nvSpPr>
        <p:spPr>
          <a:xfrm>
            <a:off x="7662557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7" name="object 117"/>
          <p:cNvSpPr/>
          <p:nvPr/>
        </p:nvSpPr>
        <p:spPr>
          <a:xfrm>
            <a:off x="7824101" y="2343911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8" name="object 118"/>
          <p:cNvSpPr/>
          <p:nvPr/>
        </p:nvSpPr>
        <p:spPr>
          <a:xfrm>
            <a:off x="5889891" y="1078738"/>
            <a:ext cx="1978647" cy="895096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19" name="object 119"/>
          <p:cNvSpPr txBox="1"/>
          <p:nvPr/>
        </p:nvSpPr>
        <p:spPr>
          <a:xfrm>
            <a:off x="5752471" y="2285746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20" name="object 120"/>
          <p:cNvSpPr txBox="1"/>
          <p:nvPr/>
        </p:nvSpPr>
        <p:spPr>
          <a:xfrm>
            <a:off x="5708272" y="1807207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21" name="object 121"/>
          <p:cNvSpPr txBox="1"/>
          <p:nvPr/>
        </p:nvSpPr>
        <p:spPr>
          <a:xfrm>
            <a:off x="5665603" y="1328669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22" name="object 122"/>
          <p:cNvSpPr txBox="1"/>
          <p:nvPr/>
        </p:nvSpPr>
        <p:spPr>
          <a:xfrm>
            <a:off x="5621404" y="850131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23" name="object 123"/>
          <p:cNvSpPr/>
          <p:nvPr/>
        </p:nvSpPr>
        <p:spPr>
          <a:xfrm>
            <a:off x="7999361" y="1374647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4" name="object 124"/>
          <p:cNvSpPr/>
          <p:nvPr/>
        </p:nvSpPr>
        <p:spPr>
          <a:xfrm>
            <a:off x="8066405" y="1348739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5" name="object 125"/>
          <p:cNvSpPr/>
          <p:nvPr/>
        </p:nvSpPr>
        <p:spPr>
          <a:xfrm>
            <a:off x="8063369" y="1345691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5" h="56515">
                <a:moveTo>
                  <a:pt x="56387" y="30480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30480"/>
                </a:lnTo>
                <a:lnTo>
                  <a:pt x="4571" y="35052"/>
                </a:lnTo>
                <a:lnTo>
                  <a:pt x="4571" y="25908"/>
                </a:lnTo>
                <a:lnTo>
                  <a:pt x="6857" y="28193"/>
                </a:lnTo>
                <a:lnTo>
                  <a:pt x="25907" y="9143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9144"/>
                </a:lnTo>
                <a:lnTo>
                  <a:pt x="49529" y="28194"/>
                </a:lnTo>
                <a:lnTo>
                  <a:pt x="51815" y="25908"/>
                </a:lnTo>
                <a:lnTo>
                  <a:pt x="51815" y="35052"/>
                </a:lnTo>
                <a:lnTo>
                  <a:pt x="56387" y="30480"/>
                </a:lnTo>
                <a:close/>
              </a:path>
              <a:path w="56515" h="56515">
                <a:moveTo>
                  <a:pt x="6857" y="28194"/>
                </a:moveTo>
                <a:lnTo>
                  <a:pt x="4571" y="25908"/>
                </a:lnTo>
                <a:lnTo>
                  <a:pt x="4571" y="30480"/>
                </a:lnTo>
                <a:lnTo>
                  <a:pt x="6857" y="28194"/>
                </a:lnTo>
                <a:close/>
              </a:path>
              <a:path w="56515" h="56515">
                <a:moveTo>
                  <a:pt x="28193" y="49530"/>
                </a:moveTo>
                <a:lnTo>
                  <a:pt x="6857" y="28194"/>
                </a:lnTo>
                <a:lnTo>
                  <a:pt x="4571" y="30480"/>
                </a:lnTo>
                <a:lnTo>
                  <a:pt x="4571" y="35052"/>
                </a:lnTo>
                <a:lnTo>
                  <a:pt x="25907" y="56388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6515">
                <a:moveTo>
                  <a:pt x="30479" y="4572"/>
                </a:moveTo>
                <a:lnTo>
                  <a:pt x="25907" y="4572"/>
                </a:lnTo>
                <a:lnTo>
                  <a:pt x="28193" y="6857"/>
                </a:lnTo>
                <a:lnTo>
                  <a:pt x="30479" y="4572"/>
                </a:lnTo>
                <a:close/>
              </a:path>
              <a:path w="56515" h="56515">
                <a:moveTo>
                  <a:pt x="28193" y="6858"/>
                </a:moveTo>
                <a:lnTo>
                  <a:pt x="25907" y="4572"/>
                </a:lnTo>
                <a:lnTo>
                  <a:pt x="25907" y="9143"/>
                </a:lnTo>
                <a:lnTo>
                  <a:pt x="28193" y="6858"/>
                </a:lnTo>
                <a:close/>
              </a:path>
              <a:path w="56515" h="56515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6515">
                <a:moveTo>
                  <a:pt x="30479" y="56388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6388"/>
                </a:lnTo>
                <a:lnTo>
                  <a:pt x="30479" y="56388"/>
                </a:lnTo>
                <a:close/>
              </a:path>
              <a:path w="56515" h="56515">
                <a:moveTo>
                  <a:pt x="30479" y="9144"/>
                </a:moveTo>
                <a:lnTo>
                  <a:pt x="30479" y="4572"/>
                </a:lnTo>
                <a:lnTo>
                  <a:pt x="28193" y="6858"/>
                </a:lnTo>
                <a:lnTo>
                  <a:pt x="30479" y="9144"/>
                </a:lnTo>
                <a:close/>
              </a:path>
              <a:path w="56515" h="56515">
                <a:moveTo>
                  <a:pt x="51815" y="35052"/>
                </a:moveTo>
                <a:lnTo>
                  <a:pt x="51815" y="30480"/>
                </a:lnTo>
                <a:lnTo>
                  <a:pt x="49529" y="28193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6388"/>
                </a:lnTo>
                <a:lnTo>
                  <a:pt x="51815" y="35052"/>
                </a:lnTo>
                <a:close/>
              </a:path>
              <a:path w="56515" h="56515">
                <a:moveTo>
                  <a:pt x="51815" y="30480"/>
                </a:moveTo>
                <a:lnTo>
                  <a:pt x="51815" y="25908"/>
                </a:lnTo>
                <a:lnTo>
                  <a:pt x="49529" y="28193"/>
                </a:lnTo>
                <a:lnTo>
                  <a:pt x="51815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6" name="object 126"/>
          <p:cNvSpPr/>
          <p:nvPr/>
        </p:nvSpPr>
        <p:spPr>
          <a:xfrm>
            <a:off x="7999361" y="1668779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7" name="object 127"/>
          <p:cNvSpPr/>
          <p:nvPr/>
        </p:nvSpPr>
        <p:spPr>
          <a:xfrm>
            <a:off x="8066417" y="1668779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8" name="object 128"/>
          <p:cNvSpPr/>
          <p:nvPr/>
        </p:nvSpPr>
        <p:spPr>
          <a:xfrm>
            <a:off x="8063369" y="1639823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19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19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19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19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19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19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19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19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29" name="object 129"/>
          <p:cNvSpPr/>
          <p:nvPr/>
        </p:nvSpPr>
        <p:spPr>
          <a:xfrm>
            <a:off x="7999361" y="1962911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0" name="object 130"/>
          <p:cNvSpPr/>
          <p:nvPr/>
        </p:nvSpPr>
        <p:spPr>
          <a:xfrm>
            <a:off x="8066405" y="1937004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69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1" name="object 131"/>
          <p:cNvSpPr/>
          <p:nvPr/>
        </p:nvSpPr>
        <p:spPr>
          <a:xfrm>
            <a:off x="8063369" y="1933955"/>
            <a:ext cx="56515" cy="58419"/>
          </a:xfrm>
          <a:custGeom>
            <a:avLst/>
            <a:gdLst/>
            <a:ahLst/>
            <a:cxnLst/>
            <a:rect l="l" t="t" r="r" b="b"/>
            <a:pathLst>
              <a:path w="56515" h="58419">
                <a:moveTo>
                  <a:pt x="56387" y="56388"/>
                </a:moveTo>
                <a:lnTo>
                  <a:pt x="56387" y="53340"/>
                </a:lnTo>
                <a:lnTo>
                  <a:pt x="30479" y="1524"/>
                </a:lnTo>
                <a:lnTo>
                  <a:pt x="28955" y="0"/>
                </a:lnTo>
                <a:lnTo>
                  <a:pt x="25907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6857" y="51816"/>
                </a:lnTo>
                <a:lnTo>
                  <a:pt x="25907" y="13716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13716"/>
                </a:lnTo>
                <a:lnTo>
                  <a:pt x="49529" y="51816"/>
                </a:lnTo>
                <a:lnTo>
                  <a:pt x="54863" y="51816"/>
                </a:lnTo>
                <a:lnTo>
                  <a:pt x="54863" y="57912"/>
                </a:lnTo>
                <a:lnTo>
                  <a:pt x="56387" y="56388"/>
                </a:lnTo>
                <a:close/>
              </a:path>
              <a:path w="56515" h="58419">
                <a:moveTo>
                  <a:pt x="6857" y="51816"/>
                </a:moveTo>
                <a:lnTo>
                  <a:pt x="3047" y="51816"/>
                </a:lnTo>
                <a:lnTo>
                  <a:pt x="4571" y="56388"/>
                </a:lnTo>
                <a:lnTo>
                  <a:pt x="6857" y="51816"/>
                </a:lnTo>
                <a:close/>
              </a:path>
              <a:path w="56515" h="58419">
                <a:moveTo>
                  <a:pt x="54863" y="57912"/>
                </a:moveTo>
                <a:lnTo>
                  <a:pt x="54863" y="51816"/>
                </a:lnTo>
                <a:lnTo>
                  <a:pt x="51815" y="56388"/>
                </a:lnTo>
                <a:lnTo>
                  <a:pt x="49529" y="51816"/>
                </a:lnTo>
                <a:lnTo>
                  <a:pt x="6857" y="51816"/>
                </a:lnTo>
                <a:lnTo>
                  <a:pt x="4571" y="56388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close/>
              </a:path>
              <a:path w="56515" h="58419">
                <a:moveTo>
                  <a:pt x="30479" y="4572"/>
                </a:moveTo>
                <a:lnTo>
                  <a:pt x="25907" y="4572"/>
                </a:lnTo>
                <a:lnTo>
                  <a:pt x="28193" y="9144"/>
                </a:lnTo>
                <a:lnTo>
                  <a:pt x="30479" y="4572"/>
                </a:lnTo>
                <a:close/>
              </a:path>
              <a:path w="56515" h="58419">
                <a:moveTo>
                  <a:pt x="28193" y="9144"/>
                </a:moveTo>
                <a:lnTo>
                  <a:pt x="25907" y="4572"/>
                </a:lnTo>
                <a:lnTo>
                  <a:pt x="25907" y="13716"/>
                </a:lnTo>
                <a:lnTo>
                  <a:pt x="28193" y="9144"/>
                </a:lnTo>
                <a:close/>
              </a:path>
              <a:path w="56515" h="58419">
                <a:moveTo>
                  <a:pt x="30479" y="13716"/>
                </a:moveTo>
                <a:lnTo>
                  <a:pt x="30479" y="4572"/>
                </a:lnTo>
                <a:lnTo>
                  <a:pt x="28193" y="9144"/>
                </a:lnTo>
                <a:lnTo>
                  <a:pt x="30479" y="13716"/>
                </a:lnTo>
                <a:close/>
              </a:path>
              <a:path w="56515" h="58419">
                <a:moveTo>
                  <a:pt x="54863" y="51816"/>
                </a:moveTo>
                <a:lnTo>
                  <a:pt x="49529" y="51816"/>
                </a:lnTo>
                <a:lnTo>
                  <a:pt x="51815" y="56388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2" name="object 132"/>
          <p:cNvSpPr/>
          <p:nvPr/>
        </p:nvSpPr>
        <p:spPr>
          <a:xfrm>
            <a:off x="5178437" y="792480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5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5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5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5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5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5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33" name="object 133"/>
          <p:cNvSpPr txBox="1"/>
          <p:nvPr/>
        </p:nvSpPr>
        <p:spPr>
          <a:xfrm>
            <a:off x="5854575" y="2385817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34" name="object 134"/>
          <p:cNvSpPr txBox="1"/>
          <p:nvPr/>
        </p:nvSpPr>
        <p:spPr>
          <a:xfrm>
            <a:off x="8180203" y="1310340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5" name="object 135"/>
          <p:cNvSpPr txBox="1"/>
          <p:nvPr/>
        </p:nvSpPr>
        <p:spPr>
          <a:xfrm>
            <a:off x="8180203" y="1610614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6" name="object 136"/>
          <p:cNvSpPr txBox="1"/>
          <p:nvPr/>
        </p:nvSpPr>
        <p:spPr>
          <a:xfrm>
            <a:off x="8180203" y="1904746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7" name="object 137"/>
          <p:cNvSpPr txBox="1"/>
          <p:nvPr/>
        </p:nvSpPr>
        <p:spPr>
          <a:xfrm>
            <a:off x="8085714" y="904532"/>
            <a:ext cx="448309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1</a:t>
            </a:r>
            <a:r>
              <a:rPr sz="750" b="1" spc="-5" dirty="0">
                <a:latin typeface="Calibri"/>
                <a:cs typeface="Calibri"/>
              </a:rPr>
              <a:t>1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38" name="object 138"/>
          <p:cNvSpPr txBox="1"/>
          <p:nvPr/>
        </p:nvSpPr>
        <p:spPr>
          <a:xfrm>
            <a:off x="5270887" y="854664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39" name="object 139"/>
          <p:cNvSpPr/>
          <p:nvPr/>
        </p:nvSpPr>
        <p:spPr>
          <a:xfrm>
            <a:off x="5861189" y="3840479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0" name="object 140"/>
          <p:cNvSpPr/>
          <p:nvPr/>
        </p:nvSpPr>
        <p:spPr>
          <a:xfrm>
            <a:off x="5861189" y="3361944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1" name="object 141"/>
          <p:cNvSpPr/>
          <p:nvPr/>
        </p:nvSpPr>
        <p:spPr>
          <a:xfrm>
            <a:off x="5861189" y="2883407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2" name="object 142"/>
          <p:cNvSpPr/>
          <p:nvPr/>
        </p:nvSpPr>
        <p:spPr>
          <a:xfrm>
            <a:off x="5888621" y="2883407"/>
            <a:ext cx="0" cy="1466215"/>
          </a:xfrm>
          <a:custGeom>
            <a:avLst/>
            <a:gdLst/>
            <a:ahLst/>
            <a:cxnLst/>
            <a:rect l="l" t="t" r="r" b="b"/>
            <a:pathLst>
              <a:path h="1466214">
                <a:moveTo>
                  <a:pt x="0" y="0"/>
                </a:moveTo>
                <a:lnTo>
                  <a:pt x="0" y="1466087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3" name="object 143"/>
          <p:cNvSpPr/>
          <p:nvPr/>
        </p:nvSpPr>
        <p:spPr>
          <a:xfrm>
            <a:off x="5861189" y="4319015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4" name="object 144"/>
          <p:cNvSpPr/>
          <p:nvPr/>
        </p:nvSpPr>
        <p:spPr>
          <a:xfrm>
            <a:off x="6047117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5" name="object 145"/>
          <p:cNvSpPr/>
          <p:nvPr/>
        </p:nvSpPr>
        <p:spPr>
          <a:xfrm>
            <a:off x="6208662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6" name="object 146"/>
          <p:cNvSpPr/>
          <p:nvPr/>
        </p:nvSpPr>
        <p:spPr>
          <a:xfrm>
            <a:off x="6370193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7" name="object 147"/>
          <p:cNvSpPr/>
          <p:nvPr/>
        </p:nvSpPr>
        <p:spPr>
          <a:xfrm>
            <a:off x="6531749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8" name="object 148"/>
          <p:cNvSpPr/>
          <p:nvPr/>
        </p:nvSpPr>
        <p:spPr>
          <a:xfrm>
            <a:off x="6693281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49" name="object 149"/>
          <p:cNvSpPr/>
          <p:nvPr/>
        </p:nvSpPr>
        <p:spPr>
          <a:xfrm>
            <a:off x="6854825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0" name="object 150"/>
          <p:cNvSpPr/>
          <p:nvPr/>
        </p:nvSpPr>
        <p:spPr>
          <a:xfrm>
            <a:off x="7016381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1" name="object 151"/>
          <p:cNvSpPr/>
          <p:nvPr/>
        </p:nvSpPr>
        <p:spPr>
          <a:xfrm>
            <a:off x="7177925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2" name="object 152"/>
          <p:cNvSpPr/>
          <p:nvPr/>
        </p:nvSpPr>
        <p:spPr>
          <a:xfrm>
            <a:off x="7339469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3" name="object 153"/>
          <p:cNvSpPr/>
          <p:nvPr/>
        </p:nvSpPr>
        <p:spPr>
          <a:xfrm>
            <a:off x="7501001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4" name="object 154"/>
          <p:cNvSpPr/>
          <p:nvPr/>
        </p:nvSpPr>
        <p:spPr>
          <a:xfrm>
            <a:off x="7662557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5" name="object 155"/>
          <p:cNvSpPr/>
          <p:nvPr/>
        </p:nvSpPr>
        <p:spPr>
          <a:xfrm>
            <a:off x="7824101" y="4319015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6" name="object 156"/>
          <p:cNvSpPr/>
          <p:nvPr/>
        </p:nvSpPr>
        <p:spPr>
          <a:xfrm>
            <a:off x="5889891" y="3110229"/>
            <a:ext cx="1978647" cy="754888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57" name="object 157"/>
          <p:cNvSpPr txBox="1"/>
          <p:nvPr/>
        </p:nvSpPr>
        <p:spPr>
          <a:xfrm>
            <a:off x="5752471" y="4260850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58" name="object 158"/>
          <p:cNvSpPr txBox="1"/>
          <p:nvPr/>
        </p:nvSpPr>
        <p:spPr>
          <a:xfrm>
            <a:off x="5708272" y="3782311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59" name="object 159"/>
          <p:cNvSpPr txBox="1"/>
          <p:nvPr/>
        </p:nvSpPr>
        <p:spPr>
          <a:xfrm>
            <a:off x="5665603" y="3303773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0" name="object 160"/>
          <p:cNvSpPr txBox="1"/>
          <p:nvPr/>
        </p:nvSpPr>
        <p:spPr>
          <a:xfrm>
            <a:off x="5621404" y="2825234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61" name="object 161"/>
          <p:cNvSpPr/>
          <p:nvPr/>
        </p:nvSpPr>
        <p:spPr>
          <a:xfrm>
            <a:off x="7999361" y="3349752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2" name="object 162"/>
          <p:cNvSpPr/>
          <p:nvPr/>
        </p:nvSpPr>
        <p:spPr>
          <a:xfrm>
            <a:off x="8066405" y="3323844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3" name="object 163"/>
          <p:cNvSpPr/>
          <p:nvPr/>
        </p:nvSpPr>
        <p:spPr>
          <a:xfrm>
            <a:off x="8063369" y="3320796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5" h="56514">
                <a:moveTo>
                  <a:pt x="56387" y="30480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30480"/>
                </a:lnTo>
                <a:lnTo>
                  <a:pt x="4571" y="35052"/>
                </a:lnTo>
                <a:lnTo>
                  <a:pt x="4571" y="25908"/>
                </a:lnTo>
                <a:lnTo>
                  <a:pt x="6857" y="28193"/>
                </a:lnTo>
                <a:lnTo>
                  <a:pt x="25907" y="9143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9144"/>
                </a:lnTo>
                <a:lnTo>
                  <a:pt x="49529" y="28194"/>
                </a:lnTo>
                <a:lnTo>
                  <a:pt x="51815" y="25908"/>
                </a:lnTo>
                <a:lnTo>
                  <a:pt x="51815" y="35052"/>
                </a:lnTo>
                <a:lnTo>
                  <a:pt x="56387" y="30480"/>
                </a:lnTo>
                <a:close/>
              </a:path>
              <a:path w="56515" h="56514">
                <a:moveTo>
                  <a:pt x="6857" y="28194"/>
                </a:moveTo>
                <a:lnTo>
                  <a:pt x="4571" y="25908"/>
                </a:lnTo>
                <a:lnTo>
                  <a:pt x="4571" y="30480"/>
                </a:lnTo>
                <a:lnTo>
                  <a:pt x="6857" y="28194"/>
                </a:lnTo>
                <a:close/>
              </a:path>
              <a:path w="56515" h="56514">
                <a:moveTo>
                  <a:pt x="28193" y="49530"/>
                </a:moveTo>
                <a:lnTo>
                  <a:pt x="6857" y="28194"/>
                </a:lnTo>
                <a:lnTo>
                  <a:pt x="4571" y="30480"/>
                </a:lnTo>
                <a:lnTo>
                  <a:pt x="4571" y="35052"/>
                </a:lnTo>
                <a:lnTo>
                  <a:pt x="25907" y="56388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6514">
                <a:moveTo>
                  <a:pt x="30479" y="4572"/>
                </a:moveTo>
                <a:lnTo>
                  <a:pt x="25907" y="4572"/>
                </a:lnTo>
                <a:lnTo>
                  <a:pt x="28193" y="6857"/>
                </a:lnTo>
                <a:lnTo>
                  <a:pt x="30479" y="4572"/>
                </a:lnTo>
                <a:close/>
              </a:path>
              <a:path w="56515" h="56514">
                <a:moveTo>
                  <a:pt x="28193" y="6858"/>
                </a:moveTo>
                <a:lnTo>
                  <a:pt x="25907" y="4572"/>
                </a:lnTo>
                <a:lnTo>
                  <a:pt x="25907" y="9143"/>
                </a:lnTo>
                <a:lnTo>
                  <a:pt x="28193" y="6858"/>
                </a:lnTo>
                <a:close/>
              </a:path>
              <a:path w="56515" h="56514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6514">
                <a:moveTo>
                  <a:pt x="30479" y="56388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6388"/>
                </a:lnTo>
                <a:lnTo>
                  <a:pt x="30479" y="56388"/>
                </a:lnTo>
                <a:close/>
              </a:path>
              <a:path w="56515" h="56514">
                <a:moveTo>
                  <a:pt x="30479" y="9144"/>
                </a:moveTo>
                <a:lnTo>
                  <a:pt x="30479" y="4572"/>
                </a:lnTo>
                <a:lnTo>
                  <a:pt x="28193" y="6858"/>
                </a:lnTo>
                <a:lnTo>
                  <a:pt x="30479" y="9144"/>
                </a:lnTo>
                <a:close/>
              </a:path>
              <a:path w="56515" h="56514">
                <a:moveTo>
                  <a:pt x="51815" y="35052"/>
                </a:moveTo>
                <a:lnTo>
                  <a:pt x="51815" y="30480"/>
                </a:lnTo>
                <a:lnTo>
                  <a:pt x="49529" y="28193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6388"/>
                </a:lnTo>
                <a:lnTo>
                  <a:pt x="51815" y="35052"/>
                </a:lnTo>
                <a:close/>
              </a:path>
              <a:path w="56515" h="56514">
                <a:moveTo>
                  <a:pt x="51815" y="30480"/>
                </a:moveTo>
                <a:lnTo>
                  <a:pt x="51815" y="25908"/>
                </a:lnTo>
                <a:lnTo>
                  <a:pt x="49529" y="28193"/>
                </a:lnTo>
                <a:lnTo>
                  <a:pt x="51815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4" name="object 164"/>
          <p:cNvSpPr/>
          <p:nvPr/>
        </p:nvSpPr>
        <p:spPr>
          <a:xfrm>
            <a:off x="7999361" y="3643884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5" name="object 165"/>
          <p:cNvSpPr/>
          <p:nvPr/>
        </p:nvSpPr>
        <p:spPr>
          <a:xfrm>
            <a:off x="8066417" y="3643884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6" name="object 166"/>
          <p:cNvSpPr/>
          <p:nvPr/>
        </p:nvSpPr>
        <p:spPr>
          <a:xfrm>
            <a:off x="8063369" y="3614928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7" name="object 167"/>
          <p:cNvSpPr/>
          <p:nvPr/>
        </p:nvSpPr>
        <p:spPr>
          <a:xfrm>
            <a:off x="7999361" y="393801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8" name="object 168"/>
          <p:cNvSpPr/>
          <p:nvPr/>
        </p:nvSpPr>
        <p:spPr>
          <a:xfrm>
            <a:off x="8066405" y="3912108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69" name="object 169"/>
          <p:cNvSpPr/>
          <p:nvPr/>
        </p:nvSpPr>
        <p:spPr>
          <a:xfrm>
            <a:off x="8063369" y="3909059"/>
            <a:ext cx="56515" cy="58419"/>
          </a:xfrm>
          <a:custGeom>
            <a:avLst/>
            <a:gdLst/>
            <a:ahLst/>
            <a:cxnLst/>
            <a:rect l="l" t="t" r="r" b="b"/>
            <a:pathLst>
              <a:path w="56515" h="58420">
                <a:moveTo>
                  <a:pt x="56387" y="56388"/>
                </a:moveTo>
                <a:lnTo>
                  <a:pt x="56387" y="53340"/>
                </a:lnTo>
                <a:lnTo>
                  <a:pt x="30479" y="1524"/>
                </a:lnTo>
                <a:lnTo>
                  <a:pt x="28955" y="0"/>
                </a:lnTo>
                <a:lnTo>
                  <a:pt x="25907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6857" y="51816"/>
                </a:lnTo>
                <a:lnTo>
                  <a:pt x="25907" y="13716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13716"/>
                </a:lnTo>
                <a:lnTo>
                  <a:pt x="49529" y="51816"/>
                </a:lnTo>
                <a:lnTo>
                  <a:pt x="54863" y="51816"/>
                </a:lnTo>
                <a:lnTo>
                  <a:pt x="54863" y="57912"/>
                </a:lnTo>
                <a:lnTo>
                  <a:pt x="56387" y="56388"/>
                </a:lnTo>
                <a:close/>
              </a:path>
              <a:path w="56515" h="58420">
                <a:moveTo>
                  <a:pt x="6857" y="51816"/>
                </a:moveTo>
                <a:lnTo>
                  <a:pt x="3047" y="51816"/>
                </a:lnTo>
                <a:lnTo>
                  <a:pt x="4571" y="56388"/>
                </a:lnTo>
                <a:lnTo>
                  <a:pt x="6857" y="51816"/>
                </a:lnTo>
                <a:close/>
              </a:path>
              <a:path w="56515" h="58420">
                <a:moveTo>
                  <a:pt x="54863" y="57912"/>
                </a:moveTo>
                <a:lnTo>
                  <a:pt x="54863" y="51816"/>
                </a:lnTo>
                <a:lnTo>
                  <a:pt x="51815" y="56388"/>
                </a:lnTo>
                <a:lnTo>
                  <a:pt x="49529" y="51816"/>
                </a:lnTo>
                <a:lnTo>
                  <a:pt x="6857" y="51816"/>
                </a:lnTo>
                <a:lnTo>
                  <a:pt x="4571" y="56388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close/>
              </a:path>
              <a:path w="56515" h="58420">
                <a:moveTo>
                  <a:pt x="30479" y="4572"/>
                </a:moveTo>
                <a:lnTo>
                  <a:pt x="25907" y="4572"/>
                </a:lnTo>
                <a:lnTo>
                  <a:pt x="28193" y="9144"/>
                </a:lnTo>
                <a:lnTo>
                  <a:pt x="30479" y="4572"/>
                </a:lnTo>
                <a:close/>
              </a:path>
              <a:path w="56515" h="58420">
                <a:moveTo>
                  <a:pt x="28193" y="9144"/>
                </a:moveTo>
                <a:lnTo>
                  <a:pt x="25907" y="4572"/>
                </a:lnTo>
                <a:lnTo>
                  <a:pt x="25907" y="13716"/>
                </a:lnTo>
                <a:lnTo>
                  <a:pt x="28193" y="9144"/>
                </a:lnTo>
                <a:close/>
              </a:path>
              <a:path w="56515" h="58420">
                <a:moveTo>
                  <a:pt x="30479" y="13716"/>
                </a:moveTo>
                <a:lnTo>
                  <a:pt x="30479" y="4572"/>
                </a:lnTo>
                <a:lnTo>
                  <a:pt x="28193" y="9144"/>
                </a:lnTo>
                <a:lnTo>
                  <a:pt x="30479" y="13716"/>
                </a:lnTo>
                <a:close/>
              </a:path>
              <a:path w="56515" h="58420">
                <a:moveTo>
                  <a:pt x="54863" y="51816"/>
                </a:moveTo>
                <a:lnTo>
                  <a:pt x="49529" y="51816"/>
                </a:lnTo>
                <a:lnTo>
                  <a:pt x="51815" y="56388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0" name="object 170"/>
          <p:cNvSpPr/>
          <p:nvPr/>
        </p:nvSpPr>
        <p:spPr>
          <a:xfrm>
            <a:off x="5178437" y="2767583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1" name="object 171"/>
          <p:cNvSpPr txBox="1"/>
          <p:nvPr/>
        </p:nvSpPr>
        <p:spPr>
          <a:xfrm>
            <a:off x="5854575" y="4360922"/>
            <a:ext cx="234061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6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72" name="object 172"/>
          <p:cNvSpPr txBox="1"/>
          <p:nvPr/>
        </p:nvSpPr>
        <p:spPr>
          <a:xfrm>
            <a:off x="8180203" y="3285444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73" name="object 173"/>
          <p:cNvSpPr txBox="1"/>
          <p:nvPr/>
        </p:nvSpPr>
        <p:spPr>
          <a:xfrm>
            <a:off x="8180203" y="3585717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74" name="object 174"/>
          <p:cNvSpPr txBox="1"/>
          <p:nvPr/>
        </p:nvSpPr>
        <p:spPr>
          <a:xfrm>
            <a:off x="8180203" y="3879850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75" name="object 175"/>
          <p:cNvSpPr txBox="1"/>
          <p:nvPr/>
        </p:nvSpPr>
        <p:spPr>
          <a:xfrm>
            <a:off x="8085714" y="2879635"/>
            <a:ext cx="448309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1</a:t>
            </a:r>
            <a:r>
              <a:rPr sz="750" b="1" spc="-5" dirty="0">
                <a:latin typeface="Calibri"/>
                <a:cs typeface="Calibri"/>
              </a:rPr>
              <a:t>2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176" name="object 176"/>
          <p:cNvSpPr txBox="1"/>
          <p:nvPr/>
        </p:nvSpPr>
        <p:spPr>
          <a:xfrm>
            <a:off x="5270887" y="2829768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77" name="object 177"/>
          <p:cNvSpPr/>
          <p:nvPr/>
        </p:nvSpPr>
        <p:spPr>
          <a:xfrm>
            <a:off x="5861189" y="5815584"/>
            <a:ext cx="1935480" cy="0"/>
          </a:xfrm>
          <a:custGeom>
            <a:avLst/>
            <a:gdLst/>
            <a:ahLst/>
            <a:cxnLst/>
            <a:rect l="l" t="t" r="r" b="b"/>
            <a:pathLst>
              <a:path w="1935479">
                <a:moveTo>
                  <a:pt x="0" y="0"/>
                </a:moveTo>
                <a:lnTo>
                  <a:pt x="1935479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8" name="object 178"/>
          <p:cNvSpPr/>
          <p:nvPr/>
        </p:nvSpPr>
        <p:spPr>
          <a:xfrm>
            <a:off x="6403721" y="5337048"/>
            <a:ext cx="1423670" cy="0"/>
          </a:xfrm>
          <a:custGeom>
            <a:avLst/>
            <a:gdLst/>
            <a:ahLst/>
            <a:cxnLst/>
            <a:rect l="l" t="t" r="r" b="b"/>
            <a:pathLst>
              <a:path w="1423670">
                <a:moveTo>
                  <a:pt x="0" y="0"/>
                </a:moveTo>
                <a:lnTo>
                  <a:pt x="1423428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79" name="object 179"/>
          <p:cNvSpPr/>
          <p:nvPr/>
        </p:nvSpPr>
        <p:spPr>
          <a:xfrm>
            <a:off x="5861189" y="5337048"/>
            <a:ext cx="481965" cy="0"/>
          </a:xfrm>
          <a:custGeom>
            <a:avLst/>
            <a:gdLst/>
            <a:ahLst/>
            <a:cxnLst/>
            <a:rect l="l" t="t" r="r" b="b"/>
            <a:pathLst>
              <a:path w="481964">
                <a:moveTo>
                  <a:pt x="0" y="0"/>
                </a:moveTo>
                <a:lnTo>
                  <a:pt x="481571" y="0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0" name="object 180"/>
          <p:cNvSpPr/>
          <p:nvPr/>
        </p:nvSpPr>
        <p:spPr>
          <a:xfrm>
            <a:off x="5861189" y="4858511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1" name="object 181"/>
          <p:cNvSpPr/>
          <p:nvPr/>
        </p:nvSpPr>
        <p:spPr>
          <a:xfrm>
            <a:off x="5888621" y="4858511"/>
            <a:ext cx="0" cy="1466215"/>
          </a:xfrm>
          <a:custGeom>
            <a:avLst/>
            <a:gdLst/>
            <a:ahLst/>
            <a:cxnLst/>
            <a:rect l="l" t="t" r="r" b="b"/>
            <a:pathLst>
              <a:path h="1466214">
                <a:moveTo>
                  <a:pt x="0" y="0"/>
                </a:moveTo>
                <a:lnTo>
                  <a:pt x="0" y="1466087"/>
                </a:lnTo>
              </a:path>
            </a:pathLst>
          </a:custGeom>
          <a:ln w="7365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2" name="object 182"/>
          <p:cNvSpPr/>
          <p:nvPr/>
        </p:nvSpPr>
        <p:spPr>
          <a:xfrm>
            <a:off x="5861189" y="6294120"/>
            <a:ext cx="1965960" cy="0"/>
          </a:xfrm>
          <a:custGeom>
            <a:avLst/>
            <a:gdLst/>
            <a:ahLst/>
            <a:cxnLst/>
            <a:rect l="l" t="t" r="r" b="b"/>
            <a:pathLst>
              <a:path w="1965959">
                <a:moveTo>
                  <a:pt x="0" y="0"/>
                </a:moveTo>
                <a:lnTo>
                  <a:pt x="1965959" y="0"/>
                </a:lnTo>
              </a:path>
            </a:pathLst>
          </a:custGeom>
          <a:ln w="7366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3" name="object 183"/>
          <p:cNvSpPr/>
          <p:nvPr/>
        </p:nvSpPr>
        <p:spPr>
          <a:xfrm>
            <a:off x="6047117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4" name="object 184"/>
          <p:cNvSpPr/>
          <p:nvPr/>
        </p:nvSpPr>
        <p:spPr>
          <a:xfrm>
            <a:off x="6208662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5" name="object 185"/>
          <p:cNvSpPr/>
          <p:nvPr/>
        </p:nvSpPr>
        <p:spPr>
          <a:xfrm>
            <a:off x="6370193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6" name="object 186"/>
          <p:cNvSpPr/>
          <p:nvPr/>
        </p:nvSpPr>
        <p:spPr>
          <a:xfrm>
            <a:off x="6531749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7" name="object 187"/>
          <p:cNvSpPr/>
          <p:nvPr/>
        </p:nvSpPr>
        <p:spPr>
          <a:xfrm>
            <a:off x="669328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8" name="object 188"/>
          <p:cNvSpPr/>
          <p:nvPr/>
        </p:nvSpPr>
        <p:spPr>
          <a:xfrm>
            <a:off x="6854825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89" name="object 189"/>
          <p:cNvSpPr/>
          <p:nvPr/>
        </p:nvSpPr>
        <p:spPr>
          <a:xfrm>
            <a:off x="701638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0" name="object 190"/>
          <p:cNvSpPr/>
          <p:nvPr/>
        </p:nvSpPr>
        <p:spPr>
          <a:xfrm>
            <a:off x="7177925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1" name="object 191"/>
          <p:cNvSpPr/>
          <p:nvPr/>
        </p:nvSpPr>
        <p:spPr>
          <a:xfrm>
            <a:off x="7339469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2" name="object 192"/>
          <p:cNvSpPr/>
          <p:nvPr/>
        </p:nvSpPr>
        <p:spPr>
          <a:xfrm>
            <a:off x="750100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3" name="object 193"/>
          <p:cNvSpPr/>
          <p:nvPr/>
        </p:nvSpPr>
        <p:spPr>
          <a:xfrm>
            <a:off x="7662557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5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4" name="object 194"/>
          <p:cNvSpPr/>
          <p:nvPr/>
        </p:nvSpPr>
        <p:spPr>
          <a:xfrm>
            <a:off x="7824101" y="6294120"/>
            <a:ext cx="6350" cy="27940"/>
          </a:xfrm>
          <a:custGeom>
            <a:avLst/>
            <a:gdLst/>
            <a:ahLst/>
            <a:cxnLst/>
            <a:rect l="l" t="t" r="r" b="b"/>
            <a:pathLst>
              <a:path w="6350" h="27939">
                <a:moveTo>
                  <a:pt x="0" y="13716"/>
                </a:moveTo>
                <a:lnTo>
                  <a:pt x="6096" y="13716"/>
                </a:lnTo>
              </a:path>
            </a:pathLst>
          </a:custGeom>
          <a:ln w="28702">
            <a:solidFill>
              <a:srgbClr val="868686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5" name="object 195"/>
          <p:cNvSpPr/>
          <p:nvPr/>
        </p:nvSpPr>
        <p:spPr>
          <a:xfrm>
            <a:off x="5889891" y="5079238"/>
            <a:ext cx="1978647" cy="783844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196" name="object 196"/>
          <p:cNvSpPr txBox="1"/>
          <p:nvPr/>
        </p:nvSpPr>
        <p:spPr>
          <a:xfrm>
            <a:off x="5708272" y="5757415"/>
            <a:ext cx="11430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7" name="object 197"/>
          <p:cNvSpPr txBox="1"/>
          <p:nvPr/>
        </p:nvSpPr>
        <p:spPr>
          <a:xfrm>
            <a:off x="5665603" y="5278877"/>
            <a:ext cx="15684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8" name="object 198"/>
          <p:cNvSpPr txBox="1"/>
          <p:nvPr/>
        </p:nvSpPr>
        <p:spPr>
          <a:xfrm>
            <a:off x="5621404" y="4800338"/>
            <a:ext cx="201295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199" name="object 199"/>
          <p:cNvSpPr/>
          <p:nvPr/>
        </p:nvSpPr>
        <p:spPr>
          <a:xfrm>
            <a:off x="7999361" y="5324855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9BBB59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0" name="object 200"/>
          <p:cNvSpPr/>
          <p:nvPr/>
        </p:nvSpPr>
        <p:spPr>
          <a:xfrm>
            <a:off x="8066405" y="5298947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25908"/>
                </a:moveTo>
                <a:lnTo>
                  <a:pt x="25907" y="0"/>
                </a:lnTo>
                <a:lnTo>
                  <a:pt x="0" y="25908"/>
                </a:lnTo>
                <a:lnTo>
                  <a:pt x="25907" y="51816"/>
                </a:lnTo>
                <a:lnTo>
                  <a:pt x="51815" y="25908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1" name="object 201"/>
          <p:cNvSpPr/>
          <p:nvPr/>
        </p:nvSpPr>
        <p:spPr>
          <a:xfrm>
            <a:off x="8063369" y="5295900"/>
            <a:ext cx="56515" cy="56515"/>
          </a:xfrm>
          <a:custGeom>
            <a:avLst/>
            <a:gdLst/>
            <a:ahLst/>
            <a:cxnLst/>
            <a:rect l="l" t="t" r="r" b="b"/>
            <a:pathLst>
              <a:path w="56515" h="56514">
                <a:moveTo>
                  <a:pt x="56387" y="30480"/>
                </a:moveTo>
                <a:lnTo>
                  <a:pt x="56387" y="25908"/>
                </a:lnTo>
                <a:lnTo>
                  <a:pt x="30479" y="0"/>
                </a:lnTo>
                <a:lnTo>
                  <a:pt x="25907" y="0"/>
                </a:lnTo>
                <a:lnTo>
                  <a:pt x="0" y="25908"/>
                </a:lnTo>
                <a:lnTo>
                  <a:pt x="0" y="30480"/>
                </a:lnTo>
                <a:lnTo>
                  <a:pt x="4571" y="35052"/>
                </a:lnTo>
                <a:lnTo>
                  <a:pt x="4571" y="25908"/>
                </a:lnTo>
                <a:lnTo>
                  <a:pt x="6857" y="28193"/>
                </a:lnTo>
                <a:lnTo>
                  <a:pt x="25907" y="9143"/>
                </a:lnTo>
                <a:lnTo>
                  <a:pt x="25907" y="4572"/>
                </a:lnTo>
                <a:lnTo>
                  <a:pt x="30479" y="4572"/>
                </a:lnTo>
                <a:lnTo>
                  <a:pt x="30479" y="9144"/>
                </a:lnTo>
                <a:lnTo>
                  <a:pt x="49529" y="28194"/>
                </a:lnTo>
                <a:lnTo>
                  <a:pt x="51815" y="25908"/>
                </a:lnTo>
                <a:lnTo>
                  <a:pt x="51815" y="35052"/>
                </a:lnTo>
                <a:lnTo>
                  <a:pt x="56387" y="30480"/>
                </a:lnTo>
                <a:close/>
              </a:path>
              <a:path w="56515" h="56514">
                <a:moveTo>
                  <a:pt x="6857" y="28194"/>
                </a:moveTo>
                <a:lnTo>
                  <a:pt x="4571" y="25908"/>
                </a:lnTo>
                <a:lnTo>
                  <a:pt x="4571" y="30480"/>
                </a:lnTo>
                <a:lnTo>
                  <a:pt x="6857" y="28194"/>
                </a:lnTo>
                <a:close/>
              </a:path>
              <a:path w="56515" h="56514">
                <a:moveTo>
                  <a:pt x="28193" y="49530"/>
                </a:moveTo>
                <a:lnTo>
                  <a:pt x="6857" y="28194"/>
                </a:lnTo>
                <a:lnTo>
                  <a:pt x="4571" y="30480"/>
                </a:lnTo>
                <a:lnTo>
                  <a:pt x="4571" y="35052"/>
                </a:lnTo>
                <a:lnTo>
                  <a:pt x="25907" y="56388"/>
                </a:lnTo>
                <a:lnTo>
                  <a:pt x="25907" y="51816"/>
                </a:lnTo>
                <a:lnTo>
                  <a:pt x="28193" y="49530"/>
                </a:lnTo>
                <a:close/>
              </a:path>
              <a:path w="56515" h="56514">
                <a:moveTo>
                  <a:pt x="30479" y="4572"/>
                </a:moveTo>
                <a:lnTo>
                  <a:pt x="25907" y="4572"/>
                </a:lnTo>
                <a:lnTo>
                  <a:pt x="28193" y="6857"/>
                </a:lnTo>
                <a:lnTo>
                  <a:pt x="30479" y="4572"/>
                </a:lnTo>
                <a:close/>
              </a:path>
              <a:path w="56515" h="56514">
                <a:moveTo>
                  <a:pt x="28193" y="6858"/>
                </a:moveTo>
                <a:lnTo>
                  <a:pt x="25907" y="4572"/>
                </a:lnTo>
                <a:lnTo>
                  <a:pt x="25907" y="9143"/>
                </a:lnTo>
                <a:lnTo>
                  <a:pt x="28193" y="6858"/>
                </a:lnTo>
                <a:close/>
              </a:path>
              <a:path w="56515" h="56514">
                <a:moveTo>
                  <a:pt x="30479" y="51816"/>
                </a:moveTo>
                <a:lnTo>
                  <a:pt x="28193" y="49530"/>
                </a:lnTo>
                <a:lnTo>
                  <a:pt x="25907" y="51816"/>
                </a:lnTo>
                <a:lnTo>
                  <a:pt x="30479" y="51816"/>
                </a:lnTo>
                <a:close/>
              </a:path>
              <a:path w="56515" h="56514">
                <a:moveTo>
                  <a:pt x="30479" y="56388"/>
                </a:moveTo>
                <a:lnTo>
                  <a:pt x="30479" y="51816"/>
                </a:lnTo>
                <a:lnTo>
                  <a:pt x="25907" y="51816"/>
                </a:lnTo>
                <a:lnTo>
                  <a:pt x="25907" y="56388"/>
                </a:lnTo>
                <a:lnTo>
                  <a:pt x="30479" y="56388"/>
                </a:lnTo>
                <a:close/>
              </a:path>
              <a:path w="56515" h="56514">
                <a:moveTo>
                  <a:pt x="30479" y="9144"/>
                </a:moveTo>
                <a:lnTo>
                  <a:pt x="30479" y="4572"/>
                </a:lnTo>
                <a:lnTo>
                  <a:pt x="28193" y="6858"/>
                </a:lnTo>
                <a:lnTo>
                  <a:pt x="30479" y="9144"/>
                </a:lnTo>
                <a:close/>
              </a:path>
              <a:path w="56515" h="56514">
                <a:moveTo>
                  <a:pt x="51815" y="35052"/>
                </a:moveTo>
                <a:lnTo>
                  <a:pt x="51815" y="30480"/>
                </a:lnTo>
                <a:lnTo>
                  <a:pt x="49529" y="28193"/>
                </a:lnTo>
                <a:lnTo>
                  <a:pt x="28193" y="49530"/>
                </a:lnTo>
                <a:lnTo>
                  <a:pt x="30479" y="51816"/>
                </a:lnTo>
                <a:lnTo>
                  <a:pt x="30479" y="56388"/>
                </a:lnTo>
                <a:lnTo>
                  <a:pt x="51815" y="35052"/>
                </a:lnTo>
                <a:close/>
              </a:path>
              <a:path w="56515" h="56514">
                <a:moveTo>
                  <a:pt x="51815" y="30480"/>
                </a:moveTo>
                <a:lnTo>
                  <a:pt x="51815" y="25908"/>
                </a:lnTo>
                <a:lnTo>
                  <a:pt x="49529" y="28193"/>
                </a:lnTo>
                <a:lnTo>
                  <a:pt x="51815" y="30480"/>
                </a:lnTo>
                <a:close/>
              </a:path>
            </a:pathLst>
          </a:custGeom>
          <a:solidFill>
            <a:srgbClr val="9BBB59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2" name="object 202"/>
          <p:cNvSpPr txBox="1"/>
          <p:nvPr/>
        </p:nvSpPr>
        <p:spPr>
          <a:xfrm>
            <a:off x="8180203" y="5260548"/>
            <a:ext cx="405765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5" dirty="0">
                <a:latin typeface="Calibri"/>
                <a:cs typeface="Calibri"/>
              </a:rPr>
              <a:t>R</a:t>
            </a:r>
            <a:r>
              <a:rPr sz="650" spc="5" dirty="0">
                <a:latin typeface="Calibri"/>
                <a:cs typeface="Calibri"/>
              </a:rPr>
              <a:t>efe</a:t>
            </a:r>
            <a:r>
              <a:rPr sz="650" spc="10" dirty="0">
                <a:latin typeface="Calibri"/>
                <a:cs typeface="Calibri"/>
              </a:rPr>
              <a:t>re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10" dirty="0">
                <a:latin typeface="Calibri"/>
                <a:cs typeface="Calibri"/>
              </a:rPr>
              <a:t>e</a:t>
            </a:r>
            <a:r>
              <a:rPr sz="650" spc="5" dirty="0">
                <a:latin typeface="Calibri"/>
                <a:cs typeface="Calibri"/>
              </a:rPr>
              <a:t>:</a:t>
            </a:r>
            <a:r>
              <a:rPr sz="650" spc="10" dirty="0">
                <a:latin typeface="Calibri"/>
                <a:cs typeface="Calibri"/>
              </a:rPr>
              <a:t> Z</a:t>
            </a:r>
            <a:r>
              <a:rPr sz="650" dirty="0">
                <a:latin typeface="Calibri"/>
                <a:cs typeface="Calibri"/>
              </a:rPr>
              <a:t>o</a:t>
            </a:r>
            <a:r>
              <a:rPr sz="650" spc="10" dirty="0">
                <a:latin typeface="Calibri"/>
                <a:cs typeface="Calibri"/>
              </a:rPr>
              <a:t>v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rax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3" name="object 203"/>
          <p:cNvSpPr/>
          <p:nvPr/>
        </p:nvSpPr>
        <p:spPr>
          <a:xfrm>
            <a:off x="7999361" y="5618988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4" name="object 204"/>
          <p:cNvSpPr/>
          <p:nvPr/>
        </p:nvSpPr>
        <p:spPr>
          <a:xfrm>
            <a:off x="8066417" y="5618988"/>
            <a:ext cx="52069" cy="0"/>
          </a:xfrm>
          <a:custGeom>
            <a:avLst/>
            <a:gdLst/>
            <a:ahLst/>
            <a:cxnLst/>
            <a:rect l="l" t="t" r="r" b="b"/>
            <a:pathLst>
              <a:path w="52070">
                <a:moveTo>
                  <a:pt x="0" y="0"/>
                </a:moveTo>
                <a:lnTo>
                  <a:pt x="51816" y="0"/>
                </a:lnTo>
              </a:path>
            </a:pathLst>
          </a:custGeom>
          <a:ln w="53085">
            <a:solidFill>
              <a:srgbClr val="4F81B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5" name="object 205"/>
          <p:cNvSpPr/>
          <p:nvPr/>
        </p:nvSpPr>
        <p:spPr>
          <a:xfrm>
            <a:off x="8063369" y="5590032"/>
            <a:ext cx="58419" cy="58419"/>
          </a:xfrm>
          <a:custGeom>
            <a:avLst/>
            <a:gdLst/>
            <a:ahLst/>
            <a:cxnLst/>
            <a:rect l="l" t="t" r="r" b="b"/>
            <a:pathLst>
              <a:path w="58420" h="58420">
                <a:moveTo>
                  <a:pt x="57912" y="54864"/>
                </a:moveTo>
                <a:lnTo>
                  <a:pt x="57912" y="3048"/>
                </a:lnTo>
                <a:lnTo>
                  <a:pt x="54864" y="0"/>
                </a:lnTo>
                <a:lnTo>
                  <a:pt x="3047" y="0"/>
                </a:lnTo>
                <a:lnTo>
                  <a:pt x="0" y="3048"/>
                </a:lnTo>
                <a:lnTo>
                  <a:pt x="0" y="54864"/>
                </a:lnTo>
                <a:lnTo>
                  <a:pt x="3048" y="57912"/>
                </a:lnTo>
                <a:lnTo>
                  <a:pt x="3048" y="6096"/>
                </a:lnTo>
                <a:lnTo>
                  <a:pt x="6096" y="3048"/>
                </a:lnTo>
                <a:lnTo>
                  <a:pt x="6096" y="6096"/>
                </a:lnTo>
                <a:lnTo>
                  <a:pt x="51816" y="6096"/>
                </a:lnTo>
                <a:lnTo>
                  <a:pt x="51816" y="3048"/>
                </a:lnTo>
                <a:lnTo>
                  <a:pt x="54864" y="6096"/>
                </a:lnTo>
                <a:lnTo>
                  <a:pt x="54864" y="57912"/>
                </a:lnTo>
                <a:lnTo>
                  <a:pt x="57912" y="54864"/>
                </a:lnTo>
                <a:close/>
              </a:path>
              <a:path w="58420" h="58420">
                <a:moveTo>
                  <a:pt x="6096" y="6096"/>
                </a:moveTo>
                <a:lnTo>
                  <a:pt x="6096" y="3048"/>
                </a:lnTo>
                <a:lnTo>
                  <a:pt x="3048" y="6096"/>
                </a:lnTo>
                <a:lnTo>
                  <a:pt x="6096" y="6096"/>
                </a:lnTo>
                <a:close/>
              </a:path>
              <a:path w="58420" h="58420">
                <a:moveTo>
                  <a:pt x="6096" y="51816"/>
                </a:moveTo>
                <a:lnTo>
                  <a:pt x="6096" y="6096"/>
                </a:lnTo>
                <a:lnTo>
                  <a:pt x="3048" y="6096"/>
                </a:lnTo>
                <a:lnTo>
                  <a:pt x="3048" y="51816"/>
                </a:lnTo>
                <a:lnTo>
                  <a:pt x="6096" y="51816"/>
                </a:lnTo>
                <a:close/>
              </a:path>
              <a:path w="58420" h="58420">
                <a:moveTo>
                  <a:pt x="54864" y="51816"/>
                </a:moveTo>
                <a:lnTo>
                  <a:pt x="3048" y="51816"/>
                </a:lnTo>
                <a:lnTo>
                  <a:pt x="6096" y="54864"/>
                </a:lnTo>
                <a:lnTo>
                  <a:pt x="6096" y="57912"/>
                </a:lnTo>
                <a:lnTo>
                  <a:pt x="51816" y="57912"/>
                </a:lnTo>
                <a:lnTo>
                  <a:pt x="51816" y="54864"/>
                </a:lnTo>
                <a:lnTo>
                  <a:pt x="54864" y="51816"/>
                </a:lnTo>
                <a:close/>
              </a:path>
              <a:path w="58420" h="58420">
                <a:moveTo>
                  <a:pt x="6096" y="57912"/>
                </a:moveTo>
                <a:lnTo>
                  <a:pt x="6096" y="54864"/>
                </a:lnTo>
                <a:lnTo>
                  <a:pt x="3048" y="51816"/>
                </a:lnTo>
                <a:lnTo>
                  <a:pt x="3048" y="57912"/>
                </a:lnTo>
                <a:lnTo>
                  <a:pt x="6096" y="57912"/>
                </a:lnTo>
                <a:close/>
              </a:path>
              <a:path w="58420" h="58420">
                <a:moveTo>
                  <a:pt x="54864" y="6096"/>
                </a:moveTo>
                <a:lnTo>
                  <a:pt x="51816" y="3048"/>
                </a:lnTo>
                <a:lnTo>
                  <a:pt x="51816" y="6096"/>
                </a:lnTo>
                <a:lnTo>
                  <a:pt x="54864" y="6096"/>
                </a:lnTo>
                <a:close/>
              </a:path>
              <a:path w="58420" h="58420">
                <a:moveTo>
                  <a:pt x="54864" y="51816"/>
                </a:moveTo>
                <a:lnTo>
                  <a:pt x="54864" y="6096"/>
                </a:lnTo>
                <a:lnTo>
                  <a:pt x="51816" y="6096"/>
                </a:lnTo>
                <a:lnTo>
                  <a:pt x="51816" y="51816"/>
                </a:lnTo>
                <a:lnTo>
                  <a:pt x="54864" y="51816"/>
                </a:lnTo>
                <a:close/>
              </a:path>
              <a:path w="58420" h="58420">
                <a:moveTo>
                  <a:pt x="54864" y="57912"/>
                </a:moveTo>
                <a:lnTo>
                  <a:pt x="54864" y="51816"/>
                </a:lnTo>
                <a:lnTo>
                  <a:pt x="51816" y="54864"/>
                </a:lnTo>
                <a:lnTo>
                  <a:pt x="51816" y="57912"/>
                </a:lnTo>
                <a:lnTo>
                  <a:pt x="54864" y="57912"/>
                </a:lnTo>
                <a:close/>
              </a:path>
            </a:pathLst>
          </a:custGeom>
          <a:solidFill>
            <a:srgbClr val="4F81B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6" name="object 206"/>
          <p:cNvSpPr txBox="1"/>
          <p:nvPr/>
        </p:nvSpPr>
        <p:spPr>
          <a:xfrm>
            <a:off x="8180203" y="5560821"/>
            <a:ext cx="516890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1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</a:t>
            </a:r>
            <a:r>
              <a:rPr sz="650" spc="10" dirty="0">
                <a:latin typeface="Calibri"/>
                <a:cs typeface="Calibri"/>
              </a:rPr>
              <a:t> mg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0" dirty="0">
                <a:latin typeface="Calibri"/>
                <a:cs typeface="Calibri"/>
              </a:rPr>
              <a:t>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07" name="object 207"/>
          <p:cNvSpPr/>
          <p:nvPr/>
        </p:nvSpPr>
        <p:spPr>
          <a:xfrm>
            <a:off x="7999361" y="5913120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0" y="0"/>
                </a:moveTo>
                <a:lnTo>
                  <a:pt x="184403" y="0"/>
                </a:lnTo>
              </a:path>
            </a:pathLst>
          </a:custGeom>
          <a:ln w="19557">
            <a:solidFill>
              <a:srgbClr val="C0504D"/>
            </a:solidFill>
          </a:ln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8" name="object 208"/>
          <p:cNvSpPr/>
          <p:nvPr/>
        </p:nvSpPr>
        <p:spPr>
          <a:xfrm>
            <a:off x="8066405" y="5887211"/>
            <a:ext cx="52069" cy="52069"/>
          </a:xfrm>
          <a:custGeom>
            <a:avLst/>
            <a:gdLst/>
            <a:ahLst/>
            <a:cxnLst/>
            <a:rect l="l" t="t" r="r" b="b"/>
            <a:pathLst>
              <a:path w="52070" h="52070">
                <a:moveTo>
                  <a:pt x="51815" y="51816"/>
                </a:moveTo>
                <a:lnTo>
                  <a:pt x="25907" y="0"/>
                </a:lnTo>
                <a:lnTo>
                  <a:pt x="0" y="51816"/>
                </a:lnTo>
                <a:lnTo>
                  <a:pt x="51815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09" name="object 209"/>
          <p:cNvSpPr/>
          <p:nvPr/>
        </p:nvSpPr>
        <p:spPr>
          <a:xfrm>
            <a:off x="8063369" y="5884164"/>
            <a:ext cx="56515" cy="58419"/>
          </a:xfrm>
          <a:custGeom>
            <a:avLst/>
            <a:gdLst/>
            <a:ahLst/>
            <a:cxnLst/>
            <a:rect l="l" t="t" r="r" b="b"/>
            <a:pathLst>
              <a:path w="56515" h="58420">
                <a:moveTo>
                  <a:pt x="56387" y="56388"/>
                </a:moveTo>
                <a:lnTo>
                  <a:pt x="56387" y="53340"/>
                </a:lnTo>
                <a:lnTo>
                  <a:pt x="30479" y="1524"/>
                </a:lnTo>
                <a:lnTo>
                  <a:pt x="28955" y="0"/>
                </a:lnTo>
                <a:lnTo>
                  <a:pt x="25907" y="1524"/>
                </a:lnTo>
                <a:lnTo>
                  <a:pt x="0" y="53340"/>
                </a:lnTo>
                <a:lnTo>
                  <a:pt x="0" y="56388"/>
                </a:lnTo>
                <a:lnTo>
                  <a:pt x="3047" y="57912"/>
                </a:lnTo>
                <a:lnTo>
                  <a:pt x="3047" y="51816"/>
                </a:lnTo>
                <a:lnTo>
                  <a:pt x="6095" y="51816"/>
                </a:lnTo>
                <a:lnTo>
                  <a:pt x="25907" y="12192"/>
                </a:lnTo>
                <a:lnTo>
                  <a:pt x="25907" y="3048"/>
                </a:lnTo>
                <a:lnTo>
                  <a:pt x="30479" y="3048"/>
                </a:lnTo>
                <a:lnTo>
                  <a:pt x="30479" y="12192"/>
                </a:lnTo>
                <a:lnTo>
                  <a:pt x="50291" y="51816"/>
                </a:lnTo>
                <a:lnTo>
                  <a:pt x="54863" y="51816"/>
                </a:lnTo>
                <a:lnTo>
                  <a:pt x="54863" y="57912"/>
                </a:lnTo>
                <a:lnTo>
                  <a:pt x="56387" y="56388"/>
                </a:lnTo>
                <a:close/>
              </a:path>
              <a:path w="56515" h="58420">
                <a:moveTo>
                  <a:pt x="6095" y="51816"/>
                </a:moveTo>
                <a:lnTo>
                  <a:pt x="3047" y="51816"/>
                </a:lnTo>
                <a:lnTo>
                  <a:pt x="4571" y="54864"/>
                </a:lnTo>
                <a:lnTo>
                  <a:pt x="6095" y="51816"/>
                </a:lnTo>
                <a:close/>
              </a:path>
              <a:path w="56515" h="58420">
                <a:moveTo>
                  <a:pt x="54863" y="57912"/>
                </a:moveTo>
                <a:lnTo>
                  <a:pt x="54863" y="51816"/>
                </a:lnTo>
                <a:lnTo>
                  <a:pt x="51815" y="54864"/>
                </a:lnTo>
                <a:lnTo>
                  <a:pt x="50291" y="51816"/>
                </a:lnTo>
                <a:lnTo>
                  <a:pt x="6095" y="51816"/>
                </a:lnTo>
                <a:lnTo>
                  <a:pt x="4571" y="54864"/>
                </a:lnTo>
                <a:lnTo>
                  <a:pt x="3047" y="51816"/>
                </a:lnTo>
                <a:lnTo>
                  <a:pt x="3047" y="57912"/>
                </a:lnTo>
                <a:lnTo>
                  <a:pt x="54863" y="57912"/>
                </a:lnTo>
                <a:close/>
              </a:path>
              <a:path w="56515" h="58420">
                <a:moveTo>
                  <a:pt x="30479" y="3048"/>
                </a:moveTo>
                <a:lnTo>
                  <a:pt x="25907" y="3048"/>
                </a:lnTo>
                <a:lnTo>
                  <a:pt x="28193" y="7620"/>
                </a:lnTo>
                <a:lnTo>
                  <a:pt x="30479" y="3048"/>
                </a:lnTo>
                <a:close/>
              </a:path>
              <a:path w="56515" h="58420">
                <a:moveTo>
                  <a:pt x="28193" y="7620"/>
                </a:moveTo>
                <a:lnTo>
                  <a:pt x="25907" y="3048"/>
                </a:lnTo>
                <a:lnTo>
                  <a:pt x="25907" y="12192"/>
                </a:lnTo>
                <a:lnTo>
                  <a:pt x="28193" y="7620"/>
                </a:lnTo>
                <a:close/>
              </a:path>
              <a:path w="56515" h="58420">
                <a:moveTo>
                  <a:pt x="30479" y="12192"/>
                </a:moveTo>
                <a:lnTo>
                  <a:pt x="30479" y="3048"/>
                </a:lnTo>
                <a:lnTo>
                  <a:pt x="28193" y="7620"/>
                </a:lnTo>
                <a:lnTo>
                  <a:pt x="30479" y="12192"/>
                </a:lnTo>
                <a:close/>
              </a:path>
              <a:path w="56515" h="58420">
                <a:moveTo>
                  <a:pt x="54863" y="51816"/>
                </a:moveTo>
                <a:lnTo>
                  <a:pt x="50291" y="51816"/>
                </a:lnTo>
                <a:lnTo>
                  <a:pt x="51815" y="54864"/>
                </a:lnTo>
                <a:lnTo>
                  <a:pt x="54863" y="51816"/>
                </a:lnTo>
                <a:close/>
              </a:path>
            </a:pathLst>
          </a:custGeom>
          <a:solidFill>
            <a:srgbClr val="C0504D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0" name="object 210"/>
          <p:cNvSpPr txBox="1"/>
          <p:nvPr/>
        </p:nvSpPr>
        <p:spPr>
          <a:xfrm>
            <a:off x="8180203" y="5854953"/>
            <a:ext cx="433705" cy="2222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T</a:t>
            </a:r>
            <a:r>
              <a:rPr sz="650" dirty="0">
                <a:latin typeface="Calibri"/>
                <a:cs typeface="Calibri"/>
              </a:rPr>
              <a:t>2</a:t>
            </a:r>
            <a:r>
              <a:rPr sz="650" spc="5" dirty="0">
                <a:latin typeface="Calibri"/>
                <a:cs typeface="Calibri"/>
              </a:rPr>
              <a:t>: </a:t>
            </a:r>
            <a:r>
              <a:rPr sz="650" spc="15" dirty="0">
                <a:latin typeface="Calibri"/>
                <a:cs typeface="Calibri"/>
              </a:rPr>
              <a:t>Z+</a:t>
            </a:r>
            <a:r>
              <a:rPr sz="65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0</a:t>
            </a:r>
            <a:r>
              <a:rPr sz="650" spc="15" dirty="0">
                <a:latin typeface="Calibri"/>
                <a:cs typeface="Calibri"/>
              </a:rPr>
              <a:t>00</a:t>
            </a:r>
            <a:endParaRPr sz="6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15" dirty="0">
                <a:latin typeface="Calibri"/>
                <a:cs typeface="Calibri"/>
              </a:rPr>
              <a:t>mg</a:t>
            </a:r>
            <a:r>
              <a:rPr sz="650" spc="10" dirty="0">
                <a:latin typeface="Calibri"/>
                <a:cs typeface="Calibri"/>
              </a:rPr>
              <a:t> C</a:t>
            </a:r>
            <a:r>
              <a:rPr sz="650" spc="15" dirty="0">
                <a:latin typeface="Calibri"/>
                <a:cs typeface="Calibri"/>
              </a:rPr>
              <a:t>h</a:t>
            </a:r>
            <a:r>
              <a:rPr sz="650" dirty="0">
                <a:latin typeface="Calibri"/>
                <a:cs typeface="Calibri"/>
              </a:rPr>
              <a:t>i</a:t>
            </a:r>
            <a:r>
              <a:rPr sz="650" spc="10" dirty="0">
                <a:latin typeface="Calibri"/>
                <a:cs typeface="Calibri"/>
              </a:rPr>
              <a:t>t</a:t>
            </a:r>
            <a:r>
              <a:rPr sz="650" spc="5" dirty="0">
                <a:latin typeface="Calibri"/>
                <a:cs typeface="Calibri"/>
              </a:rPr>
              <a:t> HCl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11" name="object 211"/>
          <p:cNvSpPr/>
          <p:nvPr/>
        </p:nvSpPr>
        <p:spPr>
          <a:xfrm>
            <a:off x="5178437" y="4742688"/>
            <a:ext cx="3584575" cy="1754505"/>
          </a:xfrm>
          <a:custGeom>
            <a:avLst/>
            <a:gdLst/>
            <a:ahLst/>
            <a:cxnLst/>
            <a:rect l="l" t="t" r="r" b="b"/>
            <a:pathLst>
              <a:path w="3584575" h="1754504">
                <a:moveTo>
                  <a:pt x="3584448" y="1752599"/>
                </a:moveTo>
                <a:lnTo>
                  <a:pt x="3584448" y="1523"/>
                </a:lnTo>
                <a:lnTo>
                  <a:pt x="3582924" y="0"/>
                </a:lnTo>
                <a:lnTo>
                  <a:pt x="1523" y="0"/>
                </a:lnTo>
                <a:lnTo>
                  <a:pt x="0" y="1524"/>
                </a:lnTo>
                <a:lnTo>
                  <a:pt x="0" y="1752600"/>
                </a:lnTo>
                <a:lnTo>
                  <a:pt x="1524" y="1754124"/>
                </a:lnTo>
                <a:lnTo>
                  <a:pt x="3048" y="1754124"/>
                </a:lnTo>
                <a:lnTo>
                  <a:pt x="3048" y="7620"/>
                </a:lnTo>
                <a:lnTo>
                  <a:pt x="7620" y="3048"/>
                </a:lnTo>
                <a:lnTo>
                  <a:pt x="7620" y="7620"/>
                </a:lnTo>
                <a:lnTo>
                  <a:pt x="3576828" y="7619"/>
                </a:lnTo>
                <a:lnTo>
                  <a:pt x="3576828" y="3047"/>
                </a:lnTo>
                <a:lnTo>
                  <a:pt x="3579876" y="7619"/>
                </a:lnTo>
                <a:lnTo>
                  <a:pt x="3579876" y="1754123"/>
                </a:lnTo>
                <a:lnTo>
                  <a:pt x="3582924" y="1754123"/>
                </a:lnTo>
                <a:lnTo>
                  <a:pt x="3584448" y="1752599"/>
                </a:lnTo>
                <a:close/>
              </a:path>
              <a:path w="3584575" h="1754504">
                <a:moveTo>
                  <a:pt x="7620" y="7620"/>
                </a:moveTo>
                <a:lnTo>
                  <a:pt x="7620" y="3048"/>
                </a:lnTo>
                <a:lnTo>
                  <a:pt x="3048" y="7620"/>
                </a:lnTo>
                <a:lnTo>
                  <a:pt x="7620" y="7620"/>
                </a:lnTo>
                <a:close/>
              </a:path>
              <a:path w="3584575" h="1754504">
                <a:moveTo>
                  <a:pt x="7620" y="1746504"/>
                </a:moveTo>
                <a:lnTo>
                  <a:pt x="7620" y="7620"/>
                </a:lnTo>
                <a:lnTo>
                  <a:pt x="3048" y="7620"/>
                </a:lnTo>
                <a:lnTo>
                  <a:pt x="3048" y="1746504"/>
                </a:lnTo>
                <a:lnTo>
                  <a:pt x="7620" y="1746504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048" y="1746504"/>
                </a:lnTo>
                <a:lnTo>
                  <a:pt x="7620" y="1751076"/>
                </a:lnTo>
                <a:lnTo>
                  <a:pt x="7619" y="1754124"/>
                </a:lnTo>
                <a:lnTo>
                  <a:pt x="3576828" y="1754123"/>
                </a:lnTo>
                <a:lnTo>
                  <a:pt x="3576828" y="1751075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7619" y="1754124"/>
                </a:moveTo>
                <a:lnTo>
                  <a:pt x="7620" y="1751076"/>
                </a:lnTo>
                <a:lnTo>
                  <a:pt x="3048" y="1746504"/>
                </a:lnTo>
                <a:lnTo>
                  <a:pt x="3048" y="1754124"/>
                </a:lnTo>
                <a:lnTo>
                  <a:pt x="7619" y="1754124"/>
                </a:lnTo>
                <a:close/>
              </a:path>
              <a:path w="3584575" h="1754504">
                <a:moveTo>
                  <a:pt x="3579876" y="7619"/>
                </a:moveTo>
                <a:lnTo>
                  <a:pt x="3576828" y="3047"/>
                </a:lnTo>
                <a:lnTo>
                  <a:pt x="3576828" y="7619"/>
                </a:lnTo>
                <a:lnTo>
                  <a:pt x="3579876" y="7619"/>
                </a:lnTo>
                <a:close/>
              </a:path>
              <a:path w="3584575" h="1754504">
                <a:moveTo>
                  <a:pt x="3579876" y="1746503"/>
                </a:moveTo>
                <a:lnTo>
                  <a:pt x="3579876" y="7619"/>
                </a:lnTo>
                <a:lnTo>
                  <a:pt x="3576828" y="7619"/>
                </a:lnTo>
                <a:lnTo>
                  <a:pt x="3576828" y="1746503"/>
                </a:lnTo>
                <a:lnTo>
                  <a:pt x="3579876" y="1746503"/>
                </a:lnTo>
                <a:close/>
              </a:path>
              <a:path w="3584575" h="1754504">
                <a:moveTo>
                  <a:pt x="3579876" y="1754123"/>
                </a:moveTo>
                <a:lnTo>
                  <a:pt x="3579876" y="1746503"/>
                </a:lnTo>
                <a:lnTo>
                  <a:pt x="3576828" y="1751075"/>
                </a:lnTo>
                <a:lnTo>
                  <a:pt x="3576828" y="1754123"/>
                </a:lnTo>
                <a:lnTo>
                  <a:pt x="3579876" y="1754123"/>
                </a:lnTo>
                <a:close/>
              </a:path>
            </a:pathLst>
          </a:custGeom>
          <a:solidFill>
            <a:srgbClr val="868686"/>
          </a:solidFill>
        </p:spPr>
        <p:txBody>
          <a:bodyPr wrap="square" lIns="0" tIns="0" rIns="0" bIns="0" rtlCol="0">
            <a:spAutoFit/>
          </a:bodyPr>
          <a:lstStyle/>
          <a:p>
            <a:endParaRPr/>
          </a:p>
        </p:txBody>
      </p:sp>
      <p:sp>
        <p:nvSpPr>
          <p:cNvPr id="212" name="object 212"/>
          <p:cNvSpPr txBox="1"/>
          <p:nvPr/>
        </p:nvSpPr>
        <p:spPr>
          <a:xfrm>
            <a:off x="8085714" y="4854740"/>
            <a:ext cx="448309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1299"/>
              </a:lnSpc>
            </a:pPr>
            <a:r>
              <a:rPr sz="750" b="1" spc="-10" dirty="0">
                <a:latin typeface="Calibri"/>
                <a:cs typeface="Calibri"/>
              </a:rPr>
              <a:t>P1</a:t>
            </a:r>
            <a:r>
              <a:rPr sz="750" b="1" spc="-5" dirty="0">
                <a:latin typeface="Calibri"/>
                <a:cs typeface="Calibri"/>
              </a:rPr>
              <a:t>3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10" dirty="0">
                <a:latin typeface="Calibri"/>
                <a:cs typeface="Calibri"/>
              </a:rPr>
              <a:t>log</a:t>
            </a:r>
            <a:r>
              <a:rPr sz="750" b="1" spc="-5" dirty="0">
                <a:latin typeface="Calibri"/>
                <a:cs typeface="Calibri"/>
              </a:rPr>
              <a:t>/</a:t>
            </a:r>
            <a:r>
              <a:rPr sz="750" b="1" spc="-10" dirty="0">
                <a:latin typeface="Calibri"/>
                <a:cs typeface="Calibri"/>
              </a:rPr>
              <a:t>lin Se</a:t>
            </a:r>
            <a:r>
              <a:rPr sz="750" b="1" spc="-5" dirty="0">
                <a:latin typeface="Calibri"/>
                <a:cs typeface="Calibri"/>
              </a:rPr>
              <a:t>q</a:t>
            </a:r>
            <a:r>
              <a:rPr sz="750" b="1" spc="5" dirty="0">
                <a:latin typeface="Calibri"/>
                <a:cs typeface="Calibri"/>
              </a:rPr>
              <a:t> </a:t>
            </a:r>
            <a:r>
              <a:rPr sz="750" b="1" spc="-5" dirty="0">
                <a:latin typeface="Calibri"/>
                <a:cs typeface="Calibri"/>
              </a:rPr>
              <a:t>R</a:t>
            </a:r>
            <a:r>
              <a:rPr sz="750" b="1" spc="-10" dirty="0">
                <a:latin typeface="Calibri"/>
                <a:cs typeface="Calibri"/>
              </a:rPr>
              <a:t>21</a:t>
            </a:r>
            <a:r>
              <a:rPr sz="750" b="1" spc="-5" dirty="0">
                <a:latin typeface="Calibri"/>
                <a:cs typeface="Calibri"/>
              </a:rPr>
              <a:t>T1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214" name="object 214"/>
          <p:cNvSpPr txBox="1"/>
          <p:nvPr/>
        </p:nvSpPr>
        <p:spPr>
          <a:xfrm>
            <a:off x="1622431" y="6235953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15" name="object 215"/>
          <p:cNvSpPr txBox="1"/>
          <p:nvPr/>
        </p:nvSpPr>
        <p:spPr>
          <a:xfrm>
            <a:off x="5752471" y="6235953"/>
            <a:ext cx="69850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1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16" name="object 216"/>
          <p:cNvSpPr txBox="1">
            <a:spLocks noGrp="1"/>
          </p:cNvSpPr>
          <p:nvPr>
            <p:ph type="ftr" sz="quarter" idx="5"/>
          </p:nvPr>
        </p:nvSpPr>
        <p:spPr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/>
              <a:t>6     </a:t>
            </a:r>
            <a:r>
              <a:rPr sz="650" spc="40" dirty="0"/>
              <a:t> </a:t>
            </a:r>
            <a:r>
              <a:rPr sz="650" spc="15" dirty="0"/>
              <a:t>7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8</a:t>
            </a:r>
            <a:r>
              <a:rPr sz="650" dirty="0"/>
              <a:t>     </a:t>
            </a:r>
            <a:r>
              <a:rPr sz="650" spc="40" dirty="0"/>
              <a:t> </a:t>
            </a:r>
            <a:r>
              <a:rPr sz="650" spc="15" dirty="0"/>
              <a:t>9</a:t>
            </a:r>
            <a:r>
              <a:rPr sz="650" dirty="0"/>
              <a:t>    </a:t>
            </a:r>
            <a:r>
              <a:rPr sz="650" spc="20" dirty="0"/>
              <a:t> </a:t>
            </a:r>
            <a:r>
              <a:rPr sz="650" spc="15" dirty="0"/>
              <a:t>10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1</a:t>
            </a:r>
            <a:r>
              <a:rPr sz="650" dirty="0"/>
              <a:t>   </a:t>
            </a:r>
            <a:r>
              <a:rPr sz="650" spc="-15" dirty="0"/>
              <a:t> </a:t>
            </a:r>
            <a:r>
              <a:rPr sz="650" spc="15" dirty="0"/>
              <a:t>1</a:t>
            </a:r>
            <a:r>
              <a:rPr sz="650" spc="30" dirty="0"/>
              <a:t>2</a:t>
            </a:r>
            <a:r>
              <a:rPr spc="-5" dirty="0"/>
              <a:t>t</a:t>
            </a:r>
            <a:r>
              <a:rPr spc="-10" dirty="0"/>
              <a:t>i</a:t>
            </a:r>
            <a:r>
              <a:rPr spc="-5" dirty="0"/>
              <a:t>me</a:t>
            </a:r>
            <a:r>
              <a:rPr dirty="0"/>
              <a:t> </a:t>
            </a:r>
            <a:r>
              <a:rPr spc="-5" dirty="0"/>
              <a:t>(h)</a:t>
            </a:r>
            <a:endParaRPr sz="650"/>
          </a:p>
        </p:txBody>
      </p:sp>
      <p:sp>
        <p:nvSpPr>
          <p:cNvPr id="217" name="object 217"/>
          <p:cNvSpPr txBox="1"/>
          <p:nvPr/>
        </p:nvSpPr>
        <p:spPr>
          <a:xfrm>
            <a:off x="6823918" y="6336026"/>
            <a:ext cx="1371600" cy="1301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6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7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8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9</a:t>
            </a:r>
            <a:r>
              <a:rPr sz="650" dirty="0">
                <a:latin typeface="Calibri"/>
                <a:cs typeface="Calibri"/>
              </a:rPr>
              <a:t>    </a:t>
            </a:r>
            <a:r>
              <a:rPr sz="650" spc="2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0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1</a:t>
            </a:r>
            <a:r>
              <a:rPr sz="650" dirty="0">
                <a:latin typeface="Calibri"/>
                <a:cs typeface="Calibri"/>
              </a:rPr>
              <a:t>   </a:t>
            </a:r>
            <a:r>
              <a:rPr sz="650" spc="-15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spc="30" dirty="0">
                <a:latin typeface="Calibri"/>
                <a:cs typeface="Calibri"/>
              </a:rPr>
              <a:t>2</a:t>
            </a:r>
            <a:r>
              <a:rPr sz="750" spc="-5" dirty="0">
                <a:latin typeface="Calibri"/>
                <a:cs typeface="Calibri"/>
              </a:rPr>
              <a:t>t</a:t>
            </a:r>
            <a:r>
              <a:rPr sz="750" spc="-10" dirty="0">
                <a:latin typeface="Calibri"/>
                <a:cs typeface="Calibri"/>
              </a:rPr>
              <a:t>i</a:t>
            </a:r>
            <a:r>
              <a:rPr sz="750" spc="-5" dirty="0">
                <a:latin typeface="Calibri"/>
                <a:cs typeface="Calibri"/>
              </a:rPr>
              <a:t>me</a:t>
            </a:r>
            <a:r>
              <a:rPr sz="750" dirty="0">
                <a:latin typeface="Calibri"/>
                <a:cs typeface="Calibri"/>
              </a:rPr>
              <a:t> </a:t>
            </a:r>
            <a:r>
              <a:rPr sz="750" spc="-5" dirty="0">
                <a:latin typeface="Calibri"/>
                <a:cs typeface="Calibri"/>
              </a:rPr>
              <a:t>(h)</a:t>
            </a:r>
            <a:endParaRPr sz="750">
              <a:latin typeface="Calibri"/>
              <a:cs typeface="Calibri"/>
            </a:endParaRPr>
          </a:p>
        </p:txBody>
      </p:sp>
      <p:sp>
        <p:nvSpPr>
          <p:cNvPr id="218" name="object 218"/>
          <p:cNvSpPr txBox="1">
            <a:spLocks noGrp="1"/>
          </p:cNvSpPr>
          <p:nvPr>
            <p:ph type="dt" sz="half" idx="6"/>
          </p:nvPr>
        </p:nvSpPr>
        <p:spPr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pc="15" dirty="0"/>
              <a:t>0     </a:t>
            </a:r>
            <a:r>
              <a:rPr spc="40" dirty="0"/>
              <a:t> </a:t>
            </a:r>
            <a:r>
              <a:rPr spc="15" dirty="0"/>
              <a:t>1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2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3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4</a:t>
            </a:r>
            <a:r>
              <a:rPr dirty="0"/>
              <a:t>     </a:t>
            </a:r>
            <a:r>
              <a:rPr spc="40" dirty="0"/>
              <a:t> </a:t>
            </a:r>
            <a:r>
              <a:rPr spc="15" dirty="0"/>
              <a:t>5</a:t>
            </a:r>
          </a:p>
        </p:txBody>
      </p:sp>
      <p:sp>
        <p:nvSpPr>
          <p:cNvPr id="219" name="object 219"/>
          <p:cNvSpPr txBox="1"/>
          <p:nvPr/>
        </p:nvSpPr>
        <p:spPr>
          <a:xfrm>
            <a:off x="5854575" y="6348726"/>
            <a:ext cx="877569" cy="1174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650" spc="15" dirty="0">
                <a:latin typeface="Calibri"/>
                <a:cs typeface="Calibri"/>
              </a:rPr>
              <a:t>0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1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2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3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4</a:t>
            </a:r>
            <a:r>
              <a:rPr sz="650" dirty="0">
                <a:latin typeface="Calibri"/>
                <a:cs typeface="Calibri"/>
              </a:rPr>
              <a:t>     </a:t>
            </a:r>
            <a:r>
              <a:rPr sz="650" spc="40" dirty="0">
                <a:latin typeface="Calibri"/>
                <a:cs typeface="Calibri"/>
              </a:rPr>
              <a:t> </a:t>
            </a:r>
            <a:r>
              <a:rPr sz="650" spc="15" dirty="0">
                <a:latin typeface="Calibri"/>
                <a:cs typeface="Calibri"/>
              </a:rPr>
              <a:t>5</a:t>
            </a:r>
            <a:endParaRPr sz="650">
              <a:latin typeface="Calibri"/>
              <a:cs typeface="Calibri"/>
            </a:endParaRPr>
          </a:p>
        </p:txBody>
      </p:sp>
      <p:sp>
        <p:nvSpPr>
          <p:cNvPr id="213" name="object 213"/>
          <p:cNvSpPr txBox="1"/>
          <p:nvPr/>
        </p:nvSpPr>
        <p:spPr>
          <a:xfrm>
            <a:off x="5270887" y="4804872"/>
            <a:ext cx="288290" cy="2286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6350">
              <a:lnSpc>
                <a:spcPct val="106200"/>
              </a:lnSpc>
            </a:pPr>
            <a:r>
              <a:rPr sz="650" spc="10" dirty="0">
                <a:latin typeface="Calibri"/>
                <a:cs typeface="Calibri"/>
              </a:rPr>
              <a:t>Co</a:t>
            </a:r>
            <a:r>
              <a:rPr sz="650" spc="15" dirty="0">
                <a:latin typeface="Calibri"/>
                <a:cs typeface="Calibri"/>
              </a:rPr>
              <a:t>nc</a:t>
            </a:r>
            <a:r>
              <a:rPr sz="650" spc="5" dirty="0">
                <a:latin typeface="Calibri"/>
                <a:cs typeface="Calibri"/>
              </a:rPr>
              <a:t> </a:t>
            </a:r>
            <a:r>
              <a:rPr sz="650" dirty="0">
                <a:latin typeface="Calibri"/>
                <a:cs typeface="Calibri"/>
              </a:rPr>
              <a:t>(</a:t>
            </a:r>
            <a:r>
              <a:rPr sz="650" spc="15" dirty="0">
                <a:latin typeface="Calibri"/>
                <a:cs typeface="Calibri"/>
              </a:rPr>
              <a:t>ng</a:t>
            </a:r>
            <a:r>
              <a:rPr sz="650" spc="5" dirty="0">
                <a:latin typeface="Calibri"/>
                <a:cs typeface="Calibri"/>
              </a:rPr>
              <a:t>/</a:t>
            </a:r>
            <a:r>
              <a:rPr sz="650" spc="30" dirty="0">
                <a:latin typeface="Calibri"/>
                <a:cs typeface="Calibri"/>
              </a:rPr>
              <a:t>m</a:t>
            </a:r>
            <a:r>
              <a:rPr sz="650" dirty="0">
                <a:latin typeface="Calibri"/>
                <a:cs typeface="Calibri"/>
              </a:rPr>
              <a:t>l</a:t>
            </a:r>
            <a:r>
              <a:rPr sz="650" spc="5" dirty="0">
                <a:latin typeface="Calibri"/>
                <a:cs typeface="Calibri"/>
              </a:rPr>
              <a:t>)</a:t>
            </a:r>
            <a:endParaRPr sz="65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Words>1161</Words>
  <Application>Microsoft Office PowerPoint</Application>
  <PresentationFormat>Custom</PresentationFormat>
  <Paragraphs>34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dividual plasma profiles_130426.xlsx</dc:title>
  <dc:creator>kubbingm</dc:creator>
  <cp:lastModifiedBy>Marlies Kubbinga</cp:lastModifiedBy>
  <cp:revision>2</cp:revision>
  <dcterms:created xsi:type="dcterms:W3CDTF">2014-09-28T23:10:07Z</dcterms:created>
  <dcterms:modified xsi:type="dcterms:W3CDTF">2014-09-28T21:13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3-04-26T00:00:00Z</vt:filetime>
  </property>
  <property fmtid="{D5CDD505-2E9C-101B-9397-08002B2CF9AE}" pid="3" name="LastSaved">
    <vt:filetime>2014-09-28T00:00:00Z</vt:filetime>
  </property>
</Properties>
</file>